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diagrams/data1.xml" ContentType="application/vnd.openxmlformats-officedocument.drawingml.diagramData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diagrams/data3.xml" ContentType="application/vnd.openxmlformats-officedocument.drawingml.diagramData+xml"/>
  <Override PartName="/ppt/diagrams/data2.xml" ContentType="application/vnd.openxmlformats-officedocument.drawingml.diagramData+xml"/>
  <Override PartName="/ppt/slideLayouts/slideLayout2.xml" ContentType="application/vnd.openxmlformats-officedocument.presentationml.slideLayout+xml"/>
  <Override PartName="/ppt/slideMasters/slideMaster1.xml" ContentType="application/vnd.openxmlformats-officedocument.presentationml.slideMaster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slideLayouts/slideLayout1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notesSlides/notesSlide6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colors1.xml" ContentType="application/vnd.openxmlformats-officedocument.drawingml.diagramColors+xml"/>
  <Override PartName="/ppt/diagrams/layout3.xml" ContentType="application/vnd.openxmlformats-officedocument.drawingml.diagramLayout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heme/theme1.xml" ContentType="application/vnd.openxmlformats-officedocument.theme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theme/theme2.xml" ContentType="application/vnd.openxmlformats-officedocument.theme+xml"/>
  <Override PartName="/ppt/theme/theme3.xml" ContentType="application/vnd.openxmlformats-officedocument.theme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drawing3.xml" ContentType="application/vnd.ms-office.drawingml.diagramDrawing+xml"/>
  <Override PartName="/ppt/diagrams/drawing1.xml" ContentType="application/vnd.ms-office.drawingml.diagramDrawing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ink/ink1.xml" ContentType="application/inkml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1.xml" ContentType="application/vnd.openxmlformats-officedocument.customXmlProperties+xml"/>
  <Override PartName="/docProps/app.xml" ContentType="application/vnd.openxmlformats-officedocument.extended-properties+xml"/>
  <Override PartName="/ppt/revisionInfo.xml" ContentType="application/vnd.ms-powerpoint.revisioninfo+xml"/>
  <Override PartName="/docProps/core.xml" ContentType="application/vnd.openxmlformats-package.core-properties+xml"/>
  <Override PartName="/ppt/changesInfos/changesInfo1.xml" ContentType="application/vnd.ms-powerpoint.changesinfo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4"/>
  </p:sldMasterIdLst>
  <p:notesMasterIdLst>
    <p:notesMasterId r:id="rId26"/>
  </p:notesMasterIdLst>
  <p:handoutMasterIdLst>
    <p:handoutMasterId r:id="rId27"/>
  </p:handoutMasterIdLst>
  <p:sldIdLst>
    <p:sldId id="496" r:id="rId5"/>
    <p:sldId id="497" r:id="rId6"/>
    <p:sldId id="550" r:id="rId7"/>
    <p:sldId id="499" r:id="rId8"/>
    <p:sldId id="498" r:id="rId9"/>
    <p:sldId id="507" r:id="rId10"/>
    <p:sldId id="508" r:id="rId11"/>
    <p:sldId id="556" r:id="rId12"/>
    <p:sldId id="545" r:id="rId13"/>
    <p:sldId id="547" r:id="rId14"/>
    <p:sldId id="557" r:id="rId15"/>
    <p:sldId id="548" r:id="rId16"/>
    <p:sldId id="511" r:id="rId17"/>
    <p:sldId id="522" r:id="rId18"/>
    <p:sldId id="525" r:id="rId19"/>
    <p:sldId id="523" r:id="rId20"/>
    <p:sldId id="526" r:id="rId21"/>
    <p:sldId id="527" r:id="rId22"/>
    <p:sldId id="528" r:id="rId23"/>
    <p:sldId id="516" r:id="rId24"/>
    <p:sldId id="560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Intro" id="{174C5AA5-6644-46B7-92BC-A464194A038D}">
          <p14:sldIdLst>
            <p14:sldId id="496"/>
            <p14:sldId id="497"/>
            <p14:sldId id="550"/>
            <p14:sldId id="499"/>
            <p14:sldId id="498"/>
            <p14:sldId id="507"/>
            <p14:sldId id="508"/>
            <p14:sldId id="556"/>
            <p14:sldId id="545"/>
            <p14:sldId id="547"/>
            <p14:sldId id="557"/>
            <p14:sldId id="548"/>
            <p14:sldId id="511"/>
            <p14:sldId id="522"/>
            <p14:sldId id="525"/>
            <p14:sldId id="523"/>
            <p14:sldId id="526"/>
            <p14:sldId id="527"/>
            <p14:sldId id="528"/>
            <p14:sldId id="516"/>
            <p14:sldId id="5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68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1E6241-1427-4A90-95DE-06763A40A075}" v="179" dt="2022-10-20T13:28:31.63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19" autoAdjust="0"/>
    <p:restoredTop sz="83314" autoAdjust="0"/>
  </p:normalViewPr>
  <p:slideViewPr>
    <p:cSldViewPr snapToGrid="0" showGuides="1">
      <p:cViewPr varScale="1">
        <p:scale>
          <a:sx n="91" d="100"/>
          <a:sy n="91" d="100"/>
        </p:scale>
        <p:origin x="1170" y="90"/>
      </p:cViewPr>
      <p:guideLst>
        <p:guide orient="horz" pos="196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0" d="100"/>
          <a:sy n="60" d="100"/>
        </p:scale>
        <p:origin x="2333" y="4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microsoft.com/office/2016/11/relationships/changesInfo" Target="changesInfos/changesInfo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handoutMaster" Target="handoutMasters/handoutMaster1.xml"/><Relationship Id="rId30" Type="http://schemas.openxmlformats.org/officeDocument/2006/relationships/theme" Target="theme/theme1.xml"/><Relationship Id="rId8" Type="http://schemas.openxmlformats.org/officeDocument/2006/relationships/slide" Target="slides/slide4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ly M. Murphy" userId="356800e2-27aa-4b4f-9e7a-e979cf0bfcd7" providerId="ADAL" clId="{681E6241-1427-4A90-95DE-06763A40A075}"/>
    <pc:docChg chg="undo custSel addSld delSld modSld sldOrd modSection">
      <pc:chgData name="Karly M. Murphy" userId="356800e2-27aa-4b4f-9e7a-e979cf0bfcd7" providerId="ADAL" clId="{681E6241-1427-4A90-95DE-06763A40A075}" dt="2022-10-20T13:32:58.234" v="2257" actId="20577"/>
      <pc:docMkLst>
        <pc:docMk/>
      </pc:docMkLst>
      <pc:sldChg chg="modNotesTx">
        <pc:chgData name="Karly M. Murphy" userId="356800e2-27aa-4b4f-9e7a-e979cf0bfcd7" providerId="ADAL" clId="{681E6241-1427-4A90-95DE-06763A40A075}" dt="2022-10-20T13:18:36.446" v="327" actId="20577"/>
        <pc:sldMkLst>
          <pc:docMk/>
          <pc:sldMk cId="2442842964" sldId="497"/>
        </pc:sldMkLst>
      </pc:sldChg>
      <pc:sldChg chg="addSp delSp modSp mod delAnim modAnim modNotesTx">
        <pc:chgData name="Karly M. Murphy" userId="356800e2-27aa-4b4f-9e7a-e979cf0bfcd7" providerId="ADAL" clId="{681E6241-1427-4A90-95DE-06763A40A075}" dt="2022-10-20T13:26:34.411" v="1323"/>
        <pc:sldMkLst>
          <pc:docMk/>
          <pc:sldMk cId="1034633810" sldId="507"/>
        </pc:sldMkLst>
        <pc:spChg chg="add del mod">
          <ac:chgData name="Karly M. Murphy" userId="356800e2-27aa-4b4f-9e7a-e979cf0bfcd7" providerId="ADAL" clId="{681E6241-1427-4A90-95DE-06763A40A075}" dt="2022-10-18T18:20:17.158" v="45"/>
          <ac:spMkLst>
            <pc:docMk/>
            <pc:sldMk cId="1034633810" sldId="507"/>
            <ac:spMk id="4" creationId="{0D2D16D5-A075-38FE-51E8-7CBB79C4D58E}"/>
          </ac:spMkLst>
        </pc:spChg>
        <pc:spChg chg="add del mod">
          <ac:chgData name="Karly M. Murphy" userId="356800e2-27aa-4b4f-9e7a-e979cf0bfcd7" providerId="ADAL" clId="{681E6241-1427-4A90-95DE-06763A40A075}" dt="2022-10-18T18:21:48.455" v="57" actId="478"/>
          <ac:spMkLst>
            <pc:docMk/>
            <pc:sldMk cId="1034633810" sldId="507"/>
            <ac:spMk id="6" creationId="{637A0F83-6E1A-31A8-D3BE-50DB8DF6E95B}"/>
          </ac:spMkLst>
        </pc:spChg>
        <pc:spChg chg="add del mod">
          <ac:chgData name="Karly M. Murphy" userId="356800e2-27aa-4b4f-9e7a-e979cf0bfcd7" providerId="ADAL" clId="{681E6241-1427-4A90-95DE-06763A40A075}" dt="2022-10-18T18:24:20.138" v="63"/>
          <ac:spMkLst>
            <pc:docMk/>
            <pc:sldMk cId="1034633810" sldId="507"/>
            <ac:spMk id="10" creationId="{26349F7E-991E-5D61-C28E-8F77C2681BD6}"/>
          </ac:spMkLst>
        </pc:spChg>
        <pc:spChg chg="mod">
          <ac:chgData name="Karly M. Murphy" userId="356800e2-27aa-4b4f-9e7a-e979cf0bfcd7" providerId="ADAL" clId="{681E6241-1427-4A90-95DE-06763A40A075}" dt="2022-10-18T18:26:57.146" v="86" actId="122"/>
          <ac:spMkLst>
            <pc:docMk/>
            <pc:sldMk cId="1034633810" sldId="507"/>
            <ac:spMk id="18" creationId="{BB4301C3-99BC-452E-ABDF-29E684C6725C}"/>
          </ac:spMkLst>
        </pc:spChg>
        <pc:spChg chg="mod">
          <ac:chgData name="Karly M. Murphy" userId="356800e2-27aa-4b4f-9e7a-e979cf0bfcd7" providerId="ADAL" clId="{681E6241-1427-4A90-95DE-06763A40A075}" dt="2022-10-18T18:26:57.146" v="86" actId="122"/>
          <ac:spMkLst>
            <pc:docMk/>
            <pc:sldMk cId="1034633810" sldId="507"/>
            <ac:spMk id="20" creationId="{ADD95370-8C42-4401-ABCF-88212868EA4A}"/>
          </ac:spMkLst>
        </pc:spChg>
        <pc:spChg chg="mod">
          <ac:chgData name="Karly M. Murphy" userId="356800e2-27aa-4b4f-9e7a-e979cf0bfcd7" providerId="ADAL" clId="{681E6241-1427-4A90-95DE-06763A40A075}" dt="2022-10-18T18:26:57.146" v="86" actId="122"/>
          <ac:spMkLst>
            <pc:docMk/>
            <pc:sldMk cId="1034633810" sldId="507"/>
            <ac:spMk id="22" creationId="{B7FF1001-E7ED-4A97-85F7-DEFDD3343677}"/>
          </ac:spMkLst>
        </pc:spChg>
        <pc:picChg chg="add del mod">
          <ac:chgData name="Karly M. Murphy" userId="356800e2-27aa-4b4f-9e7a-e979cf0bfcd7" providerId="ADAL" clId="{681E6241-1427-4A90-95DE-06763A40A075}" dt="2022-10-18T18:20:14.840" v="44" actId="21"/>
          <ac:picMkLst>
            <pc:docMk/>
            <pc:sldMk cId="1034633810" sldId="507"/>
            <ac:picMk id="2" creationId="{064A3320-86C7-2813-4062-76B61C351F15}"/>
          </ac:picMkLst>
        </pc:picChg>
        <pc:picChg chg="add mod">
          <ac:chgData name="Karly M. Murphy" userId="356800e2-27aa-4b4f-9e7a-e979cf0bfcd7" providerId="ADAL" clId="{681E6241-1427-4A90-95DE-06763A40A075}" dt="2022-10-20T13:26:00.137" v="1316" actId="1076"/>
          <ac:picMkLst>
            <pc:docMk/>
            <pc:sldMk cId="1034633810" sldId="507"/>
            <ac:picMk id="5" creationId="{179C1557-EE2B-C11A-840F-B57590936E98}"/>
          </ac:picMkLst>
        </pc:picChg>
        <pc:picChg chg="add del mod">
          <ac:chgData name="Karly M. Murphy" userId="356800e2-27aa-4b4f-9e7a-e979cf0bfcd7" providerId="ADAL" clId="{681E6241-1427-4A90-95DE-06763A40A075}" dt="2022-10-18T18:21:55.609" v="60" actId="478"/>
          <ac:picMkLst>
            <pc:docMk/>
            <pc:sldMk cId="1034633810" sldId="507"/>
            <ac:picMk id="8" creationId="{3E59E051-88DC-6D68-D7BA-2A566FF6EDB9}"/>
          </ac:picMkLst>
        </pc:picChg>
        <pc:picChg chg="add mod">
          <ac:chgData name="Karly M. Murphy" userId="356800e2-27aa-4b4f-9e7a-e979cf0bfcd7" providerId="ADAL" clId="{681E6241-1427-4A90-95DE-06763A40A075}" dt="2022-10-18T18:27:05.744" v="88" actId="1076"/>
          <ac:picMkLst>
            <pc:docMk/>
            <pc:sldMk cId="1034633810" sldId="507"/>
            <ac:picMk id="9" creationId="{2AB6B28C-397F-023C-20D1-FB87F9C11207}"/>
          </ac:picMkLst>
        </pc:picChg>
        <pc:picChg chg="del">
          <ac:chgData name="Karly M. Murphy" userId="356800e2-27aa-4b4f-9e7a-e979cf0bfcd7" providerId="ADAL" clId="{681E6241-1427-4A90-95DE-06763A40A075}" dt="2022-10-18T18:20:12.223" v="42" actId="478"/>
          <ac:picMkLst>
            <pc:docMk/>
            <pc:sldMk cId="1034633810" sldId="507"/>
            <ac:picMk id="31" creationId="{0EA8F386-7774-4C27-8CCE-CD7D812D100C}"/>
          </ac:picMkLst>
        </pc:picChg>
        <pc:picChg chg="del">
          <ac:chgData name="Karly M. Murphy" userId="356800e2-27aa-4b4f-9e7a-e979cf0bfcd7" providerId="ADAL" clId="{681E6241-1427-4A90-95DE-06763A40A075}" dt="2022-10-18T18:21:32.197" v="52" actId="21"/>
          <ac:picMkLst>
            <pc:docMk/>
            <pc:sldMk cId="1034633810" sldId="507"/>
            <ac:picMk id="32" creationId="{5F205D16-4921-4C61-A0E7-F3A9EACD489C}"/>
          </ac:picMkLst>
        </pc:picChg>
        <pc:picChg chg="add del">
          <ac:chgData name="Karly M. Murphy" userId="356800e2-27aa-4b4f-9e7a-e979cf0bfcd7" providerId="ADAL" clId="{681E6241-1427-4A90-95DE-06763A40A075}" dt="2022-10-18T18:21:32.197" v="52" actId="21"/>
          <ac:picMkLst>
            <pc:docMk/>
            <pc:sldMk cId="1034633810" sldId="507"/>
            <ac:picMk id="1026" creationId="{961123A3-7369-372F-8AA3-861F29937354}"/>
          </ac:picMkLst>
        </pc:picChg>
        <pc:picChg chg="add mod">
          <ac:chgData name="Karly M. Murphy" userId="356800e2-27aa-4b4f-9e7a-e979cf0bfcd7" providerId="ADAL" clId="{681E6241-1427-4A90-95DE-06763A40A075}" dt="2022-10-18T18:27:14.647" v="89" actId="1076"/>
          <ac:picMkLst>
            <pc:docMk/>
            <pc:sldMk cId="1034633810" sldId="507"/>
            <ac:picMk id="1028" creationId="{3E2AFD9D-1E2C-E492-2DCF-5A0F6E40B2C4}"/>
          </ac:picMkLst>
        </pc:picChg>
        <pc:picChg chg="del">
          <ac:chgData name="Karly M. Murphy" userId="356800e2-27aa-4b4f-9e7a-e979cf0bfcd7" providerId="ADAL" clId="{681E6241-1427-4A90-95DE-06763A40A075}" dt="2022-10-18T18:22:03.056" v="62" actId="478"/>
          <ac:picMkLst>
            <pc:docMk/>
            <pc:sldMk cId="1034633810" sldId="507"/>
            <ac:picMk id="2050" creationId="{6CC505C3-484B-4DB1-BA20-C2B9B0258728}"/>
          </ac:picMkLst>
        </pc:picChg>
      </pc:sldChg>
      <pc:sldChg chg="addSp delSp modSp mod modAnim modNotesTx">
        <pc:chgData name="Karly M. Murphy" userId="356800e2-27aa-4b4f-9e7a-e979cf0bfcd7" providerId="ADAL" clId="{681E6241-1427-4A90-95DE-06763A40A075}" dt="2022-10-20T13:28:31.630" v="1382"/>
        <pc:sldMkLst>
          <pc:docMk/>
          <pc:sldMk cId="3142463500" sldId="508"/>
        </pc:sldMkLst>
        <pc:spChg chg="mod">
          <ac:chgData name="Karly M. Murphy" userId="356800e2-27aa-4b4f-9e7a-e979cf0bfcd7" providerId="ADAL" clId="{681E6241-1427-4A90-95DE-06763A40A075}" dt="2022-10-18T18:28:48.913" v="95" actId="122"/>
          <ac:spMkLst>
            <pc:docMk/>
            <pc:sldMk cId="3142463500" sldId="508"/>
            <ac:spMk id="3" creationId="{305CF2C0-C2CF-47B9-8E9C-2F68FD783DFD}"/>
          </ac:spMkLst>
        </pc:spChg>
        <pc:spChg chg="add del mod">
          <ac:chgData name="Karly M. Murphy" userId="356800e2-27aa-4b4f-9e7a-e979cf0bfcd7" providerId="ADAL" clId="{681E6241-1427-4A90-95DE-06763A40A075}" dt="2022-10-18T18:29:13.043" v="100" actId="478"/>
          <ac:spMkLst>
            <pc:docMk/>
            <pc:sldMk cId="3142463500" sldId="508"/>
            <ac:spMk id="4" creationId="{D7183DE5-2991-07EA-2417-3C38FDBF8BFB}"/>
          </ac:spMkLst>
        </pc:spChg>
        <pc:spChg chg="mod">
          <ac:chgData name="Karly M. Murphy" userId="356800e2-27aa-4b4f-9e7a-e979cf0bfcd7" providerId="ADAL" clId="{681E6241-1427-4A90-95DE-06763A40A075}" dt="2022-10-18T18:30:14.724" v="151" actId="6549"/>
          <ac:spMkLst>
            <pc:docMk/>
            <pc:sldMk cId="3142463500" sldId="508"/>
            <ac:spMk id="6" creationId="{2364AD90-74E3-412B-83C5-7A813982A858}"/>
          </ac:spMkLst>
        </pc:spChg>
        <pc:spChg chg="mod">
          <ac:chgData name="Karly M. Murphy" userId="356800e2-27aa-4b4f-9e7a-e979cf0bfcd7" providerId="ADAL" clId="{681E6241-1427-4A90-95DE-06763A40A075}" dt="2022-10-18T18:29:29.304" v="103" actId="14100"/>
          <ac:spMkLst>
            <pc:docMk/>
            <pc:sldMk cId="3142463500" sldId="508"/>
            <ac:spMk id="12" creationId="{13534AE0-80C5-4C0E-B7A6-283190A5F280}"/>
          </ac:spMkLst>
        </pc:spChg>
        <pc:spChg chg="mod">
          <ac:chgData name="Karly M. Murphy" userId="356800e2-27aa-4b4f-9e7a-e979cf0bfcd7" providerId="ADAL" clId="{681E6241-1427-4A90-95DE-06763A40A075}" dt="2022-10-18T18:29:37.816" v="104" actId="1076"/>
          <ac:spMkLst>
            <pc:docMk/>
            <pc:sldMk cId="3142463500" sldId="508"/>
            <ac:spMk id="13" creationId="{5BD998EA-A56D-4100-A2C2-C04977387A9E}"/>
          </ac:spMkLst>
        </pc:spChg>
        <pc:picChg chg="add mod">
          <ac:chgData name="Karly M. Murphy" userId="356800e2-27aa-4b4f-9e7a-e979cf0bfcd7" providerId="ADAL" clId="{681E6241-1427-4A90-95DE-06763A40A075}" dt="2022-10-18T18:29:20.502" v="101" actId="1076"/>
          <ac:picMkLst>
            <pc:docMk/>
            <pc:sldMk cId="3142463500" sldId="508"/>
            <ac:picMk id="2050" creationId="{99782E9B-B34C-B676-BA01-78218DFA05AE}"/>
          </ac:picMkLst>
        </pc:picChg>
        <pc:picChg chg="del mod">
          <ac:chgData name="Karly M. Murphy" userId="356800e2-27aa-4b4f-9e7a-e979cf0bfcd7" providerId="ADAL" clId="{681E6241-1427-4A90-95DE-06763A40A075}" dt="2022-10-18T18:28:44.308" v="94" actId="478"/>
          <ac:picMkLst>
            <pc:docMk/>
            <pc:sldMk cId="3142463500" sldId="508"/>
            <ac:picMk id="3076" creationId="{D10973C8-60C2-4DE9-85AC-A1094C524198}"/>
          </ac:picMkLst>
        </pc:picChg>
      </pc:sldChg>
      <pc:sldChg chg="modSp mod modNotesTx">
        <pc:chgData name="Karly M. Murphy" userId="356800e2-27aa-4b4f-9e7a-e979cf0bfcd7" providerId="ADAL" clId="{681E6241-1427-4A90-95DE-06763A40A075}" dt="2022-10-19T22:42:18.394" v="264"/>
        <pc:sldMkLst>
          <pc:docMk/>
          <pc:sldMk cId="87644926" sldId="528"/>
        </pc:sldMkLst>
        <pc:spChg chg="mod">
          <ac:chgData name="Karly M. Murphy" userId="356800e2-27aa-4b4f-9e7a-e979cf0bfcd7" providerId="ADAL" clId="{681E6241-1427-4A90-95DE-06763A40A075}" dt="2022-10-19T22:41:47.362" v="263" actId="14100"/>
          <ac:spMkLst>
            <pc:docMk/>
            <pc:sldMk cId="87644926" sldId="528"/>
            <ac:spMk id="20" creationId="{F80D0526-C261-4096-B6B1-8CCB7D465256}"/>
          </ac:spMkLst>
        </pc:spChg>
        <pc:graphicFrameChg chg="mod">
          <ac:chgData name="Karly M. Murphy" userId="356800e2-27aa-4b4f-9e7a-e979cf0bfcd7" providerId="ADAL" clId="{681E6241-1427-4A90-95DE-06763A40A075}" dt="2022-10-18T18:33:39.581" v="175" actId="13782"/>
          <ac:graphicFrameMkLst>
            <pc:docMk/>
            <pc:sldMk cId="87644926" sldId="528"/>
            <ac:graphicFrameMk id="14" creationId="{224916A4-AFA4-4283-8A34-8159CAA8E1BD}"/>
          </ac:graphicFrameMkLst>
        </pc:graphicFrameChg>
      </pc:sldChg>
      <pc:sldChg chg="modNotesTx">
        <pc:chgData name="Karly M. Murphy" userId="356800e2-27aa-4b4f-9e7a-e979cf0bfcd7" providerId="ADAL" clId="{681E6241-1427-4A90-95DE-06763A40A075}" dt="2022-10-20T13:32:58.234" v="2257" actId="20577"/>
        <pc:sldMkLst>
          <pc:docMk/>
          <pc:sldMk cId="444580038" sldId="547"/>
        </pc:sldMkLst>
      </pc:sldChg>
      <pc:sldChg chg="modSp mod">
        <pc:chgData name="Karly M. Murphy" userId="356800e2-27aa-4b4f-9e7a-e979cf0bfcd7" providerId="ADAL" clId="{681E6241-1427-4A90-95DE-06763A40A075}" dt="2022-10-19T21:25:42.520" v="201" actId="20577"/>
        <pc:sldMkLst>
          <pc:docMk/>
          <pc:sldMk cId="606625595" sldId="548"/>
        </pc:sldMkLst>
        <pc:spChg chg="mod">
          <ac:chgData name="Karly M. Murphy" userId="356800e2-27aa-4b4f-9e7a-e979cf0bfcd7" providerId="ADAL" clId="{681E6241-1427-4A90-95DE-06763A40A075}" dt="2022-10-19T21:25:42.520" v="201" actId="20577"/>
          <ac:spMkLst>
            <pc:docMk/>
            <pc:sldMk cId="606625595" sldId="548"/>
            <ac:spMk id="8" creationId="{7A8C61D1-2BF0-787A-D8B8-69EDE7F78EE5}"/>
          </ac:spMkLst>
        </pc:spChg>
        <pc:picChg chg="mod">
          <ac:chgData name="Karly M. Murphy" userId="356800e2-27aa-4b4f-9e7a-e979cf0bfcd7" providerId="ADAL" clId="{681E6241-1427-4A90-95DE-06763A40A075}" dt="2022-10-18T18:02:23.160" v="12" actId="14100"/>
          <ac:picMkLst>
            <pc:docMk/>
            <pc:sldMk cId="606625595" sldId="548"/>
            <ac:picMk id="51" creationId="{83A76F30-59B9-05CA-4C43-9DDE3CFA4726}"/>
          </ac:picMkLst>
        </pc:picChg>
      </pc:sldChg>
      <pc:sldChg chg="add del">
        <pc:chgData name="Karly M. Murphy" userId="356800e2-27aa-4b4f-9e7a-e979cf0bfcd7" providerId="ADAL" clId="{681E6241-1427-4A90-95DE-06763A40A075}" dt="2022-10-18T18:05:11.888" v="27" actId="47"/>
        <pc:sldMkLst>
          <pc:docMk/>
          <pc:sldMk cId="150285476" sldId="553"/>
        </pc:sldMkLst>
      </pc:sldChg>
      <pc:sldChg chg="modSp mod">
        <pc:chgData name="Karly M. Murphy" userId="356800e2-27aa-4b4f-9e7a-e979cf0bfcd7" providerId="ADAL" clId="{681E6241-1427-4A90-95DE-06763A40A075}" dt="2022-10-20T13:16:43.097" v="326" actId="20577"/>
        <pc:sldMkLst>
          <pc:docMk/>
          <pc:sldMk cId="2795915291" sldId="556"/>
        </pc:sldMkLst>
        <pc:spChg chg="mod">
          <ac:chgData name="Karly M. Murphy" userId="356800e2-27aa-4b4f-9e7a-e979cf0bfcd7" providerId="ADAL" clId="{681E6241-1427-4A90-95DE-06763A40A075}" dt="2022-10-20T13:16:43.097" v="326" actId="20577"/>
          <ac:spMkLst>
            <pc:docMk/>
            <pc:sldMk cId="2795915291" sldId="556"/>
            <ac:spMk id="12" creationId="{5C4F976C-BDEF-F466-6DC1-A58A26DF458C}"/>
          </ac:spMkLst>
        </pc:spChg>
        <pc:graphicFrameChg chg="mod">
          <ac:chgData name="Karly M. Murphy" userId="356800e2-27aa-4b4f-9e7a-e979cf0bfcd7" providerId="ADAL" clId="{681E6241-1427-4A90-95DE-06763A40A075}" dt="2022-10-18T17:58:38.694" v="1" actId="20577"/>
          <ac:graphicFrameMkLst>
            <pc:docMk/>
            <pc:sldMk cId="2795915291" sldId="556"/>
            <ac:graphicFrameMk id="14" creationId="{07F44882-4ECE-EA5F-2F31-94EFC3086433}"/>
          </ac:graphicFrameMkLst>
        </pc:graphicFrameChg>
      </pc:sldChg>
      <pc:sldChg chg="modSp modNotesTx">
        <pc:chgData name="Karly M. Murphy" userId="356800e2-27aa-4b4f-9e7a-e979cf0bfcd7" providerId="ADAL" clId="{681E6241-1427-4A90-95DE-06763A40A075}" dt="2022-10-19T22:40:43.381" v="258"/>
        <pc:sldMkLst>
          <pc:docMk/>
          <pc:sldMk cId="983002330" sldId="557"/>
        </pc:sldMkLst>
        <pc:spChg chg="mod">
          <ac:chgData name="Karly M. Murphy" userId="356800e2-27aa-4b4f-9e7a-e979cf0bfcd7" providerId="ADAL" clId="{681E6241-1427-4A90-95DE-06763A40A075}" dt="2022-10-19T21:27:05.367" v="257" actId="20577"/>
          <ac:spMkLst>
            <pc:docMk/>
            <pc:sldMk cId="983002330" sldId="557"/>
            <ac:spMk id="8" creationId="{7A8C61D1-2BF0-787A-D8B8-69EDE7F78EE5}"/>
          </ac:spMkLst>
        </pc:spChg>
      </pc:sldChg>
      <pc:sldChg chg="addSp delSp modSp add del mod ord setBg delDesignElem">
        <pc:chgData name="Karly M. Murphy" userId="356800e2-27aa-4b4f-9e7a-e979cf0bfcd7" providerId="ADAL" clId="{681E6241-1427-4A90-95DE-06763A40A075}" dt="2022-10-19T19:32:29.638" v="176" actId="47"/>
        <pc:sldMkLst>
          <pc:docMk/>
          <pc:sldMk cId="2776182404" sldId="558"/>
        </pc:sldMkLst>
        <pc:spChg chg="mod">
          <ac:chgData name="Karly M. Murphy" userId="356800e2-27aa-4b4f-9e7a-e979cf0bfcd7" providerId="ADAL" clId="{681E6241-1427-4A90-95DE-06763A40A075}" dt="2022-10-18T18:05:46.336" v="28" actId="26606"/>
          <ac:spMkLst>
            <pc:docMk/>
            <pc:sldMk cId="2776182404" sldId="558"/>
            <ac:spMk id="2" creationId="{4F26BF8F-4CE9-58AD-7731-84EFE4FDCB1D}"/>
          </ac:spMkLst>
        </pc:spChg>
        <pc:spChg chg="add">
          <ac:chgData name="Karly M. Murphy" userId="356800e2-27aa-4b4f-9e7a-e979cf0bfcd7" providerId="ADAL" clId="{681E6241-1427-4A90-95DE-06763A40A075}" dt="2022-10-18T18:05:46.336" v="28" actId="26606"/>
          <ac:spMkLst>
            <pc:docMk/>
            <pc:sldMk cId="2776182404" sldId="558"/>
            <ac:spMk id="18" creationId="{EBDD1931-9E86-4402-9A68-33A2D9EFB198}"/>
          </ac:spMkLst>
        </pc:spChg>
        <pc:spChg chg="add">
          <ac:chgData name="Karly M. Murphy" userId="356800e2-27aa-4b4f-9e7a-e979cf0bfcd7" providerId="ADAL" clId="{681E6241-1427-4A90-95DE-06763A40A075}" dt="2022-10-18T18:05:46.336" v="28" actId="26606"/>
          <ac:spMkLst>
            <pc:docMk/>
            <pc:sldMk cId="2776182404" sldId="558"/>
            <ac:spMk id="20" creationId="{743AA782-23D1-4521-8CAD-47662984AA08}"/>
          </ac:spMkLst>
        </pc:spChg>
        <pc:spChg chg="add">
          <ac:chgData name="Karly M. Murphy" userId="356800e2-27aa-4b4f-9e7a-e979cf0bfcd7" providerId="ADAL" clId="{681E6241-1427-4A90-95DE-06763A40A075}" dt="2022-10-18T18:05:46.336" v="28" actId="26606"/>
          <ac:spMkLst>
            <pc:docMk/>
            <pc:sldMk cId="2776182404" sldId="558"/>
            <ac:spMk id="22" creationId="{3CE8AF5E-D374-4CF1-90CC-35CF73B81C3E}"/>
          </ac:spMkLst>
        </pc:spChg>
        <pc:spChg chg="add del">
          <ac:chgData name="Karly M. Murphy" userId="356800e2-27aa-4b4f-9e7a-e979cf0bfcd7" providerId="ADAL" clId="{681E6241-1427-4A90-95DE-06763A40A075}" dt="2022-10-18T18:02:53.131" v="18"/>
          <ac:spMkLst>
            <pc:docMk/>
            <pc:sldMk cId="2776182404" sldId="558"/>
            <ac:spMk id="26" creationId="{EBDD1931-9E86-4402-9A68-33A2D9EFB198}"/>
          </ac:spMkLst>
        </pc:spChg>
        <pc:spChg chg="add del">
          <ac:chgData name="Karly M. Murphy" userId="356800e2-27aa-4b4f-9e7a-e979cf0bfcd7" providerId="ADAL" clId="{681E6241-1427-4A90-95DE-06763A40A075}" dt="2022-10-18T18:02:53.131" v="18"/>
          <ac:spMkLst>
            <pc:docMk/>
            <pc:sldMk cId="2776182404" sldId="558"/>
            <ac:spMk id="30" creationId="{2C61293E-6EBE-43EF-A52C-9BEBFD7679D4}"/>
          </ac:spMkLst>
        </pc:spChg>
        <pc:spChg chg="add del">
          <ac:chgData name="Karly M. Murphy" userId="356800e2-27aa-4b4f-9e7a-e979cf0bfcd7" providerId="ADAL" clId="{681E6241-1427-4A90-95DE-06763A40A075}" dt="2022-10-18T18:02:53.131" v="18"/>
          <ac:spMkLst>
            <pc:docMk/>
            <pc:sldMk cId="2776182404" sldId="558"/>
            <ac:spMk id="34" creationId="{3FCFB1DE-0B7E-48CC-BA90-B2AB0889F9D6}"/>
          </ac:spMkLst>
        </pc:spChg>
        <pc:graphicFrameChg chg="mod modGraphic">
          <ac:chgData name="Karly M. Murphy" userId="356800e2-27aa-4b4f-9e7a-e979cf0bfcd7" providerId="ADAL" clId="{681E6241-1427-4A90-95DE-06763A40A075}" dt="2022-10-18T18:06:29.199" v="40" actId="404"/>
          <ac:graphicFrameMkLst>
            <pc:docMk/>
            <pc:sldMk cId="2776182404" sldId="558"/>
            <ac:graphicFrameMk id="13" creationId="{3F971041-186F-EA9F-E87E-AFC63A34A245}"/>
          </ac:graphicFrameMkLst>
        </pc:graphicFrameChg>
        <pc:picChg chg="add del mod">
          <ac:chgData name="Karly M. Murphy" userId="356800e2-27aa-4b4f-9e7a-e979cf0bfcd7" providerId="ADAL" clId="{681E6241-1427-4A90-95DE-06763A40A075}" dt="2022-10-18T18:03:48.182" v="24" actId="478"/>
          <ac:picMkLst>
            <pc:docMk/>
            <pc:sldMk cId="2776182404" sldId="558"/>
            <ac:picMk id="3" creationId="{0360E244-0786-C174-87B0-7BAA98CBB462}"/>
          </ac:picMkLst>
        </pc:picChg>
        <pc:picChg chg="mod">
          <ac:chgData name="Karly M. Murphy" userId="356800e2-27aa-4b4f-9e7a-e979cf0bfcd7" providerId="ADAL" clId="{681E6241-1427-4A90-95DE-06763A40A075}" dt="2022-10-18T18:05:46.336" v="28" actId="26606"/>
          <ac:picMkLst>
            <pc:docMk/>
            <pc:sldMk cId="2776182404" sldId="558"/>
            <ac:picMk id="9" creationId="{53BA4B28-D5D3-964E-835D-12748F446E07}"/>
          </ac:picMkLst>
        </pc:picChg>
        <pc:inkChg chg="add">
          <ac:chgData name="Karly M. Murphy" userId="356800e2-27aa-4b4f-9e7a-e979cf0bfcd7" providerId="ADAL" clId="{681E6241-1427-4A90-95DE-06763A40A075}" dt="2022-10-18T18:05:46.336" v="28" actId="26606"/>
          <ac:inkMkLst>
            <pc:docMk/>
            <pc:sldMk cId="2776182404" sldId="558"/>
            <ac:inkMk id="24" creationId="{070477C5-0410-4E4F-97A1-F84C2465C187}"/>
          </ac:inkMkLst>
        </pc:inkChg>
      </pc:sldChg>
      <pc:sldChg chg="new del">
        <pc:chgData name="Karly M. Murphy" userId="356800e2-27aa-4b4f-9e7a-e979cf0bfcd7" providerId="ADAL" clId="{681E6241-1427-4A90-95DE-06763A40A075}" dt="2022-10-18T18:02:42.200" v="16" actId="680"/>
        <pc:sldMkLst>
          <pc:docMk/>
          <pc:sldMk cId="3022047805" sldId="561"/>
        </pc:sldMkLst>
      </pc:sldChg>
    </pc:docChg>
  </pc:docChgLst>
  <pc:docChgLst>
    <pc:chgData name="Karly M. Murphy" userId="356800e2-27aa-4b4f-9e7a-e979cf0bfcd7" providerId="ADAL" clId="{606EF2E4-010D-4992-98E9-E106A0635534}"/>
    <pc:docChg chg="modSld">
      <pc:chgData name="Karly M. Murphy" userId="356800e2-27aa-4b4f-9e7a-e979cf0bfcd7" providerId="ADAL" clId="{606EF2E4-010D-4992-98E9-E106A0635534}" dt="2022-09-12T19:55:01.944" v="58" actId="20577"/>
      <pc:docMkLst>
        <pc:docMk/>
      </pc:docMkLst>
      <pc:sldChg chg="modSp">
        <pc:chgData name="Karly M. Murphy" userId="356800e2-27aa-4b4f-9e7a-e979cf0bfcd7" providerId="ADAL" clId="{606EF2E4-010D-4992-98E9-E106A0635534}" dt="2022-09-12T19:55:01.944" v="58" actId="20577"/>
        <pc:sldMkLst>
          <pc:docMk/>
          <pc:sldMk cId="3142463500" sldId="508"/>
        </pc:sldMkLst>
        <pc:spChg chg="mod">
          <ac:chgData name="Karly M. Murphy" userId="356800e2-27aa-4b4f-9e7a-e979cf0bfcd7" providerId="ADAL" clId="{606EF2E4-010D-4992-98E9-E106A0635534}" dt="2022-09-12T19:55:01.944" v="58" actId="20577"/>
          <ac:spMkLst>
            <pc:docMk/>
            <pc:sldMk cId="3142463500" sldId="508"/>
            <ac:spMk id="13" creationId="{5BD998EA-A56D-4100-A2C2-C04977387A9E}"/>
          </ac:spMkLst>
        </pc:spChg>
      </pc:sldChg>
      <pc:sldChg chg="modSp">
        <pc:chgData name="Karly M. Murphy" userId="356800e2-27aa-4b4f-9e7a-e979cf0bfcd7" providerId="ADAL" clId="{606EF2E4-010D-4992-98E9-E106A0635534}" dt="2022-09-12T19:54:00.878" v="51" actId="20577"/>
        <pc:sldMkLst>
          <pc:docMk/>
          <pc:sldMk cId="3703203546" sldId="550"/>
        </pc:sldMkLst>
        <pc:graphicFrameChg chg="mod">
          <ac:chgData name="Karly M. Murphy" userId="356800e2-27aa-4b4f-9e7a-e979cf0bfcd7" providerId="ADAL" clId="{606EF2E4-010D-4992-98E9-E106A0635534}" dt="2022-09-12T19:54:00.878" v="51" actId="20577"/>
          <ac:graphicFrameMkLst>
            <pc:docMk/>
            <pc:sldMk cId="3703203546" sldId="550"/>
            <ac:graphicFrameMk id="3100" creationId="{D764984C-E29A-841E-4AC6-541B46BA6156}"/>
          </ac:graphicFrameMkLst>
        </pc:graphicFrameChg>
      </pc:sldChg>
    </pc:docChg>
  </pc:docChgLst>
</pc:chgInfo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svg"/><Relationship Id="rId1" Type="http://schemas.openxmlformats.org/officeDocument/2006/relationships/image" Target="../media/image6.png"/><Relationship Id="rId4" Type="http://schemas.openxmlformats.org/officeDocument/2006/relationships/image" Target="../media/image9.sv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svg"/><Relationship Id="rId1" Type="http://schemas.openxmlformats.org/officeDocument/2006/relationships/image" Target="../media/image6.png"/><Relationship Id="rId4" Type="http://schemas.openxmlformats.org/officeDocument/2006/relationships/image" Target="../media/image9.sv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08F38FE-14E3-4C21-AD12-47E684B1047E}" type="doc">
      <dgm:prSet loTypeId="urn:microsoft.com/office/officeart/2005/8/layout/vList2" loCatId="list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200618B5-DB1B-4B65-B5A1-73438D7D7B65}">
      <dgm:prSet/>
      <dgm:spPr/>
      <dgm:t>
        <a:bodyPr/>
        <a:lstStyle/>
        <a:p>
          <a:r>
            <a:rPr lang="en-US"/>
            <a:t>Name/Alias</a:t>
          </a:r>
        </a:p>
      </dgm:t>
    </dgm:pt>
    <dgm:pt modelId="{A8803A30-6D3B-4928-8282-75D4A31A70E8}" type="parTrans" cxnId="{15E64ADF-1C85-483D-8F98-E6C9A3D215BE}">
      <dgm:prSet/>
      <dgm:spPr/>
      <dgm:t>
        <a:bodyPr/>
        <a:lstStyle/>
        <a:p>
          <a:endParaRPr lang="en-US"/>
        </a:p>
      </dgm:t>
    </dgm:pt>
    <dgm:pt modelId="{2339FA3F-2033-49B2-8561-03752447E8E3}" type="sibTrans" cxnId="{15E64ADF-1C85-483D-8F98-E6C9A3D215BE}">
      <dgm:prSet/>
      <dgm:spPr/>
      <dgm:t>
        <a:bodyPr/>
        <a:lstStyle/>
        <a:p>
          <a:endParaRPr lang="en-US"/>
        </a:p>
      </dgm:t>
    </dgm:pt>
    <dgm:pt modelId="{4739854E-5FD7-4FA4-B038-081FFAB75DC3}">
      <dgm:prSet/>
      <dgm:spPr/>
      <dgm:t>
        <a:bodyPr/>
        <a:lstStyle/>
        <a:p>
          <a:r>
            <a:rPr lang="en-US" dirty="0"/>
            <a:t>Discipline/Specialty</a:t>
          </a:r>
        </a:p>
      </dgm:t>
    </dgm:pt>
    <dgm:pt modelId="{8474F28D-F237-4785-AF93-3927DA67ECFB}" type="parTrans" cxnId="{B97E8992-3C84-4891-A62F-FDC3760F4BFA}">
      <dgm:prSet/>
      <dgm:spPr/>
      <dgm:t>
        <a:bodyPr/>
        <a:lstStyle/>
        <a:p>
          <a:endParaRPr lang="en-US"/>
        </a:p>
      </dgm:t>
    </dgm:pt>
    <dgm:pt modelId="{DB8C0905-8CC1-49F9-88AB-2732E7EAE3B3}" type="sibTrans" cxnId="{B97E8992-3C84-4891-A62F-FDC3760F4BFA}">
      <dgm:prSet/>
      <dgm:spPr/>
      <dgm:t>
        <a:bodyPr/>
        <a:lstStyle/>
        <a:p>
          <a:endParaRPr lang="en-US"/>
        </a:p>
      </dgm:t>
    </dgm:pt>
    <dgm:pt modelId="{312D9347-494C-4285-98DB-A687A60E7832}" type="pres">
      <dgm:prSet presAssocID="{908F38FE-14E3-4C21-AD12-47E684B1047E}" presName="linear" presStyleCnt="0">
        <dgm:presLayoutVars>
          <dgm:animLvl val="lvl"/>
          <dgm:resizeHandles val="exact"/>
        </dgm:presLayoutVars>
      </dgm:prSet>
      <dgm:spPr/>
    </dgm:pt>
    <dgm:pt modelId="{10E01BC6-9847-44B2-9F52-CE2C9910FB08}" type="pres">
      <dgm:prSet presAssocID="{200618B5-DB1B-4B65-B5A1-73438D7D7B65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39087EFF-2BA4-461A-9825-866C72D2E70F}" type="pres">
      <dgm:prSet presAssocID="{2339FA3F-2033-49B2-8561-03752447E8E3}" presName="spacer" presStyleCnt="0"/>
      <dgm:spPr/>
    </dgm:pt>
    <dgm:pt modelId="{79151D0E-C663-4CB3-AB51-408409B681B8}" type="pres">
      <dgm:prSet presAssocID="{4739854E-5FD7-4FA4-B038-081FFAB75DC3}" presName="parentText" presStyleLbl="node1" presStyleIdx="1" presStyleCnt="2">
        <dgm:presLayoutVars>
          <dgm:chMax val="0"/>
          <dgm:bulletEnabled val="1"/>
        </dgm:presLayoutVars>
      </dgm:prSet>
      <dgm:spPr/>
    </dgm:pt>
  </dgm:ptLst>
  <dgm:cxnLst>
    <dgm:cxn modelId="{398E6000-A105-4C4A-897C-81E3E997AF31}" type="presOf" srcId="{4739854E-5FD7-4FA4-B038-081FFAB75DC3}" destId="{79151D0E-C663-4CB3-AB51-408409B681B8}" srcOrd="0" destOrd="0" presId="urn:microsoft.com/office/officeart/2005/8/layout/vList2"/>
    <dgm:cxn modelId="{83203919-D0C9-4066-8B92-4BFB0503FA25}" type="presOf" srcId="{200618B5-DB1B-4B65-B5A1-73438D7D7B65}" destId="{10E01BC6-9847-44B2-9F52-CE2C9910FB08}" srcOrd="0" destOrd="0" presId="urn:microsoft.com/office/officeart/2005/8/layout/vList2"/>
    <dgm:cxn modelId="{C3478C66-04FB-4EED-A65D-B5EA73CFF609}" type="presOf" srcId="{908F38FE-14E3-4C21-AD12-47E684B1047E}" destId="{312D9347-494C-4285-98DB-A687A60E7832}" srcOrd="0" destOrd="0" presId="urn:microsoft.com/office/officeart/2005/8/layout/vList2"/>
    <dgm:cxn modelId="{B97E8992-3C84-4891-A62F-FDC3760F4BFA}" srcId="{908F38FE-14E3-4C21-AD12-47E684B1047E}" destId="{4739854E-5FD7-4FA4-B038-081FFAB75DC3}" srcOrd="1" destOrd="0" parTransId="{8474F28D-F237-4785-AF93-3927DA67ECFB}" sibTransId="{DB8C0905-8CC1-49F9-88AB-2732E7EAE3B3}"/>
    <dgm:cxn modelId="{15E64ADF-1C85-483D-8F98-E6C9A3D215BE}" srcId="{908F38FE-14E3-4C21-AD12-47E684B1047E}" destId="{200618B5-DB1B-4B65-B5A1-73438D7D7B65}" srcOrd="0" destOrd="0" parTransId="{A8803A30-6D3B-4928-8282-75D4A31A70E8}" sibTransId="{2339FA3F-2033-49B2-8561-03752447E8E3}"/>
    <dgm:cxn modelId="{C5984887-697B-41DD-B155-73F5EA416786}" type="presParOf" srcId="{312D9347-494C-4285-98DB-A687A60E7832}" destId="{10E01BC6-9847-44B2-9F52-CE2C9910FB08}" srcOrd="0" destOrd="0" presId="urn:microsoft.com/office/officeart/2005/8/layout/vList2"/>
    <dgm:cxn modelId="{210C0A76-746B-40DC-AECB-3C2E69430F98}" type="presParOf" srcId="{312D9347-494C-4285-98DB-A687A60E7832}" destId="{39087EFF-2BA4-461A-9825-866C72D2E70F}" srcOrd="1" destOrd="0" presId="urn:microsoft.com/office/officeart/2005/8/layout/vList2"/>
    <dgm:cxn modelId="{D1A2EB4D-F913-4883-A812-73ED54DBCE08}" type="presParOf" srcId="{312D9347-494C-4285-98DB-A687A60E7832}" destId="{79151D0E-C663-4CB3-AB51-408409B681B8}" srcOrd="2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A63B248F-E8A4-4EB2-8EDD-747942429B29}" type="doc">
      <dgm:prSet loTypeId="urn:microsoft.com/office/officeart/2005/8/layout/hList2" loCatId="pictur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219C2705-6C89-46B6-B707-3194F9800933}">
      <dgm:prSet phldrT="[Text]"/>
      <dgm:spPr/>
      <dgm:t>
        <a:bodyPr/>
        <a:lstStyle/>
        <a:p>
          <a:r>
            <a:rPr lang="en-US" dirty="0"/>
            <a:t>Ideas</a:t>
          </a:r>
        </a:p>
      </dgm:t>
    </dgm:pt>
    <dgm:pt modelId="{77A0C298-8FB6-426A-A73A-8AB7E7FA7E75}" type="parTrans" cxnId="{2FA7BF73-F2B3-4276-BC13-D790789C5CE5}">
      <dgm:prSet/>
      <dgm:spPr/>
      <dgm:t>
        <a:bodyPr/>
        <a:lstStyle/>
        <a:p>
          <a:endParaRPr lang="en-US"/>
        </a:p>
      </dgm:t>
    </dgm:pt>
    <dgm:pt modelId="{43222245-30E3-4358-9F52-F67BA6FA0134}" type="sibTrans" cxnId="{2FA7BF73-F2B3-4276-BC13-D790789C5CE5}">
      <dgm:prSet/>
      <dgm:spPr/>
      <dgm:t>
        <a:bodyPr/>
        <a:lstStyle/>
        <a:p>
          <a:endParaRPr lang="en-US"/>
        </a:p>
      </dgm:t>
    </dgm:pt>
    <dgm:pt modelId="{5192792B-E23D-47BC-B385-44954E4E2B72}">
      <dgm:prSet phldrT="[Text]"/>
      <dgm:spPr/>
      <dgm:t>
        <a:bodyPr/>
        <a:lstStyle/>
        <a:p>
          <a:r>
            <a:rPr lang="en-US" dirty="0"/>
            <a:t>How might we…?</a:t>
          </a:r>
        </a:p>
      </dgm:t>
    </dgm:pt>
    <dgm:pt modelId="{7F114FE1-7315-4E61-86D3-F079573419DD}" type="parTrans" cxnId="{F806A0A9-C1FB-44C9-A5E7-CAFDEA74F60A}">
      <dgm:prSet/>
      <dgm:spPr/>
      <dgm:t>
        <a:bodyPr/>
        <a:lstStyle/>
        <a:p>
          <a:endParaRPr lang="en-US"/>
        </a:p>
      </dgm:t>
    </dgm:pt>
    <dgm:pt modelId="{5EB073AC-A90F-43CB-866A-713A82602BB7}" type="sibTrans" cxnId="{F806A0A9-C1FB-44C9-A5E7-CAFDEA74F60A}">
      <dgm:prSet/>
      <dgm:spPr/>
      <dgm:t>
        <a:bodyPr/>
        <a:lstStyle/>
        <a:p>
          <a:endParaRPr lang="en-US"/>
        </a:p>
      </dgm:t>
    </dgm:pt>
    <dgm:pt modelId="{356543E8-3CE9-4B0D-A927-032E7C47932D}">
      <dgm:prSet phldrT="[Text]"/>
      <dgm:spPr/>
      <dgm:t>
        <a:bodyPr/>
        <a:lstStyle/>
        <a:p>
          <a:r>
            <a:rPr lang="en-US" dirty="0"/>
            <a:t>Feedback</a:t>
          </a:r>
        </a:p>
      </dgm:t>
    </dgm:pt>
    <dgm:pt modelId="{AD55E6DB-D426-4FC9-B9FB-6CE035023A65}" type="parTrans" cxnId="{E6DA6A37-1E35-4918-8EA1-7214CC8788CC}">
      <dgm:prSet/>
      <dgm:spPr/>
      <dgm:t>
        <a:bodyPr/>
        <a:lstStyle/>
        <a:p>
          <a:endParaRPr lang="en-US"/>
        </a:p>
      </dgm:t>
    </dgm:pt>
    <dgm:pt modelId="{9CFAE13F-CAF1-4B79-9BCC-FF7F3D08F2BF}" type="sibTrans" cxnId="{E6DA6A37-1E35-4918-8EA1-7214CC8788CC}">
      <dgm:prSet/>
      <dgm:spPr/>
      <dgm:t>
        <a:bodyPr/>
        <a:lstStyle/>
        <a:p>
          <a:endParaRPr lang="en-US"/>
        </a:p>
      </dgm:t>
    </dgm:pt>
    <dgm:pt modelId="{E9703C76-AB23-4030-B26C-0F2177F3DA8A}">
      <dgm:prSet phldrT="[Text]"/>
      <dgm:spPr/>
      <dgm:t>
        <a:bodyPr/>
        <a:lstStyle/>
        <a:p>
          <a:r>
            <a:rPr lang="en-US" dirty="0"/>
            <a:t>Online mindfulness course</a:t>
          </a:r>
        </a:p>
      </dgm:t>
    </dgm:pt>
    <dgm:pt modelId="{D042C575-EA3F-4FE4-B86E-36241AA608B4}" type="parTrans" cxnId="{EA073753-AF60-4DA2-8F42-982FECE85F6E}">
      <dgm:prSet/>
      <dgm:spPr/>
      <dgm:t>
        <a:bodyPr/>
        <a:lstStyle/>
        <a:p>
          <a:endParaRPr lang="en-US"/>
        </a:p>
      </dgm:t>
    </dgm:pt>
    <dgm:pt modelId="{19F1CA62-8D86-4138-880E-BF3D57FC6FEF}" type="sibTrans" cxnId="{EA073753-AF60-4DA2-8F42-982FECE85F6E}">
      <dgm:prSet/>
      <dgm:spPr/>
      <dgm:t>
        <a:bodyPr/>
        <a:lstStyle/>
        <a:p>
          <a:endParaRPr lang="en-US"/>
        </a:p>
      </dgm:t>
    </dgm:pt>
    <dgm:pt modelId="{C6E8AAF9-2AC9-489D-A2F3-90DA414C98DE}" type="pres">
      <dgm:prSet presAssocID="{A63B248F-E8A4-4EB2-8EDD-747942429B29}" presName="linearFlow" presStyleCnt="0">
        <dgm:presLayoutVars>
          <dgm:dir/>
          <dgm:animLvl val="lvl"/>
          <dgm:resizeHandles/>
        </dgm:presLayoutVars>
      </dgm:prSet>
      <dgm:spPr/>
    </dgm:pt>
    <dgm:pt modelId="{3B3A2088-F5F2-49DA-B98C-E13E13580550}" type="pres">
      <dgm:prSet presAssocID="{219C2705-6C89-46B6-B707-3194F9800933}" presName="compositeNode" presStyleCnt="0">
        <dgm:presLayoutVars>
          <dgm:bulletEnabled val="1"/>
        </dgm:presLayoutVars>
      </dgm:prSet>
      <dgm:spPr/>
    </dgm:pt>
    <dgm:pt modelId="{0DBCEAC0-7FE7-42B4-9AAE-200A6A97052F}" type="pres">
      <dgm:prSet presAssocID="{219C2705-6C89-46B6-B707-3194F9800933}" presName="image" presStyleLbl="fgImgPlace1" presStyleIdx="0" presStyleCnt="2"/>
      <dgm:spPr>
        <a:blipFill rotWithShape="1">
          <a:blip xmlns:r="http://schemas.openxmlformats.org/officeDocument/2006/relationships"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</dgm:spPr>
    </dgm:pt>
    <dgm:pt modelId="{625BF70F-5B8F-42DE-8C2B-7BC242902281}" type="pres">
      <dgm:prSet presAssocID="{219C2705-6C89-46B6-B707-3194F9800933}" presName="childNode" presStyleLbl="node1" presStyleIdx="0" presStyleCnt="2">
        <dgm:presLayoutVars>
          <dgm:bulletEnabled val="1"/>
        </dgm:presLayoutVars>
      </dgm:prSet>
      <dgm:spPr/>
    </dgm:pt>
    <dgm:pt modelId="{6652A172-2A12-4A52-BFD0-9140DD77A212}" type="pres">
      <dgm:prSet presAssocID="{219C2705-6C89-46B6-B707-3194F9800933}" presName="parentNode" presStyleLbl="revTx" presStyleIdx="0" presStyleCnt="2">
        <dgm:presLayoutVars>
          <dgm:chMax val="0"/>
          <dgm:bulletEnabled val="1"/>
        </dgm:presLayoutVars>
      </dgm:prSet>
      <dgm:spPr/>
    </dgm:pt>
    <dgm:pt modelId="{79E55EC9-A90F-4F4C-9564-FEB8E2202791}" type="pres">
      <dgm:prSet presAssocID="{43222245-30E3-4358-9F52-F67BA6FA0134}" presName="sibTrans" presStyleCnt="0"/>
      <dgm:spPr/>
    </dgm:pt>
    <dgm:pt modelId="{C077FB8A-9BE6-45A0-AC79-EEAEB8ACDCBA}" type="pres">
      <dgm:prSet presAssocID="{356543E8-3CE9-4B0D-A927-032E7C47932D}" presName="compositeNode" presStyleCnt="0">
        <dgm:presLayoutVars>
          <dgm:bulletEnabled val="1"/>
        </dgm:presLayoutVars>
      </dgm:prSet>
      <dgm:spPr/>
    </dgm:pt>
    <dgm:pt modelId="{1BD1FCA9-401C-43A7-997A-9A78A824E211}" type="pres">
      <dgm:prSet presAssocID="{356543E8-3CE9-4B0D-A927-032E7C47932D}" presName="image" presStyleLbl="fgImgPlace1" presStyleIdx="1" presStyleCnt="2"/>
      <dgm:spPr>
        <a:blipFill rotWithShape="1"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</dgm:spPr>
    </dgm:pt>
    <dgm:pt modelId="{D97367F5-533B-4417-B954-DD7F429B1A26}" type="pres">
      <dgm:prSet presAssocID="{356543E8-3CE9-4B0D-A927-032E7C47932D}" presName="childNode" presStyleLbl="node1" presStyleIdx="1" presStyleCnt="2">
        <dgm:presLayoutVars>
          <dgm:bulletEnabled val="1"/>
        </dgm:presLayoutVars>
      </dgm:prSet>
      <dgm:spPr/>
    </dgm:pt>
    <dgm:pt modelId="{91F3EFFF-44E3-4612-9142-A6FB53CD2705}" type="pres">
      <dgm:prSet presAssocID="{356543E8-3CE9-4B0D-A927-032E7C47932D}" presName="parentNode" presStyleLbl="revTx" presStyleIdx="1" presStyleCnt="2">
        <dgm:presLayoutVars>
          <dgm:chMax val="0"/>
          <dgm:bulletEnabled val="1"/>
        </dgm:presLayoutVars>
      </dgm:prSet>
      <dgm:spPr/>
    </dgm:pt>
  </dgm:ptLst>
  <dgm:cxnLst>
    <dgm:cxn modelId="{4F4A9F2E-E9EC-471B-A198-400532CE840E}" type="presOf" srcId="{219C2705-6C89-46B6-B707-3194F9800933}" destId="{6652A172-2A12-4A52-BFD0-9140DD77A212}" srcOrd="0" destOrd="0" presId="urn:microsoft.com/office/officeart/2005/8/layout/hList2"/>
    <dgm:cxn modelId="{E6DA6A37-1E35-4918-8EA1-7214CC8788CC}" srcId="{A63B248F-E8A4-4EB2-8EDD-747942429B29}" destId="{356543E8-3CE9-4B0D-A927-032E7C47932D}" srcOrd="1" destOrd="0" parTransId="{AD55E6DB-D426-4FC9-B9FB-6CE035023A65}" sibTransId="{9CFAE13F-CAF1-4B79-9BCC-FF7F3D08F2BF}"/>
    <dgm:cxn modelId="{51A7D64D-07D3-4236-A5B2-A3DA04423C77}" type="presOf" srcId="{E9703C76-AB23-4030-B26C-0F2177F3DA8A}" destId="{D97367F5-533B-4417-B954-DD7F429B1A26}" srcOrd="0" destOrd="0" presId="urn:microsoft.com/office/officeart/2005/8/layout/hList2"/>
    <dgm:cxn modelId="{EA073753-AF60-4DA2-8F42-982FECE85F6E}" srcId="{356543E8-3CE9-4B0D-A927-032E7C47932D}" destId="{E9703C76-AB23-4030-B26C-0F2177F3DA8A}" srcOrd="0" destOrd="0" parTransId="{D042C575-EA3F-4FE4-B86E-36241AA608B4}" sibTransId="{19F1CA62-8D86-4138-880E-BF3D57FC6FEF}"/>
    <dgm:cxn modelId="{2FA7BF73-F2B3-4276-BC13-D790789C5CE5}" srcId="{A63B248F-E8A4-4EB2-8EDD-747942429B29}" destId="{219C2705-6C89-46B6-B707-3194F9800933}" srcOrd="0" destOrd="0" parTransId="{77A0C298-8FB6-426A-A73A-8AB7E7FA7E75}" sibTransId="{43222245-30E3-4358-9F52-F67BA6FA0134}"/>
    <dgm:cxn modelId="{1BC21F9D-C747-4F16-8058-0FA3912F0CC0}" type="presOf" srcId="{A63B248F-E8A4-4EB2-8EDD-747942429B29}" destId="{C6E8AAF9-2AC9-489D-A2F3-90DA414C98DE}" srcOrd="0" destOrd="0" presId="urn:microsoft.com/office/officeart/2005/8/layout/hList2"/>
    <dgm:cxn modelId="{F806A0A9-C1FB-44C9-A5E7-CAFDEA74F60A}" srcId="{219C2705-6C89-46B6-B707-3194F9800933}" destId="{5192792B-E23D-47BC-B385-44954E4E2B72}" srcOrd="0" destOrd="0" parTransId="{7F114FE1-7315-4E61-86D3-F079573419DD}" sibTransId="{5EB073AC-A90F-43CB-866A-713A82602BB7}"/>
    <dgm:cxn modelId="{EAEB49C6-EF4F-4033-9A71-F106002C90B5}" type="presOf" srcId="{5192792B-E23D-47BC-B385-44954E4E2B72}" destId="{625BF70F-5B8F-42DE-8C2B-7BC242902281}" srcOrd="0" destOrd="0" presId="urn:microsoft.com/office/officeart/2005/8/layout/hList2"/>
    <dgm:cxn modelId="{B8A711CC-B740-4331-B004-1560DE3ABA30}" type="presOf" srcId="{356543E8-3CE9-4B0D-A927-032E7C47932D}" destId="{91F3EFFF-44E3-4612-9142-A6FB53CD2705}" srcOrd="0" destOrd="0" presId="urn:microsoft.com/office/officeart/2005/8/layout/hList2"/>
    <dgm:cxn modelId="{5FFFBAAB-39CC-44E3-8ABF-403B1C1D2635}" type="presParOf" srcId="{C6E8AAF9-2AC9-489D-A2F3-90DA414C98DE}" destId="{3B3A2088-F5F2-49DA-B98C-E13E13580550}" srcOrd="0" destOrd="0" presId="urn:microsoft.com/office/officeart/2005/8/layout/hList2"/>
    <dgm:cxn modelId="{D041A2AB-46E3-4886-910C-D93D74FBA3EC}" type="presParOf" srcId="{3B3A2088-F5F2-49DA-B98C-E13E13580550}" destId="{0DBCEAC0-7FE7-42B4-9AAE-200A6A97052F}" srcOrd="0" destOrd="0" presId="urn:microsoft.com/office/officeart/2005/8/layout/hList2"/>
    <dgm:cxn modelId="{C9BCBE82-1DC7-4816-8DEE-5B36C08A083D}" type="presParOf" srcId="{3B3A2088-F5F2-49DA-B98C-E13E13580550}" destId="{625BF70F-5B8F-42DE-8C2B-7BC242902281}" srcOrd="1" destOrd="0" presId="urn:microsoft.com/office/officeart/2005/8/layout/hList2"/>
    <dgm:cxn modelId="{E96E6487-12FF-4FA0-932F-1C5ECB35DE79}" type="presParOf" srcId="{3B3A2088-F5F2-49DA-B98C-E13E13580550}" destId="{6652A172-2A12-4A52-BFD0-9140DD77A212}" srcOrd="2" destOrd="0" presId="urn:microsoft.com/office/officeart/2005/8/layout/hList2"/>
    <dgm:cxn modelId="{074CE035-A473-4CA9-807F-A2B1872919D1}" type="presParOf" srcId="{C6E8AAF9-2AC9-489D-A2F3-90DA414C98DE}" destId="{79E55EC9-A90F-4F4C-9564-FEB8E2202791}" srcOrd="1" destOrd="0" presId="urn:microsoft.com/office/officeart/2005/8/layout/hList2"/>
    <dgm:cxn modelId="{FDE35680-701B-4919-B3A7-52DFD84DA008}" type="presParOf" srcId="{C6E8AAF9-2AC9-489D-A2F3-90DA414C98DE}" destId="{C077FB8A-9BE6-45A0-AC79-EEAEB8ACDCBA}" srcOrd="2" destOrd="0" presId="urn:microsoft.com/office/officeart/2005/8/layout/hList2"/>
    <dgm:cxn modelId="{07FCBE44-86A2-41B7-A0AE-46A868C22C4D}" type="presParOf" srcId="{C077FB8A-9BE6-45A0-AC79-EEAEB8ACDCBA}" destId="{1BD1FCA9-401C-43A7-997A-9A78A824E211}" srcOrd="0" destOrd="0" presId="urn:microsoft.com/office/officeart/2005/8/layout/hList2"/>
    <dgm:cxn modelId="{A8EEE7C2-53CF-467A-A996-551FD1F9BFDD}" type="presParOf" srcId="{C077FB8A-9BE6-45A0-AC79-EEAEB8ACDCBA}" destId="{D97367F5-533B-4417-B954-DD7F429B1A26}" srcOrd="1" destOrd="0" presId="urn:microsoft.com/office/officeart/2005/8/layout/hList2"/>
    <dgm:cxn modelId="{2D3C27DC-D426-4C84-9EC4-23BD1B4ED105}" type="presParOf" srcId="{C077FB8A-9BE6-45A0-AC79-EEAEB8ACDCBA}" destId="{91F3EFFF-44E3-4612-9142-A6FB53CD2705}" srcOrd="2" destOrd="0" presId="urn:microsoft.com/office/officeart/2005/8/layout/h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A55CA2FF-594E-40AF-8799-9D87EC4F9F99}" type="doc">
      <dgm:prSet loTypeId="urn:microsoft.com/office/officeart/2005/8/layout/vList6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0941698B-666A-499A-B8C1-E833D9E6FEAE}">
      <dgm:prSet phldrT="[Text]"/>
      <dgm:spPr/>
      <dgm:t>
        <a:bodyPr/>
        <a:lstStyle/>
        <a:p>
          <a:r>
            <a:rPr lang="en-US" dirty="0"/>
            <a:t>I like…</a:t>
          </a:r>
        </a:p>
      </dgm:t>
    </dgm:pt>
    <dgm:pt modelId="{B6560138-5860-41EE-A482-E31752342607}" type="parTrans" cxnId="{91347357-B221-40B9-AB46-97E7C0437918}">
      <dgm:prSet/>
      <dgm:spPr/>
      <dgm:t>
        <a:bodyPr/>
        <a:lstStyle/>
        <a:p>
          <a:endParaRPr lang="en-US"/>
        </a:p>
      </dgm:t>
    </dgm:pt>
    <dgm:pt modelId="{674CC868-94AC-49E5-8602-203425BDC9F5}" type="sibTrans" cxnId="{91347357-B221-40B9-AB46-97E7C0437918}">
      <dgm:prSet/>
      <dgm:spPr/>
      <dgm:t>
        <a:bodyPr/>
        <a:lstStyle/>
        <a:p>
          <a:endParaRPr lang="en-US"/>
        </a:p>
      </dgm:t>
    </dgm:pt>
    <dgm:pt modelId="{904A32D4-0188-4BD8-813A-8742F32CCB8D}">
      <dgm:prSet phldrT="[Text]"/>
      <dgm:spPr/>
      <dgm:t>
        <a:bodyPr/>
        <a:lstStyle/>
        <a:p>
          <a:r>
            <a:rPr lang="en-US" dirty="0"/>
            <a:t>I wish…</a:t>
          </a:r>
        </a:p>
      </dgm:t>
    </dgm:pt>
    <dgm:pt modelId="{947B086F-1FA0-4D86-948E-686492A2B4C7}" type="parTrans" cxnId="{1D89B079-C2E9-4702-A534-22AA1181E81A}">
      <dgm:prSet/>
      <dgm:spPr/>
      <dgm:t>
        <a:bodyPr/>
        <a:lstStyle/>
        <a:p>
          <a:endParaRPr lang="en-US"/>
        </a:p>
      </dgm:t>
    </dgm:pt>
    <dgm:pt modelId="{5BE75791-4704-4AB5-BC8B-8813DCD8A65E}" type="sibTrans" cxnId="{1D89B079-C2E9-4702-A534-22AA1181E81A}">
      <dgm:prSet/>
      <dgm:spPr/>
      <dgm:t>
        <a:bodyPr/>
        <a:lstStyle/>
        <a:p>
          <a:endParaRPr lang="en-US"/>
        </a:p>
      </dgm:t>
    </dgm:pt>
    <dgm:pt modelId="{88AAFB89-5A0A-47A7-B6F3-322BC7142653}">
      <dgm:prSet phldrT="[Text]"/>
      <dgm:spPr/>
      <dgm:t>
        <a:bodyPr/>
        <a:lstStyle/>
        <a:p>
          <a:r>
            <a:rPr lang="en-US" dirty="0"/>
            <a:t>I wonder…</a:t>
          </a:r>
        </a:p>
      </dgm:t>
    </dgm:pt>
    <dgm:pt modelId="{D565C209-7593-4939-9F13-BE7B29E2C74D}" type="parTrans" cxnId="{2A25DF03-A9AE-47CA-9B90-4C99D767188E}">
      <dgm:prSet/>
      <dgm:spPr/>
      <dgm:t>
        <a:bodyPr/>
        <a:lstStyle/>
        <a:p>
          <a:endParaRPr lang="en-US"/>
        </a:p>
      </dgm:t>
    </dgm:pt>
    <dgm:pt modelId="{E36D5650-364A-4BC5-A38C-40AA182793E0}" type="sibTrans" cxnId="{2A25DF03-A9AE-47CA-9B90-4C99D767188E}">
      <dgm:prSet/>
      <dgm:spPr/>
      <dgm:t>
        <a:bodyPr/>
        <a:lstStyle/>
        <a:p>
          <a:endParaRPr lang="en-US"/>
        </a:p>
      </dgm:t>
    </dgm:pt>
    <dgm:pt modelId="{15891C76-79F3-42C5-B97D-26A3DE5D1FA3}">
      <dgm:prSet phldrT="[Text]"/>
      <dgm:spPr/>
      <dgm:t>
        <a:bodyPr/>
        <a:lstStyle/>
        <a:p>
          <a:r>
            <a:rPr lang="en-US" dirty="0"/>
            <a:t>Things you liked or found remarkable</a:t>
          </a:r>
        </a:p>
      </dgm:t>
    </dgm:pt>
    <dgm:pt modelId="{5F29376F-4D83-4960-8485-0C7479E1C902}" type="parTrans" cxnId="{02123F7A-2DD9-4006-BB8F-10C61C0A3768}">
      <dgm:prSet/>
      <dgm:spPr/>
      <dgm:t>
        <a:bodyPr/>
        <a:lstStyle/>
        <a:p>
          <a:endParaRPr lang="en-US"/>
        </a:p>
      </dgm:t>
    </dgm:pt>
    <dgm:pt modelId="{683A83DB-6F7B-47F8-A9C1-189CF076D89D}" type="sibTrans" cxnId="{02123F7A-2DD9-4006-BB8F-10C61C0A3768}">
      <dgm:prSet/>
      <dgm:spPr/>
      <dgm:t>
        <a:bodyPr/>
        <a:lstStyle/>
        <a:p>
          <a:endParaRPr lang="en-US"/>
        </a:p>
      </dgm:t>
    </dgm:pt>
    <dgm:pt modelId="{09D2A206-9AE8-4026-ADD4-A94C37C7A47B}">
      <dgm:prSet phldrT="[Text]"/>
      <dgm:spPr/>
      <dgm:t>
        <a:bodyPr/>
        <a:lstStyle/>
        <a:p>
          <a:r>
            <a:rPr lang="en-US" dirty="0"/>
            <a:t>Constructive criticism</a:t>
          </a:r>
        </a:p>
      </dgm:t>
    </dgm:pt>
    <dgm:pt modelId="{B66BF6B9-6EA0-4013-8725-9B6BB5A56BEB}" type="parTrans" cxnId="{13267D4C-42F8-4760-A706-0FE211729D12}">
      <dgm:prSet/>
      <dgm:spPr/>
      <dgm:t>
        <a:bodyPr/>
        <a:lstStyle/>
        <a:p>
          <a:endParaRPr lang="en-US"/>
        </a:p>
      </dgm:t>
    </dgm:pt>
    <dgm:pt modelId="{F133CC96-E6E2-4CE4-8F65-0845EA7FB5E6}" type="sibTrans" cxnId="{13267D4C-42F8-4760-A706-0FE211729D12}">
      <dgm:prSet/>
      <dgm:spPr/>
      <dgm:t>
        <a:bodyPr/>
        <a:lstStyle/>
        <a:p>
          <a:endParaRPr lang="en-US"/>
        </a:p>
      </dgm:t>
    </dgm:pt>
    <dgm:pt modelId="{CBC7E6D3-09DB-4155-85E8-0BC83E8B86D3}">
      <dgm:prSet phldrT="[Text]"/>
      <dgm:spPr/>
      <dgm:t>
        <a:bodyPr/>
        <a:lstStyle/>
        <a:p>
          <a:r>
            <a:rPr lang="en-US" dirty="0"/>
            <a:t>Questions or ideas that have arisen</a:t>
          </a:r>
        </a:p>
      </dgm:t>
    </dgm:pt>
    <dgm:pt modelId="{1E1E4E36-3F20-422E-8FEB-F1CD5F43F338}" type="parTrans" cxnId="{E833AD43-F3EA-4CA1-86EF-F6E5A49B1FC6}">
      <dgm:prSet/>
      <dgm:spPr/>
      <dgm:t>
        <a:bodyPr/>
        <a:lstStyle/>
        <a:p>
          <a:endParaRPr lang="en-US"/>
        </a:p>
      </dgm:t>
    </dgm:pt>
    <dgm:pt modelId="{50F26D39-2DE8-40E3-A143-87C7CD4E907B}" type="sibTrans" cxnId="{E833AD43-F3EA-4CA1-86EF-F6E5A49B1FC6}">
      <dgm:prSet/>
      <dgm:spPr/>
      <dgm:t>
        <a:bodyPr/>
        <a:lstStyle/>
        <a:p>
          <a:endParaRPr lang="en-US"/>
        </a:p>
      </dgm:t>
    </dgm:pt>
    <dgm:pt modelId="{C0AAA353-84D2-48CD-A87C-FE2E956D74D4}" type="pres">
      <dgm:prSet presAssocID="{A55CA2FF-594E-40AF-8799-9D87EC4F9F99}" presName="Name0" presStyleCnt="0">
        <dgm:presLayoutVars>
          <dgm:dir/>
          <dgm:animLvl val="lvl"/>
          <dgm:resizeHandles/>
        </dgm:presLayoutVars>
      </dgm:prSet>
      <dgm:spPr/>
    </dgm:pt>
    <dgm:pt modelId="{1AC71643-11BB-4E5D-9AA6-A02E1CCAB617}" type="pres">
      <dgm:prSet presAssocID="{0941698B-666A-499A-B8C1-E833D9E6FEAE}" presName="linNode" presStyleCnt="0"/>
      <dgm:spPr/>
    </dgm:pt>
    <dgm:pt modelId="{008E0E4E-184D-4E9A-B8A3-6E8361E1FEB6}" type="pres">
      <dgm:prSet presAssocID="{0941698B-666A-499A-B8C1-E833D9E6FEAE}" presName="parentShp" presStyleLbl="node1" presStyleIdx="0" presStyleCnt="3">
        <dgm:presLayoutVars>
          <dgm:bulletEnabled val="1"/>
        </dgm:presLayoutVars>
      </dgm:prSet>
      <dgm:spPr/>
    </dgm:pt>
    <dgm:pt modelId="{F6027CFE-61F0-43A6-B44E-663F81E345BB}" type="pres">
      <dgm:prSet presAssocID="{0941698B-666A-499A-B8C1-E833D9E6FEAE}" presName="childShp" presStyleLbl="bgAccFollowNode1" presStyleIdx="0" presStyleCnt="3">
        <dgm:presLayoutVars>
          <dgm:bulletEnabled val="1"/>
        </dgm:presLayoutVars>
      </dgm:prSet>
      <dgm:spPr/>
    </dgm:pt>
    <dgm:pt modelId="{9A375CFD-02FB-4856-A918-651B77A2155E}" type="pres">
      <dgm:prSet presAssocID="{674CC868-94AC-49E5-8602-203425BDC9F5}" presName="spacing" presStyleCnt="0"/>
      <dgm:spPr/>
    </dgm:pt>
    <dgm:pt modelId="{2EB14BB0-FA4E-4565-B6A4-DD4280A8D889}" type="pres">
      <dgm:prSet presAssocID="{904A32D4-0188-4BD8-813A-8742F32CCB8D}" presName="linNode" presStyleCnt="0"/>
      <dgm:spPr/>
    </dgm:pt>
    <dgm:pt modelId="{E7B845FE-00CE-49C3-9B41-119C94FB503B}" type="pres">
      <dgm:prSet presAssocID="{904A32D4-0188-4BD8-813A-8742F32CCB8D}" presName="parentShp" presStyleLbl="node1" presStyleIdx="1" presStyleCnt="3">
        <dgm:presLayoutVars>
          <dgm:bulletEnabled val="1"/>
        </dgm:presLayoutVars>
      </dgm:prSet>
      <dgm:spPr/>
    </dgm:pt>
    <dgm:pt modelId="{B26FD6A8-F227-45BE-9F8A-33554BA60EC7}" type="pres">
      <dgm:prSet presAssocID="{904A32D4-0188-4BD8-813A-8742F32CCB8D}" presName="childShp" presStyleLbl="bgAccFollowNode1" presStyleIdx="1" presStyleCnt="3">
        <dgm:presLayoutVars>
          <dgm:bulletEnabled val="1"/>
        </dgm:presLayoutVars>
      </dgm:prSet>
      <dgm:spPr/>
    </dgm:pt>
    <dgm:pt modelId="{A8157498-F03A-47D1-9CA6-C5D80E42EF8A}" type="pres">
      <dgm:prSet presAssocID="{5BE75791-4704-4AB5-BC8B-8813DCD8A65E}" presName="spacing" presStyleCnt="0"/>
      <dgm:spPr/>
    </dgm:pt>
    <dgm:pt modelId="{2F1813F3-F0F8-4DE1-AFC8-6B84DFEB497B}" type="pres">
      <dgm:prSet presAssocID="{88AAFB89-5A0A-47A7-B6F3-322BC7142653}" presName="linNode" presStyleCnt="0"/>
      <dgm:spPr/>
    </dgm:pt>
    <dgm:pt modelId="{CC648BCE-11E0-422A-9E6A-D88CCBE951C8}" type="pres">
      <dgm:prSet presAssocID="{88AAFB89-5A0A-47A7-B6F3-322BC7142653}" presName="parentShp" presStyleLbl="node1" presStyleIdx="2" presStyleCnt="3">
        <dgm:presLayoutVars>
          <dgm:bulletEnabled val="1"/>
        </dgm:presLayoutVars>
      </dgm:prSet>
      <dgm:spPr/>
    </dgm:pt>
    <dgm:pt modelId="{2FA5026B-D836-4CDA-ACD3-E55925020C6C}" type="pres">
      <dgm:prSet presAssocID="{88AAFB89-5A0A-47A7-B6F3-322BC7142653}" presName="childShp" presStyleLbl="bgAccFollowNode1" presStyleIdx="2" presStyleCnt="3">
        <dgm:presLayoutVars>
          <dgm:bulletEnabled val="1"/>
        </dgm:presLayoutVars>
      </dgm:prSet>
      <dgm:spPr/>
    </dgm:pt>
  </dgm:ptLst>
  <dgm:cxnLst>
    <dgm:cxn modelId="{2A25DF03-A9AE-47CA-9B90-4C99D767188E}" srcId="{A55CA2FF-594E-40AF-8799-9D87EC4F9F99}" destId="{88AAFB89-5A0A-47A7-B6F3-322BC7142653}" srcOrd="2" destOrd="0" parTransId="{D565C209-7593-4939-9F13-BE7B29E2C74D}" sibTransId="{E36D5650-364A-4BC5-A38C-40AA182793E0}"/>
    <dgm:cxn modelId="{E833AD43-F3EA-4CA1-86EF-F6E5A49B1FC6}" srcId="{88AAFB89-5A0A-47A7-B6F3-322BC7142653}" destId="{CBC7E6D3-09DB-4155-85E8-0BC83E8B86D3}" srcOrd="0" destOrd="0" parTransId="{1E1E4E36-3F20-422E-8FEB-F1CD5F43F338}" sibTransId="{50F26D39-2DE8-40E3-A143-87C7CD4E907B}"/>
    <dgm:cxn modelId="{09D84E45-F9DD-468D-BB50-0413C1DD52BA}" type="presOf" srcId="{0941698B-666A-499A-B8C1-E833D9E6FEAE}" destId="{008E0E4E-184D-4E9A-B8A3-6E8361E1FEB6}" srcOrd="0" destOrd="0" presId="urn:microsoft.com/office/officeart/2005/8/layout/vList6"/>
    <dgm:cxn modelId="{13267D4C-42F8-4760-A706-0FE211729D12}" srcId="{904A32D4-0188-4BD8-813A-8742F32CCB8D}" destId="{09D2A206-9AE8-4026-ADD4-A94C37C7A47B}" srcOrd="0" destOrd="0" parTransId="{B66BF6B9-6EA0-4013-8725-9B6BB5A56BEB}" sibTransId="{F133CC96-E6E2-4CE4-8F65-0845EA7FB5E6}"/>
    <dgm:cxn modelId="{91347357-B221-40B9-AB46-97E7C0437918}" srcId="{A55CA2FF-594E-40AF-8799-9D87EC4F9F99}" destId="{0941698B-666A-499A-B8C1-E833D9E6FEAE}" srcOrd="0" destOrd="0" parTransId="{B6560138-5860-41EE-A482-E31752342607}" sibTransId="{674CC868-94AC-49E5-8602-203425BDC9F5}"/>
    <dgm:cxn modelId="{1D89B079-C2E9-4702-A534-22AA1181E81A}" srcId="{A55CA2FF-594E-40AF-8799-9D87EC4F9F99}" destId="{904A32D4-0188-4BD8-813A-8742F32CCB8D}" srcOrd="1" destOrd="0" parTransId="{947B086F-1FA0-4D86-948E-686492A2B4C7}" sibTransId="{5BE75791-4704-4AB5-BC8B-8813DCD8A65E}"/>
    <dgm:cxn modelId="{02123F7A-2DD9-4006-BB8F-10C61C0A3768}" srcId="{0941698B-666A-499A-B8C1-E833D9E6FEAE}" destId="{15891C76-79F3-42C5-B97D-26A3DE5D1FA3}" srcOrd="0" destOrd="0" parTransId="{5F29376F-4D83-4960-8485-0C7479E1C902}" sibTransId="{683A83DB-6F7B-47F8-A9C1-189CF076D89D}"/>
    <dgm:cxn modelId="{562C618A-04E7-47C5-BF0B-21F35277CFED}" type="presOf" srcId="{88AAFB89-5A0A-47A7-B6F3-322BC7142653}" destId="{CC648BCE-11E0-422A-9E6A-D88CCBE951C8}" srcOrd="0" destOrd="0" presId="urn:microsoft.com/office/officeart/2005/8/layout/vList6"/>
    <dgm:cxn modelId="{C194CF92-B702-4A34-A2F6-0D3C282F744D}" type="presOf" srcId="{A55CA2FF-594E-40AF-8799-9D87EC4F9F99}" destId="{C0AAA353-84D2-48CD-A87C-FE2E956D74D4}" srcOrd="0" destOrd="0" presId="urn:microsoft.com/office/officeart/2005/8/layout/vList6"/>
    <dgm:cxn modelId="{E0D062A3-6EBC-4E66-AAB5-086CC9830B97}" type="presOf" srcId="{09D2A206-9AE8-4026-ADD4-A94C37C7A47B}" destId="{B26FD6A8-F227-45BE-9F8A-33554BA60EC7}" srcOrd="0" destOrd="0" presId="urn:microsoft.com/office/officeart/2005/8/layout/vList6"/>
    <dgm:cxn modelId="{F93E0EA4-B3F8-4D27-B5AC-0BF30CE95DC1}" type="presOf" srcId="{904A32D4-0188-4BD8-813A-8742F32CCB8D}" destId="{E7B845FE-00CE-49C3-9B41-119C94FB503B}" srcOrd="0" destOrd="0" presId="urn:microsoft.com/office/officeart/2005/8/layout/vList6"/>
    <dgm:cxn modelId="{02C251B2-908D-49AC-A050-DA54EC7331D4}" type="presOf" srcId="{CBC7E6D3-09DB-4155-85E8-0BC83E8B86D3}" destId="{2FA5026B-D836-4CDA-ACD3-E55925020C6C}" srcOrd="0" destOrd="0" presId="urn:microsoft.com/office/officeart/2005/8/layout/vList6"/>
    <dgm:cxn modelId="{75F47ED1-E97D-4FD6-8CE7-FC30003C1B55}" type="presOf" srcId="{15891C76-79F3-42C5-B97D-26A3DE5D1FA3}" destId="{F6027CFE-61F0-43A6-B44E-663F81E345BB}" srcOrd="0" destOrd="0" presId="urn:microsoft.com/office/officeart/2005/8/layout/vList6"/>
    <dgm:cxn modelId="{E2978F3C-090B-48E1-AEFB-B967938AA5C0}" type="presParOf" srcId="{C0AAA353-84D2-48CD-A87C-FE2E956D74D4}" destId="{1AC71643-11BB-4E5D-9AA6-A02E1CCAB617}" srcOrd="0" destOrd="0" presId="urn:microsoft.com/office/officeart/2005/8/layout/vList6"/>
    <dgm:cxn modelId="{8C5A9768-4BC4-480B-818E-70AEFDCFB65F}" type="presParOf" srcId="{1AC71643-11BB-4E5D-9AA6-A02E1CCAB617}" destId="{008E0E4E-184D-4E9A-B8A3-6E8361E1FEB6}" srcOrd="0" destOrd="0" presId="urn:microsoft.com/office/officeart/2005/8/layout/vList6"/>
    <dgm:cxn modelId="{31273839-B616-4890-94C1-728C7D566E14}" type="presParOf" srcId="{1AC71643-11BB-4E5D-9AA6-A02E1CCAB617}" destId="{F6027CFE-61F0-43A6-B44E-663F81E345BB}" srcOrd="1" destOrd="0" presId="urn:microsoft.com/office/officeart/2005/8/layout/vList6"/>
    <dgm:cxn modelId="{51A021AE-D9B3-4877-9B54-B5C7BFFE6E13}" type="presParOf" srcId="{C0AAA353-84D2-48CD-A87C-FE2E956D74D4}" destId="{9A375CFD-02FB-4856-A918-651B77A2155E}" srcOrd="1" destOrd="0" presId="urn:microsoft.com/office/officeart/2005/8/layout/vList6"/>
    <dgm:cxn modelId="{DFE7065F-2F2E-4D9F-853A-825EF5AFBD25}" type="presParOf" srcId="{C0AAA353-84D2-48CD-A87C-FE2E956D74D4}" destId="{2EB14BB0-FA4E-4565-B6A4-DD4280A8D889}" srcOrd="2" destOrd="0" presId="urn:microsoft.com/office/officeart/2005/8/layout/vList6"/>
    <dgm:cxn modelId="{5B577499-E19D-4822-A97C-D1142D6A833F}" type="presParOf" srcId="{2EB14BB0-FA4E-4565-B6A4-DD4280A8D889}" destId="{E7B845FE-00CE-49C3-9B41-119C94FB503B}" srcOrd="0" destOrd="0" presId="urn:microsoft.com/office/officeart/2005/8/layout/vList6"/>
    <dgm:cxn modelId="{9284BCD8-4D3E-48FA-98BD-45385A331531}" type="presParOf" srcId="{2EB14BB0-FA4E-4565-B6A4-DD4280A8D889}" destId="{B26FD6A8-F227-45BE-9F8A-33554BA60EC7}" srcOrd="1" destOrd="0" presId="urn:microsoft.com/office/officeart/2005/8/layout/vList6"/>
    <dgm:cxn modelId="{386EE6BF-5F6B-48E7-867F-44AA07438A4B}" type="presParOf" srcId="{C0AAA353-84D2-48CD-A87C-FE2E956D74D4}" destId="{A8157498-F03A-47D1-9CA6-C5D80E42EF8A}" srcOrd="3" destOrd="0" presId="urn:microsoft.com/office/officeart/2005/8/layout/vList6"/>
    <dgm:cxn modelId="{5C65FC2F-E9E0-4B9D-9238-D7868F0ADD87}" type="presParOf" srcId="{C0AAA353-84D2-48CD-A87C-FE2E956D74D4}" destId="{2F1813F3-F0F8-4DE1-AFC8-6B84DFEB497B}" srcOrd="4" destOrd="0" presId="urn:microsoft.com/office/officeart/2005/8/layout/vList6"/>
    <dgm:cxn modelId="{5E551503-5536-4D89-B411-643A41E5BBEA}" type="presParOf" srcId="{2F1813F3-F0F8-4DE1-AFC8-6B84DFEB497B}" destId="{CC648BCE-11E0-422A-9E6A-D88CCBE951C8}" srcOrd="0" destOrd="0" presId="urn:microsoft.com/office/officeart/2005/8/layout/vList6"/>
    <dgm:cxn modelId="{62FE8FF9-0B86-4A12-A475-DF1F2D5870F5}" type="presParOf" srcId="{2F1813F3-F0F8-4DE1-AFC8-6B84DFEB497B}" destId="{2FA5026B-D836-4CDA-ACD3-E55925020C6C}" srcOrd="1" destOrd="0" presId="urn:microsoft.com/office/officeart/2005/8/layout/vList6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0E01BC6-9847-44B2-9F52-CE2C9910FB08}">
      <dsp:nvSpPr>
        <dsp:cNvPr id="0" name=""/>
        <dsp:cNvSpPr/>
      </dsp:nvSpPr>
      <dsp:spPr>
        <a:xfrm>
          <a:off x="0" y="1115445"/>
          <a:ext cx="6900512" cy="1559025"/>
        </a:xfrm>
        <a:prstGeom prst="round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47650" tIns="247650" rIns="247650" bIns="247650" numCol="1" spcCol="1270" anchor="ctr" anchorCtr="0">
          <a:noAutofit/>
        </a:bodyPr>
        <a:lstStyle/>
        <a:p>
          <a:pPr marL="0" lvl="0" indent="0" algn="l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6500" kern="1200"/>
            <a:t>Name/Alias</a:t>
          </a:r>
        </a:p>
      </dsp:txBody>
      <dsp:txXfrm>
        <a:off x="76105" y="1191550"/>
        <a:ext cx="6748302" cy="1406815"/>
      </dsp:txXfrm>
    </dsp:sp>
    <dsp:sp modelId="{79151D0E-C663-4CB3-AB51-408409B681B8}">
      <dsp:nvSpPr>
        <dsp:cNvPr id="0" name=""/>
        <dsp:cNvSpPr/>
      </dsp:nvSpPr>
      <dsp:spPr>
        <a:xfrm>
          <a:off x="0" y="2861670"/>
          <a:ext cx="6900512" cy="1559025"/>
        </a:xfrm>
        <a:prstGeom prst="roundRect">
          <a:avLst/>
        </a:prstGeom>
        <a:solidFill>
          <a:schemeClr val="accent2">
            <a:hueOff val="-1446200"/>
            <a:satOff val="-9924"/>
            <a:lumOff val="509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47650" tIns="247650" rIns="247650" bIns="247650" numCol="1" spcCol="1270" anchor="ctr" anchorCtr="0">
          <a:noAutofit/>
        </a:bodyPr>
        <a:lstStyle/>
        <a:p>
          <a:pPr marL="0" lvl="0" indent="0" algn="l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6500" kern="1200" dirty="0"/>
            <a:t>Discipline/Specialty</a:t>
          </a:r>
        </a:p>
      </dsp:txBody>
      <dsp:txXfrm>
        <a:off x="76105" y="2937775"/>
        <a:ext cx="6748302" cy="1406815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652A172-2A12-4A52-BFD0-9140DD77A212}">
      <dsp:nvSpPr>
        <dsp:cNvPr id="0" name=""/>
        <dsp:cNvSpPr/>
      </dsp:nvSpPr>
      <dsp:spPr>
        <a:xfrm rot="16200000">
          <a:off x="-1226800" y="2161016"/>
          <a:ext cx="3202114" cy="67737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0" rIns="597403" bIns="0" numCol="1" spcCol="1270" anchor="t" anchorCtr="0">
          <a:noAutofit/>
        </a:bodyPr>
        <a:lstStyle/>
        <a:p>
          <a:pPr marL="0" lvl="0" indent="0" algn="r" defTabSz="2178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900" kern="1200" dirty="0"/>
            <a:t>Ideas</a:t>
          </a:r>
        </a:p>
      </dsp:txBody>
      <dsp:txXfrm>
        <a:off x="-1226800" y="2161016"/>
        <a:ext cx="3202114" cy="677370"/>
      </dsp:txXfrm>
    </dsp:sp>
    <dsp:sp modelId="{625BF70F-5B8F-42DE-8C2B-7BC242902281}">
      <dsp:nvSpPr>
        <dsp:cNvPr id="0" name=""/>
        <dsp:cNvSpPr/>
      </dsp:nvSpPr>
      <dsp:spPr>
        <a:xfrm>
          <a:off x="712941" y="898644"/>
          <a:ext cx="4026779" cy="3202114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62280" tIns="597403" rIns="462280" bIns="462280" numCol="1" spcCol="1270" anchor="t" anchorCtr="0">
          <a:noAutofit/>
        </a:bodyPr>
        <a:lstStyle/>
        <a:p>
          <a:pPr marL="285750" lvl="1" indent="-285750" algn="l" defTabSz="2266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5100" kern="1200" dirty="0"/>
            <a:t>How might we…?</a:t>
          </a:r>
        </a:p>
      </dsp:txBody>
      <dsp:txXfrm>
        <a:off x="712941" y="898644"/>
        <a:ext cx="4026779" cy="3202114"/>
      </dsp:txXfrm>
    </dsp:sp>
    <dsp:sp modelId="{0DBCEAC0-7FE7-42B4-9AAE-200A6A97052F}">
      <dsp:nvSpPr>
        <dsp:cNvPr id="0" name=""/>
        <dsp:cNvSpPr/>
      </dsp:nvSpPr>
      <dsp:spPr>
        <a:xfrm>
          <a:off x="35571" y="4515"/>
          <a:ext cx="1354740" cy="1354740"/>
        </a:xfrm>
        <a:prstGeom prst="rect">
          <a:avLst/>
        </a:prstGeom>
        <a:blipFill rotWithShape="1">
          <a:blip xmlns:r="http://schemas.openxmlformats.org/officeDocument/2006/relationships"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1F3EFFF-44E3-4612-9142-A6FB53CD2705}">
      <dsp:nvSpPr>
        <dsp:cNvPr id="0" name=""/>
        <dsp:cNvSpPr/>
      </dsp:nvSpPr>
      <dsp:spPr>
        <a:xfrm rot="16200000">
          <a:off x="4513506" y="2161016"/>
          <a:ext cx="3202114" cy="67737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0" rIns="597403" bIns="0" numCol="1" spcCol="1270" anchor="t" anchorCtr="0">
          <a:noAutofit/>
        </a:bodyPr>
        <a:lstStyle/>
        <a:p>
          <a:pPr marL="0" lvl="0" indent="0" algn="r" defTabSz="2178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900" kern="1200" dirty="0"/>
            <a:t>Feedback</a:t>
          </a:r>
        </a:p>
      </dsp:txBody>
      <dsp:txXfrm>
        <a:off x="4513506" y="2161016"/>
        <a:ext cx="3202114" cy="677370"/>
      </dsp:txXfrm>
    </dsp:sp>
    <dsp:sp modelId="{D97367F5-533B-4417-B954-DD7F429B1A26}">
      <dsp:nvSpPr>
        <dsp:cNvPr id="0" name=""/>
        <dsp:cNvSpPr/>
      </dsp:nvSpPr>
      <dsp:spPr>
        <a:xfrm>
          <a:off x="6453248" y="898644"/>
          <a:ext cx="4026779" cy="3202114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62280" tIns="597403" rIns="462280" bIns="462280" numCol="1" spcCol="1270" anchor="t" anchorCtr="0">
          <a:noAutofit/>
        </a:bodyPr>
        <a:lstStyle/>
        <a:p>
          <a:pPr marL="285750" lvl="1" indent="-285750" algn="l" defTabSz="2266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5100" kern="1200" dirty="0"/>
            <a:t>Online mindfulness course</a:t>
          </a:r>
        </a:p>
      </dsp:txBody>
      <dsp:txXfrm>
        <a:off x="6453248" y="898644"/>
        <a:ext cx="4026779" cy="3202114"/>
      </dsp:txXfrm>
    </dsp:sp>
    <dsp:sp modelId="{1BD1FCA9-401C-43A7-997A-9A78A824E211}">
      <dsp:nvSpPr>
        <dsp:cNvPr id="0" name=""/>
        <dsp:cNvSpPr/>
      </dsp:nvSpPr>
      <dsp:spPr>
        <a:xfrm>
          <a:off x="5775878" y="4515"/>
          <a:ext cx="1354740" cy="1354740"/>
        </a:xfrm>
        <a:prstGeom prst="rect">
          <a:avLst/>
        </a:prstGeom>
        <a:blipFill rotWithShape="1"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6027CFE-61F0-43A6-B44E-663F81E345BB}">
      <dsp:nvSpPr>
        <dsp:cNvPr id="0" name=""/>
        <dsp:cNvSpPr/>
      </dsp:nvSpPr>
      <dsp:spPr>
        <a:xfrm>
          <a:off x="2072640" y="0"/>
          <a:ext cx="3108960" cy="1211460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685" tIns="19685" rIns="19685" bIns="19685" numCol="1" spcCol="1270" anchor="t" anchorCtr="0">
          <a:noAutofit/>
        </a:bodyPr>
        <a:lstStyle/>
        <a:p>
          <a:pPr marL="285750" lvl="1" indent="-285750" algn="l" defTabSz="1377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3100" kern="1200" dirty="0"/>
            <a:t>Things you liked or found remarkable</a:t>
          </a:r>
        </a:p>
      </dsp:txBody>
      <dsp:txXfrm>
        <a:off x="2072640" y="151433"/>
        <a:ext cx="2654663" cy="908595"/>
      </dsp:txXfrm>
    </dsp:sp>
    <dsp:sp modelId="{008E0E4E-184D-4E9A-B8A3-6E8361E1FEB6}">
      <dsp:nvSpPr>
        <dsp:cNvPr id="0" name=""/>
        <dsp:cNvSpPr/>
      </dsp:nvSpPr>
      <dsp:spPr>
        <a:xfrm>
          <a:off x="0" y="0"/>
          <a:ext cx="2072640" cy="121146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4310" tIns="97155" rIns="194310" bIns="97155" numCol="1" spcCol="1270" anchor="ctr" anchorCtr="0">
          <a:noAutofit/>
        </a:bodyPr>
        <a:lstStyle/>
        <a:p>
          <a:pPr marL="0" lvl="0" indent="0" algn="ctr" defTabSz="2266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100" kern="1200" dirty="0"/>
            <a:t>I like…</a:t>
          </a:r>
        </a:p>
      </dsp:txBody>
      <dsp:txXfrm>
        <a:off x="59139" y="59139"/>
        <a:ext cx="1954362" cy="1093182"/>
      </dsp:txXfrm>
    </dsp:sp>
    <dsp:sp modelId="{B26FD6A8-F227-45BE-9F8A-33554BA60EC7}">
      <dsp:nvSpPr>
        <dsp:cNvPr id="0" name=""/>
        <dsp:cNvSpPr/>
      </dsp:nvSpPr>
      <dsp:spPr>
        <a:xfrm>
          <a:off x="2072640" y="1332607"/>
          <a:ext cx="3108960" cy="1211460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685" tIns="19685" rIns="19685" bIns="19685" numCol="1" spcCol="1270" anchor="t" anchorCtr="0">
          <a:noAutofit/>
        </a:bodyPr>
        <a:lstStyle/>
        <a:p>
          <a:pPr marL="285750" lvl="1" indent="-285750" algn="l" defTabSz="1377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3100" kern="1200" dirty="0"/>
            <a:t>Constructive criticism</a:t>
          </a:r>
        </a:p>
      </dsp:txBody>
      <dsp:txXfrm>
        <a:off x="2072640" y="1484040"/>
        <a:ext cx="2654663" cy="908595"/>
      </dsp:txXfrm>
    </dsp:sp>
    <dsp:sp modelId="{E7B845FE-00CE-49C3-9B41-119C94FB503B}">
      <dsp:nvSpPr>
        <dsp:cNvPr id="0" name=""/>
        <dsp:cNvSpPr/>
      </dsp:nvSpPr>
      <dsp:spPr>
        <a:xfrm>
          <a:off x="0" y="1332607"/>
          <a:ext cx="2072640" cy="121146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4310" tIns="97155" rIns="194310" bIns="97155" numCol="1" spcCol="1270" anchor="ctr" anchorCtr="0">
          <a:noAutofit/>
        </a:bodyPr>
        <a:lstStyle/>
        <a:p>
          <a:pPr marL="0" lvl="0" indent="0" algn="ctr" defTabSz="2266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100" kern="1200" dirty="0"/>
            <a:t>I wish…</a:t>
          </a:r>
        </a:p>
      </dsp:txBody>
      <dsp:txXfrm>
        <a:off x="59139" y="1391746"/>
        <a:ext cx="1954362" cy="1093182"/>
      </dsp:txXfrm>
    </dsp:sp>
    <dsp:sp modelId="{2FA5026B-D836-4CDA-ACD3-E55925020C6C}">
      <dsp:nvSpPr>
        <dsp:cNvPr id="0" name=""/>
        <dsp:cNvSpPr/>
      </dsp:nvSpPr>
      <dsp:spPr>
        <a:xfrm>
          <a:off x="2072640" y="2665214"/>
          <a:ext cx="3108960" cy="1211460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685" tIns="19685" rIns="19685" bIns="19685" numCol="1" spcCol="1270" anchor="t" anchorCtr="0">
          <a:noAutofit/>
        </a:bodyPr>
        <a:lstStyle/>
        <a:p>
          <a:pPr marL="285750" lvl="1" indent="-285750" algn="l" defTabSz="1377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3100" kern="1200" dirty="0"/>
            <a:t>Questions or ideas that have arisen</a:t>
          </a:r>
        </a:p>
      </dsp:txBody>
      <dsp:txXfrm>
        <a:off x="2072640" y="2816647"/>
        <a:ext cx="2654663" cy="908595"/>
      </dsp:txXfrm>
    </dsp:sp>
    <dsp:sp modelId="{CC648BCE-11E0-422A-9E6A-D88CCBE951C8}">
      <dsp:nvSpPr>
        <dsp:cNvPr id="0" name=""/>
        <dsp:cNvSpPr/>
      </dsp:nvSpPr>
      <dsp:spPr>
        <a:xfrm>
          <a:off x="0" y="2665214"/>
          <a:ext cx="2072640" cy="121146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4310" tIns="97155" rIns="194310" bIns="97155" numCol="1" spcCol="1270" anchor="ctr" anchorCtr="0">
          <a:noAutofit/>
        </a:bodyPr>
        <a:lstStyle/>
        <a:p>
          <a:pPr marL="0" lvl="0" indent="0" algn="ctr" defTabSz="2266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100" kern="1200" dirty="0"/>
            <a:t>I wonder…</a:t>
          </a:r>
        </a:p>
      </dsp:txBody>
      <dsp:txXfrm>
        <a:off x="59139" y="2724353"/>
        <a:ext cx="1954362" cy="109318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List2">
  <dgm:title val=""/>
  <dgm:desc val=""/>
  <dgm:catLst>
    <dgm:cat type="list" pri="6000"/>
    <dgm:cat type="relationship" pri="16000"/>
    <dgm:cat type="picture" pri="29000"/>
    <dgm:cat type="pictureconvert" pri="2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/>
    </dgm:varLst>
    <dgm:choose name="Name0">
      <dgm:if name="Name1" func="var" arg="dir" op="equ" val="norm">
        <dgm:alg type="lin">
          <dgm:param type="linDir" val="fromL"/>
          <dgm:param type="nodeVertAlign" val="t"/>
        </dgm:alg>
      </dgm:if>
      <dgm:else name="Name2">
        <dgm:alg type="lin">
          <dgm:param type="linDir" val="fromR"/>
          <dgm:param type="nodeVertAlign" val="t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Node" refType="w"/>
      <dgm:constr type="h" for="ch" forName="compositeNode" refType="h"/>
      <dgm:constr type="w" for="ch" forName="sibTrans" refType="w" refFor="ch" refForName="compositeNode" op="equ" fact="0.2"/>
      <dgm:constr type="h" for="des" forName="childNode" op="equ"/>
      <dgm:constr type="w" for="des" forName="childNode" op="equ"/>
      <dgm:constr type="w" for="des" forName="parentNode" op="equ"/>
      <dgm:constr type="h" for="des" forName="image" op="equ"/>
      <dgm:constr type="w" for="des" forName="image" op="equ"/>
      <dgm:constr type="primFontSz" for="des" forName="parentNode" op="equ" val="65"/>
      <dgm:constr type="primFontSz" for="des" forName="childNode" op="equ" val="65"/>
    </dgm:constrLst>
    <dgm:ruleLst/>
    <dgm:forEach name="Name3" axis="ch" ptType="node">
      <dgm:layoutNode name="compositeNode">
        <dgm:varLst>
          <dgm:bulletEnabled val="1"/>
        </dgm:varLst>
        <dgm:alg type="composite"/>
        <dgm:presOf/>
        <dgm:choose name="Name4">
          <dgm:if name="Name5" func="var" arg="dir" op="equ" val="norm">
            <dgm:constrLst>
              <dgm:constr type="w" for="ch" forName="image" refType="w"/>
              <dgm:constr type="h" for="ch" forName="image" refType="h"/>
              <dgm:constr type="h" for="ch" forName="image" refType="w" refFor="ch" refForName="image" op="lte"/>
              <dgm:constr type="w" for="ch" forName="image" refType="h" refFor="ch" refForName="image" op="lte"/>
              <dgm:constr type="w" for="ch" forName="image" refType="w" op="lte" fact="0.33"/>
              <dgm:constr type="h" for="ch" forName="image" refType="h" op="lte" fact="0.33"/>
              <dgm:constr type="t" for="ch" forName="image"/>
              <dgm:constr type="l" for="ch" forName="image"/>
              <dgm:constr type="w" for="ch" forName="childNode" refType="w" fact="0.85"/>
              <dgm:constr type="h" for="ch" forName="childNode" refType="h" fact="0.78"/>
              <dgm:constr type="t" for="ch" forName="childNode" refType="h" refFor="ch" refForName="image" fact="0.66"/>
              <dgm:constr type="l" for="ch" forName="childNode" refType="w" refFor="ch" refForName="image" fact="0.5"/>
              <dgm:constr type="tMarg" for="ch" forName="childNode" refType="w" refFor="ch" refForName="image" fact="1.25"/>
              <dgm:constr type="t" for="ch" forName="parentNode" refType="h" refFor="ch" refForName="image" fact="0.66"/>
              <dgm:constr type="b" for="ch" forName="parentNode" refType="b" refFor="ch" refForName="childNode"/>
              <dgm:constr type="l" for="ch" forName="parentNode"/>
              <dgm:constr type="r" for="ch" forName="parentNode" refType="l" refFor="ch" refForName="childNode"/>
              <dgm:constr type="rMarg" for="ch" forName="parentNode" refType="w" refFor="ch" refForName="image" fact="1.25"/>
            </dgm:constrLst>
          </dgm:if>
          <dgm:else name="Name6">
            <dgm:constrLst>
              <dgm:constr type="w" for="ch" forName="image" refType="w"/>
              <dgm:constr type="h" for="ch" forName="image" refType="h"/>
              <dgm:constr type="h" for="ch" forName="image" refType="w" refFor="ch" refForName="image" op="lte"/>
              <dgm:constr type="w" for="ch" forName="image" refType="h" refFor="ch" refForName="image" op="lte"/>
              <dgm:constr type="w" for="ch" forName="image" refType="w" op="lte" fact="0.33"/>
              <dgm:constr type="h" for="ch" forName="image" refType="h" op="lte" fact="0.33"/>
              <dgm:constr type="t" for="ch" forName="image"/>
              <dgm:constr type="r" for="ch" forName="image" refType="w"/>
              <dgm:constr type="w" for="ch" forName="childNode" refType="w" fact="0.85"/>
              <dgm:constr type="h" for="ch" forName="childNode" refType="h" fact="0.78"/>
              <dgm:constr type="t" for="ch" forName="childNode" refType="h" refFor="ch" refForName="image" fact="0.66"/>
              <dgm:constr type="r" for="ch" forName="childNode" refType="w"/>
              <dgm:constr type="rOff" for="ch" forName="childNode" refType="w" refFor="ch" refForName="image" fact="-0.5"/>
              <dgm:constr type="tMarg" for="ch" forName="childNode" refType="w" refFor="ch" refForName="image" fact="1.25"/>
              <dgm:constr type="t" for="ch" forName="parentNode" refType="h" refFor="ch" refForName="image" fact="0.66"/>
              <dgm:constr type="b" for="ch" forName="parentNode" refType="b" refFor="ch" refForName="childNode"/>
              <dgm:constr type="r" for="ch" forName="parentNode" refType="w"/>
              <dgm:constr type="l" for="ch" forName="parentNode" refType="r" refFor="ch" refForName="childNode"/>
              <dgm:constr type="lOff" for="ch" forName="parentNode" refType="rOff" refFor="ch" refForName="childNode"/>
              <dgm:constr type="lMarg" for="ch" forName="parentNode" refType="w" refFor="ch" refForName="image" fact="1.25"/>
            </dgm:constrLst>
          </dgm:else>
        </dgm:choose>
        <dgm:ruleLst>
          <dgm:rule type="w" for="ch" forName="childNode" val="NaN" fact="0.4" max="NaN"/>
          <dgm:rule type="h" for="ch" forName="childNode" val="NaN" fact="0.5" max="NaN"/>
        </dgm:ruleLst>
        <dgm:layoutNode name="image" styleLbl="fgImgPlace1">
          <dgm:alg type="sp"/>
          <dgm:shape xmlns:r="http://schemas.openxmlformats.org/officeDocument/2006/relationships" type="rect" r:blip="" zOrderOff="4" blipPhldr="1">
            <dgm:adjLst/>
          </dgm:shape>
          <dgm:presOf/>
          <dgm:constrLst/>
          <dgm:ruleLst/>
        </dgm:layoutNode>
        <dgm:layoutNode name="childNode" styleLbl="node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ect" r:blip="" zOrderOff="2">
            <dgm:adjLst/>
          </dgm:shape>
          <dgm:presOf axis="des" ptType="node"/>
          <dgm:constrLst/>
          <dgm:ruleLst>
            <dgm:rule type="primFontSz" val="5" fact="NaN" max="NaN"/>
          </dgm:ruleLst>
        </dgm:layoutNode>
        <dgm:layoutNode name="parentNode" styleLbl="revTx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autoTxRot" val="grav"/>
                <dgm:param type="txAnchorVert" val="t"/>
                <dgm:param type="parTxLTRAlign" val="r"/>
                <dgm:param type="parTxRTLAlign" val="r"/>
              </dgm:alg>
              <dgm:shape xmlns:r="http://schemas.openxmlformats.org/officeDocument/2006/relationships" rot="270" type="rect" r:blip="">
                <dgm:adjLst/>
              </dgm:shape>
              <dgm:presOf axis="self"/>
              <dgm:constrLst>
                <dgm:constr type="lMarg"/>
                <dgm:constr type="bMarg"/>
                <dgm:constr type="tMarg"/>
              </dgm:constrLst>
            </dgm:if>
            <dgm:else name="Name9">
              <dgm:alg type="tx">
                <dgm:param type="autoTxRot" val="grav"/>
                <dgm:param type="parTxLTRAlign" val="l"/>
                <dgm:param type="parTxRTLAlign" val="l"/>
              </dgm:alg>
              <dgm:shape xmlns:r="http://schemas.openxmlformats.org/officeDocument/2006/relationships" rot="90" type="rect" r:blip="">
                <dgm:adjLst/>
              </dgm:shape>
              <dgm:presOf axis="self"/>
              <dgm:constrLst>
                <dgm:constr type="rMarg"/>
                <dgm:constr type="bMarg"/>
                <dgm:constr type="tMarg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List6">
  <dgm:title val=""/>
  <dgm:desc val=""/>
  <dgm:catLst>
    <dgm:cat type="process" pri="22000"/>
    <dgm:cat type="list" pri="1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w" for="ch" forName="linNode" refType="w"/>
      <dgm:constr type="h" for="ch" forName="linNode" refType="h"/>
      <dgm:constr type="h" for="ch" forName="spacing" refType="h" refFor="ch" refForName="linNode" fact="0.1"/>
      <dgm:constr type="primFontSz" for="des" forName="parentShp" op="equ" val="65"/>
      <dgm:constr type="primFontSz" for="des" forName="childShp" op="equ" val="65"/>
    </dgm:constrLst>
    <dgm:ruleLst/>
    <dgm:forEach name="Name1" axis="ch" ptType="node">
      <dgm:layoutNode name="linNode">
        <dgm:choose name="Name2">
          <dgm:if name="Name3" func="var" arg="dir" op="equ" val="norm">
            <dgm:alg type="lin">
              <dgm:param type="linDir" val="fromL"/>
            </dgm:alg>
          </dgm:if>
          <dgm:else name="Name4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if>
          <dgm:else name="Name7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else>
        </dgm:choose>
        <dgm:ruleLst/>
        <dgm:layoutNode name="parentShp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childShp" styleLbl="bgAccFollowNode1">
          <dgm:varLst>
            <dgm:bulletEnabled val="1"/>
          </dgm:varLst>
          <dgm:alg type="tx">
            <dgm:param type="stBulletLvl" val="1"/>
          </dgm:alg>
          <dgm:choose name="Name8">
            <dgm:if name="Name9" func="var" arg="dir" op="equ" val="norm">
              <dgm:shape xmlns:r="http://schemas.openxmlformats.org/officeDocument/2006/relationships" type="rightArrow" r:blip="" zOrderOff="-2">
                <dgm:adjLst>
                  <dgm:adj idx="1" val="0.75"/>
                </dgm:adjLst>
              </dgm:shape>
            </dgm:if>
            <dgm:else name="Name10">
              <dgm:shape xmlns:r="http://schemas.openxmlformats.org/officeDocument/2006/relationships" rot="180" type="rightArrow" r:blip="" zOrderOff="-2">
                <dgm:adjLst>
                  <dgm:adj idx="1" val="0.7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forEach name="Name11" axis="followSib" ptType="sibTrans" cnt="1">
        <dgm:layoutNode name="spacing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BA6C86A-E696-4915-84A9-365D5136836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FA275-E5BD-42D5-86C3-D4A66EF382D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4D676F-4DB5-46B8-8F00-05DB67D5471C}" type="datetimeFigureOut">
              <a:rPr lang="en-US" smtClean="0"/>
              <a:t>2/22/20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8037F-BC33-4B71-9390-1FCCB44C83C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7A39EB-596B-48AB-BC3E-069215B7692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DFD5B-C328-43D8-A4C7-929BECA315C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7013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8-10T21:34:56.846"/>
    </inkml:context>
    <inkml:brush xml:id="br0">
      <inkml:brushProperty name="width" value="0.1" units="cm"/>
      <inkml:brushProperty name="height" value="0.1" units="cm"/>
      <inkml:brushProperty name="color" value="#FFFFFF"/>
    </inkml:brush>
  </inkml:definitions>
  <inkml:trace contextRef="#ctx0" brushRef="#br0">1 0 128,'0'6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7BE5AB-3192-4552-A220-BA06EA9D867F}" type="datetimeFigureOut">
              <a:rPr lang="en-US" smtClean="0"/>
              <a:t>2/22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8D0E63-0F6A-47B0-8BD1-6E95B004C8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23284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  <a:p>
            <a:r>
              <a:rPr lang="en-US" dirty="0"/>
              <a:t>Remind about use of video recording and confidentialit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22991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ehavioral Activation: Based on the idea that our behaviors affect out mood; involves tracking and scheduling behaviors that are enjoyable or provide a sense of mastery</a:t>
            </a:r>
          </a:p>
          <a:p>
            <a:r>
              <a:rPr lang="en-US" dirty="0"/>
              <a:t>Cognitive Restructuring: Based on the idea that out thoughts affect our mood; involves tracking and challenging unhelpful thoughts</a:t>
            </a:r>
          </a:p>
          <a:p>
            <a:r>
              <a:rPr lang="en-US" dirty="0"/>
              <a:t>Mindfulness: Based on the idea that staying in the present moment (rather than ruminating on the past or worrying about the future) improves our mood; involves engaging in formal and informal mindfulness practi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1308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b-based tools/apps exist to do many of these things, but they haven’t been tailored to the needs and preferences of AYAs</a:t>
            </a:r>
          </a:p>
          <a:p>
            <a:r>
              <a:rPr lang="en-US" dirty="0"/>
              <a:t>Peer Support: Based on the idea that connecting with others improves our mood and AYAs desire to connect with other young cancer survivor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55201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rabicPeriod"/>
            </a:pPr>
            <a:r>
              <a:rPr lang="en-US" dirty="0"/>
              <a:t>We want to empower you to feel confident to share – you are here because of your expertise!</a:t>
            </a:r>
          </a:p>
          <a:p>
            <a:pPr marL="228600" indent="-228600">
              <a:buAutoNum type="arabicPeriod"/>
            </a:pPr>
            <a:r>
              <a:rPr lang="en-US" dirty="0"/>
              <a:t>Brainstorming is about coming up with a lot of ideas – even if you’re not sure if something is a “good” or feasible idea, share it!</a:t>
            </a:r>
          </a:p>
          <a:p>
            <a:pPr marL="228600" indent="-228600">
              <a:buAutoNum type="arabicPeriod"/>
            </a:pPr>
            <a:r>
              <a:rPr lang="en-US" dirty="0"/>
              <a:t>Use gestures during conversation to share support, indicate you have a question, etc.</a:t>
            </a:r>
          </a:p>
          <a:p>
            <a:pPr marL="228600" indent="-228600">
              <a:buAutoNum type="arabicPeriod"/>
            </a:pPr>
            <a:r>
              <a:rPr lang="en-US" dirty="0"/>
              <a:t>Work together to build on each others ideas – combine, modify, add to etc.</a:t>
            </a:r>
          </a:p>
          <a:p>
            <a:pPr marL="228600" indent="-228600">
              <a:buAutoNum type="arabicPeriod"/>
            </a:pPr>
            <a:r>
              <a:rPr lang="en-US" dirty="0"/>
              <a:t>Only one person talks at a time</a:t>
            </a:r>
          </a:p>
          <a:p>
            <a:pPr marL="228600" indent="-228600">
              <a:buAutoNum type="arabicPeriod"/>
            </a:pPr>
            <a:r>
              <a:rPr lang="en-US" dirty="0"/>
              <a:t>No </a:t>
            </a:r>
            <a:r>
              <a:rPr lang="en-US"/>
              <a:t>playing favorit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674940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09191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www.figma.com/file/zPTZviOLkljmop0KnTukDE/Wakeful-Feedback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9789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raphic 33" descr="Tag=AccentColor&#10;Flavor=Light&#10;Target=Fill">
            <a:extLst>
              <a:ext uri="{FF2B5EF4-FFF2-40B4-BE49-F238E27FC236}">
                <a16:creationId xmlns:a16="http://schemas.microsoft.com/office/drawing/2014/main" id="{A4E7DAC5-621F-40E6-ACD2-590570CC84F8}"/>
              </a:ext>
            </a:extLst>
          </p:cNvPr>
          <p:cNvSpPr>
            <a:spLocks noChangeAspect="1"/>
          </p:cNvSpPr>
          <p:nvPr userDrawn="1"/>
        </p:nvSpPr>
        <p:spPr>
          <a:xfrm>
            <a:off x="1318417" y="0"/>
            <a:ext cx="9570431" cy="6858000"/>
          </a:xfrm>
          <a:custGeom>
            <a:avLst/>
            <a:gdLst>
              <a:gd name="connsiteX0" fmla="*/ 7178288 w 7187261"/>
              <a:gd name="connsiteY0" fmla="*/ 2604802 h 5150263"/>
              <a:gd name="connsiteX1" fmla="*/ 7169335 w 7187261"/>
              <a:gd name="connsiteY1" fmla="*/ 2328577 h 5150263"/>
              <a:gd name="connsiteX2" fmla="*/ 7060845 w 7187261"/>
              <a:gd name="connsiteY2" fmla="*/ 1661160 h 5150263"/>
              <a:gd name="connsiteX3" fmla="*/ 6212263 w 7187261"/>
              <a:gd name="connsiteY3" fmla="*/ 243840 h 5150263"/>
              <a:gd name="connsiteX4" fmla="*/ 5953564 w 7187261"/>
              <a:gd name="connsiteY4" fmla="*/ 0 h 5150263"/>
              <a:gd name="connsiteX5" fmla="*/ 1408615 w 7187261"/>
              <a:gd name="connsiteY5" fmla="*/ 0 h 5150263"/>
              <a:gd name="connsiteX6" fmla="*/ 805111 w 7187261"/>
              <a:gd name="connsiteY6" fmla="*/ 676275 h 5150263"/>
              <a:gd name="connsiteX7" fmla="*/ 104928 w 7187261"/>
              <a:gd name="connsiteY7" fmla="*/ 2183035 h 5150263"/>
              <a:gd name="connsiteX8" fmla="*/ 51588 w 7187261"/>
              <a:gd name="connsiteY8" fmla="*/ 2400014 h 5150263"/>
              <a:gd name="connsiteX9" fmla="*/ 41301 w 7187261"/>
              <a:gd name="connsiteY9" fmla="*/ 2424208 h 5150263"/>
              <a:gd name="connsiteX10" fmla="*/ 119692 w 7187261"/>
              <a:gd name="connsiteY10" fmla="*/ 1834801 h 5150263"/>
              <a:gd name="connsiteX11" fmla="*/ 870071 w 7187261"/>
              <a:gd name="connsiteY11" fmla="*/ 462248 h 5150263"/>
              <a:gd name="connsiteX12" fmla="*/ 1389279 w 7187261"/>
              <a:gd name="connsiteY12" fmla="*/ 476 h 5150263"/>
              <a:gd name="connsiteX13" fmla="*/ 1320223 w 7187261"/>
              <a:gd name="connsiteY13" fmla="*/ 476 h 5150263"/>
              <a:gd name="connsiteX14" fmla="*/ 423158 w 7187261"/>
              <a:gd name="connsiteY14" fmla="*/ 989743 h 5150263"/>
              <a:gd name="connsiteX15" fmla="*/ 25585 w 7187261"/>
              <a:gd name="connsiteY15" fmla="*/ 2113693 h 5150263"/>
              <a:gd name="connsiteX16" fmla="*/ 2344 w 7187261"/>
              <a:gd name="connsiteY16" fmla="*/ 2725865 h 5150263"/>
              <a:gd name="connsiteX17" fmla="*/ 447256 w 7187261"/>
              <a:gd name="connsiteY17" fmla="*/ 4210717 h 5150263"/>
              <a:gd name="connsiteX18" fmla="*/ 1138962 w 7187261"/>
              <a:gd name="connsiteY18" fmla="*/ 4988910 h 5150263"/>
              <a:gd name="connsiteX19" fmla="*/ 1348512 w 7187261"/>
              <a:gd name="connsiteY19" fmla="*/ 5146834 h 5150263"/>
              <a:gd name="connsiteX20" fmla="*/ 1422712 w 7187261"/>
              <a:gd name="connsiteY20" fmla="*/ 5146834 h 5150263"/>
              <a:gd name="connsiteX21" fmla="*/ 480594 w 7187261"/>
              <a:gd name="connsiteY21" fmla="*/ 4187952 h 5150263"/>
              <a:gd name="connsiteX22" fmla="*/ 398679 w 7187261"/>
              <a:gd name="connsiteY22" fmla="*/ 4046125 h 5150263"/>
              <a:gd name="connsiteX23" fmla="*/ 411823 w 7187261"/>
              <a:gd name="connsiteY23" fmla="*/ 4053078 h 5150263"/>
              <a:gd name="connsiteX24" fmla="*/ 1439380 w 7187261"/>
              <a:gd name="connsiteY24" fmla="*/ 5147405 h 5150263"/>
              <a:gd name="connsiteX25" fmla="*/ 5710010 w 7187261"/>
              <a:gd name="connsiteY25" fmla="*/ 5150263 h 5150263"/>
              <a:gd name="connsiteX26" fmla="*/ 5999665 w 7187261"/>
              <a:gd name="connsiteY26" fmla="*/ 4910900 h 5150263"/>
              <a:gd name="connsiteX27" fmla="*/ 6954165 w 7187261"/>
              <a:gd name="connsiteY27" fmla="*/ 3545777 h 5150263"/>
              <a:gd name="connsiteX28" fmla="*/ 7137712 w 7187261"/>
              <a:gd name="connsiteY28" fmla="*/ 2799207 h 5150263"/>
              <a:gd name="connsiteX29" fmla="*/ 7142951 w 7187261"/>
              <a:gd name="connsiteY29" fmla="*/ 2754535 h 5150263"/>
              <a:gd name="connsiteX30" fmla="*/ 7149428 w 7187261"/>
              <a:gd name="connsiteY30" fmla="*/ 2774823 h 5150263"/>
              <a:gd name="connsiteX31" fmla="*/ 7066465 w 7187261"/>
              <a:gd name="connsiteY31" fmla="*/ 3465672 h 5150263"/>
              <a:gd name="connsiteX32" fmla="*/ 6452578 w 7187261"/>
              <a:gd name="connsiteY32" fmla="*/ 4552760 h 5150263"/>
              <a:gd name="connsiteX33" fmla="*/ 5752110 w 7187261"/>
              <a:gd name="connsiteY33" fmla="*/ 5150263 h 5150263"/>
              <a:gd name="connsiteX34" fmla="*/ 5827643 w 7187261"/>
              <a:gd name="connsiteY34" fmla="*/ 5150263 h 5150263"/>
              <a:gd name="connsiteX35" fmla="*/ 6642793 w 7187261"/>
              <a:gd name="connsiteY35" fmla="*/ 4389406 h 5150263"/>
              <a:gd name="connsiteX36" fmla="*/ 7102469 w 7187261"/>
              <a:gd name="connsiteY36" fmla="*/ 3490817 h 5150263"/>
              <a:gd name="connsiteX37" fmla="*/ 7187242 w 7187261"/>
              <a:gd name="connsiteY37" fmla="*/ 2990183 h 5150263"/>
              <a:gd name="connsiteX38" fmla="*/ 7178288 w 7187261"/>
              <a:gd name="connsiteY38" fmla="*/ 2604802 h 5150263"/>
              <a:gd name="connsiteX39" fmla="*/ 6342565 w 7187261"/>
              <a:gd name="connsiteY39" fmla="*/ 441389 h 5150263"/>
              <a:gd name="connsiteX40" fmla="*/ 7126567 w 7187261"/>
              <a:gd name="connsiteY40" fmla="*/ 2355056 h 5150263"/>
              <a:gd name="connsiteX41" fmla="*/ 6342565 w 7187261"/>
              <a:gd name="connsiteY41" fmla="*/ 441389 h 51502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</a:cxnLst>
            <a:rect l="l" t="t" r="r" b="b"/>
            <a:pathLst>
              <a:path w="7187261" h="5150263">
                <a:moveTo>
                  <a:pt x="7178288" y="2604802"/>
                </a:moveTo>
                <a:cubicBezTo>
                  <a:pt x="7168763" y="2513076"/>
                  <a:pt x="7174478" y="2420684"/>
                  <a:pt x="7169335" y="2328577"/>
                </a:cubicBezTo>
                <a:cubicBezTo>
                  <a:pt x="7156952" y="2102882"/>
                  <a:pt x="7120586" y="1879149"/>
                  <a:pt x="7060845" y="1661160"/>
                </a:cubicBezTo>
                <a:cubicBezTo>
                  <a:pt x="6910588" y="1121007"/>
                  <a:pt x="6617428" y="631374"/>
                  <a:pt x="6212263" y="243840"/>
                </a:cubicBezTo>
                <a:cubicBezTo>
                  <a:pt x="6126538" y="162496"/>
                  <a:pt x="6040813" y="80201"/>
                  <a:pt x="5953564" y="0"/>
                </a:cubicBezTo>
                <a:lnTo>
                  <a:pt x="1408615" y="0"/>
                </a:lnTo>
                <a:cubicBezTo>
                  <a:pt x="1180967" y="200316"/>
                  <a:pt x="978332" y="427387"/>
                  <a:pt x="805111" y="676275"/>
                </a:cubicBezTo>
                <a:cubicBezTo>
                  <a:pt x="481261" y="1136523"/>
                  <a:pt x="252089" y="1640872"/>
                  <a:pt x="104928" y="2183035"/>
                </a:cubicBezTo>
                <a:cubicBezTo>
                  <a:pt x="85878" y="2254853"/>
                  <a:pt x="69495" y="2327720"/>
                  <a:pt x="51588" y="2400014"/>
                </a:cubicBezTo>
                <a:cubicBezTo>
                  <a:pt x="49683" y="2407634"/>
                  <a:pt x="51588" y="2416969"/>
                  <a:pt x="41301" y="2424208"/>
                </a:cubicBezTo>
                <a:cubicBezTo>
                  <a:pt x="45900" y="2225469"/>
                  <a:pt x="72186" y="2027834"/>
                  <a:pt x="119692" y="1834801"/>
                </a:cubicBezTo>
                <a:cubicBezTo>
                  <a:pt x="247993" y="1310926"/>
                  <a:pt x="506121" y="857726"/>
                  <a:pt x="870071" y="462248"/>
                </a:cubicBezTo>
                <a:cubicBezTo>
                  <a:pt x="1027729" y="291823"/>
                  <a:pt x="1201617" y="137169"/>
                  <a:pt x="1389279" y="476"/>
                </a:cubicBezTo>
                <a:lnTo>
                  <a:pt x="1320223" y="476"/>
                </a:lnTo>
                <a:cubicBezTo>
                  <a:pt x="960844" y="274320"/>
                  <a:pt x="656330" y="599123"/>
                  <a:pt x="423158" y="989743"/>
                </a:cubicBezTo>
                <a:cubicBezTo>
                  <a:pt x="215608" y="1337596"/>
                  <a:pt x="80258" y="1711357"/>
                  <a:pt x="25585" y="2113693"/>
                </a:cubicBezTo>
                <a:cubicBezTo>
                  <a:pt x="-2705" y="2316480"/>
                  <a:pt x="-2228" y="2521077"/>
                  <a:pt x="2344" y="2725865"/>
                </a:cubicBezTo>
                <a:cubicBezTo>
                  <a:pt x="14155" y="3261932"/>
                  <a:pt x="170650" y="3754565"/>
                  <a:pt x="447256" y="4210717"/>
                </a:cubicBezTo>
                <a:cubicBezTo>
                  <a:pt x="629851" y="4511612"/>
                  <a:pt x="866356" y="4767167"/>
                  <a:pt x="1138962" y="4988910"/>
                </a:cubicBezTo>
                <a:cubicBezTo>
                  <a:pt x="1207161" y="5044345"/>
                  <a:pt x="1277008" y="5096990"/>
                  <a:pt x="1348512" y="5146834"/>
                </a:cubicBezTo>
                <a:lnTo>
                  <a:pt x="1422712" y="5146834"/>
                </a:lnTo>
                <a:cubicBezTo>
                  <a:pt x="1043426" y="4892802"/>
                  <a:pt x="724720" y="4577334"/>
                  <a:pt x="480594" y="4187952"/>
                </a:cubicBezTo>
                <a:cubicBezTo>
                  <a:pt x="452019" y="4141851"/>
                  <a:pt x="423444" y="4095179"/>
                  <a:pt x="398679" y="4046125"/>
                </a:cubicBezTo>
                <a:cubicBezTo>
                  <a:pt x="407442" y="4043267"/>
                  <a:pt x="409156" y="4048982"/>
                  <a:pt x="411823" y="4053078"/>
                </a:cubicBezTo>
                <a:cubicBezTo>
                  <a:pt x="683572" y="4484656"/>
                  <a:pt x="1033139" y="4842701"/>
                  <a:pt x="1439380" y="5147405"/>
                </a:cubicBezTo>
                <a:lnTo>
                  <a:pt x="5710010" y="5150263"/>
                </a:lnTo>
                <a:cubicBezTo>
                  <a:pt x="5810594" y="5075482"/>
                  <a:pt x="5907272" y="4995587"/>
                  <a:pt x="5999665" y="4910900"/>
                </a:cubicBezTo>
                <a:cubicBezTo>
                  <a:pt x="6418765" y="4526661"/>
                  <a:pt x="6746901" y="4078129"/>
                  <a:pt x="6954165" y="3545777"/>
                </a:cubicBezTo>
                <a:cubicBezTo>
                  <a:pt x="7048234" y="3306175"/>
                  <a:pt x="7109956" y="3055115"/>
                  <a:pt x="7137712" y="2799207"/>
                </a:cubicBezTo>
                <a:cubicBezTo>
                  <a:pt x="7139236" y="2784920"/>
                  <a:pt x="7141046" y="2770632"/>
                  <a:pt x="7142951" y="2754535"/>
                </a:cubicBezTo>
                <a:cubicBezTo>
                  <a:pt x="7151714" y="2760440"/>
                  <a:pt x="7149237" y="2768441"/>
                  <a:pt x="7149428" y="2774823"/>
                </a:cubicBezTo>
                <a:cubicBezTo>
                  <a:pt x="7156743" y="3007967"/>
                  <a:pt x="7128777" y="3240881"/>
                  <a:pt x="7066465" y="3465672"/>
                </a:cubicBezTo>
                <a:cubicBezTo>
                  <a:pt x="6952165" y="3878580"/>
                  <a:pt x="6737948" y="4235863"/>
                  <a:pt x="6452578" y="4552760"/>
                </a:cubicBezTo>
                <a:cubicBezTo>
                  <a:pt x="6244553" y="4783836"/>
                  <a:pt x="6008809" y="4980242"/>
                  <a:pt x="5752110" y="5150263"/>
                </a:cubicBezTo>
                <a:lnTo>
                  <a:pt x="5827643" y="5150263"/>
                </a:lnTo>
                <a:cubicBezTo>
                  <a:pt x="6136539" y="4938904"/>
                  <a:pt x="6412192" y="4689348"/>
                  <a:pt x="6642793" y="4389406"/>
                </a:cubicBezTo>
                <a:cubicBezTo>
                  <a:pt x="6851295" y="4118324"/>
                  <a:pt x="7009125" y="3820859"/>
                  <a:pt x="7102469" y="3490817"/>
                </a:cubicBezTo>
                <a:cubicBezTo>
                  <a:pt x="7148646" y="3327473"/>
                  <a:pt x="7177069" y="3159624"/>
                  <a:pt x="7187242" y="2990183"/>
                </a:cubicBezTo>
                <a:cubicBezTo>
                  <a:pt x="7187623" y="2984087"/>
                  <a:pt x="7182384" y="2642330"/>
                  <a:pt x="7178288" y="2604802"/>
                </a:cubicBezTo>
                <a:close/>
                <a:moveTo>
                  <a:pt x="6342565" y="441389"/>
                </a:moveTo>
                <a:cubicBezTo>
                  <a:pt x="6829797" y="986533"/>
                  <a:pt x="7091135" y="1624422"/>
                  <a:pt x="7126567" y="2355056"/>
                </a:cubicBezTo>
                <a:cubicBezTo>
                  <a:pt x="7001123" y="1661827"/>
                  <a:pt x="6756426" y="1017365"/>
                  <a:pt x="6342565" y="441389"/>
                </a:cubicBezTo>
                <a:close/>
              </a:path>
            </a:pathLst>
          </a:custGeom>
          <a:solidFill>
            <a:schemeClr val="accent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4EF9DF8-704A-44AE-8850-307DDACC93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560320" y="960120"/>
            <a:ext cx="7077456" cy="2898648"/>
          </a:xfrm>
        </p:spPr>
        <p:txBody>
          <a:bodyPr anchor="b">
            <a:noAutofit/>
          </a:bodyPr>
          <a:lstStyle>
            <a:lvl1pPr algn="ctr">
              <a:defRPr sz="88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C72E09-06F3-48B9-9B95-DE15EC9801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633472" y="4535424"/>
            <a:ext cx="6931152" cy="941832"/>
          </a:xfrm>
        </p:spPr>
        <p:txBody>
          <a:bodyPr>
            <a:normAutofit/>
          </a:bodyPr>
          <a:lstStyle>
            <a:lvl1pPr marL="0" indent="0" algn="ctr">
              <a:buNone/>
              <a:defRPr sz="32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371B7A5D-C918-4744-A5FA-75C904B3B8D4}"/>
              </a:ext>
            </a:extLst>
          </p:cNvPr>
          <p:cNvSpPr/>
          <p:nvPr userDrawn="1"/>
        </p:nvSpPr>
        <p:spPr>
          <a:xfrm>
            <a:off x="3974206" y="411333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568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AE282-8875-4F49-AB21-E1C2BCAEA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712EA2-EF8C-4F18-BECF-AD121F7281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2578608"/>
            <a:ext cx="5157787" cy="82391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B59D4-E93F-40C1-A1A2-F1867830C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3617842"/>
            <a:ext cx="5157787" cy="2572645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810616-1C77-42AE-8449-D0B64E2B84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2578608"/>
            <a:ext cx="5183188" cy="82391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74E172-AFE8-48E4-BBB0-CA6D4EC11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3617842"/>
            <a:ext cx="5183188" cy="2572645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9407CC-270D-4C98-B95C-7AE67D2E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070D5-9B7B-47FC-9F75-F6AD96074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8EAC17-33BE-4265-8C06-644C2D34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0" name="Rectangle 9" descr="Tag=AccentColor&#10;Flavor=Light&#10;Target=FillAndLine">
            <a:extLst>
              <a:ext uri="{FF2B5EF4-FFF2-40B4-BE49-F238E27FC236}">
                <a16:creationId xmlns:a16="http://schemas.microsoft.com/office/drawing/2014/main" id="{5A11B4AA-D861-4DDC-9A8A-7036C40D909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1408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 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AE282-8875-4F49-AB21-E1C2BCAEA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712EA2-EF8C-4F18-BECF-AD121F72816A}"/>
              </a:ext>
            </a:extLst>
          </p:cNvPr>
          <p:cNvSpPr>
            <a:spLocks noGrp="1"/>
          </p:cNvSpPr>
          <p:nvPr>
            <p:ph type="body" idx="1" hasCustomPrompt="1"/>
          </p:nvPr>
        </p:nvSpPr>
        <p:spPr>
          <a:xfrm>
            <a:off x="649224" y="2578608"/>
            <a:ext cx="3200400" cy="711244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B59D4-E93F-40C1-A1A2-F1867830C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49224" y="3339547"/>
            <a:ext cx="3200400" cy="2900635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810616-1C77-42AE-8449-D0B64E2B8475}"/>
              </a:ext>
            </a:extLst>
          </p:cNvPr>
          <p:cNvSpPr>
            <a:spLocks noGrp="1"/>
          </p:cNvSpPr>
          <p:nvPr>
            <p:ph type="body" sz="quarter" idx="3" hasCustomPrompt="1"/>
          </p:nvPr>
        </p:nvSpPr>
        <p:spPr>
          <a:xfrm>
            <a:off x="4498848" y="2578608"/>
            <a:ext cx="3200400" cy="71323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74E172-AFE8-48E4-BBB0-CA6D4EC11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498848" y="3339548"/>
            <a:ext cx="3200400" cy="28509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9407CC-270D-4C98-B95C-7AE67D2E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070D5-9B7B-47FC-9F75-F6AD96074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8EAC17-33BE-4265-8C06-644C2D34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0" name="Rectangle 9" descr="Tag=AccentColor&#10;Flavor=Light&#10;Target=FillAndLine">
            <a:extLst>
              <a:ext uri="{FF2B5EF4-FFF2-40B4-BE49-F238E27FC236}">
                <a16:creationId xmlns:a16="http://schemas.microsoft.com/office/drawing/2014/main" id="{5A11B4AA-D861-4DDC-9A8A-7036C40D909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42AA5FD4-D71A-436D-B50A-847980623CF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8339328" y="2578608"/>
            <a:ext cx="3200400" cy="71323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5">
            <a:extLst>
              <a:ext uri="{FF2B5EF4-FFF2-40B4-BE49-F238E27FC236}">
                <a16:creationId xmlns:a16="http://schemas.microsoft.com/office/drawing/2014/main" id="{498877DB-362B-4B53-84A8-D53090240FD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8339328" y="3339548"/>
            <a:ext cx="3200400" cy="28509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75974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4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icture Placeholder 25">
            <a:extLst>
              <a:ext uri="{FF2B5EF4-FFF2-40B4-BE49-F238E27FC236}">
                <a16:creationId xmlns:a16="http://schemas.microsoft.com/office/drawing/2014/main" id="{95429EAB-EC88-4283-9CAC-5C4336D68761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8263901" y="-1"/>
            <a:ext cx="3928091" cy="4143506"/>
          </a:xfrm>
          <a:custGeom>
            <a:avLst/>
            <a:gdLst>
              <a:gd name="connsiteX0" fmla="*/ 23605 w 3928091"/>
              <a:gd name="connsiteY0" fmla="*/ 0 h 4143506"/>
              <a:gd name="connsiteX1" fmla="*/ 3928091 w 3928091"/>
              <a:gd name="connsiteY1" fmla="*/ 0 h 4143506"/>
              <a:gd name="connsiteX2" fmla="*/ 3928091 w 3928091"/>
              <a:gd name="connsiteY2" fmla="*/ 4125656 h 4143506"/>
              <a:gd name="connsiteX3" fmla="*/ 3780617 w 3928091"/>
              <a:gd name="connsiteY3" fmla="*/ 4131078 h 4143506"/>
              <a:gd name="connsiteX4" fmla="*/ 3281801 w 3928091"/>
              <a:gd name="connsiteY4" fmla="*/ 4125634 h 4143506"/>
              <a:gd name="connsiteX5" fmla="*/ 2622887 w 3928091"/>
              <a:gd name="connsiteY5" fmla="*/ 4130456 h 4143506"/>
              <a:gd name="connsiteX6" fmla="*/ 2169916 w 3928091"/>
              <a:gd name="connsiteY6" fmla="*/ 4111570 h 4143506"/>
              <a:gd name="connsiteX7" fmla="*/ 1705097 w 3928091"/>
              <a:gd name="connsiteY7" fmla="*/ 4140234 h 4143506"/>
              <a:gd name="connsiteX8" fmla="*/ 1364801 w 3928091"/>
              <a:gd name="connsiteY8" fmla="*/ 4124429 h 4143506"/>
              <a:gd name="connsiteX9" fmla="*/ 1123316 w 3928091"/>
              <a:gd name="connsiteY9" fmla="*/ 4121750 h 4143506"/>
              <a:gd name="connsiteX10" fmla="*/ 688243 w 3928091"/>
              <a:gd name="connsiteY10" fmla="*/ 4130323 h 4143506"/>
              <a:gd name="connsiteX11" fmla="*/ 298918 w 3928091"/>
              <a:gd name="connsiteY11" fmla="*/ 4118266 h 4143506"/>
              <a:gd name="connsiteX12" fmla="*/ 105785 w 3928091"/>
              <a:gd name="connsiteY12" fmla="*/ 4130037 h 4143506"/>
              <a:gd name="connsiteX13" fmla="*/ 15503 w 3928091"/>
              <a:gd name="connsiteY13" fmla="*/ 4130462 h 4143506"/>
              <a:gd name="connsiteX14" fmla="*/ 14458 w 3928091"/>
              <a:gd name="connsiteY14" fmla="*/ 4122289 h 4143506"/>
              <a:gd name="connsiteX15" fmla="*/ 346 w 3928091"/>
              <a:gd name="connsiteY15" fmla="*/ 3882149 h 4143506"/>
              <a:gd name="connsiteX16" fmla="*/ 27583 w 3928091"/>
              <a:gd name="connsiteY16" fmla="*/ 3294816 h 4143506"/>
              <a:gd name="connsiteX17" fmla="*/ 21797 w 3928091"/>
              <a:gd name="connsiteY17" fmla="*/ 3078932 h 4143506"/>
              <a:gd name="connsiteX18" fmla="*/ 30264 w 3928091"/>
              <a:gd name="connsiteY18" fmla="*/ 2835999 h 4143506"/>
              <a:gd name="connsiteX19" fmla="*/ 33510 w 3928091"/>
              <a:gd name="connsiteY19" fmla="*/ 2550270 h 4143506"/>
              <a:gd name="connsiteX20" fmla="*/ 9096 w 3928091"/>
              <a:gd name="connsiteY20" fmla="*/ 1764959 h 4143506"/>
              <a:gd name="connsiteX21" fmla="*/ 30406 w 3928091"/>
              <a:gd name="connsiteY21" fmla="*/ 1598729 h 4143506"/>
              <a:gd name="connsiteX22" fmla="*/ 20244 w 3928091"/>
              <a:gd name="connsiteY22" fmla="*/ 1114767 h 4143506"/>
              <a:gd name="connsiteX23" fmla="*/ 26736 w 3928091"/>
              <a:gd name="connsiteY23" fmla="*/ 579120 h 4143506"/>
              <a:gd name="connsiteX24" fmla="*/ 38237 w 3928091"/>
              <a:gd name="connsiteY24" fmla="*/ 288533 h 41435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3928091" h="4143506">
                <a:moveTo>
                  <a:pt x="23605" y="0"/>
                </a:moveTo>
                <a:lnTo>
                  <a:pt x="3928091" y="0"/>
                </a:lnTo>
                <a:lnTo>
                  <a:pt x="3928091" y="4125656"/>
                </a:lnTo>
                <a:lnTo>
                  <a:pt x="3780617" y="4131078"/>
                </a:lnTo>
                <a:cubicBezTo>
                  <a:pt x="3614346" y="4131561"/>
                  <a:pt x="3448073" y="4118803"/>
                  <a:pt x="3281801" y="4125634"/>
                </a:cubicBezTo>
                <a:cubicBezTo>
                  <a:pt x="3062120" y="4134609"/>
                  <a:pt x="2842441" y="4144923"/>
                  <a:pt x="2622887" y="4130456"/>
                </a:cubicBezTo>
                <a:cubicBezTo>
                  <a:pt x="2472401" y="4120545"/>
                  <a:pt x="2321159" y="4107551"/>
                  <a:pt x="2169916" y="4111570"/>
                </a:cubicBezTo>
                <a:cubicBezTo>
                  <a:pt x="2014640" y="4115856"/>
                  <a:pt x="1859994" y="4129920"/>
                  <a:pt x="1705097" y="4140234"/>
                </a:cubicBezTo>
                <a:cubicBezTo>
                  <a:pt x="1591463" y="4147694"/>
                  <a:pt x="1477389" y="4142391"/>
                  <a:pt x="1364801" y="4124429"/>
                </a:cubicBezTo>
                <a:cubicBezTo>
                  <a:pt x="1284516" y="4111703"/>
                  <a:pt x="1203727" y="4117195"/>
                  <a:pt x="1123316" y="4121750"/>
                </a:cubicBezTo>
                <a:cubicBezTo>
                  <a:pt x="978124" y="4130323"/>
                  <a:pt x="833434" y="4143717"/>
                  <a:pt x="688243" y="4130323"/>
                </a:cubicBezTo>
                <a:cubicBezTo>
                  <a:pt x="558551" y="4118266"/>
                  <a:pt x="427601" y="4108489"/>
                  <a:pt x="298918" y="4118266"/>
                </a:cubicBezTo>
                <a:cubicBezTo>
                  <a:pt x="234577" y="4123155"/>
                  <a:pt x="170204" y="4128045"/>
                  <a:pt x="105785" y="4130037"/>
                </a:cubicBezTo>
                <a:lnTo>
                  <a:pt x="15503" y="4130462"/>
                </a:lnTo>
                <a:lnTo>
                  <a:pt x="14458" y="4122289"/>
                </a:lnTo>
                <a:cubicBezTo>
                  <a:pt x="3338" y="4042653"/>
                  <a:pt x="-1375" y="3962394"/>
                  <a:pt x="346" y="3882149"/>
                </a:cubicBezTo>
                <a:cubicBezTo>
                  <a:pt x="205" y="3686075"/>
                  <a:pt x="9942" y="3490383"/>
                  <a:pt x="27583" y="3294816"/>
                </a:cubicBezTo>
                <a:cubicBezTo>
                  <a:pt x="31859" y="3222826"/>
                  <a:pt x="29926" y="3150656"/>
                  <a:pt x="21797" y="3078932"/>
                </a:cubicBezTo>
                <a:cubicBezTo>
                  <a:pt x="13668" y="2997950"/>
                  <a:pt x="16505" y="2916372"/>
                  <a:pt x="30264" y="2835999"/>
                </a:cubicBezTo>
                <a:cubicBezTo>
                  <a:pt x="47622" y="2740756"/>
                  <a:pt x="39860" y="2645513"/>
                  <a:pt x="33510" y="2550270"/>
                </a:cubicBezTo>
                <a:cubicBezTo>
                  <a:pt x="16152" y="2288796"/>
                  <a:pt x="-5017" y="2027322"/>
                  <a:pt x="9096" y="1764959"/>
                </a:cubicBezTo>
                <a:cubicBezTo>
                  <a:pt x="12060" y="1708956"/>
                  <a:pt x="25042" y="1654350"/>
                  <a:pt x="30406" y="1598729"/>
                </a:cubicBezTo>
                <a:cubicBezTo>
                  <a:pt x="46071" y="1437069"/>
                  <a:pt x="27723" y="1276045"/>
                  <a:pt x="20244" y="1114767"/>
                </a:cubicBezTo>
                <a:cubicBezTo>
                  <a:pt x="9491" y="936281"/>
                  <a:pt x="11664" y="757351"/>
                  <a:pt x="26736" y="579120"/>
                </a:cubicBezTo>
                <a:cubicBezTo>
                  <a:pt x="36191" y="482353"/>
                  <a:pt x="39402" y="385459"/>
                  <a:pt x="38237" y="288533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5" name="Picture Placeholder 24">
            <a:extLst>
              <a:ext uri="{FF2B5EF4-FFF2-40B4-BE49-F238E27FC236}">
                <a16:creationId xmlns:a16="http://schemas.microsoft.com/office/drawing/2014/main" id="{95853130-EDA3-41D2-A3D5-E39613A79C81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281029" y="4328340"/>
            <a:ext cx="3910962" cy="2529660"/>
          </a:xfrm>
          <a:custGeom>
            <a:avLst/>
            <a:gdLst>
              <a:gd name="connsiteX0" fmla="*/ 842684 w 3910962"/>
              <a:gd name="connsiteY0" fmla="*/ 662 h 2529660"/>
              <a:gd name="connsiteX1" fmla="*/ 1140350 w 3910962"/>
              <a:gd name="connsiteY1" fmla="*/ 3173 h 2529660"/>
              <a:gd name="connsiteX2" fmla="*/ 1350451 w 3910962"/>
              <a:gd name="connsiteY2" fmla="*/ 29025 h 2529660"/>
              <a:gd name="connsiteX3" fmla="*/ 1903495 w 3910962"/>
              <a:gd name="connsiteY3" fmla="*/ 18310 h 2529660"/>
              <a:gd name="connsiteX4" fmla="*/ 2649374 w 3910962"/>
              <a:gd name="connsiteY4" fmla="*/ 22730 h 2529660"/>
              <a:gd name="connsiteX5" fmla="*/ 3310304 w 3910962"/>
              <a:gd name="connsiteY5" fmla="*/ 10808 h 2529660"/>
              <a:gd name="connsiteX6" fmla="*/ 3684881 w 3910962"/>
              <a:gd name="connsiteY6" fmla="*/ 10808 h 2529660"/>
              <a:gd name="connsiteX7" fmla="*/ 3887420 w 3910962"/>
              <a:gd name="connsiteY7" fmla="*/ 15630 h 2529660"/>
              <a:gd name="connsiteX8" fmla="*/ 3910962 w 3910962"/>
              <a:gd name="connsiteY8" fmla="*/ 11105 h 2529660"/>
              <a:gd name="connsiteX9" fmla="*/ 3910962 w 3910962"/>
              <a:gd name="connsiteY9" fmla="*/ 2529660 h 2529660"/>
              <a:gd name="connsiteX10" fmla="*/ 6242 w 3910962"/>
              <a:gd name="connsiteY10" fmla="*/ 2529660 h 2529660"/>
              <a:gd name="connsiteX11" fmla="*/ 25280 w 3910962"/>
              <a:gd name="connsiteY11" fmla="*/ 2158134 h 2529660"/>
              <a:gd name="connsiteX12" fmla="*/ 11167 w 3910962"/>
              <a:gd name="connsiteY12" fmla="*/ 1427303 h 2529660"/>
              <a:gd name="connsiteX13" fmla="*/ 3970 w 3910962"/>
              <a:gd name="connsiteY13" fmla="*/ 934453 h 2529660"/>
              <a:gd name="connsiteX14" fmla="*/ 5805 w 3910962"/>
              <a:gd name="connsiteY14" fmla="*/ 380010 h 2529660"/>
              <a:gd name="connsiteX15" fmla="*/ 18506 w 3910962"/>
              <a:gd name="connsiteY15" fmla="*/ 139744 h 2529660"/>
              <a:gd name="connsiteX16" fmla="*/ 19072 w 3910962"/>
              <a:gd name="connsiteY16" fmla="*/ 23791 h 2529660"/>
              <a:gd name="connsiteX17" fmla="*/ 67093 w 3910962"/>
              <a:gd name="connsiteY17" fmla="*/ 27133 h 2529660"/>
              <a:gd name="connsiteX18" fmla="*/ 545085 w 3910962"/>
              <a:gd name="connsiteY18" fmla="*/ 11612 h 2529660"/>
              <a:gd name="connsiteX19" fmla="*/ 842684 w 3910962"/>
              <a:gd name="connsiteY19" fmla="*/ 662 h 25296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3910962" h="2529660">
                <a:moveTo>
                  <a:pt x="842684" y="662"/>
                </a:moveTo>
                <a:cubicBezTo>
                  <a:pt x="941895" y="-744"/>
                  <a:pt x="1041116" y="93"/>
                  <a:pt x="1140350" y="3173"/>
                </a:cubicBezTo>
                <a:cubicBezTo>
                  <a:pt x="1210804" y="5316"/>
                  <a:pt x="1279746" y="24605"/>
                  <a:pt x="1350451" y="29025"/>
                </a:cubicBezTo>
                <a:cubicBezTo>
                  <a:pt x="1535093" y="40276"/>
                  <a:pt x="1719483" y="30901"/>
                  <a:pt x="1903495" y="18310"/>
                </a:cubicBezTo>
                <a:cubicBezTo>
                  <a:pt x="2151898" y="628"/>
                  <a:pt x="2401172" y="2101"/>
                  <a:pt x="2649374" y="22730"/>
                </a:cubicBezTo>
                <a:cubicBezTo>
                  <a:pt x="2869445" y="43947"/>
                  <a:pt x="3091027" y="39942"/>
                  <a:pt x="3310304" y="10808"/>
                </a:cubicBezTo>
                <a:cubicBezTo>
                  <a:pt x="3434575" y="-7007"/>
                  <a:pt x="3559980" y="9067"/>
                  <a:pt x="3684881" y="10808"/>
                </a:cubicBezTo>
                <a:cubicBezTo>
                  <a:pt x="3752435" y="11746"/>
                  <a:pt x="3819992" y="12684"/>
                  <a:pt x="3887420" y="15630"/>
                </a:cubicBezTo>
                <a:lnTo>
                  <a:pt x="3910962" y="11105"/>
                </a:lnTo>
                <a:lnTo>
                  <a:pt x="3910962" y="2529660"/>
                </a:lnTo>
                <a:lnTo>
                  <a:pt x="6242" y="2529660"/>
                </a:lnTo>
                <a:lnTo>
                  <a:pt x="25280" y="2158134"/>
                </a:lnTo>
                <a:cubicBezTo>
                  <a:pt x="28243" y="1914439"/>
                  <a:pt x="36288" y="1670236"/>
                  <a:pt x="11167" y="1427303"/>
                </a:cubicBezTo>
                <a:cubicBezTo>
                  <a:pt x="-5908" y="1262723"/>
                  <a:pt x="865" y="1098905"/>
                  <a:pt x="3970" y="934453"/>
                </a:cubicBezTo>
                <a:cubicBezTo>
                  <a:pt x="7498" y="749680"/>
                  <a:pt x="5805" y="564783"/>
                  <a:pt x="5805" y="380010"/>
                </a:cubicBezTo>
                <a:cubicBezTo>
                  <a:pt x="5522" y="299625"/>
                  <a:pt x="10321" y="219748"/>
                  <a:pt x="18506" y="139744"/>
                </a:cubicBezTo>
                <a:lnTo>
                  <a:pt x="19072" y="23791"/>
                </a:lnTo>
                <a:lnTo>
                  <a:pt x="67093" y="27133"/>
                </a:lnTo>
                <a:cubicBezTo>
                  <a:pt x="226530" y="32207"/>
                  <a:pt x="385807" y="21156"/>
                  <a:pt x="545085" y="11612"/>
                </a:cubicBezTo>
                <a:cubicBezTo>
                  <a:pt x="644275" y="5719"/>
                  <a:pt x="743474" y="2069"/>
                  <a:pt x="842684" y="662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Picture Placeholder 23">
            <a:extLst>
              <a:ext uri="{FF2B5EF4-FFF2-40B4-BE49-F238E27FC236}">
                <a16:creationId xmlns:a16="http://schemas.microsoft.com/office/drawing/2014/main" id="{3A9F270A-23C2-4A09-BC7C-5CB160B890C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5021992" y="3792430"/>
            <a:ext cx="3041329" cy="3065569"/>
          </a:xfrm>
          <a:custGeom>
            <a:avLst/>
            <a:gdLst>
              <a:gd name="connsiteX0" fmla="*/ 2750933 w 3041329"/>
              <a:gd name="connsiteY0" fmla="*/ 0 h 3065569"/>
              <a:gd name="connsiteX1" fmla="*/ 3041329 w 3041329"/>
              <a:gd name="connsiteY1" fmla="*/ 10946 h 3065569"/>
              <a:gd name="connsiteX2" fmla="*/ 3041329 w 3041329"/>
              <a:gd name="connsiteY2" fmla="*/ 175882 h 3065569"/>
              <a:gd name="connsiteX3" fmla="*/ 3034394 w 3041329"/>
              <a:gd name="connsiteY3" fmla="*/ 266109 h 3065569"/>
              <a:gd name="connsiteX4" fmla="*/ 3037217 w 3041329"/>
              <a:gd name="connsiteY4" fmla="*/ 802010 h 3065569"/>
              <a:gd name="connsiteX5" fmla="*/ 3025363 w 3041329"/>
              <a:gd name="connsiteY5" fmla="*/ 1170283 h 3065569"/>
              <a:gd name="connsiteX6" fmla="*/ 3020000 w 3041329"/>
              <a:gd name="connsiteY6" fmla="*/ 1316450 h 3065569"/>
              <a:gd name="connsiteX7" fmla="*/ 3014637 w 3041329"/>
              <a:gd name="connsiteY7" fmla="*/ 1344641 h 3065569"/>
              <a:gd name="connsiteX8" fmla="*/ 3014637 w 3041329"/>
              <a:gd name="connsiteY8" fmla="*/ 1357340 h 3065569"/>
              <a:gd name="connsiteX9" fmla="*/ 3021693 w 3041329"/>
              <a:gd name="connsiteY9" fmla="*/ 1384898 h 3065569"/>
              <a:gd name="connsiteX10" fmla="*/ 3029173 w 3041329"/>
              <a:gd name="connsiteY10" fmla="*/ 1911401 h 3065569"/>
              <a:gd name="connsiteX11" fmla="*/ 3039899 w 3041329"/>
              <a:gd name="connsiteY11" fmla="*/ 2395617 h 3065569"/>
              <a:gd name="connsiteX12" fmla="*/ 3041329 w 3041329"/>
              <a:gd name="connsiteY12" fmla="*/ 2446475 h 3065569"/>
              <a:gd name="connsiteX13" fmla="*/ 3041329 w 3041329"/>
              <a:gd name="connsiteY13" fmla="*/ 2649259 h 3065569"/>
              <a:gd name="connsiteX14" fmla="*/ 3040516 w 3041329"/>
              <a:gd name="connsiteY14" fmla="*/ 2683378 h 3065569"/>
              <a:gd name="connsiteX15" fmla="*/ 3029596 w 3041329"/>
              <a:gd name="connsiteY15" fmla="*/ 2971138 h 3065569"/>
              <a:gd name="connsiteX16" fmla="*/ 3031678 w 3041329"/>
              <a:gd name="connsiteY16" fmla="*/ 3022824 h 3065569"/>
              <a:gd name="connsiteX17" fmla="*/ 3034625 w 3041329"/>
              <a:gd name="connsiteY17" fmla="*/ 3065569 h 3065569"/>
              <a:gd name="connsiteX18" fmla="*/ 24938 w 3041329"/>
              <a:gd name="connsiteY18" fmla="*/ 3065569 h 3065569"/>
              <a:gd name="connsiteX19" fmla="*/ 25911 w 3041329"/>
              <a:gd name="connsiteY19" fmla="*/ 3001918 h 3065569"/>
              <a:gd name="connsiteX20" fmla="*/ 38276 w 3041329"/>
              <a:gd name="connsiteY20" fmla="*/ 2918677 h 3065569"/>
              <a:gd name="connsiteX21" fmla="*/ 28835 w 3041329"/>
              <a:gd name="connsiteY21" fmla="*/ 2491295 h 3065569"/>
              <a:gd name="connsiteX22" fmla="*/ 21053 w 3041329"/>
              <a:gd name="connsiteY22" fmla="*/ 2094786 h 3065569"/>
              <a:gd name="connsiteX23" fmla="*/ 16716 w 3041329"/>
              <a:gd name="connsiteY23" fmla="*/ 1719456 h 3065569"/>
              <a:gd name="connsiteX24" fmla="*/ 3192 w 3041329"/>
              <a:gd name="connsiteY24" fmla="*/ 1622752 h 3065569"/>
              <a:gd name="connsiteX25" fmla="*/ 24242 w 3041329"/>
              <a:gd name="connsiteY25" fmla="*/ 1269110 h 3065569"/>
              <a:gd name="connsiteX26" fmla="*/ 24242 w 3041329"/>
              <a:gd name="connsiteY26" fmla="*/ 1044447 h 3065569"/>
              <a:gd name="connsiteX27" fmla="*/ 13654 w 3041329"/>
              <a:gd name="connsiteY27" fmla="*/ 884594 h 3065569"/>
              <a:gd name="connsiteX28" fmla="*/ 23477 w 3041329"/>
              <a:gd name="connsiteY28" fmla="*/ 597929 h 3065569"/>
              <a:gd name="connsiteX29" fmla="*/ 26284 w 3041329"/>
              <a:gd name="connsiteY29" fmla="*/ 408605 h 3065569"/>
              <a:gd name="connsiteX30" fmla="*/ 33300 w 3041329"/>
              <a:gd name="connsiteY30" fmla="*/ 153452 h 3065569"/>
              <a:gd name="connsiteX31" fmla="*/ 16058 w 3041329"/>
              <a:gd name="connsiteY31" fmla="*/ 52511 h 3065569"/>
              <a:gd name="connsiteX32" fmla="*/ 13611 w 3041329"/>
              <a:gd name="connsiteY32" fmla="*/ 10473 h 3065569"/>
              <a:gd name="connsiteX33" fmla="*/ 222689 w 3041329"/>
              <a:gd name="connsiteY33" fmla="*/ 5194 h 3065569"/>
              <a:gd name="connsiteX34" fmla="*/ 988364 w 3041329"/>
              <a:gd name="connsiteY34" fmla="*/ 17002 h 3065569"/>
              <a:gd name="connsiteX35" fmla="*/ 1316477 w 3041329"/>
              <a:gd name="connsiteY35" fmla="*/ 7977 h 3065569"/>
              <a:gd name="connsiteX36" fmla="*/ 1738973 w 3041329"/>
              <a:gd name="connsiteY36" fmla="*/ 11247 h 3065569"/>
              <a:gd name="connsiteX37" fmla="*/ 2438148 w 3041329"/>
              <a:gd name="connsiteY37" fmla="*/ 11247 h 3065569"/>
              <a:gd name="connsiteX38" fmla="*/ 2750933 w 3041329"/>
              <a:gd name="connsiteY38" fmla="*/ 0 h 306556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3041329" h="3065569">
                <a:moveTo>
                  <a:pt x="2750933" y="0"/>
                </a:moveTo>
                <a:lnTo>
                  <a:pt x="3041329" y="10946"/>
                </a:lnTo>
                <a:lnTo>
                  <a:pt x="3041329" y="175882"/>
                </a:lnTo>
                <a:lnTo>
                  <a:pt x="3034394" y="266109"/>
                </a:lnTo>
                <a:cubicBezTo>
                  <a:pt x="3019012" y="444912"/>
                  <a:pt x="3025927" y="623588"/>
                  <a:pt x="3037217" y="802010"/>
                </a:cubicBezTo>
                <a:cubicBezTo>
                  <a:pt x="3044443" y="924849"/>
                  <a:pt x="3040477" y="1048016"/>
                  <a:pt x="3025363" y="1170283"/>
                </a:cubicBezTo>
                <a:cubicBezTo>
                  <a:pt x="3020000" y="1218920"/>
                  <a:pt x="3020987" y="1267685"/>
                  <a:pt x="3020000" y="1316450"/>
                </a:cubicBezTo>
                <a:cubicBezTo>
                  <a:pt x="3019717" y="1325847"/>
                  <a:pt x="3026069" y="1336767"/>
                  <a:pt x="3014637" y="1344641"/>
                </a:cubicBezTo>
                <a:lnTo>
                  <a:pt x="3014637" y="1357340"/>
                </a:lnTo>
                <a:cubicBezTo>
                  <a:pt x="3027198" y="1364325"/>
                  <a:pt x="3020706" y="1375754"/>
                  <a:pt x="3021693" y="1384898"/>
                </a:cubicBezTo>
                <a:cubicBezTo>
                  <a:pt x="3038360" y="1560005"/>
                  <a:pt x="3040872" y="1735963"/>
                  <a:pt x="3029173" y="1911401"/>
                </a:cubicBezTo>
                <a:cubicBezTo>
                  <a:pt x="3020564" y="2072933"/>
                  <a:pt x="3029455" y="2234211"/>
                  <a:pt x="3039899" y="2395617"/>
                </a:cubicBezTo>
                <a:lnTo>
                  <a:pt x="3041329" y="2446475"/>
                </a:lnTo>
                <a:lnTo>
                  <a:pt x="3041329" y="2649259"/>
                </a:lnTo>
                <a:lnTo>
                  <a:pt x="3040516" y="2683378"/>
                </a:lnTo>
                <a:cubicBezTo>
                  <a:pt x="3036759" y="2779288"/>
                  <a:pt x="3031078" y="2875197"/>
                  <a:pt x="3029596" y="2971138"/>
                </a:cubicBezTo>
                <a:cubicBezTo>
                  <a:pt x="3029314" y="2988346"/>
                  <a:pt x="3030372" y="3005585"/>
                  <a:pt x="3031678" y="3022824"/>
                </a:cubicBezTo>
                <a:lnTo>
                  <a:pt x="3034625" y="3065569"/>
                </a:lnTo>
                <a:lnTo>
                  <a:pt x="24938" y="3065569"/>
                </a:lnTo>
                <a:lnTo>
                  <a:pt x="25911" y="3001918"/>
                </a:lnTo>
                <a:cubicBezTo>
                  <a:pt x="28191" y="2973959"/>
                  <a:pt x="32318" y="2946151"/>
                  <a:pt x="38276" y="2918677"/>
                </a:cubicBezTo>
                <a:cubicBezTo>
                  <a:pt x="68779" y="2777462"/>
                  <a:pt x="65552" y="2631030"/>
                  <a:pt x="28835" y="2491295"/>
                </a:cubicBezTo>
                <a:cubicBezTo>
                  <a:pt x="-4463" y="2359636"/>
                  <a:pt x="-11352" y="2227594"/>
                  <a:pt x="21053" y="2094786"/>
                </a:cubicBezTo>
                <a:cubicBezTo>
                  <a:pt x="51646" y="1971356"/>
                  <a:pt x="50153" y="1842146"/>
                  <a:pt x="16716" y="1719456"/>
                </a:cubicBezTo>
                <a:cubicBezTo>
                  <a:pt x="9316" y="1687689"/>
                  <a:pt x="4787" y="1655323"/>
                  <a:pt x="3192" y="1622752"/>
                </a:cubicBezTo>
                <a:cubicBezTo>
                  <a:pt x="-6887" y="1503851"/>
                  <a:pt x="10081" y="1386608"/>
                  <a:pt x="24242" y="1269110"/>
                </a:cubicBezTo>
                <a:cubicBezTo>
                  <a:pt x="33683" y="1194222"/>
                  <a:pt x="48099" y="1118569"/>
                  <a:pt x="24242" y="1044447"/>
                </a:cubicBezTo>
                <a:cubicBezTo>
                  <a:pt x="7899" y="992791"/>
                  <a:pt x="4264" y="937959"/>
                  <a:pt x="13654" y="884594"/>
                </a:cubicBezTo>
                <a:cubicBezTo>
                  <a:pt x="29486" y="789881"/>
                  <a:pt x="32790" y="693497"/>
                  <a:pt x="23477" y="597929"/>
                </a:cubicBezTo>
                <a:cubicBezTo>
                  <a:pt x="17328" y="534919"/>
                  <a:pt x="18272" y="471411"/>
                  <a:pt x="26284" y="408605"/>
                </a:cubicBezTo>
                <a:cubicBezTo>
                  <a:pt x="36872" y="324149"/>
                  <a:pt x="53330" y="238162"/>
                  <a:pt x="33300" y="153452"/>
                </a:cubicBezTo>
                <a:cubicBezTo>
                  <a:pt x="25327" y="119804"/>
                  <a:pt x="19745" y="86163"/>
                  <a:pt x="16058" y="52511"/>
                </a:cubicBezTo>
                <a:lnTo>
                  <a:pt x="13611" y="10473"/>
                </a:lnTo>
                <a:lnTo>
                  <a:pt x="222689" y="5194"/>
                </a:lnTo>
                <a:cubicBezTo>
                  <a:pt x="477949" y="4054"/>
                  <a:pt x="733156" y="16119"/>
                  <a:pt x="988364" y="17002"/>
                </a:cubicBezTo>
                <a:cubicBezTo>
                  <a:pt x="1097946" y="17394"/>
                  <a:pt x="1207148" y="12424"/>
                  <a:pt x="1316477" y="7977"/>
                </a:cubicBezTo>
                <a:cubicBezTo>
                  <a:pt x="1457478" y="2353"/>
                  <a:pt x="1598225" y="13470"/>
                  <a:pt x="1738973" y="11247"/>
                </a:cubicBezTo>
                <a:cubicBezTo>
                  <a:pt x="1972073" y="7585"/>
                  <a:pt x="2205047" y="18310"/>
                  <a:pt x="2438148" y="11247"/>
                </a:cubicBezTo>
                <a:cubicBezTo>
                  <a:pt x="2542410" y="7977"/>
                  <a:pt x="2646671" y="3007"/>
                  <a:pt x="2750933" y="0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Picture Placeholder 22">
            <a:extLst>
              <a:ext uri="{FF2B5EF4-FFF2-40B4-BE49-F238E27FC236}">
                <a16:creationId xmlns:a16="http://schemas.microsoft.com/office/drawing/2014/main" id="{AE3DF8F2-18BB-45CB-8A9F-A6F8DED4CE61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5027598" y="0"/>
            <a:ext cx="3035794" cy="3597039"/>
          </a:xfrm>
          <a:custGeom>
            <a:avLst/>
            <a:gdLst>
              <a:gd name="connsiteX0" fmla="*/ 19840 w 3035794"/>
              <a:gd name="connsiteY0" fmla="*/ 0 h 3597039"/>
              <a:gd name="connsiteX1" fmla="*/ 3028263 w 3035794"/>
              <a:gd name="connsiteY1" fmla="*/ 0 h 3597039"/>
              <a:gd name="connsiteX2" fmla="*/ 3024697 w 3035794"/>
              <a:gd name="connsiteY2" fmla="*/ 140686 h 3597039"/>
              <a:gd name="connsiteX3" fmla="*/ 3035552 w 3035794"/>
              <a:gd name="connsiteY3" fmla="*/ 655695 h 3597039"/>
              <a:gd name="connsiteX4" fmla="*/ 3017206 w 3035794"/>
              <a:gd name="connsiteY4" fmla="*/ 941424 h 3597039"/>
              <a:gd name="connsiteX5" fmla="*/ 3027314 w 3035794"/>
              <a:gd name="connsiteY5" fmla="*/ 1375590 h 3597039"/>
              <a:gd name="connsiteX6" fmla="*/ 3035723 w 3035794"/>
              <a:gd name="connsiteY6" fmla="*/ 1661758 h 3597039"/>
              <a:gd name="connsiteX7" fmla="*/ 3035723 w 3035794"/>
              <a:gd name="connsiteY7" fmla="*/ 2108768 h 3597039"/>
              <a:gd name="connsiteX8" fmla="*/ 3024686 w 3035794"/>
              <a:gd name="connsiteY8" fmla="*/ 2232285 h 3597039"/>
              <a:gd name="connsiteX9" fmla="*/ 3025391 w 3035794"/>
              <a:gd name="connsiteY9" fmla="*/ 2548746 h 3597039"/>
              <a:gd name="connsiteX10" fmla="*/ 3024544 w 3035794"/>
              <a:gd name="connsiteY10" fmla="*/ 2932131 h 3597039"/>
              <a:gd name="connsiteX11" fmla="*/ 3029484 w 3035794"/>
              <a:gd name="connsiteY11" fmla="*/ 3206050 h 3597039"/>
              <a:gd name="connsiteX12" fmla="*/ 3029484 w 3035794"/>
              <a:gd name="connsiteY12" fmla="*/ 3492287 h 3597039"/>
              <a:gd name="connsiteX13" fmla="*/ 3026528 w 3035794"/>
              <a:gd name="connsiteY13" fmla="*/ 3584038 h 3597039"/>
              <a:gd name="connsiteX14" fmla="*/ 2536033 w 3035794"/>
              <a:gd name="connsiteY14" fmla="*/ 3578457 h 3597039"/>
              <a:gd name="connsiteX15" fmla="*/ 2062105 w 3035794"/>
              <a:gd name="connsiteY15" fmla="*/ 3578457 h 3597039"/>
              <a:gd name="connsiteX16" fmla="*/ 1545736 w 3035794"/>
              <a:gd name="connsiteY16" fmla="*/ 3591536 h 3597039"/>
              <a:gd name="connsiteX17" fmla="*/ 1047737 w 3035794"/>
              <a:gd name="connsiteY17" fmla="*/ 3582381 h 3597039"/>
              <a:gd name="connsiteX18" fmla="*/ 522627 w 3035794"/>
              <a:gd name="connsiteY18" fmla="*/ 3586174 h 3597039"/>
              <a:gd name="connsiteX19" fmla="*/ 179310 w 3035794"/>
              <a:gd name="connsiteY19" fmla="*/ 3582119 h 3597039"/>
              <a:gd name="connsiteX20" fmla="*/ 12768 w 3035794"/>
              <a:gd name="connsiteY20" fmla="*/ 3583434 h 3597039"/>
              <a:gd name="connsiteX21" fmla="*/ 14927 w 3035794"/>
              <a:gd name="connsiteY21" fmla="*/ 3541208 h 3597039"/>
              <a:gd name="connsiteX22" fmla="*/ 15947 w 3035794"/>
              <a:gd name="connsiteY22" fmla="*/ 3236172 h 3597039"/>
              <a:gd name="connsiteX23" fmla="*/ 15947 w 3035794"/>
              <a:gd name="connsiteY23" fmla="*/ 3093031 h 3597039"/>
              <a:gd name="connsiteX24" fmla="*/ 22581 w 3035794"/>
              <a:gd name="connsiteY24" fmla="*/ 2901666 h 3597039"/>
              <a:gd name="connsiteX25" fmla="*/ 9823 w 3035794"/>
              <a:gd name="connsiteY25" fmla="*/ 2816955 h 3597039"/>
              <a:gd name="connsiteX26" fmla="*/ 16074 w 3035794"/>
              <a:gd name="connsiteY26" fmla="*/ 2600075 h 3597039"/>
              <a:gd name="connsiteX27" fmla="*/ 22836 w 3035794"/>
              <a:gd name="connsiteY27" fmla="*/ 2349514 h 3597039"/>
              <a:gd name="connsiteX28" fmla="*/ 23857 w 3035794"/>
              <a:gd name="connsiteY28" fmla="*/ 2147560 h 3597039"/>
              <a:gd name="connsiteX29" fmla="*/ 26663 w 3035794"/>
              <a:gd name="connsiteY29" fmla="*/ 1765978 h 3597039"/>
              <a:gd name="connsiteX30" fmla="*/ 24367 w 3035794"/>
              <a:gd name="connsiteY30" fmla="*/ 1543612 h 3597039"/>
              <a:gd name="connsiteX31" fmla="*/ 24367 w 3035794"/>
              <a:gd name="connsiteY31" fmla="*/ 1033305 h 3597039"/>
              <a:gd name="connsiteX32" fmla="*/ 25133 w 3035794"/>
              <a:gd name="connsiteY32" fmla="*/ 759271 h 3597039"/>
              <a:gd name="connsiteX33" fmla="*/ 14289 w 3035794"/>
              <a:gd name="connsiteY33" fmla="*/ 353321 h 3597039"/>
              <a:gd name="connsiteX34" fmla="*/ 22581 w 3035794"/>
              <a:gd name="connsiteY34" fmla="*/ 20346 h 3597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</a:cxnLst>
            <a:rect l="l" t="t" r="r" b="b"/>
            <a:pathLst>
              <a:path w="3035794" h="3597039">
                <a:moveTo>
                  <a:pt x="19840" y="0"/>
                </a:moveTo>
                <a:lnTo>
                  <a:pt x="3028263" y="0"/>
                </a:lnTo>
                <a:lnTo>
                  <a:pt x="3024697" y="140686"/>
                </a:lnTo>
                <a:cubicBezTo>
                  <a:pt x="3025259" y="312749"/>
                  <a:pt x="3037669" y="484544"/>
                  <a:pt x="3035552" y="655695"/>
                </a:cubicBezTo>
                <a:cubicBezTo>
                  <a:pt x="3034423" y="750938"/>
                  <a:pt x="3013255" y="845927"/>
                  <a:pt x="3017206" y="941424"/>
                </a:cubicBezTo>
                <a:cubicBezTo>
                  <a:pt x="3022992" y="1086130"/>
                  <a:pt x="3024933" y="1230868"/>
                  <a:pt x="3027314" y="1375590"/>
                </a:cubicBezTo>
                <a:lnTo>
                  <a:pt x="3035723" y="1661758"/>
                </a:lnTo>
                <a:lnTo>
                  <a:pt x="3035723" y="2108768"/>
                </a:lnTo>
                <a:lnTo>
                  <a:pt x="3024686" y="2232285"/>
                </a:lnTo>
                <a:cubicBezTo>
                  <a:pt x="3008033" y="2337306"/>
                  <a:pt x="3018335" y="2443217"/>
                  <a:pt x="3025391" y="2548746"/>
                </a:cubicBezTo>
                <a:cubicBezTo>
                  <a:pt x="3034000" y="2676499"/>
                  <a:pt x="3038657" y="2804125"/>
                  <a:pt x="3024544" y="2932131"/>
                </a:cubicBezTo>
                <a:cubicBezTo>
                  <a:pt x="3014384" y="3023183"/>
                  <a:pt x="3023839" y="3114743"/>
                  <a:pt x="3029484" y="3206050"/>
                </a:cubicBezTo>
                <a:cubicBezTo>
                  <a:pt x="3036822" y="3301343"/>
                  <a:pt x="3036822" y="3396994"/>
                  <a:pt x="3029484" y="3492287"/>
                </a:cubicBezTo>
                <a:lnTo>
                  <a:pt x="3026528" y="3584038"/>
                </a:lnTo>
                <a:lnTo>
                  <a:pt x="2536033" y="3578457"/>
                </a:lnTo>
                <a:cubicBezTo>
                  <a:pt x="2378057" y="3583558"/>
                  <a:pt x="2220080" y="3585390"/>
                  <a:pt x="2062105" y="3578457"/>
                </a:cubicBezTo>
                <a:cubicBezTo>
                  <a:pt x="1889685" y="3570479"/>
                  <a:pt x="1717648" y="3579504"/>
                  <a:pt x="1545736" y="3591536"/>
                </a:cubicBezTo>
                <a:cubicBezTo>
                  <a:pt x="1379525" y="3603177"/>
                  <a:pt x="1213695" y="3594544"/>
                  <a:pt x="1047737" y="3582381"/>
                </a:cubicBezTo>
                <a:cubicBezTo>
                  <a:pt x="872873" y="3569328"/>
                  <a:pt x="697288" y="3570585"/>
                  <a:pt x="522627" y="3586174"/>
                </a:cubicBezTo>
                <a:cubicBezTo>
                  <a:pt x="408103" y="3596376"/>
                  <a:pt x="293327" y="3581074"/>
                  <a:pt x="179310" y="3582119"/>
                </a:cubicBezTo>
                <a:lnTo>
                  <a:pt x="12768" y="3583434"/>
                </a:lnTo>
                <a:lnTo>
                  <a:pt x="14927" y="3541208"/>
                </a:lnTo>
                <a:cubicBezTo>
                  <a:pt x="24495" y="3440295"/>
                  <a:pt x="35084" y="3338234"/>
                  <a:pt x="15947" y="3236172"/>
                </a:cubicBezTo>
                <a:cubicBezTo>
                  <a:pt x="7719" y="3188816"/>
                  <a:pt x="7719" y="3140388"/>
                  <a:pt x="15947" y="3093031"/>
                </a:cubicBezTo>
                <a:cubicBezTo>
                  <a:pt x="25898" y="3029243"/>
                  <a:pt x="35339" y="2966092"/>
                  <a:pt x="22581" y="2901666"/>
                </a:cubicBezTo>
                <a:cubicBezTo>
                  <a:pt x="16968" y="2873599"/>
                  <a:pt x="12758" y="2845277"/>
                  <a:pt x="9823" y="2816955"/>
                </a:cubicBezTo>
                <a:cubicBezTo>
                  <a:pt x="3980" y="2744645"/>
                  <a:pt x="6072" y="2671926"/>
                  <a:pt x="16074" y="2600075"/>
                </a:cubicBezTo>
                <a:cubicBezTo>
                  <a:pt x="25643" y="2516640"/>
                  <a:pt x="10079" y="2432694"/>
                  <a:pt x="22836" y="2349514"/>
                </a:cubicBezTo>
                <a:cubicBezTo>
                  <a:pt x="31895" y="2282524"/>
                  <a:pt x="32239" y="2214640"/>
                  <a:pt x="23857" y="2147560"/>
                </a:cubicBezTo>
                <a:cubicBezTo>
                  <a:pt x="8778" y="2020749"/>
                  <a:pt x="9721" y="1892547"/>
                  <a:pt x="26663" y="1765978"/>
                </a:cubicBezTo>
                <a:cubicBezTo>
                  <a:pt x="37125" y="1692111"/>
                  <a:pt x="43121" y="1616076"/>
                  <a:pt x="24367" y="1543612"/>
                </a:cubicBezTo>
                <a:cubicBezTo>
                  <a:pt x="-19775" y="1373297"/>
                  <a:pt x="5996" y="1202727"/>
                  <a:pt x="24367" y="1033305"/>
                </a:cubicBezTo>
                <a:cubicBezTo>
                  <a:pt x="35530" y="942318"/>
                  <a:pt x="35786" y="850322"/>
                  <a:pt x="25133" y="759271"/>
                </a:cubicBezTo>
                <a:cubicBezTo>
                  <a:pt x="6226" y="624792"/>
                  <a:pt x="2577" y="488614"/>
                  <a:pt x="14289" y="353321"/>
                </a:cubicBezTo>
                <a:cubicBezTo>
                  <a:pt x="24877" y="242712"/>
                  <a:pt x="35339" y="131848"/>
                  <a:pt x="22581" y="20346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30936" y="429768"/>
            <a:ext cx="3922776" cy="1645920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0936" y="2706624"/>
            <a:ext cx="3931920" cy="3383280"/>
          </a:xfrm>
        </p:spPr>
        <p:txBody>
          <a:bodyPr>
            <a:normAutofit/>
          </a:bodyPr>
          <a:lstStyle>
            <a:lvl1pPr marL="0" indent="0">
              <a:buNone/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3D56BB16-3103-4F61-889C-DDC4E4A678C2}"/>
              </a:ext>
            </a:extLst>
          </p:cNvPr>
          <p:cNvSpPr/>
          <p:nvPr userDrawn="1"/>
        </p:nvSpPr>
        <p:spPr>
          <a:xfrm>
            <a:off x="629328" y="2423160"/>
            <a:ext cx="3877056" cy="27432"/>
          </a:xfrm>
          <a:custGeom>
            <a:avLst/>
            <a:gdLst>
              <a:gd name="connsiteX0" fmla="*/ 0 w 3877056"/>
              <a:gd name="connsiteY0" fmla="*/ 0 h 27432"/>
              <a:gd name="connsiteX1" fmla="*/ 723717 w 3877056"/>
              <a:gd name="connsiteY1" fmla="*/ 0 h 27432"/>
              <a:gd name="connsiteX2" fmla="*/ 1408664 w 3877056"/>
              <a:gd name="connsiteY2" fmla="*/ 0 h 27432"/>
              <a:gd name="connsiteX3" fmla="*/ 2093610 w 3877056"/>
              <a:gd name="connsiteY3" fmla="*/ 0 h 27432"/>
              <a:gd name="connsiteX4" fmla="*/ 2623475 w 3877056"/>
              <a:gd name="connsiteY4" fmla="*/ 0 h 27432"/>
              <a:gd name="connsiteX5" fmla="*/ 3192109 w 3877056"/>
              <a:gd name="connsiteY5" fmla="*/ 0 h 27432"/>
              <a:gd name="connsiteX6" fmla="*/ 3877056 w 3877056"/>
              <a:gd name="connsiteY6" fmla="*/ 0 h 27432"/>
              <a:gd name="connsiteX7" fmla="*/ 3877056 w 3877056"/>
              <a:gd name="connsiteY7" fmla="*/ 27432 h 27432"/>
              <a:gd name="connsiteX8" fmla="*/ 3230880 w 3877056"/>
              <a:gd name="connsiteY8" fmla="*/ 27432 h 27432"/>
              <a:gd name="connsiteX9" fmla="*/ 2701016 w 3877056"/>
              <a:gd name="connsiteY9" fmla="*/ 27432 h 27432"/>
              <a:gd name="connsiteX10" fmla="*/ 2171151 w 3877056"/>
              <a:gd name="connsiteY10" fmla="*/ 27432 h 27432"/>
              <a:gd name="connsiteX11" fmla="*/ 1486205 w 3877056"/>
              <a:gd name="connsiteY11" fmla="*/ 27432 h 27432"/>
              <a:gd name="connsiteX12" fmla="*/ 917570 w 3877056"/>
              <a:gd name="connsiteY12" fmla="*/ 27432 h 27432"/>
              <a:gd name="connsiteX13" fmla="*/ 0 w 3877056"/>
              <a:gd name="connsiteY13" fmla="*/ 27432 h 27432"/>
              <a:gd name="connsiteX14" fmla="*/ 0 w 3877056"/>
              <a:gd name="connsiteY14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3877056" h="27432" fill="none" extrusionOk="0">
                <a:moveTo>
                  <a:pt x="0" y="0"/>
                </a:moveTo>
                <a:cubicBezTo>
                  <a:pt x="212376" y="-32836"/>
                  <a:pt x="570944" y="24926"/>
                  <a:pt x="723717" y="0"/>
                </a:cubicBezTo>
                <a:cubicBezTo>
                  <a:pt x="876490" y="-24926"/>
                  <a:pt x="1149502" y="-13047"/>
                  <a:pt x="1408664" y="0"/>
                </a:cubicBezTo>
                <a:cubicBezTo>
                  <a:pt x="1667826" y="13047"/>
                  <a:pt x="1931449" y="-10086"/>
                  <a:pt x="2093610" y="0"/>
                </a:cubicBezTo>
                <a:cubicBezTo>
                  <a:pt x="2255771" y="10086"/>
                  <a:pt x="2364217" y="17704"/>
                  <a:pt x="2623475" y="0"/>
                </a:cubicBezTo>
                <a:cubicBezTo>
                  <a:pt x="2882734" y="-17704"/>
                  <a:pt x="3039913" y="-18191"/>
                  <a:pt x="3192109" y="0"/>
                </a:cubicBezTo>
                <a:cubicBezTo>
                  <a:pt x="3344305" y="18191"/>
                  <a:pt x="3704655" y="9863"/>
                  <a:pt x="3877056" y="0"/>
                </a:cubicBezTo>
                <a:cubicBezTo>
                  <a:pt x="3876099" y="8431"/>
                  <a:pt x="3876707" y="14612"/>
                  <a:pt x="3877056" y="27432"/>
                </a:cubicBezTo>
                <a:cubicBezTo>
                  <a:pt x="3653020" y="26009"/>
                  <a:pt x="3480940" y="44647"/>
                  <a:pt x="3230880" y="27432"/>
                </a:cubicBezTo>
                <a:cubicBezTo>
                  <a:pt x="2980820" y="10217"/>
                  <a:pt x="2872670" y="48866"/>
                  <a:pt x="2701016" y="27432"/>
                </a:cubicBezTo>
                <a:cubicBezTo>
                  <a:pt x="2529362" y="5998"/>
                  <a:pt x="2364157" y="35954"/>
                  <a:pt x="2171151" y="27432"/>
                </a:cubicBezTo>
                <a:cubicBezTo>
                  <a:pt x="1978146" y="18910"/>
                  <a:pt x="1773461" y="38798"/>
                  <a:pt x="1486205" y="27432"/>
                </a:cubicBezTo>
                <a:cubicBezTo>
                  <a:pt x="1198949" y="16066"/>
                  <a:pt x="1139376" y="-574"/>
                  <a:pt x="917570" y="27432"/>
                </a:cubicBezTo>
                <a:cubicBezTo>
                  <a:pt x="695765" y="55438"/>
                  <a:pt x="293344" y="-5450"/>
                  <a:pt x="0" y="27432"/>
                </a:cubicBezTo>
                <a:cubicBezTo>
                  <a:pt x="226" y="18208"/>
                  <a:pt x="-648" y="12891"/>
                  <a:pt x="0" y="0"/>
                </a:cubicBezTo>
                <a:close/>
              </a:path>
              <a:path w="3877056" h="27432" stroke="0" extrusionOk="0">
                <a:moveTo>
                  <a:pt x="0" y="0"/>
                </a:moveTo>
                <a:cubicBezTo>
                  <a:pt x="192669" y="-10137"/>
                  <a:pt x="331692" y="-29256"/>
                  <a:pt x="607405" y="0"/>
                </a:cubicBezTo>
                <a:cubicBezTo>
                  <a:pt x="883118" y="29256"/>
                  <a:pt x="907253" y="-6037"/>
                  <a:pt x="1137270" y="0"/>
                </a:cubicBezTo>
                <a:cubicBezTo>
                  <a:pt x="1367288" y="6037"/>
                  <a:pt x="1546023" y="-32212"/>
                  <a:pt x="1860987" y="0"/>
                </a:cubicBezTo>
                <a:cubicBezTo>
                  <a:pt x="2175951" y="32212"/>
                  <a:pt x="2298836" y="29855"/>
                  <a:pt x="2468392" y="0"/>
                </a:cubicBezTo>
                <a:cubicBezTo>
                  <a:pt x="2637949" y="-29855"/>
                  <a:pt x="2790821" y="13504"/>
                  <a:pt x="3075798" y="0"/>
                </a:cubicBezTo>
                <a:cubicBezTo>
                  <a:pt x="3360775" y="-13504"/>
                  <a:pt x="3584812" y="38899"/>
                  <a:pt x="3877056" y="0"/>
                </a:cubicBezTo>
                <a:cubicBezTo>
                  <a:pt x="3875701" y="9524"/>
                  <a:pt x="3875854" y="13975"/>
                  <a:pt x="3877056" y="27432"/>
                </a:cubicBezTo>
                <a:cubicBezTo>
                  <a:pt x="3651600" y="-703"/>
                  <a:pt x="3532844" y="44229"/>
                  <a:pt x="3230880" y="27432"/>
                </a:cubicBezTo>
                <a:cubicBezTo>
                  <a:pt x="2928916" y="10635"/>
                  <a:pt x="2860399" y="20237"/>
                  <a:pt x="2701016" y="27432"/>
                </a:cubicBezTo>
                <a:cubicBezTo>
                  <a:pt x="2541633" y="34627"/>
                  <a:pt x="2238516" y="40277"/>
                  <a:pt x="2054840" y="27432"/>
                </a:cubicBezTo>
                <a:cubicBezTo>
                  <a:pt x="1871164" y="14587"/>
                  <a:pt x="1583795" y="3252"/>
                  <a:pt x="1408664" y="27432"/>
                </a:cubicBezTo>
                <a:cubicBezTo>
                  <a:pt x="1233533" y="51612"/>
                  <a:pt x="956608" y="20984"/>
                  <a:pt x="801258" y="27432"/>
                </a:cubicBezTo>
                <a:cubicBezTo>
                  <a:pt x="645908" y="33880"/>
                  <a:pt x="165566" y="12646"/>
                  <a:pt x="0" y="27432"/>
                </a:cubicBezTo>
                <a:cubicBezTo>
                  <a:pt x="-800" y="16780"/>
                  <a:pt x="-583" y="12910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093660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: Shape 8" descr="Tag=AccentColor&#10;Flavor=Light&#10;Target=Fill">
            <a:extLst>
              <a:ext uri="{FF2B5EF4-FFF2-40B4-BE49-F238E27FC236}">
                <a16:creationId xmlns:a16="http://schemas.microsoft.com/office/drawing/2014/main" id="{6E9FA88B-AFEE-4852-B85E-7E7C8AF78BFF}"/>
              </a:ext>
            </a:extLst>
          </p:cNvPr>
          <p:cNvSpPr/>
          <p:nvPr userDrawn="1"/>
        </p:nvSpPr>
        <p:spPr>
          <a:xfrm>
            <a:off x="0" y="0"/>
            <a:ext cx="12192000" cy="2347414"/>
          </a:xfrm>
          <a:custGeom>
            <a:avLst/>
            <a:gdLst>
              <a:gd name="connsiteX0" fmla="*/ 0 w 12192000"/>
              <a:gd name="connsiteY0" fmla="*/ 0 h 2347414"/>
              <a:gd name="connsiteX1" fmla="*/ 12192000 w 12192000"/>
              <a:gd name="connsiteY1" fmla="*/ 0 h 2347414"/>
              <a:gd name="connsiteX2" fmla="*/ 12192000 w 12192000"/>
              <a:gd name="connsiteY2" fmla="*/ 1736458 h 2347414"/>
              <a:gd name="connsiteX3" fmla="*/ 11967601 w 12192000"/>
              <a:gd name="connsiteY3" fmla="*/ 1784034 h 2347414"/>
              <a:gd name="connsiteX4" fmla="*/ 10829000 w 12192000"/>
              <a:gd name="connsiteY4" fmla="*/ 1983294 h 2347414"/>
              <a:gd name="connsiteX5" fmla="*/ 10743779 w 12192000"/>
              <a:gd name="connsiteY5" fmla="*/ 1996027 h 2347414"/>
              <a:gd name="connsiteX6" fmla="*/ 10829254 w 12192000"/>
              <a:gd name="connsiteY6" fmla="*/ 1987751 h 2347414"/>
              <a:gd name="connsiteX7" fmla="*/ 10847162 w 12192000"/>
              <a:gd name="connsiteY7" fmla="*/ 1988388 h 2347414"/>
              <a:gd name="connsiteX8" fmla="*/ 11575155 w 12192000"/>
              <a:gd name="connsiteY8" fmla="*/ 1921415 h 2347414"/>
              <a:gd name="connsiteX9" fmla="*/ 12192000 w 12192000"/>
              <a:gd name="connsiteY9" fmla="*/ 1851213 h 2347414"/>
              <a:gd name="connsiteX10" fmla="*/ 12192000 w 12192000"/>
              <a:gd name="connsiteY10" fmla="*/ 1907356 h 2347414"/>
              <a:gd name="connsiteX11" fmla="*/ 12035532 w 12192000"/>
              <a:gd name="connsiteY11" fmla="*/ 1927033 h 2347414"/>
              <a:gd name="connsiteX12" fmla="*/ 11576932 w 12192000"/>
              <a:gd name="connsiteY12" fmla="*/ 1976291 h 2347414"/>
              <a:gd name="connsiteX13" fmla="*/ 10627316 w 12192000"/>
              <a:gd name="connsiteY13" fmla="*/ 2061470 h 2347414"/>
              <a:gd name="connsiteX14" fmla="*/ 9804196 w 12192000"/>
              <a:gd name="connsiteY14" fmla="*/ 2123478 h 2347414"/>
              <a:gd name="connsiteX15" fmla="*/ 9243851 w 12192000"/>
              <a:gd name="connsiteY15" fmla="*/ 2180008 h 2347414"/>
              <a:gd name="connsiteX16" fmla="*/ 8731259 w 12192000"/>
              <a:gd name="connsiteY16" fmla="*/ 2225081 h 2347414"/>
              <a:gd name="connsiteX17" fmla="*/ 8065752 w 12192000"/>
              <a:gd name="connsiteY17" fmla="*/ 2271681 h 2347414"/>
              <a:gd name="connsiteX18" fmla="*/ 7658065 w 12192000"/>
              <a:gd name="connsiteY18" fmla="*/ 2292562 h 2347414"/>
              <a:gd name="connsiteX19" fmla="*/ 6531024 w 12192000"/>
              <a:gd name="connsiteY19" fmla="*/ 2324138 h 2347414"/>
              <a:gd name="connsiteX20" fmla="*/ 6178331 w 12192000"/>
              <a:gd name="connsiteY20" fmla="*/ 2345655 h 2347414"/>
              <a:gd name="connsiteX21" fmla="*/ 5977282 w 12192000"/>
              <a:gd name="connsiteY21" fmla="*/ 2344127 h 2347414"/>
              <a:gd name="connsiteX22" fmla="*/ 5367658 w 12192000"/>
              <a:gd name="connsiteY22" fmla="*/ 2329230 h 2347414"/>
              <a:gd name="connsiteX23" fmla="*/ 4387306 w 12192000"/>
              <a:gd name="connsiteY23" fmla="*/ 2288614 h 2347414"/>
              <a:gd name="connsiteX24" fmla="*/ 4180287 w 12192000"/>
              <a:gd name="connsiteY24" fmla="*/ 2280211 h 2347414"/>
              <a:gd name="connsiteX25" fmla="*/ 3842199 w 12192000"/>
              <a:gd name="connsiteY25" fmla="*/ 2257039 h 2347414"/>
              <a:gd name="connsiteX26" fmla="*/ 3730309 w 12192000"/>
              <a:gd name="connsiteY26" fmla="*/ 2251182 h 2347414"/>
              <a:gd name="connsiteX27" fmla="*/ 3425496 w 12192000"/>
              <a:gd name="connsiteY27" fmla="*/ 2231320 h 2347414"/>
              <a:gd name="connsiteX28" fmla="*/ 3076106 w 12192000"/>
              <a:gd name="connsiteY28" fmla="*/ 2201781 h 2347414"/>
              <a:gd name="connsiteX29" fmla="*/ 2819682 w 12192000"/>
              <a:gd name="connsiteY29" fmla="*/ 2182427 h 2347414"/>
              <a:gd name="connsiteX30" fmla="*/ 2525539 w 12192000"/>
              <a:gd name="connsiteY30" fmla="*/ 2152888 h 2347414"/>
              <a:gd name="connsiteX31" fmla="*/ 2311915 w 12192000"/>
              <a:gd name="connsiteY31" fmla="*/ 2133536 h 2347414"/>
              <a:gd name="connsiteX32" fmla="*/ 2054223 w 12192000"/>
              <a:gd name="connsiteY32" fmla="*/ 2104760 h 2347414"/>
              <a:gd name="connsiteX33" fmla="*/ 1865367 w 12192000"/>
              <a:gd name="connsiteY33" fmla="*/ 2084770 h 2347414"/>
              <a:gd name="connsiteX34" fmla="*/ 1629263 w 12192000"/>
              <a:gd name="connsiteY34" fmla="*/ 2055996 h 2347414"/>
              <a:gd name="connsiteX35" fmla="*/ 1458823 w 12192000"/>
              <a:gd name="connsiteY35" fmla="*/ 2035751 h 2347414"/>
              <a:gd name="connsiteX36" fmla="*/ 1241390 w 12192000"/>
              <a:gd name="connsiteY36" fmla="*/ 2007103 h 2347414"/>
              <a:gd name="connsiteX37" fmla="*/ 1047453 w 12192000"/>
              <a:gd name="connsiteY37" fmla="*/ 1980748 h 2347414"/>
              <a:gd name="connsiteX38" fmla="*/ 814907 w 12192000"/>
              <a:gd name="connsiteY38" fmla="*/ 1949045 h 2347414"/>
              <a:gd name="connsiteX39" fmla="*/ 592649 w 12192000"/>
              <a:gd name="connsiteY39" fmla="*/ 1913776 h 2347414"/>
              <a:gd name="connsiteX40" fmla="*/ 343591 w 12192000"/>
              <a:gd name="connsiteY40" fmla="*/ 1872650 h 2347414"/>
              <a:gd name="connsiteX41" fmla="*/ 35731 w 12192000"/>
              <a:gd name="connsiteY41" fmla="*/ 1821722 h 2347414"/>
              <a:gd name="connsiteX42" fmla="*/ 0 w 12192000"/>
              <a:gd name="connsiteY42" fmla="*/ 1814848 h 2347414"/>
              <a:gd name="connsiteX43" fmla="*/ 0 w 12192000"/>
              <a:gd name="connsiteY43" fmla="*/ 1758489 h 2347414"/>
              <a:gd name="connsiteX44" fmla="*/ 274248 w 12192000"/>
              <a:gd name="connsiteY44" fmla="*/ 1808735 h 2347414"/>
              <a:gd name="connsiteX45" fmla="*/ 498157 w 12192000"/>
              <a:gd name="connsiteY45" fmla="*/ 1846167 h 2347414"/>
              <a:gd name="connsiteX46" fmla="*/ 722828 w 12192000"/>
              <a:gd name="connsiteY46" fmla="*/ 1878635 h 2347414"/>
              <a:gd name="connsiteX47" fmla="*/ 949913 w 12192000"/>
              <a:gd name="connsiteY47" fmla="*/ 1912375 h 2347414"/>
              <a:gd name="connsiteX48" fmla="*/ 1195414 w 12192000"/>
              <a:gd name="connsiteY48" fmla="*/ 1947516 h 2347414"/>
              <a:gd name="connsiteX49" fmla="*/ 1342867 w 12192000"/>
              <a:gd name="connsiteY49" fmla="*/ 1968397 h 2347414"/>
              <a:gd name="connsiteX50" fmla="*/ 1518007 w 12192000"/>
              <a:gd name="connsiteY50" fmla="*/ 1988006 h 2347414"/>
              <a:gd name="connsiteX51" fmla="*/ 1701403 w 12192000"/>
              <a:gd name="connsiteY51" fmla="*/ 2010669 h 2347414"/>
              <a:gd name="connsiteX52" fmla="*/ 1879210 w 12192000"/>
              <a:gd name="connsiteY52" fmla="*/ 2031167 h 2347414"/>
              <a:gd name="connsiteX53" fmla="*/ 2068702 w 12192000"/>
              <a:gd name="connsiteY53" fmla="*/ 2052940 h 2347414"/>
              <a:gd name="connsiteX54" fmla="*/ 2212090 w 12192000"/>
              <a:gd name="connsiteY54" fmla="*/ 2067583 h 2347414"/>
              <a:gd name="connsiteX55" fmla="*/ 2416949 w 12192000"/>
              <a:gd name="connsiteY55" fmla="*/ 2089609 h 2347414"/>
              <a:gd name="connsiteX56" fmla="*/ 2582055 w 12192000"/>
              <a:gd name="connsiteY56" fmla="*/ 2105397 h 2347414"/>
              <a:gd name="connsiteX57" fmla="*/ 2802282 w 12192000"/>
              <a:gd name="connsiteY57" fmla="*/ 2126405 h 2347414"/>
              <a:gd name="connsiteX58" fmla="*/ 2984916 w 12192000"/>
              <a:gd name="connsiteY58" fmla="*/ 2141684 h 2347414"/>
              <a:gd name="connsiteX59" fmla="*/ 3241847 w 12192000"/>
              <a:gd name="connsiteY59" fmla="*/ 2164094 h 2347414"/>
              <a:gd name="connsiteX60" fmla="*/ 3439848 w 12192000"/>
              <a:gd name="connsiteY60" fmla="*/ 2176826 h 2347414"/>
              <a:gd name="connsiteX61" fmla="*/ 3658678 w 12192000"/>
              <a:gd name="connsiteY61" fmla="*/ 2194523 h 2347414"/>
              <a:gd name="connsiteX62" fmla="*/ 3881317 w 12192000"/>
              <a:gd name="connsiteY62" fmla="*/ 2206491 h 2347414"/>
              <a:gd name="connsiteX63" fmla="*/ 4148916 w 12192000"/>
              <a:gd name="connsiteY63" fmla="*/ 2225081 h 2347414"/>
              <a:gd name="connsiteX64" fmla="*/ 4468337 w 12192000"/>
              <a:gd name="connsiteY64" fmla="*/ 2237813 h 2347414"/>
              <a:gd name="connsiteX65" fmla="*/ 4605375 w 12192000"/>
              <a:gd name="connsiteY65" fmla="*/ 2240232 h 2347414"/>
              <a:gd name="connsiteX66" fmla="*/ 4527647 w 12192000"/>
              <a:gd name="connsiteY66" fmla="*/ 2236412 h 2347414"/>
              <a:gd name="connsiteX67" fmla="*/ 4175589 w 12192000"/>
              <a:gd name="connsiteY67" fmla="*/ 2212985 h 2347414"/>
              <a:gd name="connsiteX68" fmla="*/ 3988255 w 12192000"/>
              <a:gd name="connsiteY68" fmla="*/ 2200253 h 2347414"/>
              <a:gd name="connsiteX69" fmla="*/ 3686492 w 12192000"/>
              <a:gd name="connsiteY69" fmla="*/ 2176062 h 2347414"/>
              <a:gd name="connsiteX70" fmla="*/ 3517320 w 12192000"/>
              <a:gd name="connsiteY70" fmla="*/ 2163330 h 2347414"/>
              <a:gd name="connsiteX71" fmla="*/ 3258357 w 12192000"/>
              <a:gd name="connsiteY71" fmla="*/ 2139519 h 2347414"/>
              <a:gd name="connsiteX72" fmla="*/ 3101506 w 12192000"/>
              <a:gd name="connsiteY72" fmla="*/ 2126787 h 2347414"/>
              <a:gd name="connsiteX73" fmla="*/ 2809395 w 12192000"/>
              <a:gd name="connsiteY73" fmla="*/ 2097502 h 2347414"/>
              <a:gd name="connsiteX74" fmla="*/ 2598566 w 12192000"/>
              <a:gd name="connsiteY74" fmla="*/ 2078532 h 2347414"/>
              <a:gd name="connsiteX75" fmla="*/ 2337444 w 12192000"/>
              <a:gd name="connsiteY75" fmla="*/ 2048611 h 2347414"/>
              <a:gd name="connsiteX76" fmla="*/ 2091054 w 12192000"/>
              <a:gd name="connsiteY76" fmla="*/ 2023146 h 2347414"/>
              <a:gd name="connsiteX77" fmla="*/ 1755761 w 12192000"/>
              <a:gd name="connsiteY77" fmla="*/ 1981384 h 2347414"/>
              <a:gd name="connsiteX78" fmla="*/ 1441169 w 12192000"/>
              <a:gd name="connsiteY78" fmla="*/ 1943824 h 2347414"/>
              <a:gd name="connsiteX79" fmla="*/ 1017607 w 12192000"/>
              <a:gd name="connsiteY79" fmla="*/ 1883345 h 2347414"/>
              <a:gd name="connsiteX80" fmla="*/ 594427 w 12192000"/>
              <a:gd name="connsiteY80" fmla="*/ 1821849 h 2347414"/>
              <a:gd name="connsiteX81" fmla="*/ 200711 w 12192000"/>
              <a:gd name="connsiteY81" fmla="*/ 1755132 h 2347414"/>
              <a:gd name="connsiteX82" fmla="*/ 0 w 12192000"/>
              <a:gd name="connsiteY82" fmla="*/ 1718743 h 23474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</a:cxnLst>
            <a:rect l="l" t="t" r="r" b="b"/>
            <a:pathLst>
              <a:path w="12192000" h="2347414">
                <a:moveTo>
                  <a:pt x="0" y="0"/>
                </a:moveTo>
                <a:lnTo>
                  <a:pt x="12192000" y="0"/>
                </a:lnTo>
                <a:lnTo>
                  <a:pt x="12192000" y="1736458"/>
                </a:lnTo>
                <a:lnTo>
                  <a:pt x="11967601" y="1784034"/>
                </a:lnTo>
                <a:cubicBezTo>
                  <a:pt x="11589888" y="1859409"/>
                  <a:pt x="11209762" y="1923961"/>
                  <a:pt x="10829000" y="1983294"/>
                </a:cubicBezTo>
                <a:lnTo>
                  <a:pt x="10743779" y="1996027"/>
                </a:lnTo>
                <a:cubicBezTo>
                  <a:pt x="10772495" y="1996778"/>
                  <a:pt x="10801211" y="1993989"/>
                  <a:pt x="10829254" y="1987751"/>
                </a:cubicBezTo>
                <a:cubicBezTo>
                  <a:pt x="10835198" y="1988337"/>
                  <a:pt x="10841180" y="1988553"/>
                  <a:pt x="10847162" y="1988388"/>
                </a:cubicBezTo>
                <a:cubicBezTo>
                  <a:pt x="11090123" y="1968907"/>
                  <a:pt x="11332703" y="1945734"/>
                  <a:pt x="11575155" y="1921415"/>
                </a:cubicBezTo>
                <a:lnTo>
                  <a:pt x="12192000" y="1851213"/>
                </a:lnTo>
                <a:lnTo>
                  <a:pt x="12192000" y="1907356"/>
                </a:lnTo>
                <a:lnTo>
                  <a:pt x="12035532" y="1927033"/>
                </a:lnTo>
                <a:cubicBezTo>
                  <a:pt x="11882793" y="1944747"/>
                  <a:pt x="11729910" y="1961077"/>
                  <a:pt x="11576932" y="1976291"/>
                </a:cubicBezTo>
                <a:cubicBezTo>
                  <a:pt x="11260690" y="2008122"/>
                  <a:pt x="10944193" y="2037279"/>
                  <a:pt x="10627316" y="2061470"/>
                </a:cubicBezTo>
                <a:cubicBezTo>
                  <a:pt x="10352985" y="2082351"/>
                  <a:pt x="10078401" y="2100431"/>
                  <a:pt x="9804196" y="2123478"/>
                </a:cubicBezTo>
                <a:cubicBezTo>
                  <a:pt x="9617118" y="2139137"/>
                  <a:pt x="9430675" y="2161674"/>
                  <a:pt x="9243851" y="2180008"/>
                </a:cubicBezTo>
                <a:cubicBezTo>
                  <a:pt x="9073157" y="2196433"/>
                  <a:pt x="8902207" y="2211966"/>
                  <a:pt x="8731259" y="2225081"/>
                </a:cubicBezTo>
                <a:cubicBezTo>
                  <a:pt x="8509507" y="2242054"/>
                  <a:pt x="8287667" y="2257586"/>
                  <a:pt x="8065752" y="2271681"/>
                </a:cubicBezTo>
                <a:cubicBezTo>
                  <a:pt x="7929984" y="2280466"/>
                  <a:pt x="7793961" y="2285814"/>
                  <a:pt x="7658065" y="2292562"/>
                </a:cubicBezTo>
                <a:cubicBezTo>
                  <a:pt x="7282640" y="2311661"/>
                  <a:pt x="6906704" y="2314208"/>
                  <a:pt x="6531024" y="2324138"/>
                </a:cubicBezTo>
                <a:cubicBezTo>
                  <a:pt x="6413417" y="2327322"/>
                  <a:pt x="6295937" y="2338399"/>
                  <a:pt x="6178331" y="2345655"/>
                </a:cubicBezTo>
                <a:cubicBezTo>
                  <a:pt x="6111271" y="2349730"/>
                  <a:pt x="6044342" y="2345655"/>
                  <a:pt x="5977282" y="2344127"/>
                </a:cubicBezTo>
                <a:cubicBezTo>
                  <a:pt x="5774073" y="2338908"/>
                  <a:pt x="5570866" y="2334960"/>
                  <a:pt x="5367658" y="2329230"/>
                </a:cubicBezTo>
                <a:cubicBezTo>
                  <a:pt x="5040746" y="2319809"/>
                  <a:pt x="4713963" y="2306274"/>
                  <a:pt x="4387306" y="2288614"/>
                </a:cubicBezTo>
                <a:cubicBezTo>
                  <a:pt x="4318342" y="2284796"/>
                  <a:pt x="4249253" y="2284286"/>
                  <a:pt x="4180287" y="2280211"/>
                </a:cubicBezTo>
                <a:cubicBezTo>
                  <a:pt x="4067634" y="2273463"/>
                  <a:pt x="3954980" y="2265060"/>
                  <a:pt x="3842199" y="2257039"/>
                </a:cubicBezTo>
                <a:cubicBezTo>
                  <a:pt x="3804988" y="2254492"/>
                  <a:pt x="3767648" y="2254620"/>
                  <a:pt x="3730309" y="2251182"/>
                </a:cubicBezTo>
                <a:cubicBezTo>
                  <a:pt x="3628704" y="2242142"/>
                  <a:pt x="3527101" y="2238449"/>
                  <a:pt x="3425496" y="2231320"/>
                </a:cubicBezTo>
                <a:cubicBezTo>
                  <a:pt x="3308906" y="2222534"/>
                  <a:pt x="3192569" y="2211330"/>
                  <a:pt x="3076106" y="2201781"/>
                </a:cubicBezTo>
                <a:cubicBezTo>
                  <a:pt x="2990757" y="2194905"/>
                  <a:pt x="2905157" y="2190067"/>
                  <a:pt x="2819682" y="2182427"/>
                </a:cubicBezTo>
                <a:cubicBezTo>
                  <a:pt x="2721507" y="2173515"/>
                  <a:pt x="2623586" y="2162311"/>
                  <a:pt x="2525539" y="2152888"/>
                </a:cubicBezTo>
                <a:cubicBezTo>
                  <a:pt x="2454289" y="2145886"/>
                  <a:pt x="2383038" y="2140920"/>
                  <a:pt x="2311915" y="2133536"/>
                </a:cubicBezTo>
                <a:cubicBezTo>
                  <a:pt x="2225933" y="2124749"/>
                  <a:pt x="2140204" y="2114182"/>
                  <a:pt x="2054223" y="2104760"/>
                </a:cubicBezTo>
                <a:cubicBezTo>
                  <a:pt x="1990719" y="2097758"/>
                  <a:pt x="1928233" y="2092028"/>
                  <a:pt x="1865367" y="2084770"/>
                </a:cubicBezTo>
                <a:cubicBezTo>
                  <a:pt x="1786622" y="2075603"/>
                  <a:pt x="1708006" y="2065545"/>
                  <a:pt x="1629263" y="2055996"/>
                </a:cubicBezTo>
                <a:cubicBezTo>
                  <a:pt x="1572492" y="2049120"/>
                  <a:pt x="1515595" y="2043264"/>
                  <a:pt x="1458823" y="2035751"/>
                </a:cubicBezTo>
                <a:cubicBezTo>
                  <a:pt x="1386303" y="2026585"/>
                  <a:pt x="1313784" y="2016780"/>
                  <a:pt x="1241390" y="2007103"/>
                </a:cubicBezTo>
                <a:lnTo>
                  <a:pt x="1047453" y="1980748"/>
                </a:lnTo>
                <a:cubicBezTo>
                  <a:pt x="969980" y="1970180"/>
                  <a:pt x="892254" y="1960377"/>
                  <a:pt x="814907" y="1949045"/>
                </a:cubicBezTo>
                <a:cubicBezTo>
                  <a:pt x="740609" y="1938094"/>
                  <a:pt x="666692" y="1925744"/>
                  <a:pt x="592649" y="1913776"/>
                </a:cubicBezTo>
                <a:cubicBezTo>
                  <a:pt x="509587" y="1900280"/>
                  <a:pt x="426653" y="1886274"/>
                  <a:pt x="343591" y="1872650"/>
                </a:cubicBezTo>
                <a:cubicBezTo>
                  <a:pt x="240972" y="1855716"/>
                  <a:pt x="138225" y="1839673"/>
                  <a:pt x="35731" y="1821722"/>
                </a:cubicBezTo>
                <a:lnTo>
                  <a:pt x="0" y="1814848"/>
                </a:lnTo>
                <a:lnTo>
                  <a:pt x="0" y="1758489"/>
                </a:lnTo>
                <a:lnTo>
                  <a:pt x="274248" y="1808735"/>
                </a:lnTo>
                <a:cubicBezTo>
                  <a:pt x="348926" y="1821467"/>
                  <a:pt x="423604" y="1832798"/>
                  <a:pt x="498157" y="1846167"/>
                </a:cubicBezTo>
                <a:cubicBezTo>
                  <a:pt x="572708" y="1859536"/>
                  <a:pt x="647896" y="1867813"/>
                  <a:pt x="722828" y="1878635"/>
                </a:cubicBezTo>
                <a:cubicBezTo>
                  <a:pt x="797762" y="1889457"/>
                  <a:pt x="874219" y="1901426"/>
                  <a:pt x="949913" y="1912375"/>
                </a:cubicBezTo>
                <a:cubicBezTo>
                  <a:pt x="1031704" y="1924343"/>
                  <a:pt x="1113496" y="1935802"/>
                  <a:pt x="1195414" y="1947516"/>
                </a:cubicBezTo>
                <a:cubicBezTo>
                  <a:pt x="1244566" y="1954519"/>
                  <a:pt x="1293589" y="1962285"/>
                  <a:pt x="1342867" y="1968397"/>
                </a:cubicBezTo>
                <a:cubicBezTo>
                  <a:pt x="1401162" y="1975656"/>
                  <a:pt x="1459712" y="1981130"/>
                  <a:pt x="1518007" y="1988006"/>
                </a:cubicBezTo>
                <a:cubicBezTo>
                  <a:pt x="1579224" y="1995263"/>
                  <a:pt x="1640186" y="2003411"/>
                  <a:pt x="1701403" y="2010669"/>
                </a:cubicBezTo>
                <a:cubicBezTo>
                  <a:pt x="1762618" y="2017926"/>
                  <a:pt x="1820279" y="2024292"/>
                  <a:pt x="1879210" y="2031167"/>
                </a:cubicBezTo>
                <a:cubicBezTo>
                  <a:pt x="1942712" y="2038425"/>
                  <a:pt x="2006214" y="2046064"/>
                  <a:pt x="2068702" y="2052940"/>
                </a:cubicBezTo>
                <a:cubicBezTo>
                  <a:pt x="2116455" y="2058160"/>
                  <a:pt x="2164335" y="2062362"/>
                  <a:pt x="2212090" y="2067583"/>
                </a:cubicBezTo>
                <a:cubicBezTo>
                  <a:pt x="2280419" y="2074967"/>
                  <a:pt x="2348493" y="2085152"/>
                  <a:pt x="2416949" y="2089609"/>
                </a:cubicBezTo>
                <a:cubicBezTo>
                  <a:pt x="2472070" y="2093302"/>
                  <a:pt x="2526936" y="2099540"/>
                  <a:pt x="2582055" y="2105397"/>
                </a:cubicBezTo>
                <a:cubicBezTo>
                  <a:pt x="2655337" y="2113291"/>
                  <a:pt x="2729001" y="2119785"/>
                  <a:pt x="2802282" y="2126405"/>
                </a:cubicBezTo>
                <a:cubicBezTo>
                  <a:pt x="2862991" y="2131753"/>
                  <a:pt x="2924207" y="2136337"/>
                  <a:pt x="2984916" y="2141684"/>
                </a:cubicBezTo>
                <a:cubicBezTo>
                  <a:pt x="3070516" y="2149324"/>
                  <a:pt x="3156373" y="2152888"/>
                  <a:pt x="3241847" y="2164094"/>
                </a:cubicBezTo>
                <a:cubicBezTo>
                  <a:pt x="3307255" y="2172624"/>
                  <a:pt x="3374060" y="2169822"/>
                  <a:pt x="3439848" y="2176826"/>
                </a:cubicBezTo>
                <a:cubicBezTo>
                  <a:pt x="3512622" y="2184592"/>
                  <a:pt x="3585777" y="2186247"/>
                  <a:pt x="3658678" y="2194523"/>
                </a:cubicBezTo>
                <a:cubicBezTo>
                  <a:pt x="3731578" y="2202800"/>
                  <a:pt x="3807019" y="2201781"/>
                  <a:pt x="3881317" y="2206491"/>
                </a:cubicBezTo>
                <a:cubicBezTo>
                  <a:pt x="3970222" y="2212094"/>
                  <a:pt x="4059124" y="2223552"/>
                  <a:pt x="4148916" y="2225081"/>
                </a:cubicBezTo>
                <a:cubicBezTo>
                  <a:pt x="4255600" y="2226736"/>
                  <a:pt x="4361779" y="2236539"/>
                  <a:pt x="4468337" y="2237813"/>
                </a:cubicBezTo>
                <a:cubicBezTo>
                  <a:pt x="4511390" y="2238577"/>
                  <a:pt x="4554190" y="2246852"/>
                  <a:pt x="4605375" y="2240232"/>
                </a:cubicBezTo>
                <a:cubicBezTo>
                  <a:pt x="4574131" y="2238704"/>
                  <a:pt x="4550762" y="2237940"/>
                  <a:pt x="4527647" y="2236412"/>
                </a:cubicBezTo>
                <a:cubicBezTo>
                  <a:pt x="4410293" y="2228773"/>
                  <a:pt x="4292942" y="2220751"/>
                  <a:pt x="4175589" y="2212985"/>
                </a:cubicBezTo>
                <a:cubicBezTo>
                  <a:pt x="4113101" y="2208783"/>
                  <a:pt x="4050615" y="2205219"/>
                  <a:pt x="3988255" y="2200253"/>
                </a:cubicBezTo>
                <a:cubicBezTo>
                  <a:pt x="3887668" y="2192487"/>
                  <a:pt x="3787079" y="2184082"/>
                  <a:pt x="3686492" y="2176062"/>
                </a:cubicBezTo>
                <a:cubicBezTo>
                  <a:pt x="3630102" y="2171605"/>
                  <a:pt x="3573711" y="2168040"/>
                  <a:pt x="3517320" y="2163330"/>
                </a:cubicBezTo>
                <a:cubicBezTo>
                  <a:pt x="3430958" y="2155689"/>
                  <a:pt x="3344721" y="2147159"/>
                  <a:pt x="3258357" y="2139519"/>
                </a:cubicBezTo>
                <a:cubicBezTo>
                  <a:pt x="3206031" y="2134809"/>
                  <a:pt x="3153705" y="2131371"/>
                  <a:pt x="3101506" y="2126787"/>
                </a:cubicBezTo>
                <a:cubicBezTo>
                  <a:pt x="3004220" y="2117365"/>
                  <a:pt x="2907061" y="2106798"/>
                  <a:pt x="2809395" y="2097502"/>
                </a:cubicBezTo>
                <a:cubicBezTo>
                  <a:pt x="2739161" y="2090628"/>
                  <a:pt x="2668673" y="2085916"/>
                  <a:pt x="2598566" y="2078532"/>
                </a:cubicBezTo>
                <a:cubicBezTo>
                  <a:pt x="2511441" y="2069365"/>
                  <a:pt x="2424569" y="2058160"/>
                  <a:pt x="2337444" y="2048611"/>
                </a:cubicBezTo>
                <a:cubicBezTo>
                  <a:pt x="2255399" y="2039699"/>
                  <a:pt x="2173099" y="2032950"/>
                  <a:pt x="2091054" y="2023146"/>
                </a:cubicBezTo>
                <a:cubicBezTo>
                  <a:pt x="1979162" y="2010414"/>
                  <a:pt x="1867524" y="1995008"/>
                  <a:pt x="1755761" y="1981384"/>
                </a:cubicBezTo>
                <a:cubicBezTo>
                  <a:pt x="1650982" y="1968652"/>
                  <a:pt x="1545821" y="1957830"/>
                  <a:pt x="1441169" y="1943824"/>
                </a:cubicBezTo>
                <a:cubicBezTo>
                  <a:pt x="1299813" y="1924980"/>
                  <a:pt x="1158837" y="1903718"/>
                  <a:pt x="1017607" y="1883345"/>
                </a:cubicBezTo>
                <a:cubicBezTo>
                  <a:pt x="876378" y="1862974"/>
                  <a:pt x="735402" y="1844003"/>
                  <a:pt x="594427" y="1821849"/>
                </a:cubicBezTo>
                <a:cubicBezTo>
                  <a:pt x="462850" y="1801222"/>
                  <a:pt x="331526" y="1778304"/>
                  <a:pt x="200711" y="1755132"/>
                </a:cubicBezTo>
                <a:lnTo>
                  <a:pt x="0" y="1718743"/>
                </a:lnTo>
                <a:close/>
              </a:path>
            </a:pathLst>
          </a:custGeom>
          <a:solidFill>
            <a:schemeClr val="accent1"/>
          </a:solidFill>
          <a:ln w="8199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1248" y="402336"/>
            <a:ext cx="10515600" cy="1344168"/>
          </a:xfrm>
        </p:spPr>
        <p:txBody>
          <a:bodyPr/>
          <a:lstStyle>
            <a:lvl1pPr algn="ctr">
              <a:defRPr sz="7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4308AE94-7094-4D70-9812-D22ECD79C7D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970635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1" name="Picture Placeholder 10">
            <a:extLst>
              <a:ext uri="{FF2B5EF4-FFF2-40B4-BE49-F238E27FC236}">
                <a16:creationId xmlns:a16="http://schemas.microsoft.com/office/drawing/2014/main" id="{2B505429-1B51-4AA8-8307-05F64474936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572871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2" name="Picture Placeholder 11">
            <a:extLst>
              <a:ext uri="{FF2B5EF4-FFF2-40B4-BE49-F238E27FC236}">
                <a16:creationId xmlns:a16="http://schemas.microsoft.com/office/drawing/2014/main" id="{F3F3360D-2801-410A-A4E5-7AE529A3E3C8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175107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Text Placeholder 32">
            <a:extLst>
              <a:ext uri="{FF2B5EF4-FFF2-40B4-BE49-F238E27FC236}">
                <a16:creationId xmlns:a16="http://schemas.microsoft.com/office/drawing/2014/main" id="{B745A5D6-A4E0-4308-9600-DE5E19572946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85216" y="4315968"/>
            <a:ext cx="3063240" cy="548640"/>
          </a:xfrm>
          <a:prstGeom prst="rect">
            <a:avLst/>
          </a:prstGeo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Presenter Name</a:t>
            </a:r>
          </a:p>
        </p:txBody>
      </p:sp>
      <p:sp>
        <p:nvSpPr>
          <p:cNvPr id="14" name="Text Placeholder 32">
            <a:extLst>
              <a:ext uri="{FF2B5EF4-FFF2-40B4-BE49-F238E27FC236}">
                <a16:creationId xmlns:a16="http://schemas.microsoft.com/office/drawing/2014/main" id="{C3466BB8-D955-4280-BA4D-66F3DC034164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4562856" y="4315968"/>
            <a:ext cx="3063240" cy="548640"/>
          </a:xfr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Email</a:t>
            </a:r>
          </a:p>
        </p:txBody>
      </p:sp>
      <p:sp>
        <p:nvSpPr>
          <p:cNvPr id="15" name="Text Placeholder 32">
            <a:extLst>
              <a:ext uri="{FF2B5EF4-FFF2-40B4-BE49-F238E27FC236}">
                <a16:creationId xmlns:a16="http://schemas.microsoft.com/office/drawing/2014/main" id="{F829B8DE-3184-4E0A-AAD4-8F27B55DA95F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8540496" y="4315968"/>
            <a:ext cx="3063240" cy="548640"/>
          </a:xfr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Website</a:t>
            </a:r>
          </a:p>
        </p:txBody>
      </p:sp>
    </p:spTree>
    <p:extLst>
      <p:ext uri="{BB962C8B-B14F-4D97-AF65-F5344CB8AC3E}">
        <p14:creationId xmlns:p14="http://schemas.microsoft.com/office/powerpoint/2010/main" val="248033879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2816A0-77C4-4A3F-87BD-A7321E3C8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C3464-F026-4C77-9441-55ECA5054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7D9257-BADE-4D0B-AF0B-D09FE95FA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418607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A1C48E-F751-45A2-9010-208B81EDB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3429000"/>
          </a:xfrm>
        </p:spPr>
        <p:txBody>
          <a:bodyPr anchor="b">
            <a:normAutofit/>
          </a:bodyPr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501F6-8430-4758-8636-74D68E990E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03520" y="548640"/>
            <a:ext cx="6053328" cy="5431536"/>
          </a:xfrm>
        </p:spPr>
        <p:txBody>
          <a:bodyPr anchor="ctr"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79DC39-A29C-494C-98B6-999746C5F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977640"/>
            <a:ext cx="3932237" cy="2002536"/>
          </a:xfrm>
        </p:spPr>
        <p:txBody>
          <a:bodyPr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84C988-A6DB-469A-B8AA-31866F36E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BC39C3-81EB-4828-9AD3-2F1FAC521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59376C-9810-49A5-BC9A-4E6A02175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6" descr="Tag=AccentColor&#10;Flavor=Light&#10;Target=FillAndLine">
            <a:extLst>
              <a:ext uri="{FF2B5EF4-FFF2-40B4-BE49-F238E27FC236}">
                <a16:creationId xmlns:a16="http://schemas.microsoft.com/office/drawing/2014/main" id="{B9F96F3A-E64D-4401-B02C-BCD5CAA97CFF}"/>
              </a:ext>
            </a:extLst>
          </p:cNvPr>
          <p:cNvSpPr/>
          <p:nvPr/>
        </p:nvSpPr>
        <p:spPr>
          <a:xfrm rot="5400000">
            <a:off x="2797492" y="3254143"/>
            <a:ext cx="4480560" cy="27432"/>
          </a:xfrm>
          <a:custGeom>
            <a:avLst/>
            <a:gdLst>
              <a:gd name="connsiteX0" fmla="*/ 0 w 4480560"/>
              <a:gd name="connsiteY0" fmla="*/ 0 h 27432"/>
              <a:gd name="connsiteX1" fmla="*/ 595274 w 4480560"/>
              <a:gd name="connsiteY1" fmla="*/ 0 h 27432"/>
              <a:gd name="connsiteX2" fmla="*/ 1100938 w 4480560"/>
              <a:gd name="connsiteY2" fmla="*/ 0 h 27432"/>
              <a:gd name="connsiteX3" fmla="*/ 1651406 w 4480560"/>
              <a:gd name="connsiteY3" fmla="*/ 0 h 27432"/>
              <a:gd name="connsiteX4" fmla="*/ 2336292 w 4480560"/>
              <a:gd name="connsiteY4" fmla="*/ 0 h 27432"/>
              <a:gd name="connsiteX5" fmla="*/ 2931566 w 4480560"/>
              <a:gd name="connsiteY5" fmla="*/ 0 h 27432"/>
              <a:gd name="connsiteX6" fmla="*/ 3482035 w 4480560"/>
              <a:gd name="connsiteY6" fmla="*/ 0 h 27432"/>
              <a:gd name="connsiteX7" fmla="*/ 4480560 w 4480560"/>
              <a:gd name="connsiteY7" fmla="*/ 0 h 27432"/>
              <a:gd name="connsiteX8" fmla="*/ 4480560 w 4480560"/>
              <a:gd name="connsiteY8" fmla="*/ 27432 h 27432"/>
              <a:gd name="connsiteX9" fmla="*/ 3840480 w 4480560"/>
              <a:gd name="connsiteY9" fmla="*/ 27432 h 27432"/>
              <a:gd name="connsiteX10" fmla="*/ 3290011 w 4480560"/>
              <a:gd name="connsiteY10" fmla="*/ 27432 h 27432"/>
              <a:gd name="connsiteX11" fmla="*/ 2560320 w 4480560"/>
              <a:gd name="connsiteY11" fmla="*/ 27432 h 27432"/>
              <a:gd name="connsiteX12" fmla="*/ 1965046 w 4480560"/>
              <a:gd name="connsiteY12" fmla="*/ 27432 h 27432"/>
              <a:gd name="connsiteX13" fmla="*/ 1459382 w 4480560"/>
              <a:gd name="connsiteY13" fmla="*/ 27432 h 27432"/>
              <a:gd name="connsiteX14" fmla="*/ 774497 w 4480560"/>
              <a:gd name="connsiteY14" fmla="*/ 27432 h 27432"/>
              <a:gd name="connsiteX15" fmla="*/ 0 w 4480560"/>
              <a:gd name="connsiteY15" fmla="*/ 27432 h 27432"/>
              <a:gd name="connsiteX16" fmla="*/ 0 w 4480560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480560" h="27432" fill="none" extrusionOk="0">
                <a:moveTo>
                  <a:pt x="0" y="0"/>
                </a:moveTo>
                <a:cubicBezTo>
                  <a:pt x="267821" y="8731"/>
                  <a:pt x="334105" y="2629"/>
                  <a:pt x="595274" y="0"/>
                </a:cubicBezTo>
                <a:cubicBezTo>
                  <a:pt x="856443" y="-2629"/>
                  <a:pt x="863808" y="-13353"/>
                  <a:pt x="1100938" y="0"/>
                </a:cubicBezTo>
                <a:cubicBezTo>
                  <a:pt x="1338068" y="13353"/>
                  <a:pt x="1431663" y="-25862"/>
                  <a:pt x="1651406" y="0"/>
                </a:cubicBezTo>
                <a:cubicBezTo>
                  <a:pt x="1871149" y="25862"/>
                  <a:pt x="2173163" y="23827"/>
                  <a:pt x="2336292" y="0"/>
                </a:cubicBezTo>
                <a:cubicBezTo>
                  <a:pt x="2499421" y="-23827"/>
                  <a:pt x="2720589" y="28148"/>
                  <a:pt x="2931566" y="0"/>
                </a:cubicBezTo>
                <a:cubicBezTo>
                  <a:pt x="3142543" y="-28148"/>
                  <a:pt x="3323630" y="27022"/>
                  <a:pt x="3482035" y="0"/>
                </a:cubicBezTo>
                <a:cubicBezTo>
                  <a:pt x="3640440" y="-27022"/>
                  <a:pt x="4012110" y="-20118"/>
                  <a:pt x="4480560" y="0"/>
                </a:cubicBezTo>
                <a:cubicBezTo>
                  <a:pt x="4479587" y="8304"/>
                  <a:pt x="4480082" y="21512"/>
                  <a:pt x="4480560" y="27432"/>
                </a:cubicBezTo>
                <a:cubicBezTo>
                  <a:pt x="4314132" y="24068"/>
                  <a:pt x="4028383" y="45776"/>
                  <a:pt x="3840480" y="27432"/>
                </a:cubicBezTo>
                <a:cubicBezTo>
                  <a:pt x="3652577" y="9088"/>
                  <a:pt x="3547615" y="11992"/>
                  <a:pt x="3290011" y="27432"/>
                </a:cubicBezTo>
                <a:cubicBezTo>
                  <a:pt x="3032407" y="42872"/>
                  <a:pt x="2830268" y="17863"/>
                  <a:pt x="2560320" y="27432"/>
                </a:cubicBezTo>
                <a:cubicBezTo>
                  <a:pt x="2290372" y="37001"/>
                  <a:pt x="2147422" y="15872"/>
                  <a:pt x="1965046" y="27432"/>
                </a:cubicBezTo>
                <a:cubicBezTo>
                  <a:pt x="1782670" y="38992"/>
                  <a:pt x="1689791" y="49824"/>
                  <a:pt x="1459382" y="27432"/>
                </a:cubicBezTo>
                <a:cubicBezTo>
                  <a:pt x="1228973" y="5040"/>
                  <a:pt x="915486" y="45645"/>
                  <a:pt x="774497" y="27432"/>
                </a:cubicBezTo>
                <a:cubicBezTo>
                  <a:pt x="633508" y="9219"/>
                  <a:pt x="361442" y="-1963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480560" h="27432" stroke="0" extrusionOk="0">
                <a:moveTo>
                  <a:pt x="0" y="0"/>
                </a:moveTo>
                <a:cubicBezTo>
                  <a:pt x="285465" y="225"/>
                  <a:pt x="322691" y="16223"/>
                  <a:pt x="595274" y="0"/>
                </a:cubicBezTo>
                <a:cubicBezTo>
                  <a:pt x="867857" y="-16223"/>
                  <a:pt x="989129" y="-11242"/>
                  <a:pt x="1100938" y="0"/>
                </a:cubicBezTo>
                <a:cubicBezTo>
                  <a:pt x="1212747" y="11242"/>
                  <a:pt x="1574350" y="-36410"/>
                  <a:pt x="1830629" y="0"/>
                </a:cubicBezTo>
                <a:cubicBezTo>
                  <a:pt x="2086908" y="36410"/>
                  <a:pt x="2180922" y="4645"/>
                  <a:pt x="2425903" y="0"/>
                </a:cubicBezTo>
                <a:cubicBezTo>
                  <a:pt x="2670884" y="-4645"/>
                  <a:pt x="2782024" y="22929"/>
                  <a:pt x="3021178" y="0"/>
                </a:cubicBezTo>
                <a:cubicBezTo>
                  <a:pt x="3260332" y="-22929"/>
                  <a:pt x="3456982" y="-1586"/>
                  <a:pt x="3750869" y="0"/>
                </a:cubicBezTo>
                <a:cubicBezTo>
                  <a:pt x="4044756" y="1586"/>
                  <a:pt x="4302726" y="17043"/>
                  <a:pt x="4480560" y="0"/>
                </a:cubicBezTo>
                <a:cubicBezTo>
                  <a:pt x="4481045" y="9333"/>
                  <a:pt x="4481838" y="19699"/>
                  <a:pt x="4480560" y="27432"/>
                </a:cubicBezTo>
                <a:cubicBezTo>
                  <a:pt x="4279652" y="2294"/>
                  <a:pt x="4200762" y="50710"/>
                  <a:pt x="3930091" y="27432"/>
                </a:cubicBezTo>
                <a:cubicBezTo>
                  <a:pt x="3659420" y="4154"/>
                  <a:pt x="3456052" y="31438"/>
                  <a:pt x="3290011" y="27432"/>
                </a:cubicBezTo>
                <a:cubicBezTo>
                  <a:pt x="3123970" y="23426"/>
                  <a:pt x="2882392" y="41962"/>
                  <a:pt x="2649931" y="27432"/>
                </a:cubicBezTo>
                <a:cubicBezTo>
                  <a:pt x="2417470" y="12902"/>
                  <a:pt x="2238426" y="16481"/>
                  <a:pt x="2054657" y="27432"/>
                </a:cubicBezTo>
                <a:cubicBezTo>
                  <a:pt x="1870888" y="38383"/>
                  <a:pt x="1566368" y="54184"/>
                  <a:pt x="1324966" y="27432"/>
                </a:cubicBezTo>
                <a:cubicBezTo>
                  <a:pt x="1083564" y="680"/>
                  <a:pt x="787410" y="20090"/>
                  <a:pt x="595274" y="27432"/>
                </a:cubicBezTo>
                <a:cubicBezTo>
                  <a:pt x="403138" y="34774"/>
                  <a:pt x="169622" y="19643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4445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71420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37704-80BD-41B0-8395-41618EC3A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1920" cy="3429000"/>
          </a:xfrm>
        </p:spPr>
        <p:txBody>
          <a:bodyPr anchor="b">
            <a:normAutofit/>
          </a:bodyPr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DA4032-EC66-4974-BD30-898B60E4B5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303520" y="548640"/>
            <a:ext cx="6053328" cy="543153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1802D0-5574-4631-BA49-92362F8E40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977640"/>
            <a:ext cx="3931920" cy="2002536"/>
          </a:xfrm>
        </p:spPr>
        <p:txBody>
          <a:bodyPr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2C2F5B-DDDD-4E64-94A9-99E46F4B0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A8D36-8865-48E7-8249-ED729A5F7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0F98C3-0B62-4361-8408-A01F70807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6" descr="Tag=AccentColor&#10;Flavor=Light&#10;Target=FillAndLine">
            <a:extLst>
              <a:ext uri="{FF2B5EF4-FFF2-40B4-BE49-F238E27FC236}">
                <a16:creationId xmlns:a16="http://schemas.microsoft.com/office/drawing/2014/main" id="{FE511AB6-FEAF-4549-BA88-0764BD10B63D}"/>
              </a:ext>
            </a:extLst>
          </p:cNvPr>
          <p:cNvSpPr/>
          <p:nvPr/>
        </p:nvSpPr>
        <p:spPr>
          <a:xfrm rot="5400000">
            <a:off x="2798064" y="3254143"/>
            <a:ext cx="4480560" cy="27432"/>
          </a:xfrm>
          <a:custGeom>
            <a:avLst/>
            <a:gdLst>
              <a:gd name="connsiteX0" fmla="*/ 0 w 4480560"/>
              <a:gd name="connsiteY0" fmla="*/ 0 h 27432"/>
              <a:gd name="connsiteX1" fmla="*/ 595274 w 4480560"/>
              <a:gd name="connsiteY1" fmla="*/ 0 h 27432"/>
              <a:gd name="connsiteX2" fmla="*/ 1100938 w 4480560"/>
              <a:gd name="connsiteY2" fmla="*/ 0 h 27432"/>
              <a:gd name="connsiteX3" fmla="*/ 1651406 w 4480560"/>
              <a:gd name="connsiteY3" fmla="*/ 0 h 27432"/>
              <a:gd name="connsiteX4" fmla="*/ 2336292 w 4480560"/>
              <a:gd name="connsiteY4" fmla="*/ 0 h 27432"/>
              <a:gd name="connsiteX5" fmla="*/ 2931566 w 4480560"/>
              <a:gd name="connsiteY5" fmla="*/ 0 h 27432"/>
              <a:gd name="connsiteX6" fmla="*/ 3482035 w 4480560"/>
              <a:gd name="connsiteY6" fmla="*/ 0 h 27432"/>
              <a:gd name="connsiteX7" fmla="*/ 4480560 w 4480560"/>
              <a:gd name="connsiteY7" fmla="*/ 0 h 27432"/>
              <a:gd name="connsiteX8" fmla="*/ 4480560 w 4480560"/>
              <a:gd name="connsiteY8" fmla="*/ 27432 h 27432"/>
              <a:gd name="connsiteX9" fmla="*/ 3840480 w 4480560"/>
              <a:gd name="connsiteY9" fmla="*/ 27432 h 27432"/>
              <a:gd name="connsiteX10" fmla="*/ 3290011 w 4480560"/>
              <a:gd name="connsiteY10" fmla="*/ 27432 h 27432"/>
              <a:gd name="connsiteX11" fmla="*/ 2560320 w 4480560"/>
              <a:gd name="connsiteY11" fmla="*/ 27432 h 27432"/>
              <a:gd name="connsiteX12" fmla="*/ 1965046 w 4480560"/>
              <a:gd name="connsiteY12" fmla="*/ 27432 h 27432"/>
              <a:gd name="connsiteX13" fmla="*/ 1459382 w 4480560"/>
              <a:gd name="connsiteY13" fmla="*/ 27432 h 27432"/>
              <a:gd name="connsiteX14" fmla="*/ 774497 w 4480560"/>
              <a:gd name="connsiteY14" fmla="*/ 27432 h 27432"/>
              <a:gd name="connsiteX15" fmla="*/ 0 w 4480560"/>
              <a:gd name="connsiteY15" fmla="*/ 27432 h 27432"/>
              <a:gd name="connsiteX16" fmla="*/ 0 w 4480560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480560" h="27432" fill="none" extrusionOk="0">
                <a:moveTo>
                  <a:pt x="0" y="0"/>
                </a:moveTo>
                <a:cubicBezTo>
                  <a:pt x="267821" y="8731"/>
                  <a:pt x="334105" y="2629"/>
                  <a:pt x="595274" y="0"/>
                </a:cubicBezTo>
                <a:cubicBezTo>
                  <a:pt x="856443" y="-2629"/>
                  <a:pt x="863808" y="-13353"/>
                  <a:pt x="1100938" y="0"/>
                </a:cubicBezTo>
                <a:cubicBezTo>
                  <a:pt x="1338068" y="13353"/>
                  <a:pt x="1431663" y="-25862"/>
                  <a:pt x="1651406" y="0"/>
                </a:cubicBezTo>
                <a:cubicBezTo>
                  <a:pt x="1871149" y="25862"/>
                  <a:pt x="2173163" y="23827"/>
                  <a:pt x="2336292" y="0"/>
                </a:cubicBezTo>
                <a:cubicBezTo>
                  <a:pt x="2499421" y="-23827"/>
                  <a:pt x="2720589" y="28148"/>
                  <a:pt x="2931566" y="0"/>
                </a:cubicBezTo>
                <a:cubicBezTo>
                  <a:pt x="3142543" y="-28148"/>
                  <a:pt x="3323630" y="27022"/>
                  <a:pt x="3482035" y="0"/>
                </a:cubicBezTo>
                <a:cubicBezTo>
                  <a:pt x="3640440" y="-27022"/>
                  <a:pt x="4012110" y="-20118"/>
                  <a:pt x="4480560" y="0"/>
                </a:cubicBezTo>
                <a:cubicBezTo>
                  <a:pt x="4479587" y="8304"/>
                  <a:pt x="4480082" y="21512"/>
                  <a:pt x="4480560" y="27432"/>
                </a:cubicBezTo>
                <a:cubicBezTo>
                  <a:pt x="4314132" y="24068"/>
                  <a:pt x="4028383" y="45776"/>
                  <a:pt x="3840480" y="27432"/>
                </a:cubicBezTo>
                <a:cubicBezTo>
                  <a:pt x="3652577" y="9088"/>
                  <a:pt x="3547615" y="11992"/>
                  <a:pt x="3290011" y="27432"/>
                </a:cubicBezTo>
                <a:cubicBezTo>
                  <a:pt x="3032407" y="42872"/>
                  <a:pt x="2830268" y="17863"/>
                  <a:pt x="2560320" y="27432"/>
                </a:cubicBezTo>
                <a:cubicBezTo>
                  <a:pt x="2290372" y="37001"/>
                  <a:pt x="2147422" y="15872"/>
                  <a:pt x="1965046" y="27432"/>
                </a:cubicBezTo>
                <a:cubicBezTo>
                  <a:pt x="1782670" y="38992"/>
                  <a:pt x="1689791" y="49824"/>
                  <a:pt x="1459382" y="27432"/>
                </a:cubicBezTo>
                <a:cubicBezTo>
                  <a:pt x="1228973" y="5040"/>
                  <a:pt x="915486" y="45645"/>
                  <a:pt x="774497" y="27432"/>
                </a:cubicBezTo>
                <a:cubicBezTo>
                  <a:pt x="633508" y="9219"/>
                  <a:pt x="361442" y="-1963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480560" h="27432" stroke="0" extrusionOk="0">
                <a:moveTo>
                  <a:pt x="0" y="0"/>
                </a:moveTo>
                <a:cubicBezTo>
                  <a:pt x="285465" y="225"/>
                  <a:pt x="322691" y="16223"/>
                  <a:pt x="595274" y="0"/>
                </a:cubicBezTo>
                <a:cubicBezTo>
                  <a:pt x="867857" y="-16223"/>
                  <a:pt x="989129" y="-11242"/>
                  <a:pt x="1100938" y="0"/>
                </a:cubicBezTo>
                <a:cubicBezTo>
                  <a:pt x="1212747" y="11242"/>
                  <a:pt x="1574350" y="-36410"/>
                  <a:pt x="1830629" y="0"/>
                </a:cubicBezTo>
                <a:cubicBezTo>
                  <a:pt x="2086908" y="36410"/>
                  <a:pt x="2180922" y="4645"/>
                  <a:pt x="2425903" y="0"/>
                </a:cubicBezTo>
                <a:cubicBezTo>
                  <a:pt x="2670884" y="-4645"/>
                  <a:pt x="2782024" y="22929"/>
                  <a:pt x="3021178" y="0"/>
                </a:cubicBezTo>
                <a:cubicBezTo>
                  <a:pt x="3260332" y="-22929"/>
                  <a:pt x="3456982" y="-1586"/>
                  <a:pt x="3750869" y="0"/>
                </a:cubicBezTo>
                <a:cubicBezTo>
                  <a:pt x="4044756" y="1586"/>
                  <a:pt x="4302726" y="17043"/>
                  <a:pt x="4480560" y="0"/>
                </a:cubicBezTo>
                <a:cubicBezTo>
                  <a:pt x="4481045" y="9333"/>
                  <a:pt x="4481838" y="19699"/>
                  <a:pt x="4480560" y="27432"/>
                </a:cubicBezTo>
                <a:cubicBezTo>
                  <a:pt x="4279652" y="2294"/>
                  <a:pt x="4200762" y="50710"/>
                  <a:pt x="3930091" y="27432"/>
                </a:cubicBezTo>
                <a:cubicBezTo>
                  <a:pt x="3659420" y="4154"/>
                  <a:pt x="3456052" y="31438"/>
                  <a:pt x="3290011" y="27432"/>
                </a:cubicBezTo>
                <a:cubicBezTo>
                  <a:pt x="3123970" y="23426"/>
                  <a:pt x="2882392" y="41962"/>
                  <a:pt x="2649931" y="27432"/>
                </a:cubicBezTo>
                <a:cubicBezTo>
                  <a:pt x="2417470" y="12902"/>
                  <a:pt x="2238426" y="16481"/>
                  <a:pt x="2054657" y="27432"/>
                </a:cubicBezTo>
                <a:cubicBezTo>
                  <a:pt x="1870888" y="38383"/>
                  <a:pt x="1566368" y="54184"/>
                  <a:pt x="1324966" y="27432"/>
                </a:cubicBezTo>
                <a:cubicBezTo>
                  <a:pt x="1083564" y="680"/>
                  <a:pt x="787410" y="20090"/>
                  <a:pt x="595274" y="27432"/>
                </a:cubicBezTo>
                <a:cubicBezTo>
                  <a:pt x="403138" y="34774"/>
                  <a:pt x="169622" y="19643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4445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6312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77CE2522-15B5-4BC5-91A9-523F325A8324}"/>
              </a:ext>
            </a:extLst>
          </p:cNvPr>
          <p:cNvSpPr/>
          <p:nvPr userDrawn="1"/>
        </p:nvSpPr>
        <p:spPr>
          <a:xfrm>
            <a:off x="5477731" y="0"/>
            <a:ext cx="6714269" cy="6858000"/>
          </a:xfrm>
          <a:custGeom>
            <a:avLst/>
            <a:gdLst>
              <a:gd name="connsiteX0" fmla="*/ 1097203 w 6714269"/>
              <a:gd name="connsiteY0" fmla="*/ 0 h 6858000"/>
              <a:gd name="connsiteX1" fmla="*/ 1154155 w 6714269"/>
              <a:gd name="connsiteY1" fmla="*/ 0 h 6858000"/>
              <a:gd name="connsiteX2" fmla="*/ 972305 w 6714269"/>
              <a:gd name="connsiteY2" fmla="*/ 343212 h 6858000"/>
              <a:gd name="connsiteX3" fmla="*/ 780524 w 6714269"/>
              <a:gd name="connsiteY3" fmla="*/ 761067 h 6858000"/>
              <a:gd name="connsiteX4" fmla="*/ 737045 w 6714269"/>
              <a:gd name="connsiteY4" fmla="*/ 865164 h 6858000"/>
              <a:gd name="connsiteX5" fmla="*/ 762322 w 6714269"/>
              <a:gd name="connsiteY5" fmla="*/ 830676 h 6858000"/>
              <a:gd name="connsiteX6" fmla="*/ 1118805 w 6714269"/>
              <a:gd name="connsiteY6" fmla="*/ 160440 h 6858000"/>
              <a:gd name="connsiteX7" fmla="*/ 1221640 w 6714269"/>
              <a:gd name="connsiteY7" fmla="*/ 0 h 6858000"/>
              <a:gd name="connsiteX8" fmla="*/ 6714269 w 6714269"/>
              <a:gd name="connsiteY8" fmla="*/ 0 h 6858000"/>
              <a:gd name="connsiteX9" fmla="*/ 6714269 w 6714269"/>
              <a:gd name="connsiteY9" fmla="*/ 6858000 h 6858000"/>
              <a:gd name="connsiteX10" fmla="*/ 704817 w 6714269"/>
              <a:gd name="connsiteY10" fmla="*/ 6858000 h 6858000"/>
              <a:gd name="connsiteX11" fmla="*/ 618717 w 6714269"/>
              <a:gd name="connsiteY11" fmla="*/ 6672538 h 6858000"/>
              <a:gd name="connsiteX12" fmla="*/ 309324 w 6714269"/>
              <a:gd name="connsiteY12" fmla="*/ 5833618 h 6858000"/>
              <a:gd name="connsiteX13" fmla="*/ 209850 w 6714269"/>
              <a:gd name="connsiteY13" fmla="*/ 5484180 h 6858000"/>
              <a:gd name="connsiteX14" fmla="*/ 211619 w 6714269"/>
              <a:gd name="connsiteY14" fmla="*/ 5517653 h 6858000"/>
              <a:gd name="connsiteX15" fmla="*/ 361778 w 6714269"/>
              <a:gd name="connsiteY15" fmla="*/ 6145524 h 6858000"/>
              <a:gd name="connsiteX16" fmla="*/ 591356 w 6714269"/>
              <a:gd name="connsiteY16" fmla="*/ 6843306 h 6858000"/>
              <a:gd name="connsiteX17" fmla="*/ 597415 w 6714269"/>
              <a:gd name="connsiteY17" fmla="*/ 6858000 h 6858000"/>
              <a:gd name="connsiteX18" fmla="*/ 545224 w 6714269"/>
              <a:gd name="connsiteY18" fmla="*/ 6858000 h 6858000"/>
              <a:gd name="connsiteX19" fmla="*/ 533604 w 6714269"/>
              <a:gd name="connsiteY19" fmla="*/ 6830072 h 6858000"/>
              <a:gd name="connsiteX20" fmla="*/ 169657 w 6714269"/>
              <a:gd name="connsiteY20" fmla="*/ 5556577 h 6858000"/>
              <a:gd name="connsiteX21" fmla="*/ 12169 w 6714269"/>
              <a:gd name="connsiteY21" fmla="*/ 4362835 h 6858000"/>
              <a:gd name="connsiteX22" fmla="*/ 46168 w 6714269"/>
              <a:gd name="connsiteY22" fmla="*/ 3338487 h 6858000"/>
              <a:gd name="connsiteX23" fmla="*/ 490574 w 6714269"/>
              <a:gd name="connsiteY23" fmla="*/ 1381078 h 6858000"/>
              <a:gd name="connsiteX24" fmla="*/ 984701 w 6714269"/>
              <a:gd name="connsiteY24" fmla="*/ 208241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6714269" h="6858000">
                <a:moveTo>
                  <a:pt x="1097203" y="0"/>
                </a:moveTo>
                <a:lnTo>
                  <a:pt x="1154155" y="0"/>
                </a:lnTo>
                <a:lnTo>
                  <a:pt x="972305" y="343212"/>
                </a:lnTo>
                <a:cubicBezTo>
                  <a:pt x="904739" y="480367"/>
                  <a:pt x="840941" y="619727"/>
                  <a:pt x="780524" y="761067"/>
                </a:cubicBezTo>
                <a:cubicBezTo>
                  <a:pt x="765737" y="795681"/>
                  <a:pt x="751579" y="830550"/>
                  <a:pt x="737045" y="865164"/>
                </a:cubicBezTo>
                <a:cubicBezTo>
                  <a:pt x="748306" y="856057"/>
                  <a:pt x="757014" y="844174"/>
                  <a:pt x="762322" y="830676"/>
                </a:cubicBezTo>
                <a:cubicBezTo>
                  <a:pt x="870201" y="600612"/>
                  <a:pt x="988539" y="376889"/>
                  <a:pt x="1118805" y="160440"/>
                </a:cubicBezTo>
                <a:lnTo>
                  <a:pt x="1221640" y="0"/>
                </a:lnTo>
                <a:lnTo>
                  <a:pt x="6714269" y="0"/>
                </a:lnTo>
                <a:lnTo>
                  <a:pt x="6714269" y="6858000"/>
                </a:lnTo>
                <a:lnTo>
                  <a:pt x="704817" y="6858000"/>
                </a:lnTo>
                <a:lnTo>
                  <a:pt x="618717" y="6672538"/>
                </a:lnTo>
                <a:cubicBezTo>
                  <a:pt x="501618" y="6400947"/>
                  <a:pt x="398622" y="6121213"/>
                  <a:pt x="309324" y="5833618"/>
                </a:cubicBezTo>
                <a:cubicBezTo>
                  <a:pt x="275071" y="5723183"/>
                  <a:pt x="246125" y="5611225"/>
                  <a:pt x="209850" y="5484180"/>
                </a:cubicBezTo>
                <a:cubicBezTo>
                  <a:pt x="209859" y="5495363"/>
                  <a:pt x="210448" y="5506534"/>
                  <a:pt x="211619" y="5517653"/>
                </a:cubicBezTo>
                <a:cubicBezTo>
                  <a:pt x="261166" y="5727113"/>
                  <a:pt x="303888" y="5938474"/>
                  <a:pt x="361778" y="6145524"/>
                </a:cubicBezTo>
                <a:cubicBezTo>
                  <a:pt x="428356" y="6383258"/>
                  <a:pt x="504422" y="6616111"/>
                  <a:pt x="591356" y="6843306"/>
                </a:cubicBezTo>
                <a:lnTo>
                  <a:pt x="597415" y="6858000"/>
                </a:lnTo>
                <a:lnTo>
                  <a:pt x="545224" y="6858000"/>
                </a:lnTo>
                <a:lnTo>
                  <a:pt x="533604" y="6830072"/>
                </a:lnTo>
                <a:cubicBezTo>
                  <a:pt x="376384" y="6416985"/>
                  <a:pt x="257344" y="5991917"/>
                  <a:pt x="169657" y="5556577"/>
                </a:cubicBezTo>
                <a:cubicBezTo>
                  <a:pt x="90154" y="5162256"/>
                  <a:pt x="43261" y="4763750"/>
                  <a:pt x="12169" y="4362835"/>
                </a:cubicBezTo>
                <a:cubicBezTo>
                  <a:pt x="-14122" y="4019865"/>
                  <a:pt x="4458" y="3679429"/>
                  <a:pt x="46168" y="3338487"/>
                </a:cubicBezTo>
                <a:cubicBezTo>
                  <a:pt x="125796" y="2672248"/>
                  <a:pt x="274744" y="2016203"/>
                  <a:pt x="490574" y="1381078"/>
                </a:cubicBezTo>
                <a:cubicBezTo>
                  <a:pt x="629230" y="976550"/>
                  <a:pt x="791584" y="584320"/>
                  <a:pt x="984701" y="208241"/>
                </a:cubicBezTo>
                <a:close/>
              </a:path>
            </a:pathLst>
          </a:custGeom>
          <a:solidFill>
            <a:schemeClr val="accent1"/>
          </a:solidFill>
          <a:ln w="6857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33856" y="649224"/>
            <a:ext cx="4178808" cy="5568696"/>
          </a:xfrm>
        </p:spPr>
        <p:txBody>
          <a:bodyPr>
            <a:noAutofit/>
          </a:bodyPr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64224" y="1307592"/>
            <a:ext cx="4992624" cy="4251960"/>
          </a:xfrm>
        </p:spPr>
        <p:txBody>
          <a:bodyPr anchor="ctr">
            <a:normAutofit/>
          </a:bodyPr>
          <a:lstStyle>
            <a:lvl1pPr marL="0" indent="0">
              <a:buNone/>
              <a:defRPr sz="4400">
                <a:solidFill>
                  <a:schemeClr val="bg1"/>
                </a:solidFill>
              </a:defRPr>
            </a:lvl1pPr>
            <a:lvl2pPr marL="228600">
              <a:defRPr sz="4000">
                <a:solidFill>
                  <a:schemeClr val="bg1"/>
                </a:solidFill>
              </a:defRPr>
            </a:lvl2pPr>
            <a:lvl3pPr marL="457200">
              <a:defRPr sz="3600">
                <a:solidFill>
                  <a:schemeClr val="bg1"/>
                </a:solidFill>
              </a:defRPr>
            </a:lvl3pPr>
            <a:lvl4pPr>
              <a:defRPr sz="1800">
                <a:solidFill>
                  <a:schemeClr val="bg1"/>
                </a:solidFill>
              </a:defRPr>
            </a:lvl4pPr>
            <a:lvl5pPr>
              <a:defRPr sz="18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286000" cy="365125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364224" y="6355080"/>
            <a:ext cx="3200400" cy="365125"/>
          </a:xfrm>
        </p:spPr>
        <p:txBody>
          <a:bodyPr/>
          <a:lstStyle>
            <a:lvl1pPr algn="l"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067544" y="6355080"/>
            <a:ext cx="128016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220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icture Placeholder 19">
            <a:extLst>
              <a:ext uri="{FF2B5EF4-FFF2-40B4-BE49-F238E27FC236}">
                <a16:creationId xmlns:a16="http://schemas.microsoft.com/office/drawing/2014/main" id="{17D0AB67-E176-475C-977C-73640253B922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2" y="4361970"/>
            <a:ext cx="4038599" cy="2496030"/>
          </a:xfrm>
          <a:custGeom>
            <a:avLst/>
            <a:gdLst>
              <a:gd name="connsiteX0" fmla="*/ 2464753 w 4038599"/>
              <a:gd name="connsiteY0" fmla="*/ 4 h 2496030"/>
              <a:gd name="connsiteX1" fmla="*/ 2599067 w 4038599"/>
              <a:gd name="connsiteY1" fmla="*/ 4428 h 2496030"/>
              <a:gd name="connsiteX2" fmla="*/ 3052443 w 4038599"/>
              <a:gd name="connsiteY2" fmla="*/ 14222 h 2496030"/>
              <a:gd name="connsiteX3" fmla="*/ 3417420 w 4038599"/>
              <a:gd name="connsiteY3" fmla="*/ 9782 h 2496030"/>
              <a:gd name="connsiteX4" fmla="*/ 3757835 w 4038599"/>
              <a:gd name="connsiteY4" fmla="*/ 19315 h 2496030"/>
              <a:gd name="connsiteX5" fmla="*/ 3892671 w 4038599"/>
              <a:gd name="connsiteY5" fmla="*/ 13177 h 2496030"/>
              <a:gd name="connsiteX6" fmla="*/ 4016790 w 4038599"/>
              <a:gd name="connsiteY6" fmla="*/ 8134 h 2496030"/>
              <a:gd name="connsiteX7" fmla="*/ 4034037 w 4038599"/>
              <a:gd name="connsiteY7" fmla="*/ 8999 h 2496030"/>
              <a:gd name="connsiteX8" fmla="*/ 4035370 w 4038599"/>
              <a:gd name="connsiteY8" fmla="*/ 62503 h 2496030"/>
              <a:gd name="connsiteX9" fmla="*/ 4020562 w 4038599"/>
              <a:gd name="connsiteY9" fmla="*/ 231143 h 2496030"/>
              <a:gd name="connsiteX10" fmla="*/ 4019168 w 4038599"/>
              <a:gd name="connsiteY10" fmla="*/ 393470 h 2496030"/>
              <a:gd name="connsiteX11" fmla="*/ 4014100 w 4038599"/>
              <a:gd name="connsiteY11" fmla="*/ 651618 h 2496030"/>
              <a:gd name="connsiteX12" fmla="*/ 4019295 w 4038599"/>
              <a:gd name="connsiteY12" fmla="*/ 902406 h 2496030"/>
              <a:gd name="connsiteX13" fmla="*/ 4033231 w 4038599"/>
              <a:gd name="connsiteY13" fmla="*/ 1078946 h 2496030"/>
              <a:gd name="connsiteX14" fmla="*/ 4011566 w 4038599"/>
              <a:gd name="connsiteY14" fmla="*/ 1189872 h 2496030"/>
              <a:gd name="connsiteX15" fmla="*/ 4011566 w 4038599"/>
              <a:gd name="connsiteY15" fmla="*/ 1387989 h 2496030"/>
              <a:gd name="connsiteX16" fmla="*/ 4038599 w 4038599"/>
              <a:gd name="connsiteY16" fmla="*/ 1495613 h 2496030"/>
              <a:gd name="connsiteX17" fmla="*/ 4038599 w 4038599"/>
              <a:gd name="connsiteY17" fmla="*/ 1746509 h 2496030"/>
              <a:gd name="connsiteX18" fmla="*/ 4038283 w 4038599"/>
              <a:gd name="connsiteY18" fmla="*/ 1749734 h 2496030"/>
              <a:gd name="connsiteX19" fmla="*/ 4026896 w 4038599"/>
              <a:gd name="connsiteY19" fmla="*/ 1837274 h 2496030"/>
              <a:gd name="connsiteX20" fmla="*/ 4029684 w 4038599"/>
              <a:gd name="connsiteY20" fmla="*/ 2121948 h 2496030"/>
              <a:gd name="connsiteX21" fmla="*/ 4032978 w 4038599"/>
              <a:gd name="connsiteY21" fmla="*/ 2359155 h 2496030"/>
              <a:gd name="connsiteX22" fmla="*/ 4023519 w 4038599"/>
              <a:gd name="connsiteY22" fmla="*/ 2496030 h 2496030"/>
              <a:gd name="connsiteX23" fmla="*/ 0 w 4038599"/>
              <a:gd name="connsiteY23" fmla="*/ 2496030 h 2496030"/>
              <a:gd name="connsiteX24" fmla="*/ 0 w 4038599"/>
              <a:gd name="connsiteY24" fmla="*/ 12459 h 2496030"/>
              <a:gd name="connsiteX25" fmla="*/ 17104 w 4038599"/>
              <a:gd name="connsiteY25" fmla="*/ 15006 h 2496030"/>
              <a:gd name="connsiteX26" fmla="*/ 216416 w 4038599"/>
              <a:gd name="connsiteY26" fmla="*/ 7824 h 2496030"/>
              <a:gd name="connsiteX27" fmla="*/ 651370 w 4038599"/>
              <a:gd name="connsiteY27" fmla="*/ 17748 h 2496030"/>
              <a:gd name="connsiteX28" fmla="*/ 958396 w 4038599"/>
              <a:gd name="connsiteY28" fmla="*/ 14092 h 2496030"/>
              <a:gd name="connsiteX29" fmla="*/ 1519486 w 4038599"/>
              <a:gd name="connsiteY29" fmla="*/ 21666 h 2496030"/>
              <a:gd name="connsiteX30" fmla="*/ 2062411 w 4038599"/>
              <a:gd name="connsiteY30" fmla="*/ 17487 h 2496030"/>
              <a:gd name="connsiteX31" fmla="*/ 2464753 w 4038599"/>
              <a:gd name="connsiteY31" fmla="*/ 4 h 24960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4038599" h="2496030">
                <a:moveTo>
                  <a:pt x="2464753" y="4"/>
                </a:moveTo>
                <a:cubicBezTo>
                  <a:pt x="2509518" y="-78"/>
                  <a:pt x="2554292" y="1163"/>
                  <a:pt x="2599067" y="4428"/>
                </a:cubicBezTo>
                <a:cubicBezTo>
                  <a:pt x="2749817" y="17813"/>
                  <a:pt x="2901270" y="21079"/>
                  <a:pt x="3052443" y="14222"/>
                </a:cubicBezTo>
                <a:cubicBezTo>
                  <a:pt x="3173923" y="5694"/>
                  <a:pt x="3295774" y="4206"/>
                  <a:pt x="3417420" y="9782"/>
                </a:cubicBezTo>
                <a:cubicBezTo>
                  <a:pt x="3530764" y="16442"/>
                  <a:pt x="3644108" y="23233"/>
                  <a:pt x="3757835" y="19315"/>
                </a:cubicBezTo>
                <a:cubicBezTo>
                  <a:pt x="3803121" y="17748"/>
                  <a:pt x="3847768" y="15789"/>
                  <a:pt x="3892671" y="13177"/>
                </a:cubicBezTo>
                <a:cubicBezTo>
                  <a:pt x="3933972" y="9619"/>
                  <a:pt x="3975386" y="7938"/>
                  <a:pt x="4016790" y="8134"/>
                </a:cubicBezTo>
                <a:lnTo>
                  <a:pt x="4034037" y="8999"/>
                </a:lnTo>
                <a:lnTo>
                  <a:pt x="4035370" y="62503"/>
                </a:lnTo>
                <a:cubicBezTo>
                  <a:pt x="4033549" y="118790"/>
                  <a:pt x="4026390" y="174983"/>
                  <a:pt x="4020562" y="231143"/>
                </a:cubicBezTo>
                <a:cubicBezTo>
                  <a:pt x="4014860" y="285717"/>
                  <a:pt x="4006498" y="343464"/>
                  <a:pt x="4019168" y="393470"/>
                </a:cubicBezTo>
                <a:cubicBezTo>
                  <a:pt x="4042480" y="482184"/>
                  <a:pt x="4024236" y="566457"/>
                  <a:pt x="4014100" y="651618"/>
                </a:cubicBezTo>
                <a:cubicBezTo>
                  <a:pt x="4001874" y="734926"/>
                  <a:pt x="4003635" y="819681"/>
                  <a:pt x="4019295" y="902406"/>
                </a:cubicBezTo>
                <a:cubicBezTo>
                  <a:pt x="4031711" y="960787"/>
                  <a:pt x="4031711" y="1020184"/>
                  <a:pt x="4033231" y="1078946"/>
                </a:cubicBezTo>
                <a:cubicBezTo>
                  <a:pt x="4034118" y="1115753"/>
                  <a:pt x="4020562" y="1153193"/>
                  <a:pt x="4011566" y="1189872"/>
                </a:cubicBezTo>
                <a:cubicBezTo>
                  <a:pt x="3995476" y="1256123"/>
                  <a:pt x="3989648" y="1323388"/>
                  <a:pt x="4011566" y="1387989"/>
                </a:cubicBezTo>
                <a:lnTo>
                  <a:pt x="4038599" y="1495613"/>
                </a:lnTo>
                <a:lnTo>
                  <a:pt x="4038599" y="1746509"/>
                </a:lnTo>
                <a:lnTo>
                  <a:pt x="4038283" y="1749734"/>
                </a:lnTo>
                <a:cubicBezTo>
                  <a:pt x="4035575" y="1779147"/>
                  <a:pt x="4032408" y="1808464"/>
                  <a:pt x="4026896" y="1837274"/>
                </a:cubicBezTo>
                <a:cubicBezTo>
                  <a:pt x="4008779" y="1932843"/>
                  <a:pt x="4015240" y="2027776"/>
                  <a:pt x="4029684" y="2121948"/>
                </a:cubicBezTo>
                <a:cubicBezTo>
                  <a:pt x="4039832" y="2200637"/>
                  <a:pt x="4040934" y="2280226"/>
                  <a:pt x="4032978" y="2359155"/>
                </a:cubicBezTo>
                <a:lnTo>
                  <a:pt x="4023519" y="2496030"/>
                </a:lnTo>
                <a:lnTo>
                  <a:pt x="0" y="2496030"/>
                </a:lnTo>
                <a:lnTo>
                  <a:pt x="0" y="12459"/>
                </a:lnTo>
                <a:lnTo>
                  <a:pt x="17104" y="15006"/>
                </a:lnTo>
                <a:cubicBezTo>
                  <a:pt x="83627" y="15006"/>
                  <a:pt x="150022" y="12263"/>
                  <a:pt x="216416" y="7824"/>
                </a:cubicBezTo>
                <a:cubicBezTo>
                  <a:pt x="361434" y="-156"/>
                  <a:pt x="506837" y="3162"/>
                  <a:pt x="651370" y="17748"/>
                </a:cubicBezTo>
                <a:cubicBezTo>
                  <a:pt x="753623" y="25440"/>
                  <a:pt x="856335" y="24213"/>
                  <a:pt x="958396" y="14092"/>
                </a:cubicBezTo>
                <a:cubicBezTo>
                  <a:pt x="1145682" y="-1710"/>
                  <a:pt x="1332584" y="10958"/>
                  <a:pt x="1519486" y="21666"/>
                </a:cubicBezTo>
                <a:cubicBezTo>
                  <a:pt x="1700504" y="32113"/>
                  <a:pt x="1881394" y="24408"/>
                  <a:pt x="2062411" y="17487"/>
                </a:cubicBezTo>
                <a:cubicBezTo>
                  <a:pt x="2196255" y="12394"/>
                  <a:pt x="2330459" y="249"/>
                  <a:pt x="2464753" y="4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6" name="Picture Placeholder 15">
            <a:extLst>
              <a:ext uri="{FF2B5EF4-FFF2-40B4-BE49-F238E27FC236}">
                <a16:creationId xmlns:a16="http://schemas.microsoft.com/office/drawing/2014/main" id="{2ABE113B-49CB-42B2-AC93-B3DF04407878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0" y="0"/>
            <a:ext cx="4041336" cy="4193763"/>
          </a:xfrm>
          <a:custGeom>
            <a:avLst/>
            <a:gdLst>
              <a:gd name="connsiteX0" fmla="*/ 0 w 4041336"/>
              <a:gd name="connsiteY0" fmla="*/ 0 h 4193763"/>
              <a:gd name="connsiteX1" fmla="*/ 4019848 w 4041336"/>
              <a:gd name="connsiteY1" fmla="*/ 0 h 4193763"/>
              <a:gd name="connsiteX2" fmla="*/ 4021195 w 4041336"/>
              <a:gd name="connsiteY2" fmla="*/ 11419 h 4193763"/>
              <a:gd name="connsiteX3" fmla="*/ 4037665 w 4041336"/>
              <a:gd name="connsiteY3" fmla="*/ 264364 h 4193763"/>
              <a:gd name="connsiteX4" fmla="*/ 4034118 w 4041336"/>
              <a:gd name="connsiteY4" fmla="*/ 574168 h 4193763"/>
              <a:gd name="connsiteX5" fmla="*/ 4026263 w 4041336"/>
              <a:gd name="connsiteY5" fmla="*/ 838028 h 4193763"/>
              <a:gd name="connsiteX6" fmla="*/ 4026263 w 4041336"/>
              <a:gd name="connsiteY6" fmla="*/ 847166 h 4193763"/>
              <a:gd name="connsiteX7" fmla="*/ 4026263 w 4041336"/>
              <a:gd name="connsiteY7" fmla="*/ 1138186 h 4193763"/>
              <a:gd name="connsiteX8" fmla="*/ 4024109 w 4041336"/>
              <a:gd name="connsiteY8" fmla="*/ 1259137 h 4193763"/>
              <a:gd name="connsiteX9" fmla="*/ 4016887 w 4041336"/>
              <a:gd name="connsiteY9" fmla="*/ 1412960 h 4193763"/>
              <a:gd name="connsiteX10" fmla="*/ 4026263 w 4041336"/>
              <a:gd name="connsiteY10" fmla="*/ 1539116 h 4193763"/>
              <a:gd name="connsiteX11" fmla="*/ 4024869 w 4041336"/>
              <a:gd name="connsiteY11" fmla="*/ 1823155 h 4193763"/>
              <a:gd name="connsiteX12" fmla="*/ 4017014 w 4041336"/>
              <a:gd name="connsiteY12" fmla="*/ 2154154 h 4193763"/>
              <a:gd name="connsiteX13" fmla="*/ 4017014 w 4041336"/>
              <a:gd name="connsiteY13" fmla="*/ 2421948 h 4193763"/>
              <a:gd name="connsiteX14" fmla="*/ 4029684 w 4041336"/>
              <a:gd name="connsiteY14" fmla="*/ 2667279 h 4193763"/>
              <a:gd name="connsiteX15" fmla="*/ 4019421 w 4041336"/>
              <a:gd name="connsiteY15" fmla="*/ 2956268 h 4193763"/>
              <a:gd name="connsiteX16" fmla="*/ 4022082 w 4041336"/>
              <a:gd name="connsiteY16" fmla="*/ 3094480 h 4193763"/>
              <a:gd name="connsiteX17" fmla="*/ 4027656 w 4041336"/>
              <a:gd name="connsiteY17" fmla="*/ 3260614 h 4193763"/>
              <a:gd name="connsiteX18" fmla="*/ 4009412 w 4041336"/>
              <a:gd name="connsiteY18" fmla="*/ 3538181 h 4193763"/>
              <a:gd name="connsiteX19" fmla="*/ 4031711 w 4041336"/>
              <a:gd name="connsiteY19" fmla="*/ 3694923 h 4193763"/>
              <a:gd name="connsiteX20" fmla="*/ 4038425 w 4041336"/>
              <a:gd name="connsiteY20" fmla="*/ 3836308 h 4193763"/>
              <a:gd name="connsiteX21" fmla="*/ 4029810 w 4041336"/>
              <a:gd name="connsiteY21" fmla="*/ 3956245 h 4193763"/>
              <a:gd name="connsiteX22" fmla="*/ 4013847 w 4041336"/>
              <a:gd name="connsiteY22" fmla="*/ 4114764 h 4193763"/>
              <a:gd name="connsiteX23" fmla="*/ 4010970 w 4041336"/>
              <a:gd name="connsiteY23" fmla="*/ 4161894 h 4193763"/>
              <a:gd name="connsiteX24" fmla="*/ 4002764 w 4041336"/>
              <a:gd name="connsiteY24" fmla="*/ 4161042 h 4193763"/>
              <a:gd name="connsiteX25" fmla="*/ 3868108 w 4041336"/>
              <a:gd name="connsiteY25" fmla="*/ 4163980 h 4193763"/>
              <a:gd name="connsiteX26" fmla="*/ 3174741 w 4041336"/>
              <a:gd name="connsiteY26" fmla="*/ 4175341 h 4193763"/>
              <a:gd name="connsiteX27" fmla="*/ 2247906 w 4041336"/>
              <a:gd name="connsiteY27" fmla="*/ 4167376 h 4193763"/>
              <a:gd name="connsiteX28" fmla="*/ 2057934 w 4041336"/>
              <a:gd name="connsiteY28" fmla="*/ 4175733 h 4193763"/>
              <a:gd name="connsiteX29" fmla="*/ 1797729 w 4041336"/>
              <a:gd name="connsiteY29" fmla="*/ 4165547 h 4193763"/>
              <a:gd name="connsiteX30" fmla="*/ 1485458 w 4041336"/>
              <a:gd name="connsiteY30" fmla="*/ 4175995 h 4193763"/>
              <a:gd name="connsiteX31" fmla="*/ 949185 w 4041336"/>
              <a:gd name="connsiteY31" fmla="*/ 4186181 h 4193763"/>
              <a:gd name="connsiteX32" fmla="*/ 357136 w 4041336"/>
              <a:gd name="connsiteY32" fmla="*/ 4175995 h 4193763"/>
              <a:gd name="connsiteX33" fmla="*/ 0 w 4041336"/>
              <a:gd name="connsiteY33" fmla="*/ 4175060 h 41937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</a:cxnLst>
            <a:rect l="l" t="t" r="r" b="b"/>
            <a:pathLst>
              <a:path w="4041336" h="4193763">
                <a:moveTo>
                  <a:pt x="0" y="0"/>
                </a:moveTo>
                <a:lnTo>
                  <a:pt x="4019848" y="0"/>
                </a:lnTo>
                <a:lnTo>
                  <a:pt x="4021195" y="11419"/>
                </a:lnTo>
                <a:cubicBezTo>
                  <a:pt x="4036145" y="95184"/>
                  <a:pt x="4033611" y="180091"/>
                  <a:pt x="4037665" y="264364"/>
                </a:cubicBezTo>
                <a:cubicBezTo>
                  <a:pt x="4042480" y="367421"/>
                  <a:pt x="4036399" y="470858"/>
                  <a:pt x="4034118" y="574168"/>
                </a:cubicBezTo>
                <a:cubicBezTo>
                  <a:pt x="4032344" y="662121"/>
                  <a:pt x="4023602" y="749948"/>
                  <a:pt x="4026263" y="838028"/>
                </a:cubicBezTo>
                <a:cubicBezTo>
                  <a:pt x="4026453" y="841074"/>
                  <a:pt x="4026453" y="844120"/>
                  <a:pt x="4026263" y="847166"/>
                </a:cubicBezTo>
                <a:cubicBezTo>
                  <a:pt x="4018154" y="944003"/>
                  <a:pt x="4018154" y="1041348"/>
                  <a:pt x="4026263" y="1138186"/>
                </a:cubicBezTo>
                <a:cubicBezTo>
                  <a:pt x="4028835" y="1178494"/>
                  <a:pt x="4028113" y="1218943"/>
                  <a:pt x="4024109" y="1259137"/>
                </a:cubicBezTo>
                <a:cubicBezTo>
                  <a:pt x="4020308" y="1310285"/>
                  <a:pt x="4008145" y="1362194"/>
                  <a:pt x="4016887" y="1412960"/>
                </a:cubicBezTo>
                <a:cubicBezTo>
                  <a:pt x="4022576" y="1454780"/>
                  <a:pt x="4025705" y="1496916"/>
                  <a:pt x="4026263" y="1539116"/>
                </a:cubicBezTo>
                <a:cubicBezTo>
                  <a:pt x="4030697" y="1633542"/>
                  <a:pt x="4026516" y="1728475"/>
                  <a:pt x="4024869" y="1823155"/>
                </a:cubicBezTo>
                <a:cubicBezTo>
                  <a:pt x="4023095" y="1933446"/>
                  <a:pt x="4025883" y="2043737"/>
                  <a:pt x="4017014" y="2154154"/>
                </a:cubicBezTo>
                <a:cubicBezTo>
                  <a:pt x="4012136" y="2243351"/>
                  <a:pt x="4012136" y="2332751"/>
                  <a:pt x="4017014" y="2421948"/>
                </a:cubicBezTo>
                <a:cubicBezTo>
                  <a:pt x="4019421" y="2503683"/>
                  <a:pt x="4031711" y="2584656"/>
                  <a:pt x="4029684" y="2667279"/>
                </a:cubicBezTo>
                <a:cubicBezTo>
                  <a:pt x="4027276" y="2763608"/>
                  <a:pt x="4015874" y="2859684"/>
                  <a:pt x="4019421" y="2956268"/>
                </a:cubicBezTo>
                <a:cubicBezTo>
                  <a:pt x="4021068" y="3002339"/>
                  <a:pt x="4021195" y="3048410"/>
                  <a:pt x="4022082" y="3094480"/>
                </a:cubicBezTo>
                <a:cubicBezTo>
                  <a:pt x="4023222" y="3149943"/>
                  <a:pt x="4033231" y="3205278"/>
                  <a:pt x="4027656" y="3260614"/>
                </a:cubicBezTo>
                <a:cubicBezTo>
                  <a:pt x="4018408" y="3352883"/>
                  <a:pt x="3994462" y="3443628"/>
                  <a:pt x="4009412" y="3538181"/>
                </a:cubicBezTo>
                <a:cubicBezTo>
                  <a:pt x="4017647" y="3590217"/>
                  <a:pt x="4026896" y="3642380"/>
                  <a:pt x="4031711" y="3694923"/>
                </a:cubicBezTo>
                <a:cubicBezTo>
                  <a:pt x="4035892" y="3741882"/>
                  <a:pt x="4046407" y="3789603"/>
                  <a:pt x="4038425" y="3836308"/>
                </a:cubicBezTo>
                <a:cubicBezTo>
                  <a:pt x="4031584" y="3876287"/>
                  <a:pt x="4035131" y="3916266"/>
                  <a:pt x="4029810" y="3956245"/>
                </a:cubicBezTo>
                <a:cubicBezTo>
                  <a:pt x="4022842" y="4008661"/>
                  <a:pt x="4019168" y="4061966"/>
                  <a:pt x="4013847" y="4114764"/>
                </a:cubicBezTo>
                <a:lnTo>
                  <a:pt x="4010970" y="4161894"/>
                </a:lnTo>
                <a:lnTo>
                  <a:pt x="4002764" y="4161042"/>
                </a:lnTo>
                <a:cubicBezTo>
                  <a:pt x="3957904" y="4159210"/>
                  <a:pt x="3912934" y="4160186"/>
                  <a:pt x="3868108" y="4163980"/>
                </a:cubicBezTo>
                <a:cubicBezTo>
                  <a:pt x="3637072" y="4178737"/>
                  <a:pt x="3405779" y="4172076"/>
                  <a:pt x="3174741" y="4175341"/>
                </a:cubicBezTo>
                <a:cubicBezTo>
                  <a:pt x="2865668" y="4179782"/>
                  <a:pt x="2556851" y="4168420"/>
                  <a:pt x="2247906" y="4167376"/>
                </a:cubicBezTo>
                <a:cubicBezTo>
                  <a:pt x="2184582" y="4167115"/>
                  <a:pt x="2121002" y="4170510"/>
                  <a:pt x="2057934" y="4175733"/>
                </a:cubicBezTo>
                <a:cubicBezTo>
                  <a:pt x="1970560" y="4182786"/>
                  <a:pt x="1884336" y="4173905"/>
                  <a:pt x="1797729" y="4165547"/>
                </a:cubicBezTo>
                <a:cubicBezTo>
                  <a:pt x="1693340" y="4155492"/>
                  <a:pt x="1589207" y="4164372"/>
                  <a:pt x="1485458" y="4175995"/>
                </a:cubicBezTo>
                <a:cubicBezTo>
                  <a:pt x="1307344" y="4195571"/>
                  <a:pt x="1127888" y="4198979"/>
                  <a:pt x="949185" y="4186181"/>
                </a:cubicBezTo>
                <a:cubicBezTo>
                  <a:pt x="751793" y="4172468"/>
                  <a:pt x="554529" y="4174950"/>
                  <a:pt x="357136" y="4175995"/>
                </a:cubicBezTo>
                <a:lnTo>
                  <a:pt x="0" y="4175060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654296" y="329184"/>
            <a:ext cx="6894576" cy="1783080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54296" y="2706624"/>
            <a:ext cx="6894576" cy="3483864"/>
          </a:xfrm>
        </p:spPr>
        <p:txBody>
          <a:bodyPr>
            <a:normAutofit/>
          </a:bodyPr>
          <a:lstStyle>
            <a:lvl1pPr marL="0" indent="0">
              <a:buNone/>
              <a:defRPr sz="2400"/>
            </a:lvl1pPr>
            <a:lvl2pPr marL="228600">
              <a:defRPr sz="2000"/>
            </a:lvl2pPr>
            <a:lvl3pPr marL="457200">
              <a:defRPr sz="1800"/>
            </a:lvl3pPr>
            <a:lvl4pPr marL="685800">
              <a:defRPr sz="1600"/>
            </a:lvl4pPr>
            <a:lvl5pPr marL="914400">
              <a:defRPr sz="14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41080" y="6356350"/>
            <a:ext cx="2743200" cy="365125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9B1377BC-1A5F-4113-953E-30CA51FC6F91}"/>
              </a:ext>
            </a:extLst>
          </p:cNvPr>
          <p:cNvSpPr/>
          <p:nvPr userDrawn="1"/>
        </p:nvSpPr>
        <p:spPr>
          <a:xfrm>
            <a:off x="4654296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3803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CB56F624-1B75-47D6-8B9E-1F3E7840AE13}"/>
              </a:ext>
            </a:extLst>
          </p:cNvPr>
          <p:cNvSpPr>
            <a:spLocks noChangeAspect="1"/>
          </p:cNvSpPr>
          <p:nvPr userDrawn="1"/>
        </p:nvSpPr>
        <p:spPr>
          <a:xfrm>
            <a:off x="807242" y="612648"/>
            <a:ext cx="10577516" cy="5566372"/>
          </a:xfrm>
          <a:custGeom>
            <a:avLst/>
            <a:gdLst>
              <a:gd name="connsiteX0" fmla="*/ 2871593 w 10577516"/>
              <a:gd name="connsiteY0" fmla="*/ 5218333 h 5566372"/>
              <a:gd name="connsiteX1" fmla="*/ 3890441 w 10577516"/>
              <a:gd name="connsiteY1" fmla="*/ 5441298 h 5566372"/>
              <a:gd name="connsiteX2" fmla="*/ 4931282 w 10577516"/>
              <a:gd name="connsiteY2" fmla="*/ 5506891 h 5566372"/>
              <a:gd name="connsiteX3" fmla="*/ 2871593 w 10577516"/>
              <a:gd name="connsiteY3" fmla="*/ 5218333 h 5566372"/>
              <a:gd name="connsiteX4" fmla="*/ 4720395 w 10577516"/>
              <a:gd name="connsiteY4" fmla="*/ 128662 h 5566372"/>
              <a:gd name="connsiteX5" fmla="*/ 3554723 w 10577516"/>
              <a:gd name="connsiteY5" fmla="*/ 250059 h 5566372"/>
              <a:gd name="connsiteX6" fmla="*/ 2497230 w 10577516"/>
              <a:gd name="connsiteY6" fmla="*/ 530354 h 5566372"/>
              <a:gd name="connsiteX7" fmla="*/ 2960194 w 10577516"/>
              <a:gd name="connsiteY7" fmla="*/ 403237 h 5566372"/>
              <a:gd name="connsiteX8" fmla="*/ 3980314 w 10577516"/>
              <a:gd name="connsiteY8" fmla="*/ 212560 h 5566372"/>
              <a:gd name="connsiteX9" fmla="*/ 4677428 w 10577516"/>
              <a:gd name="connsiteY9" fmla="*/ 139593 h 5566372"/>
              <a:gd name="connsiteX10" fmla="*/ 4760675 w 10577516"/>
              <a:gd name="connsiteY10" fmla="*/ 134906 h 5566372"/>
              <a:gd name="connsiteX11" fmla="*/ 4792997 w 10577516"/>
              <a:gd name="connsiteY11" fmla="*/ 130123 h 5566372"/>
              <a:gd name="connsiteX12" fmla="*/ 4798006 w 10577516"/>
              <a:gd name="connsiteY12" fmla="*/ 130828 h 5566372"/>
              <a:gd name="connsiteX13" fmla="*/ 4798006 w 10577516"/>
              <a:gd name="connsiteY13" fmla="*/ 129381 h 5566372"/>
              <a:gd name="connsiteX14" fmla="*/ 4792997 w 10577516"/>
              <a:gd name="connsiteY14" fmla="*/ 130123 h 5566372"/>
              <a:gd name="connsiteX15" fmla="*/ 4788863 w 10577516"/>
              <a:gd name="connsiteY15" fmla="*/ 129541 h 5566372"/>
              <a:gd name="connsiteX16" fmla="*/ 4720395 w 10577516"/>
              <a:gd name="connsiteY16" fmla="*/ 128662 h 5566372"/>
              <a:gd name="connsiteX17" fmla="*/ 6438297 w 10577516"/>
              <a:gd name="connsiteY17" fmla="*/ 19 h 5566372"/>
              <a:gd name="connsiteX18" fmla="*/ 7523724 w 10577516"/>
              <a:gd name="connsiteY18" fmla="*/ 104129 h 5566372"/>
              <a:gd name="connsiteX19" fmla="*/ 8525668 w 10577516"/>
              <a:gd name="connsiteY19" fmla="*/ 421922 h 5566372"/>
              <a:gd name="connsiteX20" fmla="*/ 9518204 w 10577516"/>
              <a:gd name="connsiteY20" fmla="*/ 1055605 h 5566372"/>
              <a:gd name="connsiteX21" fmla="*/ 10008242 w 10577516"/>
              <a:gd name="connsiteY21" fmla="*/ 1589500 h 5566372"/>
              <a:gd name="connsiteX22" fmla="*/ 10325274 w 10577516"/>
              <a:gd name="connsiteY22" fmla="*/ 2051574 h 5566372"/>
              <a:gd name="connsiteX23" fmla="*/ 10565908 w 10577516"/>
              <a:gd name="connsiteY23" fmla="*/ 2649028 h 5566372"/>
              <a:gd name="connsiteX24" fmla="*/ 10542137 w 10577516"/>
              <a:gd name="connsiteY24" fmla="*/ 2966823 h 5566372"/>
              <a:gd name="connsiteX25" fmla="*/ 10513789 w 10577516"/>
              <a:gd name="connsiteY25" fmla="*/ 3066355 h 5566372"/>
              <a:gd name="connsiteX26" fmla="*/ 10417308 w 10577516"/>
              <a:gd name="connsiteY26" fmla="*/ 3369150 h 5566372"/>
              <a:gd name="connsiteX27" fmla="*/ 9794430 w 10577516"/>
              <a:gd name="connsiteY27" fmla="*/ 4220840 h 5566372"/>
              <a:gd name="connsiteX28" fmla="*/ 8719522 w 10577516"/>
              <a:gd name="connsiteY28" fmla="*/ 4888463 h 5566372"/>
              <a:gd name="connsiteX29" fmla="*/ 7693808 w 10577516"/>
              <a:gd name="connsiteY29" fmla="*/ 5234223 h 5566372"/>
              <a:gd name="connsiteX30" fmla="*/ 7092669 w 10577516"/>
              <a:gd name="connsiteY30" fmla="*/ 5363248 h 5566372"/>
              <a:gd name="connsiteX31" fmla="*/ 6240978 w 10577516"/>
              <a:gd name="connsiteY31" fmla="*/ 5507272 h 5566372"/>
              <a:gd name="connsiteX32" fmla="*/ 5462508 w 10577516"/>
              <a:gd name="connsiteY32" fmla="*/ 5559010 h 5566372"/>
              <a:gd name="connsiteX33" fmla="*/ 4386329 w 10577516"/>
              <a:gd name="connsiteY33" fmla="*/ 5548839 h 5566372"/>
              <a:gd name="connsiteX34" fmla="*/ 3501461 w 10577516"/>
              <a:gd name="connsiteY34" fmla="*/ 5432782 h 5566372"/>
              <a:gd name="connsiteX35" fmla="*/ 2624348 w 10577516"/>
              <a:gd name="connsiteY35" fmla="*/ 5200409 h 5566372"/>
              <a:gd name="connsiteX36" fmla="*/ 2221385 w 10577516"/>
              <a:gd name="connsiteY36" fmla="*/ 5053589 h 5566372"/>
              <a:gd name="connsiteX37" fmla="*/ 1173934 w 10577516"/>
              <a:gd name="connsiteY37" fmla="*/ 4636388 h 5566372"/>
              <a:gd name="connsiteX38" fmla="*/ 438176 w 10577516"/>
              <a:gd name="connsiteY38" fmla="*/ 4080883 h 5566372"/>
              <a:gd name="connsiteX39" fmla="*/ 18687 w 10577516"/>
              <a:gd name="connsiteY39" fmla="*/ 2942161 h 5566372"/>
              <a:gd name="connsiteX40" fmla="*/ 0 w 10577516"/>
              <a:gd name="connsiteY40" fmla="*/ 2832713 h 5566372"/>
              <a:gd name="connsiteX41" fmla="*/ 0 w 10577516"/>
              <a:gd name="connsiteY41" fmla="*/ 2747290 h 5566372"/>
              <a:gd name="connsiteX42" fmla="*/ 14746 w 10577516"/>
              <a:gd name="connsiteY42" fmla="*/ 2661993 h 5566372"/>
              <a:gd name="connsiteX43" fmla="*/ 292753 w 10577516"/>
              <a:gd name="connsiteY43" fmla="*/ 1968947 h 5566372"/>
              <a:gd name="connsiteX44" fmla="*/ 923893 w 10577516"/>
              <a:gd name="connsiteY44" fmla="*/ 1299417 h 5566372"/>
              <a:gd name="connsiteX45" fmla="*/ 2035538 w 10577516"/>
              <a:gd name="connsiteY45" fmla="*/ 648828 h 5566372"/>
              <a:gd name="connsiteX46" fmla="*/ 3545571 w 10577516"/>
              <a:gd name="connsiteY46" fmla="*/ 196289 h 5566372"/>
              <a:gd name="connsiteX47" fmla="*/ 5211705 w 10577516"/>
              <a:gd name="connsiteY47" fmla="*/ 78323 h 5566372"/>
              <a:gd name="connsiteX48" fmla="*/ 5467720 w 10577516"/>
              <a:gd name="connsiteY48" fmla="*/ 77052 h 5566372"/>
              <a:gd name="connsiteX49" fmla="*/ 6073564 w 10577516"/>
              <a:gd name="connsiteY49" fmla="*/ 11840 h 5566372"/>
              <a:gd name="connsiteX50" fmla="*/ 6438297 w 10577516"/>
              <a:gd name="connsiteY50" fmla="*/ 19 h 55663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</a:cxnLst>
            <a:rect l="l" t="t" r="r" b="b"/>
            <a:pathLst>
              <a:path w="10577516" h="5566372">
                <a:moveTo>
                  <a:pt x="2871593" y="5218333"/>
                </a:moveTo>
                <a:cubicBezTo>
                  <a:pt x="2990956" y="5269180"/>
                  <a:pt x="3517223" y="5383586"/>
                  <a:pt x="3890441" y="5441298"/>
                </a:cubicBezTo>
                <a:cubicBezTo>
                  <a:pt x="4162855" y="5483248"/>
                  <a:pt x="4828063" y="5526341"/>
                  <a:pt x="4931282" y="5506891"/>
                </a:cubicBezTo>
                <a:cubicBezTo>
                  <a:pt x="4236330" y="5449560"/>
                  <a:pt x="3552816" y="5364900"/>
                  <a:pt x="2871593" y="5218333"/>
                </a:cubicBezTo>
                <a:close/>
                <a:moveTo>
                  <a:pt x="4720395" y="128662"/>
                </a:moveTo>
                <a:cubicBezTo>
                  <a:pt x="4329266" y="138551"/>
                  <a:pt x="3939509" y="179153"/>
                  <a:pt x="3554723" y="250059"/>
                </a:cubicBezTo>
                <a:cubicBezTo>
                  <a:pt x="3195336" y="315207"/>
                  <a:pt x="2841707" y="408943"/>
                  <a:pt x="2497230" y="530354"/>
                </a:cubicBezTo>
                <a:cubicBezTo>
                  <a:pt x="2650917" y="485354"/>
                  <a:pt x="2804728" y="441372"/>
                  <a:pt x="2960194" y="403237"/>
                </a:cubicBezTo>
                <a:cubicBezTo>
                  <a:pt x="3296586" y="321538"/>
                  <a:pt x="3637121" y="257890"/>
                  <a:pt x="3980314" y="212560"/>
                </a:cubicBezTo>
                <a:cubicBezTo>
                  <a:pt x="4212050" y="181797"/>
                  <a:pt x="4444422" y="158280"/>
                  <a:pt x="4677428" y="139593"/>
                </a:cubicBezTo>
                <a:cubicBezTo>
                  <a:pt x="4704949" y="137369"/>
                  <a:pt x="4732915" y="137369"/>
                  <a:pt x="4760675" y="134906"/>
                </a:cubicBezTo>
                <a:lnTo>
                  <a:pt x="4792997" y="130123"/>
                </a:lnTo>
                <a:lnTo>
                  <a:pt x="4798006" y="130828"/>
                </a:lnTo>
                <a:lnTo>
                  <a:pt x="4798006" y="129381"/>
                </a:lnTo>
                <a:lnTo>
                  <a:pt x="4792997" y="130123"/>
                </a:lnTo>
                <a:lnTo>
                  <a:pt x="4788863" y="129541"/>
                </a:lnTo>
                <a:cubicBezTo>
                  <a:pt x="4766106" y="127801"/>
                  <a:pt x="4743237" y="127505"/>
                  <a:pt x="4720395" y="128662"/>
                </a:cubicBezTo>
                <a:close/>
                <a:moveTo>
                  <a:pt x="6438297" y="19"/>
                </a:moveTo>
                <a:cubicBezTo>
                  <a:pt x="6802322" y="-887"/>
                  <a:pt x="7164203" y="31671"/>
                  <a:pt x="7523724" y="104129"/>
                </a:cubicBezTo>
                <a:cubicBezTo>
                  <a:pt x="7868594" y="172060"/>
                  <a:pt x="8204694" y="278661"/>
                  <a:pt x="8525668" y="421922"/>
                </a:cubicBezTo>
                <a:cubicBezTo>
                  <a:pt x="8886414" y="582180"/>
                  <a:pt x="9221001" y="795802"/>
                  <a:pt x="9518204" y="1055605"/>
                </a:cubicBezTo>
                <a:cubicBezTo>
                  <a:pt x="9701176" y="1214502"/>
                  <a:pt x="9865578" y="1393612"/>
                  <a:pt x="10008242" y="1589500"/>
                </a:cubicBezTo>
                <a:cubicBezTo>
                  <a:pt x="10117308" y="1741190"/>
                  <a:pt x="10222982" y="1895218"/>
                  <a:pt x="10325274" y="2051574"/>
                </a:cubicBezTo>
                <a:cubicBezTo>
                  <a:pt x="10446215" y="2231789"/>
                  <a:pt x="10528180" y="2435291"/>
                  <a:pt x="10565908" y="2649028"/>
                </a:cubicBezTo>
                <a:cubicBezTo>
                  <a:pt x="10584595" y="2757459"/>
                  <a:pt x="10583451" y="2862839"/>
                  <a:pt x="10542137" y="2966823"/>
                </a:cubicBezTo>
                <a:cubicBezTo>
                  <a:pt x="10530023" y="2999186"/>
                  <a:pt x="10520540" y="3032466"/>
                  <a:pt x="10513789" y="3066355"/>
                </a:cubicBezTo>
                <a:cubicBezTo>
                  <a:pt x="10490298" y="3169843"/>
                  <a:pt x="10458023" y="3271142"/>
                  <a:pt x="10417308" y="3369150"/>
                </a:cubicBezTo>
                <a:cubicBezTo>
                  <a:pt x="10279257" y="3703851"/>
                  <a:pt x="10062140" y="3980714"/>
                  <a:pt x="9794430" y="4220840"/>
                </a:cubicBezTo>
                <a:cubicBezTo>
                  <a:pt x="9475364" y="4506346"/>
                  <a:pt x="9109391" y="4716599"/>
                  <a:pt x="8719522" y="4888463"/>
                </a:cubicBezTo>
                <a:cubicBezTo>
                  <a:pt x="8388126" y="5034394"/>
                  <a:pt x="8044526" y="5145368"/>
                  <a:pt x="7693808" y="5234223"/>
                </a:cubicBezTo>
                <a:cubicBezTo>
                  <a:pt x="7495123" y="5285070"/>
                  <a:pt x="7294022" y="5324223"/>
                  <a:pt x="7092669" y="5363248"/>
                </a:cubicBezTo>
                <a:cubicBezTo>
                  <a:pt x="6809577" y="5418035"/>
                  <a:pt x="6527120" y="5474730"/>
                  <a:pt x="6240978" y="5507272"/>
                </a:cubicBezTo>
                <a:cubicBezTo>
                  <a:pt x="5982166" y="5536509"/>
                  <a:pt x="5722845" y="5554814"/>
                  <a:pt x="5462508" y="5559010"/>
                </a:cubicBezTo>
                <a:cubicBezTo>
                  <a:pt x="5103782" y="5564730"/>
                  <a:pt x="4744928" y="5576298"/>
                  <a:pt x="4386329" y="5548839"/>
                </a:cubicBezTo>
                <a:cubicBezTo>
                  <a:pt x="4089394" y="5527103"/>
                  <a:pt x="3793960" y="5488344"/>
                  <a:pt x="3501461" y="5432782"/>
                </a:cubicBezTo>
                <a:cubicBezTo>
                  <a:pt x="3204247" y="5374930"/>
                  <a:pt x="2911229" y="5297299"/>
                  <a:pt x="2624348" y="5200409"/>
                </a:cubicBezTo>
                <a:cubicBezTo>
                  <a:pt x="2488841" y="5154775"/>
                  <a:pt x="2358417" y="5094775"/>
                  <a:pt x="2221385" y="5053589"/>
                </a:cubicBezTo>
                <a:cubicBezTo>
                  <a:pt x="1859988" y="4945157"/>
                  <a:pt x="1506856" y="4815878"/>
                  <a:pt x="1173934" y="4636388"/>
                </a:cubicBezTo>
                <a:cubicBezTo>
                  <a:pt x="900250" y="4488931"/>
                  <a:pt x="647539" y="4313508"/>
                  <a:pt x="438176" y="4080883"/>
                </a:cubicBezTo>
                <a:cubicBezTo>
                  <a:pt x="146695" y="3757114"/>
                  <a:pt x="3178" y="3378811"/>
                  <a:pt x="18687" y="2942161"/>
                </a:cubicBezTo>
                <a:cubicBezTo>
                  <a:pt x="19582" y="2904814"/>
                  <a:pt x="13236" y="2867645"/>
                  <a:pt x="0" y="2832713"/>
                </a:cubicBezTo>
                <a:lnTo>
                  <a:pt x="0" y="2747290"/>
                </a:lnTo>
                <a:cubicBezTo>
                  <a:pt x="13474" y="2720341"/>
                  <a:pt x="10296" y="2690468"/>
                  <a:pt x="14746" y="2661993"/>
                </a:cubicBezTo>
                <a:cubicBezTo>
                  <a:pt x="54533" y="2409665"/>
                  <a:pt x="152923" y="2181106"/>
                  <a:pt x="292753" y="1968947"/>
                </a:cubicBezTo>
                <a:cubicBezTo>
                  <a:pt x="464108" y="1708991"/>
                  <a:pt x="680970" y="1491747"/>
                  <a:pt x="923893" y="1299417"/>
                </a:cubicBezTo>
                <a:cubicBezTo>
                  <a:pt x="1263678" y="1030182"/>
                  <a:pt x="1638930" y="820945"/>
                  <a:pt x="2035538" y="648828"/>
                </a:cubicBezTo>
                <a:cubicBezTo>
                  <a:pt x="2521001" y="438575"/>
                  <a:pt x="3025660" y="291755"/>
                  <a:pt x="3545571" y="196289"/>
                </a:cubicBezTo>
                <a:cubicBezTo>
                  <a:pt x="4094899" y="95674"/>
                  <a:pt x="4653670" y="56116"/>
                  <a:pt x="5211705" y="78323"/>
                </a:cubicBezTo>
                <a:cubicBezTo>
                  <a:pt x="5297128" y="81756"/>
                  <a:pt x="5383313" y="88620"/>
                  <a:pt x="5467720" y="77052"/>
                </a:cubicBezTo>
                <a:cubicBezTo>
                  <a:pt x="5669076" y="49467"/>
                  <a:pt x="5870557" y="24299"/>
                  <a:pt x="6073564" y="11840"/>
                </a:cubicBezTo>
                <a:cubicBezTo>
                  <a:pt x="6195374" y="4340"/>
                  <a:pt x="6316955" y="320"/>
                  <a:pt x="6438297" y="19"/>
                </a:cubicBezTo>
                <a:close/>
              </a:path>
            </a:pathLst>
          </a:custGeom>
          <a:solidFill>
            <a:schemeClr val="accent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066544" y="1911096"/>
            <a:ext cx="8055864" cy="2075688"/>
          </a:xfrm>
        </p:spPr>
        <p:txBody>
          <a:bodyPr anchor="b"/>
          <a:lstStyle>
            <a:lvl1pPr algn="ctr">
              <a:defRPr sz="8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EC686F5F-8990-4C72-9CE5-9517854EA994}"/>
              </a:ext>
            </a:extLst>
          </p:cNvPr>
          <p:cNvSpPr/>
          <p:nvPr userDrawn="1"/>
        </p:nvSpPr>
        <p:spPr>
          <a:xfrm>
            <a:off x="3974206" y="417349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1BBF36E3-BC05-42D6-BE88-CFA8276D6AA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227832" y="4352544"/>
            <a:ext cx="5733288" cy="932688"/>
          </a:xfrm>
        </p:spPr>
        <p:txBody>
          <a:bodyPr/>
          <a:lstStyle>
            <a:lvl1pPr algn="ctr">
              <a:buNone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Subtitle</a:t>
            </a:r>
          </a:p>
        </p:txBody>
      </p:sp>
    </p:spTree>
    <p:extLst>
      <p:ext uri="{BB962C8B-B14F-4D97-AF65-F5344CB8AC3E}">
        <p14:creationId xmlns:p14="http://schemas.microsoft.com/office/powerpoint/2010/main" val="2915773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8096" y="365125"/>
            <a:ext cx="10515600" cy="1325563"/>
          </a:xfrm>
        </p:spPr>
        <p:txBody>
          <a:bodyPr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075688"/>
            <a:ext cx="10515600" cy="41056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7" descr="Tag=AccentColor&#10;Flavor=Light&#10;Target=FillAndLine">
            <a:extLst>
              <a:ext uri="{FF2B5EF4-FFF2-40B4-BE49-F238E27FC236}">
                <a16:creationId xmlns:a16="http://schemas.microsoft.com/office/drawing/2014/main" id="{EBDD1931-9E86-4402-9A68-33A2D9EFB198}"/>
              </a:ext>
            </a:extLst>
          </p:cNvPr>
          <p:cNvSpPr/>
          <p:nvPr/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552069 w 10515600"/>
              <a:gd name="connsiteY1" fmla="*/ 0 h 27432"/>
              <a:gd name="connsiteX2" fmla="*/ 893826 w 10515600"/>
              <a:gd name="connsiteY2" fmla="*/ 0 h 27432"/>
              <a:gd name="connsiteX3" fmla="*/ 1761363 w 10515600"/>
              <a:gd name="connsiteY3" fmla="*/ 0 h 27432"/>
              <a:gd name="connsiteX4" fmla="*/ 2313432 w 10515600"/>
              <a:gd name="connsiteY4" fmla="*/ 0 h 27432"/>
              <a:gd name="connsiteX5" fmla="*/ 2865501 w 10515600"/>
              <a:gd name="connsiteY5" fmla="*/ 0 h 27432"/>
              <a:gd name="connsiteX6" fmla="*/ 3733038 w 10515600"/>
              <a:gd name="connsiteY6" fmla="*/ 0 h 27432"/>
              <a:gd name="connsiteX7" fmla="*/ 4179951 w 10515600"/>
              <a:gd name="connsiteY7" fmla="*/ 0 h 27432"/>
              <a:gd name="connsiteX8" fmla="*/ 5047488 w 10515600"/>
              <a:gd name="connsiteY8" fmla="*/ 0 h 27432"/>
              <a:gd name="connsiteX9" fmla="*/ 5915025 w 10515600"/>
              <a:gd name="connsiteY9" fmla="*/ 0 h 27432"/>
              <a:gd name="connsiteX10" fmla="*/ 6572250 w 10515600"/>
              <a:gd name="connsiteY10" fmla="*/ 0 h 27432"/>
              <a:gd name="connsiteX11" fmla="*/ 7439787 w 10515600"/>
              <a:gd name="connsiteY11" fmla="*/ 0 h 27432"/>
              <a:gd name="connsiteX12" fmla="*/ 7991856 w 10515600"/>
              <a:gd name="connsiteY12" fmla="*/ 0 h 27432"/>
              <a:gd name="connsiteX13" fmla="*/ 8543925 w 10515600"/>
              <a:gd name="connsiteY13" fmla="*/ 0 h 27432"/>
              <a:gd name="connsiteX14" fmla="*/ 9306306 w 10515600"/>
              <a:gd name="connsiteY14" fmla="*/ 0 h 27432"/>
              <a:gd name="connsiteX15" fmla="*/ 9858375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9753219 w 10515600"/>
              <a:gd name="connsiteY18" fmla="*/ 27432 h 27432"/>
              <a:gd name="connsiteX19" fmla="*/ 9411462 w 10515600"/>
              <a:gd name="connsiteY19" fmla="*/ 27432 h 27432"/>
              <a:gd name="connsiteX20" fmla="*/ 8964549 w 10515600"/>
              <a:gd name="connsiteY20" fmla="*/ 27432 h 27432"/>
              <a:gd name="connsiteX21" fmla="*/ 8097012 w 10515600"/>
              <a:gd name="connsiteY21" fmla="*/ 27432 h 27432"/>
              <a:gd name="connsiteX22" fmla="*/ 7439787 w 10515600"/>
              <a:gd name="connsiteY22" fmla="*/ 27432 h 27432"/>
              <a:gd name="connsiteX23" fmla="*/ 6992874 w 10515600"/>
              <a:gd name="connsiteY23" fmla="*/ 27432 h 27432"/>
              <a:gd name="connsiteX24" fmla="*/ 6335649 w 10515600"/>
              <a:gd name="connsiteY24" fmla="*/ 27432 h 27432"/>
              <a:gd name="connsiteX25" fmla="*/ 5993892 w 10515600"/>
              <a:gd name="connsiteY25" fmla="*/ 27432 h 27432"/>
              <a:gd name="connsiteX26" fmla="*/ 5652135 w 10515600"/>
              <a:gd name="connsiteY26" fmla="*/ 27432 h 27432"/>
              <a:gd name="connsiteX27" fmla="*/ 4994910 w 10515600"/>
              <a:gd name="connsiteY27" fmla="*/ 27432 h 27432"/>
              <a:gd name="connsiteX28" fmla="*/ 4547997 w 10515600"/>
              <a:gd name="connsiteY28" fmla="*/ 27432 h 27432"/>
              <a:gd name="connsiteX29" fmla="*/ 3785616 w 10515600"/>
              <a:gd name="connsiteY29" fmla="*/ 27432 h 27432"/>
              <a:gd name="connsiteX30" fmla="*/ 3338703 w 10515600"/>
              <a:gd name="connsiteY30" fmla="*/ 27432 h 27432"/>
              <a:gd name="connsiteX31" fmla="*/ 2576322 w 10515600"/>
              <a:gd name="connsiteY31" fmla="*/ 27432 h 27432"/>
              <a:gd name="connsiteX32" fmla="*/ 2234565 w 10515600"/>
              <a:gd name="connsiteY32" fmla="*/ 27432 h 27432"/>
              <a:gd name="connsiteX33" fmla="*/ 1472184 w 10515600"/>
              <a:gd name="connsiteY33" fmla="*/ 27432 h 27432"/>
              <a:gd name="connsiteX34" fmla="*/ 1025271 w 10515600"/>
              <a:gd name="connsiteY34" fmla="*/ 27432 h 27432"/>
              <a:gd name="connsiteX35" fmla="*/ 683514 w 10515600"/>
              <a:gd name="connsiteY35" fmla="*/ 27432 h 27432"/>
              <a:gd name="connsiteX36" fmla="*/ 0 w 10515600"/>
              <a:gd name="connsiteY36" fmla="*/ 27432 h 27432"/>
              <a:gd name="connsiteX37" fmla="*/ 0 w 10515600"/>
              <a:gd name="connsiteY37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</a:cxnLst>
            <a:rect l="l" t="t" r="r" b="b"/>
            <a:pathLst>
              <a:path w="10515600" h="27432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noFill/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6438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76F9E1DA-21B7-46CB-A98B-FA0C2179E1DE}"/>
              </a:ext>
            </a:extLst>
          </p:cNvPr>
          <p:cNvSpPr/>
          <p:nvPr userDrawn="1"/>
        </p:nvSpPr>
        <p:spPr>
          <a:xfrm>
            <a:off x="0" y="1"/>
            <a:ext cx="12192000" cy="6054983"/>
          </a:xfrm>
          <a:custGeom>
            <a:avLst/>
            <a:gdLst>
              <a:gd name="connsiteX0" fmla="*/ 6788003 w 12188952"/>
              <a:gd name="connsiteY0" fmla="*/ 5986774 h 6054983"/>
              <a:gd name="connsiteX1" fmla="*/ 6787005 w 12188952"/>
              <a:gd name="connsiteY1" fmla="*/ 5986852 h 6054983"/>
              <a:gd name="connsiteX2" fmla="*/ 6786779 w 12188952"/>
              <a:gd name="connsiteY2" fmla="*/ 5987386 h 6054983"/>
              <a:gd name="connsiteX3" fmla="*/ 0 w 12188952"/>
              <a:gd name="connsiteY3" fmla="*/ 0 h 6054983"/>
              <a:gd name="connsiteX4" fmla="*/ 12188952 w 12188952"/>
              <a:gd name="connsiteY4" fmla="*/ 0 h 6054983"/>
              <a:gd name="connsiteX5" fmla="*/ 12188952 w 12188952"/>
              <a:gd name="connsiteY5" fmla="*/ 5092539 h 6054983"/>
              <a:gd name="connsiteX6" fmla="*/ 12058081 w 12188952"/>
              <a:gd name="connsiteY6" fmla="*/ 5131579 h 6054983"/>
              <a:gd name="connsiteX7" fmla="*/ 11673881 w 12188952"/>
              <a:gd name="connsiteY7" fmla="*/ 5235154 h 6054983"/>
              <a:gd name="connsiteX8" fmla="*/ 10422749 w 12188952"/>
              <a:gd name="connsiteY8" fmla="*/ 5518693 h 6054983"/>
              <a:gd name="connsiteX9" fmla="*/ 9421666 w 12188952"/>
              <a:gd name="connsiteY9" fmla="*/ 5693855 h 6054983"/>
              <a:gd name="connsiteX10" fmla="*/ 8456304 w 12188952"/>
              <a:gd name="connsiteY10" fmla="*/ 5827556 h 6054983"/>
              <a:gd name="connsiteX11" fmla="*/ 7714041 w 12188952"/>
              <a:gd name="connsiteY11" fmla="*/ 5907503 h 6054983"/>
              <a:gd name="connsiteX12" fmla="*/ 6949978 w 12188952"/>
              <a:gd name="connsiteY12" fmla="*/ 5973283 h 6054983"/>
              <a:gd name="connsiteX13" fmla="*/ 6934569 w 12188952"/>
              <a:gd name="connsiteY13" fmla="*/ 5975354 h 6054983"/>
              <a:gd name="connsiteX14" fmla="*/ 6788750 w 12188952"/>
              <a:gd name="connsiteY14" fmla="*/ 5986715 h 6054983"/>
              <a:gd name="connsiteX15" fmla="*/ 6798241 w 12188952"/>
              <a:gd name="connsiteY15" fmla="*/ 5988535 h 6054983"/>
              <a:gd name="connsiteX16" fmla="*/ 6833723 w 12188952"/>
              <a:gd name="connsiteY16" fmla="*/ 5986828 h 6054983"/>
              <a:gd name="connsiteX17" fmla="*/ 6882282 w 12188952"/>
              <a:gd name="connsiteY17" fmla="*/ 5983850 h 6054983"/>
              <a:gd name="connsiteX18" fmla="*/ 7576876 w 12188952"/>
              <a:gd name="connsiteY18" fmla="*/ 5951323 h 6054983"/>
              <a:gd name="connsiteX19" fmla="*/ 8621689 w 12188952"/>
              <a:gd name="connsiteY19" fmla="*/ 5864426 h 6054983"/>
              <a:gd name="connsiteX20" fmla="*/ 9477600 w 12188952"/>
              <a:gd name="connsiteY20" fmla="*/ 5760520 h 6054983"/>
              <a:gd name="connsiteX21" fmla="*/ 10626651 w 12188952"/>
              <a:gd name="connsiteY21" fmla="*/ 5566363 h 6054983"/>
              <a:gd name="connsiteX22" fmla="*/ 11995498 w 12188952"/>
              <a:gd name="connsiteY22" fmla="*/ 5240369 h 6054983"/>
              <a:gd name="connsiteX23" fmla="*/ 12188952 w 12188952"/>
              <a:gd name="connsiteY23" fmla="*/ 5183370 h 6054983"/>
              <a:gd name="connsiteX24" fmla="*/ 12188952 w 12188952"/>
              <a:gd name="connsiteY24" fmla="*/ 5238107 h 6054983"/>
              <a:gd name="connsiteX25" fmla="*/ 11826300 w 12188952"/>
              <a:gd name="connsiteY25" fmla="*/ 5343406 h 6054983"/>
              <a:gd name="connsiteX26" fmla="*/ 10936448 w 12188952"/>
              <a:gd name="connsiteY26" fmla="*/ 5557921 h 6054983"/>
              <a:gd name="connsiteX27" fmla="*/ 9983034 w 12188952"/>
              <a:gd name="connsiteY27" fmla="*/ 5737926 h 6054983"/>
              <a:gd name="connsiteX28" fmla="*/ 9184585 w 12188952"/>
              <a:gd name="connsiteY28" fmla="*/ 5853873 h 6054983"/>
              <a:gd name="connsiteX29" fmla="*/ 8576053 w 12188952"/>
              <a:gd name="connsiteY29" fmla="*/ 5923392 h 6054983"/>
              <a:gd name="connsiteX30" fmla="*/ 7862392 w 12188952"/>
              <a:gd name="connsiteY30" fmla="*/ 5984843 h 6054983"/>
              <a:gd name="connsiteX31" fmla="*/ 6933768 w 12188952"/>
              <a:gd name="connsiteY31" fmla="*/ 6036237 h 6054983"/>
              <a:gd name="connsiteX32" fmla="*/ 6476130 w 12188952"/>
              <a:gd name="connsiteY32" fmla="*/ 6050140 h 6054983"/>
              <a:gd name="connsiteX33" fmla="*/ 6360703 w 12188952"/>
              <a:gd name="connsiteY33" fmla="*/ 6054983 h 6054983"/>
              <a:gd name="connsiteX34" fmla="*/ 6055614 w 12188952"/>
              <a:gd name="connsiteY34" fmla="*/ 6054983 h 6054983"/>
              <a:gd name="connsiteX35" fmla="*/ 5976289 w 12188952"/>
              <a:gd name="connsiteY35" fmla="*/ 6050389 h 6054983"/>
              <a:gd name="connsiteX36" fmla="*/ 5263770 w 12188952"/>
              <a:gd name="connsiteY36" fmla="*/ 6014140 h 6054983"/>
              <a:gd name="connsiteX37" fmla="*/ 4345190 w 12188952"/>
              <a:gd name="connsiteY37" fmla="*/ 5952070 h 6054983"/>
              <a:gd name="connsiteX38" fmla="*/ 3372201 w 12188952"/>
              <a:gd name="connsiteY38" fmla="*/ 5853501 h 6054983"/>
              <a:gd name="connsiteX39" fmla="*/ 2361582 w 12188952"/>
              <a:gd name="connsiteY39" fmla="*/ 5734574 h 6054983"/>
              <a:gd name="connsiteX40" fmla="*/ 1232869 w 12188952"/>
              <a:gd name="connsiteY40" fmla="*/ 5561398 h 6054983"/>
              <a:gd name="connsiteX41" fmla="*/ 68483 w 12188952"/>
              <a:gd name="connsiteY41" fmla="*/ 5321691 h 6054983"/>
              <a:gd name="connsiteX42" fmla="*/ 0 w 12188952"/>
              <a:gd name="connsiteY42" fmla="*/ 5304336 h 6054983"/>
              <a:gd name="connsiteX43" fmla="*/ 0 w 12188952"/>
              <a:gd name="connsiteY43" fmla="*/ 5247847 h 6054983"/>
              <a:gd name="connsiteX44" fmla="*/ 72423 w 12188952"/>
              <a:gd name="connsiteY44" fmla="*/ 5266624 h 6054983"/>
              <a:gd name="connsiteX45" fmla="*/ 600566 w 12188952"/>
              <a:gd name="connsiteY45" fmla="*/ 5384994 h 6054983"/>
              <a:gd name="connsiteX46" fmla="*/ 1769069 w 12188952"/>
              <a:gd name="connsiteY46" fmla="*/ 5595162 h 6054983"/>
              <a:gd name="connsiteX47" fmla="*/ 2612900 w 12188952"/>
              <a:gd name="connsiteY47" fmla="*/ 5712104 h 6054983"/>
              <a:gd name="connsiteX48" fmla="*/ 2580488 w 12188952"/>
              <a:gd name="connsiteY48" fmla="*/ 5702173 h 6054983"/>
              <a:gd name="connsiteX49" fmla="*/ 1112357 w 12188952"/>
              <a:gd name="connsiteY49" fmla="*/ 5369476 h 6054983"/>
              <a:gd name="connsiteX50" fmla="*/ 420307 w 12188952"/>
              <a:gd name="connsiteY50" fmla="*/ 5170043 h 6054983"/>
              <a:gd name="connsiteX51" fmla="*/ 0 w 12188952"/>
              <a:gd name="connsiteY51" fmla="*/ 5031126 h 60549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</a:cxnLst>
            <a:rect l="l" t="t" r="r" b="b"/>
            <a:pathLst>
              <a:path w="12188952" h="6054983">
                <a:moveTo>
                  <a:pt x="6788003" y="5986774"/>
                </a:moveTo>
                <a:lnTo>
                  <a:pt x="6787005" y="5986852"/>
                </a:lnTo>
                <a:lnTo>
                  <a:pt x="6786779" y="5987386"/>
                </a:lnTo>
                <a:close/>
                <a:moveTo>
                  <a:pt x="0" y="0"/>
                </a:moveTo>
                <a:lnTo>
                  <a:pt x="12188952" y="0"/>
                </a:lnTo>
                <a:lnTo>
                  <a:pt x="12188952" y="5092539"/>
                </a:lnTo>
                <a:lnTo>
                  <a:pt x="12058081" y="5131579"/>
                </a:lnTo>
                <a:cubicBezTo>
                  <a:pt x="11930517" y="5167793"/>
                  <a:pt x="11802439" y="5202322"/>
                  <a:pt x="11673881" y="5235154"/>
                </a:cubicBezTo>
                <a:cubicBezTo>
                  <a:pt x="11259973" y="5342661"/>
                  <a:pt x="10842632" y="5436263"/>
                  <a:pt x="10422749" y="5518693"/>
                </a:cubicBezTo>
                <a:cubicBezTo>
                  <a:pt x="10090287" y="5583904"/>
                  <a:pt x="9756593" y="5642301"/>
                  <a:pt x="9421666" y="5693855"/>
                </a:cubicBezTo>
                <a:cubicBezTo>
                  <a:pt x="9100721" y="5743512"/>
                  <a:pt x="8778938" y="5788079"/>
                  <a:pt x="8456304" y="5827556"/>
                </a:cubicBezTo>
                <a:cubicBezTo>
                  <a:pt x="8209307" y="5857722"/>
                  <a:pt x="7961801" y="5883295"/>
                  <a:pt x="7714041" y="5907503"/>
                </a:cubicBezTo>
                <a:lnTo>
                  <a:pt x="6949978" y="5973283"/>
                </a:lnTo>
                <a:lnTo>
                  <a:pt x="6934569" y="5975354"/>
                </a:lnTo>
                <a:lnTo>
                  <a:pt x="6788750" y="5986715"/>
                </a:lnTo>
                <a:lnTo>
                  <a:pt x="6798241" y="5988535"/>
                </a:lnTo>
                <a:cubicBezTo>
                  <a:pt x="6809920" y="5989001"/>
                  <a:pt x="6822028" y="5986828"/>
                  <a:pt x="6833723" y="5986828"/>
                </a:cubicBezTo>
                <a:cubicBezTo>
                  <a:pt x="6849867" y="5986828"/>
                  <a:pt x="6866012" y="5984221"/>
                  <a:pt x="6882282" y="5983850"/>
                </a:cubicBezTo>
                <a:cubicBezTo>
                  <a:pt x="7114026" y="5978388"/>
                  <a:pt x="7345514" y="5966221"/>
                  <a:pt x="7576876" y="5951323"/>
                </a:cubicBezTo>
                <a:cubicBezTo>
                  <a:pt x="7925570" y="5928855"/>
                  <a:pt x="8274011" y="5900676"/>
                  <a:pt x="8621689" y="5864426"/>
                </a:cubicBezTo>
                <a:cubicBezTo>
                  <a:pt x="8907712" y="5835128"/>
                  <a:pt x="9193011" y="5800493"/>
                  <a:pt x="9477600" y="5760520"/>
                </a:cubicBezTo>
                <a:cubicBezTo>
                  <a:pt x="9862435" y="5706146"/>
                  <a:pt x="10245452" y="5641432"/>
                  <a:pt x="10626651" y="5566363"/>
                </a:cubicBezTo>
                <a:cubicBezTo>
                  <a:pt x="11087341" y="5475243"/>
                  <a:pt x="11544088" y="5367737"/>
                  <a:pt x="11995498" y="5240369"/>
                </a:cubicBezTo>
                <a:lnTo>
                  <a:pt x="12188952" y="5183370"/>
                </a:lnTo>
                <a:lnTo>
                  <a:pt x="12188952" y="5238107"/>
                </a:lnTo>
                <a:lnTo>
                  <a:pt x="11826300" y="5343406"/>
                </a:lnTo>
                <a:cubicBezTo>
                  <a:pt x="11531885" y="5423103"/>
                  <a:pt x="11235310" y="5493989"/>
                  <a:pt x="10936448" y="5557921"/>
                </a:cubicBezTo>
                <a:cubicBezTo>
                  <a:pt x="10620168" y="5625703"/>
                  <a:pt x="10302365" y="5685700"/>
                  <a:pt x="9983034" y="5737926"/>
                </a:cubicBezTo>
                <a:cubicBezTo>
                  <a:pt x="9717606" y="5781375"/>
                  <a:pt x="9451451" y="5820020"/>
                  <a:pt x="9184585" y="5853873"/>
                </a:cubicBezTo>
                <a:cubicBezTo>
                  <a:pt x="8981951" y="5879447"/>
                  <a:pt x="8779319" y="5903530"/>
                  <a:pt x="8576053" y="5923392"/>
                </a:cubicBezTo>
                <a:cubicBezTo>
                  <a:pt x="8338462" y="5946112"/>
                  <a:pt x="8100618" y="5967587"/>
                  <a:pt x="7862392" y="5984843"/>
                </a:cubicBezTo>
                <a:cubicBezTo>
                  <a:pt x="7553105" y="6007187"/>
                  <a:pt x="7243690" y="6025065"/>
                  <a:pt x="6933768" y="6036237"/>
                </a:cubicBezTo>
                <a:cubicBezTo>
                  <a:pt x="6781221" y="6041700"/>
                  <a:pt x="6628676" y="6045548"/>
                  <a:pt x="6476130" y="6050140"/>
                </a:cubicBezTo>
                <a:cubicBezTo>
                  <a:pt x="6437585" y="6048056"/>
                  <a:pt x="6398929" y="6049681"/>
                  <a:pt x="6360703" y="6054983"/>
                </a:cubicBezTo>
                <a:lnTo>
                  <a:pt x="6055614" y="6054983"/>
                </a:lnTo>
                <a:lnTo>
                  <a:pt x="5976289" y="6050389"/>
                </a:lnTo>
                <a:cubicBezTo>
                  <a:pt x="5738826" y="6037976"/>
                  <a:pt x="5501363" y="6024197"/>
                  <a:pt x="5263770" y="6014140"/>
                </a:cubicBezTo>
                <a:cubicBezTo>
                  <a:pt x="4957027" y="6001724"/>
                  <a:pt x="4650663" y="5981244"/>
                  <a:pt x="4345190" y="5952070"/>
                </a:cubicBezTo>
                <a:cubicBezTo>
                  <a:pt x="4020648" y="5921158"/>
                  <a:pt x="3696870" y="5886523"/>
                  <a:pt x="3372201" y="5853501"/>
                </a:cubicBezTo>
                <a:cubicBezTo>
                  <a:pt x="3034653" y="5819239"/>
                  <a:pt x="2697781" y="5779600"/>
                  <a:pt x="2361582" y="5734574"/>
                </a:cubicBezTo>
                <a:cubicBezTo>
                  <a:pt x="1984196" y="5684421"/>
                  <a:pt x="1607962" y="5626695"/>
                  <a:pt x="1232869" y="5561398"/>
                </a:cubicBezTo>
                <a:cubicBezTo>
                  <a:pt x="841970" y="5492685"/>
                  <a:pt x="453644" y="5414197"/>
                  <a:pt x="68483" y="5321691"/>
                </a:cubicBezTo>
                <a:lnTo>
                  <a:pt x="0" y="5304336"/>
                </a:lnTo>
                <a:lnTo>
                  <a:pt x="0" y="5247847"/>
                </a:lnTo>
                <a:lnTo>
                  <a:pt x="72423" y="5266624"/>
                </a:lnTo>
                <a:cubicBezTo>
                  <a:pt x="247899" y="5308802"/>
                  <a:pt x="424058" y="5348062"/>
                  <a:pt x="600566" y="5384994"/>
                </a:cubicBezTo>
                <a:cubicBezTo>
                  <a:pt x="988032" y="5465808"/>
                  <a:pt x="1377788" y="5534706"/>
                  <a:pt x="1769069" y="5595162"/>
                </a:cubicBezTo>
                <a:cubicBezTo>
                  <a:pt x="2051913" y="5638738"/>
                  <a:pt x="2335141" y="5678835"/>
                  <a:pt x="2612900" y="5712104"/>
                </a:cubicBezTo>
                <a:cubicBezTo>
                  <a:pt x="2604892" y="5714711"/>
                  <a:pt x="2593962" y="5704655"/>
                  <a:pt x="2580488" y="5702173"/>
                </a:cubicBezTo>
                <a:cubicBezTo>
                  <a:pt x="2086656" y="5610221"/>
                  <a:pt x="1597284" y="5499328"/>
                  <a:pt x="1112357" y="5369476"/>
                </a:cubicBezTo>
                <a:cubicBezTo>
                  <a:pt x="880233" y="5307405"/>
                  <a:pt x="649550" y="5240927"/>
                  <a:pt x="420307" y="5170043"/>
                </a:cubicBezTo>
                <a:lnTo>
                  <a:pt x="0" y="5031126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7048" y="932688"/>
            <a:ext cx="9144000" cy="2523744"/>
          </a:xfrm>
        </p:spPr>
        <p:txBody>
          <a:bodyPr anchor="b"/>
          <a:lstStyle>
            <a:lvl1pPr algn="ctr">
              <a:defRPr sz="6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474AF53-8E5D-4CC4-B341-32DDBD4237D3}"/>
              </a:ext>
            </a:extLst>
          </p:cNvPr>
          <p:cNvSpPr/>
          <p:nvPr userDrawn="1"/>
        </p:nvSpPr>
        <p:spPr>
          <a:xfrm>
            <a:off x="3974206" y="3542284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D9470D2B-C603-4551-B51F-8216C72B2DD5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1527048" y="3694176"/>
            <a:ext cx="9144000" cy="1627632"/>
          </a:xfrm>
        </p:spPr>
        <p:txBody>
          <a:bodyPr/>
          <a:lstStyle>
            <a:lvl1pPr algn="ctr">
              <a:buNone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Subtitle</a:t>
            </a:r>
          </a:p>
        </p:txBody>
      </p:sp>
    </p:spTree>
    <p:extLst>
      <p:ext uri="{BB962C8B-B14F-4D97-AF65-F5344CB8AC3E}">
        <p14:creationId xmlns:p14="http://schemas.microsoft.com/office/powerpoint/2010/main" val="3744367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a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icture Placeholder 30">
            <a:extLst>
              <a:ext uri="{FF2B5EF4-FFF2-40B4-BE49-F238E27FC236}">
                <a16:creationId xmlns:a16="http://schemas.microsoft.com/office/drawing/2014/main" id="{BCD35F50-8168-4166-90C4-6A55BA443EBF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7732109" y="3063095"/>
            <a:ext cx="1463039" cy="1479810"/>
          </a:xfrm>
          <a:custGeom>
            <a:avLst/>
            <a:gdLst>
              <a:gd name="connsiteX0" fmla="*/ 866622 w 1463039"/>
              <a:gd name="connsiteY0" fmla="*/ 571 h 1479810"/>
              <a:gd name="connsiteX1" fmla="*/ 964706 w 1463039"/>
              <a:gd name="connsiteY1" fmla="*/ 8669 h 1479810"/>
              <a:gd name="connsiteX2" fmla="*/ 1111825 w 1463039"/>
              <a:gd name="connsiteY2" fmla="*/ 8366 h 1479810"/>
              <a:gd name="connsiteX3" fmla="*/ 1290055 w 1463039"/>
              <a:gd name="connsiteY3" fmla="*/ 8730 h 1479810"/>
              <a:gd name="connsiteX4" fmla="*/ 1417397 w 1463039"/>
              <a:gd name="connsiteY4" fmla="*/ 6608 h 1479810"/>
              <a:gd name="connsiteX5" fmla="*/ 1454473 w 1463039"/>
              <a:gd name="connsiteY5" fmla="*/ 5290 h 1479810"/>
              <a:gd name="connsiteX6" fmla="*/ 1449518 w 1463039"/>
              <a:gd name="connsiteY6" fmla="*/ 94305 h 1479810"/>
              <a:gd name="connsiteX7" fmla="*/ 1454054 w 1463039"/>
              <a:gd name="connsiteY7" fmla="*/ 198723 h 1479810"/>
              <a:gd name="connsiteX8" fmla="*/ 1456615 w 1463039"/>
              <a:gd name="connsiteY8" fmla="*/ 391199 h 1479810"/>
              <a:gd name="connsiteX9" fmla="*/ 1452607 w 1463039"/>
              <a:gd name="connsiteY9" fmla="*/ 565102 h 1479810"/>
              <a:gd name="connsiteX10" fmla="*/ 1461012 w 1463039"/>
              <a:gd name="connsiteY10" fmla="*/ 624834 h 1479810"/>
              <a:gd name="connsiteX11" fmla="*/ 1451383 w 1463039"/>
              <a:gd name="connsiteY11" fmla="*/ 907022 h 1479810"/>
              <a:gd name="connsiteX12" fmla="*/ 1452663 w 1463039"/>
              <a:gd name="connsiteY12" fmla="*/ 1009694 h 1479810"/>
              <a:gd name="connsiteX13" fmla="*/ 1456002 w 1463039"/>
              <a:gd name="connsiteY13" fmla="*/ 1096988 h 1479810"/>
              <a:gd name="connsiteX14" fmla="*/ 1453720 w 1463039"/>
              <a:gd name="connsiteY14" fmla="*/ 1174562 h 1479810"/>
              <a:gd name="connsiteX15" fmla="*/ 1461722 w 1463039"/>
              <a:gd name="connsiteY15" fmla="*/ 1280018 h 1479810"/>
              <a:gd name="connsiteX16" fmla="*/ 1463039 w 1463039"/>
              <a:gd name="connsiteY16" fmla="*/ 1330769 h 1479810"/>
              <a:gd name="connsiteX17" fmla="*/ 1463039 w 1463039"/>
              <a:gd name="connsiteY17" fmla="*/ 1433804 h 1479810"/>
              <a:gd name="connsiteX18" fmla="*/ 1458897 w 1463039"/>
              <a:gd name="connsiteY18" fmla="*/ 1471900 h 1479810"/>
              <a:gd name="connsiteX19" fmla="*/ 1458306 w 1463039"/>
              <a:gd name="connsiteY19" fmla="*/ 1476109 h 1479810"/>
              <a:gd name="connsiteX20" fmla="*/ 1456251 w 1463039"/>
              <a:gd name="connsiteY20" fmla="*/ 1476006 h 1479810"/>
              <a:gd name="connsiteX21" fmla="*/ 1358699 w 1463039"/>
              <a:gd name="connsiteY21" fmla="*/ 1478795 h 1479810"/>
              <a:gd name="connsiteX22" fmla="*/ 1337088 w 1463039"/>
              <a:gd name="connsiteY22" fmla="*/ 1479810 h 1479810"/>
              <a:gd name="connsiteX23" fmla="*/ 1199842 w 1463039"/>
              <a:gd name="connsiteY23" fmla="*/ 1479810 h 1479810"/>
              <a:gd name="connsiteX24" fmla="*/ 1178285 w 1463039"/>
              <a:gd name="connsiteY24" fmla="*/ 1478795 h 1479810"/>
              <a:gd name="connsiteX25" fmla="*/ 859950 w 1463039"/>
              <a:gd name="connsiteY25" fmla="*/ 1471898 h 1479810"/>
              <a:gd name="connsiteX26" fmla="*/ 711774 w 1463039"/>
              <a:gd name="connsiteY26" fmla="*/ 1479810 h 1479810"/>
              <a:gd name="connsiteX27" fmla="*/ 637511 w 1463039"/>
              <a:gd name="connsiteY27" fmla="*/ 1479810 h 1479810"/>
              <a:gd name="connsiteX28" fmla="*/ 500700 w 1463039"/>
              <a:gd name="connsiteY28" fmla="*/ 1474455 h 1479810"/>
              <a:gd name="connsiteX29" fmla="*/ 234328 w 1463039"/>
              <a:gd name="connsiteY29" fmla="*/ 1468257 h 1479810"/>
              <a:gd name="connsiteX30" fmla="*/ 183686 w 1463039"/>
              <a:gd name="connsiteY30" fmla="*/ 1476228 h 1479810"/>
              <a:gd name="connsiteX31" fmla="*/ 157756 w 1463039"/>
              <a:gd name="connsiteY31" fmla="*/ 1479810 h 1479810"/>
              <a:gd name="connsiteX32" fmla="*/ 13214 w 1463039"/>
              <a:gd name="connsiteY32" fmla="*/ 1479810 h 1479810"/>
              <a:gd name="connsiteX33" fmla="*/ 15315 w 1463039"/>
              <a:gd name="connsiteY33" fmla="*/ 1462749 h 1479810"/>
              <a:gd name="connsiteX34" fmla="*/ 11891 w 1463039"/>
              <a:gd name="connsiteY34" fmla="*/ 1410409 h 1479810"/>
              <a:gd name="connsiteX35" fmla="*/ 6411 w 1463039"/>
              <a:gd name="connsiteY35" fmla="*/ 1244508 h 1479810"/>
              <a:gd name="connsiteX36" fmla="*/ 6849 w 1463039"/>
              <a:gd name="connsiteY36" fmla="*/ 1119455 h 1479810"/>
              <a:gd name="connsiteX37" fmla="*/ 6849 w 1463039"/>
              <a:gd name="connsiteY37" fmla="*/ 1060773 h 1479810"/>
              <a:gd name="connsiteX38" fmla="*/ 9698 w 1463039"/>
              <a:gd name="connsiteY38" fmla="*/ 982321 h 1479810"/>
              <a:gd name="connsiteX39" fmla="*/ 4219 w 1463039"/>
              <a:gd name="connsiteY39" fmla="*/ 947592 h 1479810"/>
              <a:gd name="connsiteX40" fmla="*/ 6903 w 1463039"/>
              <a:gd name="connsiteY40" fmla="*/ 858680 h 1479810"/>
              <a:gd name="connsiteX41" fmla="*/ 9808 w 1463039"/>
              <a:gd name="connsiteY41" fmla="*/ 755960 h 1479810"/>
              <a:gd name="connsiteX42" fmla="*/ 10247 w 1463039"/>
              <a:gd name="connsiteY42" fmla="*/ 673166 h 1479810"/>
              <a:gd name="connsiteX43" fmla="*/ 11452 w 1463039"/>
              <a:gd name="connsiteY43" fmla="*/ 516733 h 1479810"/>
              <a:gd name="connsiteX44" fmla="*/ 10465 w 1463039"/>
              <a:gd name="connsiteY44" fmla="*/ 425571 h 1479810"/>
              <a:gd name="connsiteX45" fmla="*/ 10465 w 1463039"/>
              <a:gd name="connsiteY45" fmla="*/ 216366 h 1479810"/>
              <a:gd name="connsiteX46" fmla="*/ 10795 w 1463039"/>
              <a:gd name="connsiteY46" fmla="*/ 104023 h 1479810"/>
              <a:gd name="connsiteX47" fmla="*/ 3534 w 1463039"/>
              <a:gd name="connsiteY47" fmla="*/ 20936 h 1479810"/>
              <a:gd name="connsiteX48" fmla="*/ 3924 w 1463039"/>
              <a:gd name="connsiteY48" fmla="*/ 8444 h 1479810"/>
              <a:gd name="connsiteX49" fmla="*/ 72291 w 1463039"/>
              <a:gd name="connsiteY49" fmla="*/ 7146 h 1479810"/>
              <a:gd name="connsiteX50" fmla="*/ 231770 w 1463039"/>
              <a:gd name="connsiteY50" fmla="*/ 4001 h 1479810"/>
              <a:gd name="connsiteX51" fmla="*/ 364602 w 1463039"/>
              <a:gd name="connsiteY51" fmla="*/ 11882 h 1479810"/>
              <a:gd name="connsiteX52" fmla="*/ 768233 w 1463039"/>
              <a:gd name="connsiteY52" fmla="*/ 2061 h 1479810"/>
              <a:gd name="connsiteX53" fmla="*/ 866622 w 1463039"/>
              <a:gd name="connsiteY53" fmla="*/ 571 h 14798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1463039" h="1479810">
                <a:moveTo>
                  <a:pt x="866622" y="571"/>
                </a:moveTo>
                <a:cubicBezTo>
                  <a:pt x="899405" y="1673"/>
                  <a:pt x="932136" y="4374"/>
                  <a:pt x="964706" y="8669"/>
                </a:cubicBezTo>
                <a:cubicBezTo>
                  <a:pt x="1013529" y="15823"/>
                  <a:pt x="1062766" y="11397"/>
                  <a:pt x="1111825" y="8366"/>
                </a:cubicBezTo>
                <a:cubicBezTo>
                  <a:pt x="1171216" y="4668"/>
                  <a:pt x="1230547" y="2667"/>
                  <a:pt x="1290055" y="8730"/>
                </a:cubicBezTo>
                <a:cubicBezTo>
                  <a:pt x="1332384" y="13094"/>
                  <a:pt x="1374949" y="9033"/>
                  <a:pt x="1417397" y="6608"/>
                </a:cubicBezTo>
                <a:lnTo>
                  <a:pt x="1454473" y="5290"/>
                </a:lnTo>
                <a:lnTo>
                  <a:pt x="1449518" y="94305"/>
                </a:lnTo>
                <a:cubicBezTo>
                  <a:pt x="1449059" y="129134"/>
                  <a:pt x="1450325" y="163951"/>
                  <a:pt x="1454054" y="198723"/>
                </a:cubicBezTo>
                <a:cubicBezTo>
                  <a:pt x="1459999" y="262767"/>
                  <a:pt x="1460856" y="327062"/>
                  <a:pt x="1456615" y="391199"/>
                </a:cubicBezTo>
                <a:cubicBezTo>
                  <a:pt x="1453665" y="449151"/>
                  <a:pt x="1446428" y="507012"/>
                  <a:pt x="1452607" y="565102"/>
                </a:cubicBezTo>
                <a:cubicBezTo>
                  <a:pt x="1454722" y="585089"/>
                  <a:pt x="1459843" y="604710"/>
                  <a:pt x="1461012" y="624834"/>
                </a:cubicBezTo>
                <a:cubicBezTo>
                  <a:pt x="1466578" y="719110"/>
                  <a:pt x="1458229" y="813066"/>
                  <a:pt x="1451383" y="907022"/>
                </a:cubicBezTo>
                <a:cubicBezTo>
                  <a:pt x="1448878" y="941246"/>
                  <a:pt x="1445816" y="975470"/>
                  <a:pt x="1452663" y="1009694"/>
                </a:cubicBezTo>
                <a:cubicBezTo>
                  <a:pt x="1458090" y="1038574"/>
                  <a:pt x="1459209" y="1067889"/>
                  <a:pt x="1456002" y="1096988"/>
                </a:cubicBezTo>
                <a:cubicBezTo>
                  <a:pt x="1452796" y="1122760"/>
                  <a:pt x="1452034" y="1148693"/>
                  <a:pt x="1453720" y="1174562"/>
                </a:cubicBezTo>
                <a:cubicBezTo>
                  <a:pt x="1457199" y="1209699"/>
                  <a:pt x="1459899" y="1244847"/>
                  <a:pt x="1461722" y="1280018"/>
                </a:cubicBezTo>
                <a:lnTo>
                  <a:pt x="1463039" y="1330769"/>
                </a:lnTo>
                <a:lnTo>
                  <a:pt x="1463039" y="1433804"/>
                </a:lnTo>
                <a:lnTo>
                  <a:pt x="1458897" y="1471900"/>
                </a:lnTo>
                <a:lnTo>
                  <a:pt x="1458306" y="1476109"/>
                </a:lnTo>
                <a:lnTo>
                  <a:pt x="1456251" y="1476006"/>
                </a:lnTo>
                <a:cubicBezTo>
                  <a:pt x="1423775" y="1477710"/>
                  <a:pt x="1391236" y="1478252"/>
                  <a:pt x="1358699" y="1478795"/>
                </a:cubicBezTo>
                <a:lnTo>
                  <a:pt x="1337088" y="1479810"/>
                </a:lnTo>
                <a:lnTo>
                  <a:pt x="1199842" y="1479810"/>
                </a:lnTo>
                <a:lnTo>
                  <a:pt x="1178285" y="1478795"/>
                </a:lnTo>
                <a:cubicBezTo>
                  <a:pt x="1072671" y="1461942"/>
                  <a:pt x="965946" y="1459625"/>
                  <a:pt x="859950" y="1471898"/>
                </a:cubicBezTo>
                <a:lnTo>
                  <a:pt x="711774" y="1479810"/>
                </a:lnTo>
                <a:lnTo>
                  <a:pt x="637511" y="1479810"/>
                </a:lnTo>
                <a:lnTo>
                  <a:pt x="500700" y="1474455"/>
                </a:lnTo>
                <a:cubicBezTo>
                  <a:pt x="412071" y="1467172"/>
                  <a:pt x="323261" y="1461748"/>
                  <a:pt x="234328" y="1468257"/>
                </a:cubicBezTo>
                <a:cubicBezTo>
                  <a:pt x="217301" y="1469536"/>
                  <a:pt x="200486" y="1472964"/>
                  <a:pt x="183686" y="1476228"/>
                </a:cubicBezTo>
                <a:lnTo>
                  <a:pt x="157756" y="1479810"/>
                </a:lnTo>
                <a:lnTo>
                  <a:pt x="13214" y="1479810"/>
                </a:lnTo>
                <a:lnTo>
                  <a:pt x="15315" y="1462749"/>
                </a:lnTo>
                <a:cubicBezTo>
                  <a:pt x="16576" y="1445267"/>
                  <a:pt x="16192" y="1427772"/>
                  <a:pt x="11891" y="1410409"/>
                </a:cubicBezTo>
                <a:cubicBezTo>
                  <a:pt x="-1809" y="1355230"/>
                  <a:pt x="931" y="1300104"/>
                  <a:pt x="6411" y="1244508"/>
                </a:cubicBezTo>
                <a:cubicBezTo>
                  <a:pt x="10521" y="1203137"/>
                  <a:pt x="15069" y="1161296"/>
                  <a:pt x="6849" y="1119455"/>
                </a:cubicBezTo>
                <a:cubicBezTo>
                  <a:pt x="3315" y="1100041"/>
                  <a:pt x="3315" y="1080187"/>
                  <a:pt x="6849" y="1060773"/>
                </a:cubicBezTo>
                <a:cubicBezTo>
                  <a:pt x="11123" y="1034622"/>
                  <a:pt x="15178" y="1008733"/>
                  <a:pt x="9698" y="982321"/>
                </a:cubicBezTo>
                <a:cubicBezTo>
                  <a:pt x="7288" y="970815"/>
                  <a:pt x="5480" y="959204"/>
                  <a:pt x="4219" y="947592"/>
                </a:cubicBezTo>
                <a:cubicBezTo>
                  <a:pt x="1709" y="917948"/>
                  <a:pt x="2608" y="888136"/>
                  <a:pt x="6903" y="858680"/>
                </a:cubicBezTo>
                <a:cubicBezTo>
                  <a:pt x="11014" y="824475"/>
                  <a:pt x="4328" y="790061"/>
                  <a:pt x="9808" y="755960"/>
                </a:cubicBezTo>
                <a:cubicBezTo>
                  <a:pt x="13699" y="728497"/>
                  <a:pt x="13847" y="700667"/>
                  <a:pt x="10247" y="673166"/>
                </a:cubicBezTo>
                <a:cubicBezTo>
                  <a:pt x="3769" y="621179"/>
                  <a:pt x="4174" y="568621"/>
                  <a:pt x="11452" y="516733"/>
                </a:cubicBezTo>
                <a:cubicBezTo>
                  <a:pt x="15946" y="486450"/>
                  <a:pt x="18521" y="455279"/>
                  <a:pt x="10465" y="425571"/>
                </a:cubicBezTo>
                <a:cubicBezTo>
                  <a:pt x="-8495" y="355749"/>
                  <a:pt x="2575" y="285822"/>
                  <a:pt x="10465" y="216366"/>
                </a:cubicBezTo>
                <a:cubicBezTo>
                  <a:pt x="15261" y="179065"/>
                  <a:pt x="15370" y="141350"/>
                  <a:pt x="10795" y="104023"/>
                </a:cubicBezTo>
                <a:cubicBezTo>
                  <a:pt x="6734" y="76457"/>
                  <a:pt x="4312" y="48717"/>
                  <a:pt x="3534" y="20936"/>
                </a:cubicBezTo>
                <a:lnTo>
                  <a:pt x="3924" y="8444"/>
                </a:lnTo>
                <a:lnTo>
                  <a:pt x="72291" y="7146"/>
                </a:lnTo>
                <a:cubicBezTo>
                  <a:pt x="125549" y="5562"/>
                  <a:pt x="178727" y="3395"/>
                  <a:pt x="231770" y="4001"/>
                </a:cubicBezTo>
                <a:cubicBezTo>
                  <a:pt x="276048" y="4486"/>
                  <a:pt x="320207" y="13579"/>
                  <a:pt x="364602" y="11882"/>
                </a:cubicBezTo>
                <a:cubicBezTo>
                  <a:pt x="499146" y="6911"/>
                  <a:pt x="633749" y="8548"/>
                  <a:pt x="768233" y="2061"/>
                </a:cubicBezTo>
                <a:cubicBezTo>
                  <a:pt x="801007" y="-37"/>
                  <a:pt x="833840" y="-532"/>
                  <a:pt x="866622" y="571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0" name="Picture Placeholder 29">
            <a:extLst>
              <a:ext uri="{FF2B5EF4-FFF2-40B4-BE49-F238E27FC236}">
                <a16:creationId xmlns:a16="http://schemas.microsoft.com/office/drawing/2014/main" id="{163C3609-48D8-42DB-AD9E-61699A6F1318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0101259" y="3064916"/>
            <a:ext cx="1442437" cy="1477990"/>
          </a:xfrm>
          <a:custGeom>
            <a:avLst/>
            <a:gdLst>
              <a:gd name="connsiteX0" fmla="*/ 866623 w 1442437"/>
              <a:gd name="connsiteY0" fmla="*/ 571 h 1477990"/>
              <a:gd name="connsiteX1" fmla="*/ 964707 w 1442437"/>
              <a:gd name="connsiteY1" fmla="*/ 8669 h 1477990"/>
              <a:gd name="connsiteX2" fmla="*/ 1111826 w 1442437"/>
              <a:gd name="connsiteY2" fmla="*/ 8366 h 1477990"/>
              <a:gd name="connsiteX3" fmla="*/ 1290056 w 1442437"/>
              <a:gd name="connsiteY3" fmla="*/ 8730 h 1477990"/>
              <a:gd name="connsiteX4" fmla="*/ 1417398 w 1442437"/>
              <a:gd name="connsiteY4" fmla="*/ 6608 h 1477990"/>
              <a:gd name="connsiteX5" fmla="*/ 1442437 w 1442437"/>
              <a:gd name="connsiteY5" fmla="*/ 5718 h 1477990"/>
              <a:gd name="connsiteX6" fmla="*/ 1442437 w 1442437"/>
              <a:gd name="connsiteY6" fmla="*/ 1476401 h 1477990"/>
              <a:gd name="connsiteX7" fmla="*/ 1386857 w 1442437"/>
              <a:gd name="connsiteY7" fmla="*/ 1477990 h 1477990"/>
              <a:gd name="connsiteX8" fmla="*/ 1169378 w 1442437"/>
              <a:gd name="connsiteY8" fmla="*/ 1477990 h 1477990"/>
              <a:gd name="connsiteX9" fmla="*/ 1019262 w 1442437"/>
              <a:gd name="connsiteY9" fmla="*/ 1464424 h 1477990"/>
              <a:gd name="connsiteX10" fmla="*/ 859951 w 1442437"/>
              <a:gd name="connsiteY10" fmla="*/ 1471898 h 1477990"/>
              <a:gd name="connsiteX11" fmla="*/ 745859 w 1442437"/>
              <a:gd name="connsiteY11" fmla="*/ 1477990 h 1477990"/>
              <a:gd name="connsiteX12" fmla="*/ 591014 w 1442437"/>
              <a:gd name="connsiteY12" fmla="*/ 1477990 h 1477990"/>
              <a:gd name="connsiteX13" fmla="*/ 500701 w 1442437"/>
              <a:gd name="connsiteY13" fmla="*/ 1474455 h 1477990"/>
              <a:gd name="connsiteX14" fmla="*/ 234329 w 1442437"/>
              <a:gd name="connsiteY14" fmla="*/ 1468257 h 1477990"/>
              <a:gd name="connsiteX15" fmla="*/ 183687 w 1442437"/>
              <a:gd name="connsiteY15" fmla="*/ 1476228 h 1477990"/>
              <a:gd name="connsiteX16" fmla="*/ 170933 w 1442437"/>
              <a:gd name="connsiteY16" fmla="*/ 1477990 h 1477990"/>
              <a:gd name="connsiteX17" fmla="*/ 13439 w 1442437"/>
              <a:gd name="connsiteY17" fmla="*/ 1477990 h 1477990"/>
              <a:gd name="connsiteX18" fmla="*/ 15316 w 1442437"/>
              <a:gd name="connsiteY18" fmla="*/ 1462749 h 1477990"/>
              <a:gd name="connsiteX19" fmla="*/ 11892 w 1442437"/>
              <a:gd name="connsiteY19" fmla="*/ 1410409 h 1477990"/>
              <a:gd name="connsiteX20" fmla="*/ 6412 w 1442437"/>
              <a:gd name="connsiteY20" fmla="*/ 1244508 h 1477990"/>
              <a:gd name="connsiteX21" fmla="*/ 6850 w 1442437"/>
              <a:gd name="connsiteY21" fmla="*/ 1119455 h 1477990"/>
              <a:gd name="connsiteX22" fmla="*/ 6850 w 1442437"/>
              <a:gd name="connsiteY22" fmla="*/ 1060773 h 1477990"/>
              <a:gd name="connsiteX23" fmla="*/ 9699 w 1442437"/>
              <a:gd name="connsiteY23" fmla="*/ 982321 h 1477990"/>
              <a:gd name="connsiteX24" fmla="*/ 4220 w 1442437"/>
              <a:gd name="connsiteY24" fmla="*/ 947592 h 1477990"/>
              <a:gd name="connsiteX25" fmla="*/ 6904 w 1442437"/>
              <a:gd name="connsiteY25" fmla="*/ 858680 h 1477990"/>
              <a:gd name="connsiteX26" fmla="*/ 9809 w 1442437"/>
              <a:gd name="connsiteY26" fmla="*/ 755960 h 1477990"/>
              <a:gd name="connsiteX27" fmla="*/ 10248 w 1442437"/>
              <a:gd name="connsiteY27" fmla="*/ 673166 h 1477990"/>
              <a:gd name="connsiteX28" fmla="*/ 11453 w 1442437"/>
              <a:gd name="connsiteY28" fmla="*/ 516733 h 1477990"/>
              <a:gd name="connsiteX29" fmla="*/ 10466 w 1442437"/>
              <a:gd name="connsiteY29" fmla="*/ 425571 h 1477990"/>
              <a:gd name="connsiteX30" fmla="*/ 10466 w 1442437"/>
              <a:gd name="connsiteY30" fmla="*/ 216366 h 1477990"/>
              <a:gd name="connsiteX31" fmla="*/ 10796 w 1442437"/>
              <a:gd name="connsiteY31" fmla="*/ 104023 h 1477990"/>
              <a:gd name="connsiteX32" fmla="*/ 3535 w 1442437"/>
              <a:gd name="connsiteY32" fmla="*/ 20936 h 1477990"/>
              <a:gd name="connsiteX33" fmla="*/ 3925 w 1442437"/>
              <a:gd name="connsiteY33" fmla="*/ 8444 h 1477990"/>
              <a:gd name="connsiteX34" fmla="*/ 72292 w 1442437"/>
              <a:gd name="connsiteY34" fmla="*/ 7146 h 1477990"/>
              <a:gd name="connsiteX35" fmla="*/ 231771 w 1442437"/>
              <a:gd name="connsiteY35" fmla="*/ 4001 h 1477990"/>
              <a:gd name="connsiteX36" fmla="*/ 364603 w 1442437"/>
              <a:gd name="connsiteY36" fmla="*/ 11882 h 1477990"/>
              <a:gd name="connsiteX37" fmla="*/ 768234 w 1442437"/>
              <a:gd name="connsiteY37" fmla="*/ 2061 h 1477990"/>
              <a:gd name="connsiteX38" fmla="*/ 866623 w 1442437"/>
              <a:gd name="connsiteY38" fmla="*/ 571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1442437" h="1477990">
                <a:moveTo>
                  <a:pt x="866623" y="571"/>
                </a:moveTo>
                <a:cubicBezTo>
                  <a:pt x="899406" y="1673"/>
                  <a:pt x="932137" y="4374"/>
                  <a:pt x="964707" y="8669"/>
                </a:cubicBezTo>
                <a:cubicBezTo>
                  <a:pt x="1013530" y="15823"/>
                  <a:pt x="1062767" y="11397"/>
                  <a:pt x="1111826" y="8366"/>
                </a:cubicBezTo>
                <a:cubicBezTo>
                  <a:pt x="1171217" y="4668"/>
                  <a:pt x="1230548" y="2667"/>
                  <a:pt x="1290056" y="8730"/>
                </a:cubicBezTo>
                <a:cubicBezTo>
                  <a:pt x="1332385" y="13094"/>
                  <a:pt x="1374950" y="9033"/>
                  <a:pt x="1417398" y="6608"/>
                </a:cubicBezTo>
                <a:lnTo>
                  <a:pt x="1442437" y="5718"/>
                </a:lnTo>
                <a:lnTo>
                  <a:pt x="1442437" y="1476401"/>
                </a:lnTo>
                <a:lnTo>
                  <a:pt x="1386857" y="1477990"/>
                </a:lnTo>
                <a:lnTo>
                  <a:pt x="1169378" y="1477990"/>
                </a:lnTo>
                <a:lnTo>
                  <a:pt x="1019262" y="1464424"/>
                </a:lnTo>
                <a:cubicBezTo>
                  <a:pt x="966129" y="1463273"/>
                  <a:pt x="912949" y="1465762"/>
                  <a:pt x="859951" y="1471898"/>
                </a:cubicBezTo>
                <a:lnTo>
                  <a:pt x="745859" y="1477990"/>
                </a:lnTo>
                <a:lnTo>
                  <a:pt x="591014" y="1477990"/>
                </a:lnTo>
                <a:lnTo>
                  <a:pt x="500701" y="1474455"/>
                </a:lnTo>
                <a:cubicBezTo>
                  <a:pt x="412072" y="1467172"/>
                  <a:pt x="323262" y="1461748"/>
                  <a:pt x="234329" y="1468257"/>
                </a:cubicBezTo>
                <a:cubicBezTo>
                  <a:pt x="217302" y="1469536"/>
                  <a:pt x="200487" y="1472964"/>
                  <a:pt x="183687" y="1476228"/>
                </a:cubicBezTo>
                <a:lnTo>
                  <a:pt x="170933" y="1477990"/>
                </a:lnTo>
                <a:lnTo>
                  <a:pt x="13439" y="1477990"/>
                </a:lnTo>
                <a:lnTo>
                  <a:pt x="15316" y="1462749"/>
                </a:lnTo>
                <a:cubicBezTo>
                  <a:pt x="16577" y="1445267"/>
                  <a:pt x="16193" y="1427772"/>
                  <a:pt x="11892" y="1410409"/>
                </a:cubicBezTo>
                <a:cubicBezTo>
                  <a:pt x="-1808" y="1355230"/>
                  <a:pt x="932" y="1300104"/>
                  <a:pt x="6412" y="1244508"/>
                </a:cubicBezTo>
                <a:cubicBezTo>
                  <a:pt x="10522" y="1203137"/>
                  <a:pt x="15070" y="1161296"/>
                  <a:pt x="6850" y="1119455"/>
                </a:cubicBezTo>
                <a:cubicBezTo>
                  <a:pt x="3316" y="1100041"/>
                  <a:pt x="3316" y="1080187"/>
                  <a:pt x="6850" y="1060773"/>
                </a:cubicBezTo>
                <a:cubicBezTo>
                  <a:pt x="11124" y="1034622"/>
                  <a:pt x="15179" y="1008733"/>
                  <a:pt x="9699" y="982321"/>
                </a:cubicBezTo>
                <a:cubicBezTo>
                  <a:pt x="7289" y="970815"/>
                  <a:pt x="5481" y="959204"/>
                  <a:pt x="4220" y="947592"/>
                </a:cubicBezTo>
                <a:cubicBezTo>
                  <a:pt x="1710" y="917948"/>
                  <a:pt x="2609" y="888136"/>
                  <a:pt x="6904" y="858680"/>
                </a:cubicBezTo>
                <a:cubicBezTo>
                  <a:pt x="11015" y="824475"/>
                  <a:pt x="4329" y="790061"/>
                  <a:pt x="9809" y="755960"/>
                </a:cubicBezTo>
                <a:cubicBezTo>
                  <a:pt x="13700" y="728497"/>
                  <a:pt x="13848" y="700667"/>
                  <a:pt x="10248" y="673166"/>
                </a:cubicBezTo>
                <a:cubicBezTo>
                  <a:pt x="3770" y="621179"/>
                  <a:pt x="4175" y="568621"/>
                  <a:pt x="11453" y="516733"/>
                </a:cubicBezTo>
                <a:cubicBezTo>
                  <a:pt x="15947" y="486450"/>
                  <a:pt x="18522" y="455279"/>
                  <a:pt x="10466" y="425571"/>
                </a:cubicBezTo>
                <a:cubicBezTo>
                  <a:pt x="-8494" y="355749"/>
                  <a:pt x="2576" y="285822"/>
                  <a:pt x="10466" y="216366"/>
                </a:cubicBezTo>
                <a:cubicBezTo>
                  <a:pt x="15262" y="179065"/>
                  <a:pt x="15371" y="141350"/>
                  <a:pt x="10796" y="104023"/>
                </a:cubicBezTo>
                <a:cubicBezTo>
                  <a:pt x="6735" y="76457"/>
                  <a:pt x="4313" y="48717"/>
                  <a:pt x="3535" y="20936"/>
                </a:cubicBezTo>
                <a:lnTo>
                  <a:pt x="3925" y="8444"/>
                </a:lnTo>
                <a:lnTo>
                  <a:pt x="72292" y="7146"/>
                </a:lnTo>
                <a:cubicBezTo>
                  <a:pt x="125550" y="5562"/>
                  <a:pt x="178728" y="3395"/>
                  <a:pt x="231771" y="4001"/>
                </a:cubicBezTo>
                <a:cubicBezTo>
                  <a:pt x="276049" y="4486"/>
                  <a:pt x="320208" y="13579"/>
                  <a:pt x="364603" y="11882"/>
                </a:cubicBezTo>
                <a:cubicBezTo>
                  <a:pt x="499147" y="6911"/>
                  <a:pt x="633750" y="8548"/>
                  <a:pt x="768234" y="2061"/>
                </a:cubicBezTo>
                <a:cubicBezTo>
                  <a:pt x="801008" y="-37"/>
                  <a:pt x="833841" y="-532"/>
                  <a:pt x="866623" y="571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8" name="Picture Placeholder 27">
            <a:extLst>
              <a:ext uri="{FF2B5EF4-FFF2-40B4-BE49-F238E27FC236}">
                <a16:creationId xmlns:a16="http://schemas.microsoft.com/office/drawing/2014/main" id="{2B03F1E7-A2BE-4059-85FC-6546945FA3FB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5370488" y="3064916"/>
            <a:ext cx="1455507" cy="1477990"/>
          </a:xfrm>
          <a:custGeom>
            <a:avLst/>
            <a:gdLst>
              <a:gd name="connsiteX0" fmla="*/ 100458 w 1455507"/>
              <a:gd name="connsiteY0" fmla="*/ 0 h 1477990"/>
              <a:gd name="connsiteX1" fmla="*/ 258284 w 1455507"/>
              <a:gd name="connsiteY1" fmla="*/ 0 h 1477990"/>
              <a:gd name="connsiteX2" fmla="*/ 290610 w 1455507"/>
              <a:gd name="connsiteY2" fmla="*/ 2318 h 1477990"/>
              <a:gd name="connsiteX3" fmla="*/ 357070 w 1455507"/>
              <a:gd name="connsiteY3" fmla="*/ 5440 h 1477990"/>
              <a:gd name="connsiteX4" fmla="*/ 558908 w 1455507"/>
              <a:gd name="connsiteY4" fmla="*/ 1098 h 1477990"/>
              <a:gd name="connsiteX5" fmla="*/ 599348 w 1455507"/>
              <a:gd name="connsiteY5" fmla="*/ 0 h 1477990"/>
              <a:gd name="connsiteX6" fmla="*/ 930201 w 1455507"/>
              <a:gd name="connsiteY6" fmla="*/ 0 h 1477990"/>
              <a:gd name="connsiteX7" fmla="*/ 957174 w 1455507"/>
              <a:gd name="connsiteY7" fmla="*/ 2227 h 1477990"/>
              <a:gd name="connsiteX8" fmla="*/ 1104293 w 1455507"/>
              <a:gd name="connsiteY8" fmla="*/ 1924 h 1477990"/>
              <a:gd name="connsiteX9" fmla="*/ 1153561 w 1455507"/>
              <a:gd name="connsiteY9" fmla="*/ 0 h 1477990"/>
              <a:gd name="connsiteX10" fmla="*/ 1229432 w 1455507"/>
              <a:gd name="connsiteY10" fmla="*/ 0 h 1477990"/>
              <a:gd name="connsiteX11" fmla="*/ 1282523 w 1455507"/>
              <a:gd name="connsiteY11" fmla="*/ 2288 h 1477990"/>
              <a:gd name="connsiteX12" fmla="*/ 1409865 w 1455507"/>
              <a:gd name="connsiteY12" fmla="*/ 166 h 1477990"/>
              <a:gd name="connsiteX13" fmla="*/ 1414535 w 1455507"/>
              <a:gd name="connsiteY13" fmla="*/ 0 h 1477990"/>
              <a:gd name="connsiteX14" fmla="*/ 1446877 w 1455507"/>
              <a:gd name="connsiteY14" fmla="*/ 0 h 1477990"/>
              <a:gd name="connsiteX15" fmla="*/ 1441986 w 1455507"/>
              <a:gd name="connsiteY15" fmla="*/ 87863 h 1477990"/>
              <a:gd name="connsiteX16" fmla="*/ 1446522 w 1455507"/>
              <a:gd name="connsiteY16" fmla="*/ 192281 h 1477990"/>
              <a:gd name="connsiteX17" fmla="*/ 1449083 w 1455507"/>
              <a:gd name="connsiteY17" fmla="*/ 384757 h 1477990"/>
              <a:gd name="connsiteX18" fmla="*/ 1445075 w 1455507"/>
              <a:gd name="connsiteY18" fmla="*/ 558660 h 1477990"/>
              <a:gd name="connsiteX19" fmla="*/ 1453480 w 1455507"/>
              <a:gd name="connsiteY19" fmla="*/ 618392 h 1477990"/>
              <a:gd name="connsiteX20" fmla="*/ 1443851 w 1455507"/>
              <a:gd name="connsiteY20" fmla="*/ 900580 h 1477990"/>
              <a:gd name="connsiteX21" fmla="*/ 1445131 w 1455507"/>
              <a:gd name="connsiteY21" fmla="*/ 1003252 h 1477990"/>
              <a:gd name="connsiteX22" fmla="*/ 1448470 w 1455507"/>
              <a:gd name="connsiteY22" fmla="*/ 1090546 h 1477990"/>
              <a:gd name="connsiteX23" fmla="*/ 1446188 w 1455507"/>
              <a:gd name="connsiteY23" fmla="*/ 1168120 h 1477990"/>
              <a:gd name="connsiteX24" fmla="*/ 1454190 w 1455507"/>
              <a:gd name="connsiteY24" fmla="*/ 1273576 h 1477990"/>
              <a:gd name="connsiteX25" fmla="*/ 1455507 w 1455507"/>
              <a:gd name="connsiteY25" fmla="*/ 1324327 h 1477990"/>
              <a:gd name="connsiteX26" fmla="*/ 1455507 w 1455507"/>
              <a:gd name="connsiteY26" fmla="*/ 1427362 h 1477990"/>
              <a:gd name="connsiteX27" fmla="*/ 1451365 w 1455507"/>
              <a:gd name="connsiteY27" fmla="*/ 1465458 h 1477990"/>
              <a:gd name="connsiteX28" fmla="*/ 1450774 w 1455507"/>
              <a:gd name="connsiteY28" fmla="*/ 1469667 h 1477990"/>
              <a:gd name="connsiteX29" fmla="*/ 1448719 w 1455507"/>
              <a:gd name="connsiteY29" fmla="*/ 1469564 h 1477990"/>
              <a:gd name="connsiteX30" fmla="*/ 1351167 w 1455507"/>
              <a:gd name="connsiteY30" fmla="*/ 1472353 h 1477990"/>
              <a:gd name="connsiteX31" fmla="*/ 1170753 w 1455507"/>
              <a:gd name="connsiteY31" fmla="*/ 1472353 h 1477990"/>
              <a:gd name="connsiteX32" fmla="*/ 852418 w 1455507"/>
              <a:gd name="connsiteY32" fmla="*/ 1465456 h 1477990"/>
              <a:gd name="connsiteX33" fmla="*/ 493168 w 1455507"/>
              <a:gd name="connsiteY33" fmla="*/ 1468013 h 1477990"/>
              <a:gd name="connsiteX34" fmla="*/ 226796 w 1455507"/>
              <a:gd name="connsiteY34" fmla="*/ 1461815 h 1477990"/>
              <a:gd name="connsiteX35" fmla="*/ 125602 w 1455507"/>
              <a:gd name="connsiteY35" fmla="*/ 1476769 h 1477990"/>
              <a:gd name="connsiteX36" fmla="*/ 5112 w 1455507"/>
              <a:gd name="connsiteY36" fmla="*/ 1477990 h 1477990"/>
              <a:gd name="connsiteX37" fmla="*/ 7783 w 1455507"/>
              <a:gd name="connsiteY37" fmla="*/ 1456307 h 1477990"/>
              <a:gd name="connsiteX38" fmla="*/ 4359 w 1455507"/>
              <a:gd name="connsiteY38" fmla="*/ 1403967 h 1477990"/>
              <a:gd name="connsiteX39" fmla="*/ 295 w 1455507"/>
              <a:gd name="connsiteY39" fmla="*/ 1370091 h 1477990"/>
              <a:gd name="connsiteX40" fmla="*/ 295 w 1455507"/>
              <a:gd name="connsiteY40" fmla="*/ 1219835 h 1477990"/>
              <a:gd name="connsiteX41" fmla="*/ 3722 w 1455507"/>
              <a:gd name="connsiteY41" fmla="*/ 1175716 h 1477990"/>
              <a:gd name="connsiteX42" fmla="*/ 295 w 1455507"/>
              <a:gd name="connsiteY42" fmla="*/ 1126935 h 1477990"/>
              <a:gd name="connsiteX43" fmla="*/ 295 w 1455507"/>
              <a:gd name="connsiteY43" fmla="*/ 1046801 h 1477990"/>
              <a:gd name="connsiteX44" fmla="*/ 4400 w 1455507"/>
              <a:gd name="connsiteY44" fmla="*/ 1015203 h 1477990"/>
              <a:gd name="connsiteX45" fmla="*/ 2166 w 1455507"/>
              <a:gd name="connsiteY45" fmla="*/ 975879 h 1477990"/>
              <a:gd name="connsiteX46" fmla="*/ 295 w 1455507"/>
              <a:gd name="connsiteY46" fmla="*/ 964020 h 1477990"/>
              <a:gd name="connsiteX47" fmla="*/ 295 w 1455507"/>
              <a:gd name="connsiteY47" fmla="*/ 801667 h 1477990"/>
              <a:gd name="connsiteX48" fmla="*/ 310 w 1455507"/>
              <a:gd name="connsiteY48" fmla="*/ 800839 h 1477990"/>
              <a:gd name="connsiteX49" fmla="*/ 2276 w 1455507"/>
              <a:gd name="connsiteY49" fmla="*/ 749518 h 1477990"/>
              <a:gd name="connsiteX50" fmla="*/ 2715 w 1455507"/>
              <a:gd name="connsiteY50" fmla="*/ 666724 h 1477990"/>
              <a:gd name="connsiteX51" fmla="*/ 295 w 1455507"/>
              <a:gd name="connsiteY51" fmla="*/ 625158 h 1477990"/>
              <a:gd name="connsiteX52" fmla="*/ 295 w 1455507"/>
              <a:gd name="connsiteY52" fmla="*/ 559484 h 1477990"/>
              <a:gd name="connsiteX53" fmla="*/ 3920 w 1455507"/>
              <a:gd name="connsiteY53" fmla="*/ 510291 h 1477990"/>
              <a:gd name="connsiteX54" fmla="*/ 2933 w 1455507"/>
              <a:gd name="connsiteY54" fmla="*/ 419129 h 1477990"/>
              <a:gd name="connsiteX55" fmla="*/ 295 w 1455507"/>
              <a:gd name="connsiteY55" fmla="*/ 403959 h 1477990"/>
              <a:gd name="connsiteX56" fmla="*/ 295 w 1455507"/>
              <a:gd name="connsiteY56" fmla="*/ 237294 h 1477990"/>
              <a:gd name="connsiteX57" fmla="*/ 2933 w 1455507"/>
              <a:gd name="connsiteY57" fmla="*/ 209924 h 1477990"/>
              <a:gd name="connsiteX58" fmla="*/ 3263 w 1455507"/>
              <a:gd name="connsiteY58" fmla="*/ 97581 h 1477990"/>
              <a:gd name="connsiteX59" fmla="*/ 295 w 1455507"/>
              <a:gd name="connsiteY59" fmla="*/ 63619 h 1477990"/>
              <a:gd name="connsiteX60" fmla="*/ 295 w 1455507"/>
              <a:gd name="connsiteY60" fmla="*/ 1928 h 1477990"/>
              <a:gd name="connsiteX61" fmla="*/ 64759 w 1455507"/>
              <a:gd name="connsiteY61" fmla="*/ 704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1455507" h="1477990">
                <a:moveTo>
                  <a:pt x="100458" y="0"/>
                </a:moveTo>
                <a:lnTo>
                  <a:pt x="258284" y="0"/>
                </a:lnTo>
                <a:lnTo>
                  <a:pt x="290610" y="2318"/>
                </a:lnTo>
                <a:cubicBezTo>
                  <a:pt x="312734" y="4440"/>
                  <a:pt x="334873" y="6289"/>
                  <a:pt x="357070" y="5440"/>
                </a:cubicBezTo>
                <a:cubicBezTo>
                  <a:pt x="424342" y="2955"/>
                  <a:pt x="491629" y="2121"/>
                  <a:pt x="558908" y="1098"/>
                </a:cubicBezTo>
                <a:lnTo>
                  <a:pt x="599348" y="0"/>
                </a:lnTo>
                <a:lnTo>
                  <a:pt x="930201" y="0"/>
                </a:lnTo>
                <a:lnTo>
                  <a:pt x="957174" y="2227"/>
                </a:lnTo>
                <a:cubicBezTo>
                  <a:pt x="1005997" y="9381"/>
                  <a:pt x="1055234" y="4955"/>
                  <a:pt x="1104293" y="1924"/>
                </a:cubicBezTo>
                <a:lnTo>
                  <a:pt x="1153561" y="0"/>
                </a:lnTo>
                <a:lnTo>
                  <a:pt x="1229432" y="0"/>
                </a:lnTo>
                <a:lnTo>
                  <a:pt x="1282523" y="2288"/>
                </a:lnTo>
                <a:cubicBezTo>
                  <a:pt x="1324852" y="6652"/>
                  <a:pt x="1367417" y="2591"/>
                  <a:pt x="1409865" y="166"/>
                </a:cubicBezTo>
                <a:lnTo>
                  <a:pt x="1414535" y="0"/>
                </a:lnTo>
                <a:lnTo>
                  <a:pt x="1446877" y="0"/>
                </a:lnTo>
                <a:lnTo>
                  <a:pt x="1441986" y="87863"/>
                </a:lnTo>
                <a:cubicBezTo>
                  <a:pt x="1441527" y="122692"/>
                  <a:pt x="1442793" y="157509"/>
                  <a:pt x="1446522" y="192281"/>
                </a:cubicBezTo>
                <a:cubicBezTo>
                  <a:pt x="1452467" y="256325"/>
                  <a:pt x="1453324" y="320620"/>
                  <a:pt x="1449083" y="384757"/>
                </a:cubicBezTo>
                <a:cubicBezTo>
                  <a:pt x="1446133" y="442709"/>
                  <a:pt x="1438896" y="500570"/>
                  <a:pt x="1445075" y="558660"/>
                </a:cubicBezTo>
                <a:cubicBezTo>
                  <a:pt x="1447190" y="578647"/>
                  <a:pt x="1452311" y="598268"/>
                  <a:pt x="1453480" y="618392"/>
                </a:cubicBezTo>
                <a:cubicBezTo>
                  <a:pt x="1459046" y="712668"/>
                  <a:pt x="1450697" y="806624"/>
                  <a:pt x="1443851" y="900580"/>
                </a:cubicBezTo>
                <a:cubicBezTo>
                  <a:pt x="1441346" y="934804"/>
                  <a:pt x="1438284" y="969028"/>
                  <a:pt x="1445131" y="1003252"/>
                </a:cubicBezTo>
                <a:cubicBezTo>
                  <a:pt x="1450558" y="1032132"/>
                  <a:pt x="1451677" y="1061447"/>
                  <a:pt x="1448470" y="1090546"/>
                </a:cubicBezTo>
                <a:cubicBezTo>
                  <a:pt x="1445264" y="1116318"/>
                  <a:pt x="1444502" y="1142251"/>
                  <a:pt x="1446188" y="1168120"/>
                </a:cubicBezTo>
                <a:cubicBezTo>
                  <a:pt x="1449667" y="1203257"/>
                  <a:pt x="1452367" y="1238405"/>
                  <a:pt x="1454190" y="1273576"/>
                </a:cubicBezTo>
                <a:lnTo>
                  <a:pt x="1455507" y="1324327"/>
                </a:lnTo>
                <a:lnTo>
                  <a:pt x="1455507" y="1427362"/>
                </a:lnTo>
                <a:lnTo>
                  <a:pt x="1451365" y="1465458"/>
                </a:lnTo>
                <a:lnTo>
                  <a:pt x="1450774" y="1469667"/>
                </a:lnTo>
                <a:lnTo>
                  <a:pt x="1448719" y="1469564"/>
                </a:lnTo>
                <a:cubicBezTo>
                  <a:pt x="1416243" y="1471268"/>
                  <a:pt x="1383704" y="1471810"/>
                  <a:pt x="1351167" y="1472353"/>
                </a:cubicBezTo>
                <a:cubicBezTo>
                  <a:pt x="1291009" y="1473360"/>
                  <a:pt x="1230608" y="1482658"/>
                  <a:pt x="1170753" y="1472353"/>
                </a:cubicBezTo>
                <a:cubicBezTo>
                  <a:pt x="1065139" y="1455500"/>
                  <a:pt x="958414" y="1453183"/>
                  <a:pt x="852418" y="1465456"/>
                </a:cubicBezTo>
                <a:cubicBezTo>
                  <a:pt x="732873" y="1477389"/>
                  <a:pt x="612811" y="1478242"/>
                  <a:pt x="493168" y="1468013"/>
                </a:cubicBezTo>
                <a:cubicBezTo>
                  <a:pt x="404539" y="1460730"/>
                  <a:pt x="315729" y="1455306"/>
                  <a:pt x="226796" y="1461815"/>
                </a:cubicBezTo>
                <a:cubicBezTo>
                  <a:pt x="192742" y="1464372"/>
                  <a:pt x="159536" y="1475530"/>
                  <a:pt x="125602" y="1476769"/>
                </a:cubicBezTo>
                <a:lnTo>
                  <a:pt x="5112" y="1477990"/>
                </a:lnTo>
                <a:lnTo>
                  <a:pt x="7783" y="1456307"/>
                </a:lnTo>
                <a:cubicBezTo>
                  <a:pt x="9044" y="1438825"/>
                  <a:pt x="8660" y="1421330"/>
                  <a:pt x="4359" y="1403967"/>
                </a:cubicBezTo>
                <a:lnTo>
                  <a:pt x="295" y="1370091"/>
                </a:lnTo>
                <a:lnTo>
                  <a:pt x="295" y="1219835"/>
                </a:lnTo>
                <a:lnTo>
                  <a:pt x="3722" y="1175716"/>
                </a:lnTo>
                <a:lnTo>
                  <a:pt x="295" y="1126935"/>
                </a:lnTo>
                <a:lnTo>
                  <a:pt x="295" y="1046801"/>
                </a:lnTo>
                <a:lnTo>
                  <a:pt x="4400" y="1015203"/>
                </a:lnTo>
                <a:cubicBezTo>
                  <a:pt x="5263" y="1002160"/>
                  <a:pt x="4906" y="989085"/>
                  <a:pt x="2166" y="975879"/>
                </a:cubicBezTo>
                <a:lnTo>
                  <a:pt x="295" y="964020"/>
                </a:lnTo>
                <a:lnTo>
                  <a:pt x="295" y="801667"/>
                </a:lnTo>
                <a:lnTo>
                  <a:pt x="310" y="800839"/>
                </a:lnTo>
                <a:cubicBezTo>
                  <a:pt x="-163" y="783697"/>
                  <a:pt x="-464" y="766569"/>
                  <a:pt x="2276" y="749518"/>
                </a:cubicBezTo>
                <a:cubicBezTo>
                  <a:pt x="6167" y="722055"/>
                  <a:pt x="6315" y="694225"/>
                  <a:pt x="2715" y="666724"/>
                </a:cubicBezTo>
                <a:lnTo>
                  <a:pt x="295" y="625158"/>
                </a:lnTo>
                <a:lnTo>
                  <a:pt x="295" y="559484"/>
                </a:lnTo>
                <a:lnTo>
                  <a:pt x="3920" y="510291"/>
                </a:lnTo>
                <a:cubicBezTo>
                  <a:pt x="8414" y="480008"/>
                  <a:pt x="10989" y="448837"/>
                  <a:pt x="2933" y="419129"/>
                </a:cubicBezTo>
                <a:lnTo>
                  <a:pt x="295" y="403959"/>
                </a:lnTo>
                <a:lnTo>
                  <a:pt x="295" y="237294"/>
                </a:lnTo>
                <a:lnTo>
                  <a:pt x="2933" y="209924"/>
                </a:lnTo>
                <a:cubicBezTo>
                  <a:pt x="7729" y="172623"/>
                  <a:pt x="7838" y="134908"/>
                  <a:pt x="3263" y="97581"/>
                </a:cubicBezTo>
                <a:lnTo>
                  <a:pt x="295" y="63619"/>
                </a:lnTo>
                <a:lnTo>
                  <a:pt x="295" y="1928"/>
                </a:lnTo>
                <a:lnTo>
                  <a:pt x="64759" y="704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7" name="Picture Placeholder 26">
            <a:extLst>
              <a:ext uri="{FF2B5EF4-FFF2-40B4-BE49-F238E27FC236}">
                <a16:creationId xmlns:a16="http://schemas.microsoft.com/office/drawing/2014/main" id="{C62C212D-2434-4610-A983-7FC587B517B4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3009627" y="3064916"/>
            <a:ext cx="1447216" cy="1477990"/>
          </a:xfrm>
          <a:custGeom>
            <a:avLst/>
            <a:gdLst>
              <a:gd name="connsiteX0" fmla="*/ 107991 w 1447216"/>
              <a:gd name="connsiteY0" fmla="*/ 0 h 1477990"/>
              <a:gd name="connsiteX1" fmla="*/ 265817 w 1447216"/>
              <a:gd name="connsiteY1" fmla="*/ 0 h 1477990"/>
              <a:gd name="connsiteX2" fmla="*/ 298143 w 1447216"/>
              <a:gd name="connsiteY2" fmla="*/ 2318 h 1477990"/>
              <a:gd name="connsiteX3" fmla="*/ 364603 w 1447216"/>
              <a:gd name="connsiteY3" fmla="*/ 5440 h 1477990"/>
              <a:gd name="connsiteX4" fmla="*/ 566441 w 1447216"/>
              <a:gd name="connsiteY4" fmla="*/ 1098 h 1477990"/>
              <a:gd name="connsiteX5" fmla="*/ 606880 w 1447216"/>
              <a:gd name="connsiteY5" fmla="*/ 0 h 1477990"/>
              <a:gd name="connsiteX6" fmla="*/ 937733 w 1447216"/>
              <a:gd name="connsiteY6" fmla="*/ 0 h 1477990"/>
              <a:gd name="connsiteX7" fmla="*/ 964707 w 1447216"/>
              <a:gd name="connsiteY7" fmla="*/ 2227 h 1477990"/>
              <a:gd name="connsiteX8" fmla="*/ 1111826 w 1447216"/>
              <a:gd name="connsiteY8" fmla="*/ 1924 h 1477990"/>
              <a:gd name="connsiteX9" fmla="*/ 1161094 w 1447216"/>
              <a:gd name="connsiteY9" fmla="*/ 0 h 1477990"/>
              <a:gd name="connsiteX10" fmla="*/ 1236965 w 1447216"/>
              <a:gd name="connsiteY10" fmla="*/ 0 h 1477990"/>
              <a:gd name="connsiteX11" fmla="*/ 1290056 w 1447216"/>
              <a:gd name="connsiteY11" fmla="*/ 2288 h 1477990"/>
              <a:gd name="connsiteX12" fmla="*/ 1417398 w 1447216"/>
              <a:gd name="connsiteY12" fmla="*/ 166 h 1477990"/>
              <a:gd name="connsiteX13" fmla="*/ 1422068 w 1447216"/>
              <a:gd name="connsiteY13" fmla="*/ 0 h 1477990"/>
              <a:gd name="connsiteX14" fmla="*/ 1447216 w 1447216"/>
              <a:gd name="connsiteY14" fmla="*/ 0 h 1477990"/>
              <a:gd name="connsiteX15" fmla="*/ 1447216 w 1447216"/>
              <a:gd name="connsiteY15" fmla="*/ 1469823 h 1477990"/>
              <a:gd name="connsiteX16" fmla="*/ 1358700 w 1447216"/>
              <a:gd name="connsiteY16" fmla="*/ 1472353 h 1477990"/>
              <a:gd name="connsiteX17" fmla="*/ 1178286 w 1447216"/>
              <a:gd name="connsiteY17" fmla="*/ 1472353 h 1477990"/>
              <a:gd name="connsiteX18" fmla="*/ 859951 w 1447216"/>
              <a:gd name="connsiteY18" fmla="*/ 1465456 h 1477990"/>
              <a:gd name="connsiteX19" fmla="*/ 500701 w 1447216"/>
              <a:gd name="connsiteY19" fmla="*/ 1468013 h 1477990"/>
              <a:gd name="connsiteX20" fmla="*/ 234329 w 1447216"/>
              <a:gd name="connsiteY20" fmla="*/ 1461815 h 1477990"/>
              <a:gd name="connsiteX21" fmla="*/ 133135 w 1447216"/>
              <a:gd name="connsiteY21" fmla="*/ 1476769 h 1477990"/>
              <a:gd name="connsiteX22" fmla="*/ 12645 w 1447216"/>
              <a:gd name="connsiteY22" fmla="*/ 1477990 h 1477990"/>
              <a:gd name="connsiteX23" fmla="*/ 15316 w 1447216"/>
              <a:gd name="connsiteY23" fmla="*/ 1456307 h 1477990"/>
              <a:gd name="connsiteX24" fmla="*/ 11892 w 1447216"/>
              <a:gd name="connsiteY24" fmla="*/ 1403967 h 1477990"/>
              <a:gd name="connsiteX25" fmla="*/ 6412 w 1447216"/>
              <a:gd name="connsiteY25" fmla="*/ 1238066 h 1477990"/>
              <a:gd name="connsiteX26" fmla="*/ 6850 w 1447216"/>
              <a:gd name="connsiteY26" fmla="*/ 1113013 h 1477990"/>
              <a:gd name="connsiteX27" fmla="*/ 6850 w 1447216"/>
              <a:gd name="connsiteY27" fmla="*/ 1054331 h 1477990"/>
              <a:gd name="connsiteX28" fmla="*/ 9699 w 1447216"/>
              <a:gd name="connsiteY28" fmla="*/ 975879 h 1477990"/>
              <a:gd name="connsiteX29" fmla="*/ 4220 w 1447216"/>
              <a:gd name="connsiteY29" fmla="*/ 941150 h 1477990"/>
              <a:gd name="connsiteX30" fmla="*/ 6904 w 1447216"/>
              <a:gd name="connsiteY30" fmla="*/ 852238 h 1477990"/>
              <a:gd name="connsiteX31" fmla="*/ 9809 w 1447216"/>
              <a:gd name="connsiteY31" fmla="*/ 749518 h 1477990"/>
              <a:gd name="connsiteX32" fmla="*/ 10248 w 1447216"/>
              <a:gd name="connsiteY32" fmla="*/ 666724 h 1477990"/>
              <a:gd name="connsiteX33" fmla="*/ 11453 w 1447216"/>
              <a:gd name="connsiteY33" fmla="*/ 510291 h 1477990"/>
              <a:gd name="connsiteX34" fmla="*/ 10466 w 1447216"/>
              <a:gd name="connsiteY34" fmla="*/ 419129 h 1477990"/>
              <a:gd name="connsiteX35" fmla="*/ 10466 w 1447216"/>
              <a:gd name="connsiteY35" fmla="*/ 209924 h 1477990"/>
              <a:gd name="connsiteX36" fmla="*/ 10796 w 1447216"/>
              <a:gd name="connsiteY36" fmla="*/ 97581 h 1477990"/>
              <a:gd name="connsiteX37" fmla="*/ 3535 w 1447216"/>
              <a:gd name="connsiteY37" fmla="*/ 14494 h 1477990"/>
              <a:gd name="connsiteX38" fmla="*/ 3925 w 1447216"/>
              <a:gd name="connsiteY38" fmla="*/ 2002 h 1477990"/>
              <a:gd name="connsiteX39" fmla="*/ 72292 w 1447216"/>
              <a:gd name="connsiteY39" fmla="*/ 704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</a:cxnLst>
            <a:rect l="l" t="t" r="r" b="b"/>
            <a:pathLst>
              <a:path w="1447216" h="1477990">
                <a:moveTo>
                  <a:pt x="107991" y="0"/>
                </a:moveTo>
                <a:lnTo>
                  <a:pt x="265817" y="0"/>
                </a:lnTo>
                <a:lnTo>
                  <a:pt x="298143" y="2318"/>
                </a:lnTo>
                <a:cubicBezTo>
                  <a:pt x="320267" y="4440"/>
                  <a:pt x="342406" y="6289"/>
                  <a:pt x="364603" y="5440"/>
                </a:cubicBezTo>
                <a:cubicBezTo>
                  <a:pt x="431875" y="2955"/>
                  <a:pt x="499162" y="2121"/>
                  <a:pt x="566441" y="1098"/>
                </a:cubicBezTo>
                <a:lnTo>
                  <a:pt x="606880" y="0"/>
                </a:lnTo>
                <a:lnTo>
                  <a:pt x="937733" y="0"/>
                </a:lnTo>
                <a:lnTo>
                  <a:pt x="964707" y="2227"/>
                </a:lnTo>
                <a:cubicBezTo>
                  <a:pt x="1013530" y="9381"/>
                  <a:pt x="1062767" y="4955"/>
                  <a:pt x="1111826" y="1924"/>
                </a:cubicBezTo>
                <a:lnTo>
                  <a:pt x="1161094" y="0"/>
                </a:lnTo>
                <a:lnTo>
                  <a:pt x="1236965" y="0"/>
                </a:lnTo>
                <a:lnTo>
                  <a:pt x="1290056" y="2288"/>
                </a:lnTo>
                <a:cubicBezTo>
                  <a:pt x="1332385" y="6652"/>
                  <a:pt x="1374950" y="2591"/>
                  <a:pt x="1417398" y="166"/>
                </a:cubicBezTo>
                <a:lnTo>
                  <a:pt x="1422068" y="0"/>
                </a:lnTo>
                <a:lnTo>
                  <a:pt x="1447216" y="0"/>
                </a:lnTo>
                <a:lnTo>
                  <a:pt x="1447216" y="1469823"/>
                </a:lnTo>
                <a:lnTo>
                  <a:pt x="1358700" y="1472353"/>
                </a:lnTo>
                <a:cubicBezTo>
                  <a:pt x="1298542" y="1473360"/>
                  <a:pt x="1238141" y="1482658"/>
                  <a:pt x="1178286" y="1472353"/>
                </a:cubicBezTo>
                <a:cubicBezTo>
                  <a:pt x="1072672" y="1455500"/>
                  <a:pt x="965947" y="1453183"/>
                  <a:pt x="859951" y="1465456"/>
                </a:cubicBezTo>
                <a:cubicBezTo>
                  <a:pt x="740406" y="1477389"/>
                  <a:pt x="620344" y="1478242"/>
                  <a:pt x="500701" y="1468013"/>
                </a:cubicBezTo>
                <a:cubicBezTo>
                  <a:pt x="412072" y="1460730"/>
                  <a:pt x="323262" y="1455306"/>
                  <a:pt x="234329" y="1461815"/>
                </a:cubicBezTo>
                <a:cubicBezTo>
                  <a:pt x="200275" y="1464372"/>
                  <a:pt x="167069" y="1475530"/>
                  <a:pt x="133135" y="1476769"/>
                </a:cubicBezTo>
                <a:lnTo>
                  <a:pt x="12645" y="1477990"/>
                </a:lnTo>
                <a:lnTo>
                  <a:pt x="15316" y="1456307"/>
                </a:lnTo>
                <a:cubicBezTo>
                  <a:pt x="16577" y="1438825"/>
                  <a:pt x="16193" y="1421330"/>
                  <a:pt x="11892" y="1403967"/>
                </a:cubicBezTo>
                <a:cubicBezTo>
                  <a:pt x="-1808" y="1348788"/>
                  <a:pt x="932" y="1293662"/>
                  <a:pt x="6412" y="1238066"/>
                </a:cubicBezTo>
                <a:cubicBezTo>
                  <a:pt x="10522" y="1196695"/>
                  <a:pt x="15070" y="1154854"/>
                  <a:pt x="6850" y="1113013"/>
                </a:cubicBezTo>
                <a:cubicBezTo>
                  <a:pt x="3316" y="1093599"/>
                  <a:pt x="3316" y="1073745"/>
                  <a:pt x="6850" y="1054331"/>
                </a:cubicBezTo>
                <a:cubicBezTo>
                  <a:pt x="11124" y="1028180"/>
                  <a:pt x="15179" y="1002291"/>
                  <a:pt x="9699" y="975879"/>
                </a:cubicBezTo>
                <a:cubicBezTo>
                  <a:pt x="7289" y="964373"/>
                  <a:pt x="5481" y="952762"/>
                  <a:pt x="4220" y="941150"/>
                </a:cubicBezTo>
                <a:cubicBezTo>
                  <a:pt x="1710" y="911506"/>
                  <a:pt x="2609" y="881694"/>
                  <a:pt x="6904" y="852238"/>
                </a:cubicBezTo>
                <a:cubicBezTo>
                  <a:pt x="11015" y="818033"/>
                  <a:pt x="4329" y="783619"/>
                  <a:pt x="9809" y="749518"/>
                </a:cubicBezTo>
                <a:cubicBezTo>
                  <a:pt x="13700" y="722055"/>
                  <a:pt x="13848" y="694225"/>
                  <a:pt x="10248" y="666724"/>
                </a:cubicBezTo>
                <a:cubicBezTo>
                  <a:pt x="3770" y="614737"/>
                  <a:pt x="4175" y="562179"/>
                  <a:pt x="11453" y="510291"/>
                </a:cubicBezTo>
                <a:cubicBezTo>
                  <a:pt x="15947" y="480008"/>
                  <a:pt x="18522" y="448837"/>
                  <a:pt x="10466" y="419129"/>
                </a:cubicBezTo>
                <a:cubicBezTo>
                  <a:pt x="-8494" y="349307"/>
                  <a:pt x="2576" y="279380"/>
                  <a:pt x="10466" y="209924"/>
                </a:cubicBezTo>
                <a:cubicBezTo>
                  <a:pt x="15262" y="172623"/>
                  <a:pt x="15371" y="134908"/>
                  <a:pt x="10796" y="97581"/>
                </a:cubicBezTo>
                <a:cubicBezTo>
                  <a:pt x="6735" y="70015"/>
                  <a:pt x="4313" y="42275"/>
                  <a:pt x="3535" y="14494"/>
                </a:cubicBezTo>
                <a:lnTo>
                  <a:pt x="3925" y="2002"/>
                </a:lnTo>
                <a:lnTo>
                  <a:pt x="72292" y="704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6" name="Picture Placeholder 25">
            <a:extLst>
              <a:ext uri="{FF2B5EF4-FFF2-40B4-BE49-F238E27FC236}">
                <a16:creationId xmlns:a16="http://schemas.microsoft.com/office/drawing/2014/main" id="{32959C17-53EC-4A48-8276-E73A5CF1258A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48304" y="3058476"/>
            <a:ext cx="1463039" cy="1484431"/>
          </a:xfrm>
          <a:custGeom>
            <a:avLst/>
            <a:gdLst>
              <a:gd name="connsiteX0" fmla="*/ 866623 w 1463039"/>
              <a:gd name="connsiteY0" fmla="*/ 570 h 1484431"/>
              <a:gd name="connsiteX1" fmla="*/ 964707 w 1463039"/>
              <a:gd name="connsiteY1" fmla="*/ 8668 h 1484431"/>
              <a:gd name="connsiteX2" fmla="*/ 1111826 w 1463039"/>
              <a:gd name="connsiteY2" fmla="*/ 8365 h 1484431"/>
              <a:gd name="connsiteX3" fmla="*/ 1290056 w 1463039"/>
              <a:gd name="connsiteY3" fmla="*/ 8729 h 1484431"/>
              <a:gd name="connsiteX4" fmla="*/ 1417398 w 1463039"/>
              <a:gd name="connsiteY4" fmla="*/ 6607 h 1484431"/>
              <a:gd name="connsiteX5" fmla="*/ 1454474 w 1463039"/>
              <a:gd name="connsiteY5" fmla="*/ 5289 h 1484431"/>
              <a:gd name="connsiteX6" fmla="*/ 1449519 w 1463039"/>
              <a:gd name="connsiteY6" fmla="*/ 94304 h 1484431"/>
              <a:gd name="connsiteX7" fmla="*/ 1454055 w 1463039"/>
              <a:gd name="connsiteY7" fmla="*/ 198722 h 1484431"/>
              <a:gd name="connsiteX8" fmla="*/ 1456616 w 1463039"/>
              <a:gd name="connsiteY8" fmla="*/ 391198 h 1484431"/>
              <a:gd name="connsiteX9" fmla="*/ 1452608 w 1463039"/>
              <a:gd name="connsiteY9" fmla="*/ 565101 h 1484431"/>
              <a:gd name="connsiteX10" fmla="*/ 1461013 w 1463039"/>
              <a:gd name="connsiteY10" fmla="*/ 624833 h 1484431"/>
              <a:gd name="connsiteX11" fmla="*/ 1451384 w 1463039"/>
              <a:gd name="connsiteY11" fmla="*/ 907021 h 1484431"/>
              <a:gd name="connsiteX12" fmla="*/ 1452664 w 1463039"/>
              <a:gd name="connsiteY12" fmla="*/ 1009693 h 1484431"/>
              <a:gd name="connsiteX13" fmla="*/ 1456003 w 1463039"/>
              <a:gd name="connsiteY13" fmla="*/ 1096987 h 1484431"/>
              <a:gd name="connsiteX14" fmla="*/ 1453721 w 1463039"/>
              <a:gd name="connsiteY14" fmla="*/ 1174561 h 1484431"/>
              <a:gd name="connsiteX15" fmla="*/ 1461723 w 1463039"/>
              <a:gd name="connsiteY15" fmla="*/ 1280017 h 1484431"/>
              <a:gd name="connsiteX16" fmla="*/ 1463039 w 1463039"/>
              <a:gd name="connsiteY16" fmla="*/ 1330730 h 1484431"/>
              <a:gd name="connsiteX17" fmla="*/ 1463039 w 1463039"/>
              <a:gd name="connsiteY17" fmla="*/ 1433812 h 1484431"/>
              <a:gd name="connsiteX18" fmla="*/ 1458898 w 1463039"/>
              <a:gd name="connsiteY18" fmla="*/ 1471899 h 1484431"/>
              <a:gd name="connsiteX19" fmla="*/ 1458307 w 1463039"/>
              <a:gd name="connsiteY19" fmla="*/ 1476108 h 1484431"/>
              <a:gd name="connsiteX20" fmla="*/ 1456252 w 1463039"/>
              <a:gd name="connsiteY20" fmla="*/ 1476005 h 1484431"/>
              <a:gd name="connsiteX21" fmla="*/ 1358700 w 1463039"/>
              <a:gd name="connsiteY21" fmla="*/ 1478794 h 1484431"/>
              <a:gd name="connsiteX22" fmla="*/ 1178286 w 1463039"/>
              <a:gd name="connsiteY22" fmla="*/ 1478794 h 1484431"/>
              <a:gd name="connsiteX23" fmla="*/ 859951 w 1463039"/>
              <a:gd name="connsiteY23" fmla="*/ 1471897 h 1484431"/>
              <a:gd name="connsiteX24" fmla="*/ 500701 w 1463039"/>
              <a:gd name="connsiteY24" fmla="*/ 1474454 h 1484431"/>
              <a:gd name="connsiteX25" fmla="*/ 234329 w 1463039"/>
              <a:gd name="connsiteY25" fmla="*/ 1468256 h 1484431"/>
              <a:gd name="connsiteX26" fmla="*/ 133135 w 1463039"/>
              <a:gd name="connsiteY26" fmla="*/ 1483210 h 1484431"/>
              <a:gd name="connsiteX27" fmla="*/ 12645 w 1463039"/>
              <a:gd name="connsiteY27" fmla="*/ 1484431 h 1484431"/>
              <a:gd name="connsiteX28" fmla="*/ 15316 w 1463039"/>
              <a:gd name="connsiteY28" fmla="*/ 1462748 h 1484431"/>
              <a:gd name="connsiteX29" fmla="*/ 11892 w 1463039"/>
              <a:gd name="connsiteY29" fmla="*/ 1410408 h 1484431"/>
              <a:gd name="connsiteX30" fmla="*/ 6412 w 1463039"/>
              <a:gd name="connsiteY30" fmla="*/ 1244507 h 1484431"/>
              <a:gd name="connsiteX31" fmla="*/ 6850 w 1463039"/>
              <a:gd name="connsiteY31" fmla="*/ 1119454 h 1484431"/>
              <a:gd name="connsiteX32" fmla="*/ 6850 w 1463039"/>
              <a:gd name="connsiteY32" fmla="*/ 1060772 h 1484431"/>
              <a:gd name="connsiteX33" fmla="*/ 9699 w 1463039"/>
              <a:gd name="connsiteY33" fmla="*/ 982320 h 1484431"/>
              <a:gd name="connsiteX34" fmla="*/ 4220 w 1463039"/>
              <a:gd name="connsiteY34" fmla="*/ 947591 h 1484431"/>
              <a:gd name="connsiteX35" fmla="*/ 6904 w 1463039"/>
              <a:gd name="connsiteY35" fmla="*/ 858679 h 1484431"/>
              <a:gd name="connsiteX36" fmla="*/ 9809 w 1463039"/>
              <a:gd name="connsiteY36" fmla="*/ 755959 h 1484431"/>
              <a:gd name="connsiteX37" fmla="*/ 10248 w 1463039"/>
              <a:gd name="connsiteY37" fmla="*/ 673165 h 1484431"/>
              <a:gd name="connsiteX38" fmla="*/ 11453 w 1463039"/>
              <a:gd name="connsiteY38" fmla="*/ 516732 h 1484431"/>
              <a:gd name="connsiteX39" fmla="*/ 10466 w 1463039"/>
              <a:gd name="connsiteY39" fmla="*/ 425570 h 1484431"/>
              <a:gd name="connsiteX40" fmla="*/ 10466 w 1463039"/>
              <a:gd name="connsiteY40" fmla="*/ 216365 h 1484431"/>
              <a:gd name="connsiteX41" fmla="*/ 10796 w 1463039"/>
              <a:gd name="connsiteY41" fmla="*/ 104022 h 1484431"/>
              <a:gd name="connsiteX42" fmla="*/ 3535 w 1463039"/>
              <a:gd name="connsiteY42" fmla="*/ 20935 h 1484431"/>
              <a:gd name="connsiteX43" fmla="*/ 3925 w 1463039"/>
              <a:gd name="connsiteY43" fmla="*/ 8443 h 1484431"/>
              <a:gd name="connsiteX44" fmla="*/ 72292 w 1463039"/>
              <a:gd name="connsiteY44" fmla="*/ 7145 h 1484431"/>
              <a:gd name="connsiteX45" fmla="*/ 231771 w 1463039"/>
              <a:gd name="connsiteY45" fmla="*/ 4000 h 1484431"/>
              <a:gd name="connsiteX46" fmla="*/ 364603 w 1463039"/>
              <a:gd name="connsiteY46" fmla="*/ 11881 h 1484431"/>
              <a:gd name="connsiteX47" fmla="*/ 768234 w 1463039"/>
              <a:gd name="connsiteY47" fmla="*/ 2060 h 1484431"/>
              <a:gd name="connsiteX48" fmla="*/ 866623 w 1463039"/>
              <a:gd name="connsiteY48" fmla="*/ 570 h 14844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</a:cxnLst>
            <a:rect l="l" t="t" r="r" b="b"/>
            <a:pathLst>
              <a:path w="1463039" h="1484431">
                <a:moveTo>
                  <a:pt x="866623" y="570"/>
                </a:moveTo>
                <a:cubicBezTo>
                  <a:pt x="899406" y="1672"/>
                  <a:pt x="932137" y="4373"/>
                  <a:pt x="964707" y="8668"/>
                </a:cubicBezTo>
                <a:cubicBezTo>
                  <a:pt x="1013530" y="15822"/>
                  <a:pt x="1062767" y="11396"/>
                  <a:pt x="1111826" y="8365"/>
                </a:cubicBezTo>
                <a:cubicBezTo>
                  <a:pt x="1171217" y="4667"/>
                  <a:pt x="1230548" y="2666"/>
                  <a:pt x="1290056" y="8729"/>
                </a:cubicBezTo>
                <a:cubicBezTo>
                  <a:pt x="1332385" y="13093"/>
                  <a:pt x="1374950" y="9032"/>
                  <a:pt x="1417398" y="6607"/>
                </a:cubicBezTo>
                <a:lnTo>
                  <a:pt x="1454474" y="5289"/>
                </a:lnTo>
                <a:lnTo>
                  <a:pt x="1449519" y="94304"/>
                </a:lnTo>
                <a:cubicBezTo>
                  <a:pt x="1449060" y="129133"/>
                  <a:pt x="1450326" y="163950"/>
                  <a:pt x="1454055" y="198722"/>
                </a:cubicBezTo>
                <a:cubicBezTo>
                  <a:pt x="1460000" y="262766"/>
                  <a:pt x="1460857" y="327061"/>
                  <a:pt x="1456616" y="391198"/>
                </a:cubicBezTo>
                <a:cubicBezTo>
                  <a:pt x="1453666" y="449150"/>
                  <a:pt x="1446429" y="507011"/>
                  <a:pt x="1452608" y="565101"/>
                </a:cubicBezTo>
                <a:cubicBezTo>
                  <a:pt x="1454723" y="585088"/>
                  <a:pt x="1459844" y="604709"/>
                  <a:pt x="1461013" y="624833"/>
                </a:cubicBezTo>
                <a:cubicBezTo>
                  <a:pt x="1466579" y="719109"/>
                  <a:pt x="1458230" y="813065"/>
                  <a:pt x="1451384" y="907021"/>
                </a:cubicBezTo>
                <a:cubicBezTo>
                  <a:pt x="1448879" y="941245"/>
                  <a:pt x="1445817" y="975469"/>
                  <a:pt x="1452664" y="1009693"/>
                </a:cubicBezTo>
                <a:cubicBezTo>
                  <a:pt x="1458091" y="1038573"/>
                  <a:pt x="1459210" y="1067888"/>
                  <a:pt x="1456003" y="1096987"/>
                </a:cubicBezTo>
                <a:cubicBezTo>
                  <a:pt x="1452797" y="1122759"/>
                  <a:pt x="1452035" y="1148692"/>
                  <a:pt x="1453721" y="1174561"/>
                </a:cubicBezTo>
                <a:cubicBezTo>
                  <a:pt x="1457200" y="1209698"/>
                  <a:pt x="1459900" y="1244846"/>
                  <a:pt x="1461723" y="1280017"/>
                </a:cubicBezTo>
                <a:lnTo>
                  <a:pt x="1463039" y="1330730"/>
                </a:lnTo>
                <a:lnTo>
                  <a:pt x="1463039" y="1433812"/>
                </a:lnTo>
                <a:lnTo>
                  <a:pt x="1458898" y="1471899"/>
                </a:lnTo>
                <a:lnTo>
                  <a:pt x="1458307" y="1476108"/>
                </a:lnTo>
                <a:lnTo>
                  <a:pt x="1456252" y="1476005"/>
                </a:lnTo>
                <a:cubicBezTo>
                  <a:pt x="1423776" y="1477709"/>
                  <a:pt x="1391237" y="1478251"/>
                  <a:pt x="1358700" y="1478794"/>
                </a:cubicBezTo>
                <a:cubicBezTo>
                  <a:pt x="1298542" y="1479801"/>
                  <a:pt x="1238141" y="1489099"/>
                  <a:pt x="1178286" y="1478794"/>
                </a:cubicBezTo>
                <a:cubicBezTo>
                  <a:pt x="1072672" y="1461941"/>
                  <a:pt x="965947" y="1459624"/>
                  <a:pt x="859951" y="1471897"/>
                </a:cubicBezTo>
                <a:cubicBezTo>
                  <a:pt x="740406" y="1483830"/>
                  <a:pt x="620344" y="1484683"/>
                  <a:pt x="500701" y="1474454"/>
                </a:cubicBezTo>
                <a:cubicBezTo>
                  <a:pt x="412072" y="1467171"/>
                  <a:pt x="323262" y="1461747"/>
                  <a:pt x="234329" y="1468256"/>
                </a:cubicBezTo>
                <a:cubicBezTo>
                  <a:pt x="200275" y="1470813"/>
                  <a:pt x="167069" y="1481971"/>
                  <a:pt x="133135" y="1483210"/>
                </a:cubicBezTo>
                <a:lnTo>
                  <a:pt x="12645" y="1484431"/>
                </a:lnTo>
                <a:lnTo>
                  <a:pt x="15316" y="1462748"/>
                </a:lnTo>
                <a:cubicBezTo>
                  <a:pt x="16577" y="1445266"/>
                  <a:pt x="16193" y="1427771"/>
                  <a:pt x="11892" y="1410408"/>
                </a:cubicBezTo>
                <a:cubicBezTo>
                  <a:pt x="-1808" y="1355229"/>
                  <a:pt x="932" y="1300103"/>
                  <a:pt x="6412" y="1244507"/>
                </a:cubicBezTo>
                <a:cubicBezTo>
                  <a:pt x="10522" y="1203136"/>
                  <a:pt x="15070" y="1161295"/>
                  <a:pt x="6850" y="1119454"/>
                </a:cubicBezTo>
                <a:cubicBezTo>
                  <a:pt x="3316" y="1100040"/>
                  <a:pt x="3316" y="1080186"/>
                  <a:pt x="6850" y="1060772"/>
                </a:cubicBezTo>
                <a:cubicBezTo>
                  <a:pt x="11124" y="1034621"/>
                  <a:pt x="15179" y="1008732"/>
                  <a:pt x="9699" y="982320"/>
                </a:cubicBezTo>
                <a:cubicBezTo>
                  <a:pt x="7289" y="970814"/>
                  <a:pt x="5481" y="959203"/>
                  <a:pt x="4220" y="947591"/>
                </a:cubicBezTo>
                <a:cubicBezTo>
                  <a:pt x="1710" y="917947"/>
                  <a:pt x="2609" y="888135"/>
                  <a:pt x="6904" y="858679"/>
                </a:cubicBezTo>
                <a:cubicBezTo>
                  <a:pt x="11015" y="824474"/>
                  <a:pt x="4329" y="790060"/>
                  <a:pt x="9809" y="755959"/>
                </a:cubicBezTo>
                <a:cubicBezTo>
                  <a:pt x="13700" y="728496"/>
                  <a:pt x="13848" y="700666"/>
                  <a:pt x="10248" y="673165"/>
                </a:cubicBezTo>
                <a:cubicBezTo>
                  <a:pt x="3770" y="621178"/>
                  <a:pt x="4175" y="568620"/>
                  <a:pt x="11453" y="516732"/>
                </a:cubicBezTo>
                <a:cubicBezTo>
                  <a:pt x="15947" y="486449"/>
                  <a:pt x="18522" y="455278"/>
                  <a:pt x="10466" y="425570"/>
                </a:cubicBezTo>
                <a:cubicBezTo>
                  <a:pt x="-8494" y="355748"/>
                  <a:pt x="2576" y="285821"/>
                  <a:pt x="10466" y="216365"/>
                </a:cubicBezTo>
                <a:cubicBezTo>
                  <a:pt x="15262" y="179064"/>
                  <a:pt x="15371" y="141349"/>
                  <a:pt x="10796" y="104022"/>
                </a:cubicBezTo>
                <a:cubicBezTo>
                  <a:pt x="6735" y="76456"/>
                  <a:pt x="4313" y="48716"/>
                  <a:pt x="3535" y="20935"/>
                </a:cubicBezTo>
                <a:lnTo>
                  <a:pt x="3925" y="8443"/>
                </a:lnTo>
                <a:lnTo>
                  <a:pt x="72292" y="7145"/>
                </a:lnTo>
                <a:cubicBezTo>
                  <a:pt x="125550" y="5561"/>
                  <a:pt x="178728" y="3394"/>
                  <a:pt x="231771" y="4000"/>
                </a:cubicBezTo>
                <a:cubicBezTo>
                  <a:pt x="276049" y="4485"/>
                  <a:pt x="320208" y="13578"/>
                  <a:pt x="364603" y="11881"/>
                </a:cubicBezTo>
                <a:cubicBezTo>
                  <a:pt x="499147" y="6910"/>
                  <a:pt x="633750" y="8547"/>
                  <a:pt x="768234" y="2060"/>
                </a:cubicBezTo>
                <a:cubicBezTo>
                  <a:pt x="801008" y="-38"/>
                  <a:pt x="833841" y="-533"/>
                  <a:pt x="866623" y="570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65125"/>
            <a:ext cx="12188952" cy="1325563"/>
          </a:xfrm>
        </p:spPr>
        <p:txBody>
          <a:bodyPr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9" name="Rectangle 18" descr="Tag=AccentColor&#10;Flavor=Light&#10;Target=FillAndLine">
            <a:extLst>
              <a:ext uri="{FF2B5EF4-FFF2-40B4-BE49-F238E27FC236}">
                <a16:creationId xmlns:a16="http://schemas.microsoft.com/office/drawing/2014/main" id="{2D7984C8-AF4A-4D59-BB2D-72D92F873C07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Text Placeholder 32">
            <a:extLst>
              <a:ext uri="{FF2B5EF4-FFF2-40B4-BE49-F238E27FC236}">
                <a16:creationId xmlns:a16="http://schemas.microsoft.com/office/drawing/2014/main" id="{EC125114-9BE9-4C21-BEC1-81B685162210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6309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4" name="Text Placeholder 32">
            <a:extLst>
              <a:ext uri="{FF2B5EF4-FFF2-40B4-BE49-F238E27FC236}">
                <a16:creationId xmlns:a16="http://schemas.microsoft.com/office/drawing/2014/main" id="{2AB98BFD-4068-4EDA-8DE5-E5D978EDDF2E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29931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5" name="Text Placeholder 32">
            <a:extLst>
              <a:ext uri="{FF2B5EF4-FFF2-40B4-BE49-F238E27FC236}">
                <a16:creationId xmlns:a16="http://schemas.microsoft.com/office/drawing/2014/main" id="{937737FC-57C8-4243-BE91-4E9684B83613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53553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6" name="Text Placeholder 32">
            <a:extLst>
              <a:ext uri="{FF2B5EF4-FFF2-40B4-BE49-F238E27FC236}">
                <a16:creationId xmlns:a16="http://schemas.microsoft.com/office/drawing/2014/main" id="{CA78FA67-D083-4763-B647-4554C3C50977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77175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7" name="Text Placeholder 32">
            <a:extLst>
              <a:ext uri="{FF2B5EF4-FFF2-40B4-BE49-F238E27FC236}">
                <a16:creationId xmlns:a16="http://schemas.microsoft.com/office/drawing/2014/main" id="{F1892FE5-DAA3-4902-93EF-46D6565FFB48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100797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2183427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 Center H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4"/>
            <a:ext cx="10515600" cy="1325880"/>
          </a:xfrm>
        </p:spPr>
        <p:txBody>
          <a:bodyPr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41248" y="2304288"/>
            <a:ext cx="10515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83465705-093A-460D-83A5-4A4F3275ADB7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8290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ADE264-531D-49C1-A8AF-2B4C1D218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B9A1B8-2F1B-46AA-858A-CFFF5AF7CE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2304288"/>
            <a:ext cx="5181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B9631-18C0-43BD-8AF3-9137D6D4C2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2304288"/>
            <a:ext cx="5181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032FCA-14C6-4497-9C27-3F5806244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E5057-693B-4E10-958E-0ABE79FEC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0CECB1-0A35-4C10-9D3D-FE4404283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7" descr="Tag=AccentColor&#10;Flavor=Light&#10;Target=FillAndLine">
            <a:extLst>
              <a:ext uri="{FF2B5EF4-FFF2-40B4-BE49-F238E27FC236}">
                <a16:creationId xmlns:a16="http://schemas.microsoft.com/office/drawing/2014/main" id="{23FEB8C5-87FB-41BA-B300-D935D5EEAEC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3232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72D13B-FFCB-4650-AD3C-CB50373525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CA9470-DF15-46A1-BF0E-8A5367A4B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3047CB-E94D-482F-BACA-681E96C0EC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DA4B5-E797-42FC-8B7A-2294DF24A3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/>
                </a:solidFill>
              </a:defRPr>
            </a:lvl1pPr>
          </a:lstStyle>
          <a:p>
            <a:r>
              <a:rPr lang="en-US" dirty="0">
                <a:solidFill>
                  <a:schemeClr val="tx1"/>
                </a:solidFill>
              </a:rPr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8ED201-6D0E-422C-B4EC-566A3DC298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5883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44" r:id="rId5"/>
    <p:sldLayoutId id="2147483751" r:id="rId6"/>
    <p:sldLayoutId id="2147483752" r:id="rId7"/>
    <p:sldLayoutId id="2147483753" r:id="rId8"/>
    <p:sldLayoutId id="2147483724" r:id="rId9"/>
    <p:sldLayoutId id="2147483737" r:id="rId10"/>
    <p:sldLayoutId id="2147483755" r:id="rId11"/>
    <p:sldLayoutId id="2147483754" r:id="rId12"/>
    <p:sldLayoutId id="2147483756" r:id="rId13"/>
    <p:sldLayoutId id="2147483739" r:id="rId14"/>
    <p:sldLayoutId id="2147483740" r:id="rId15"/>
    <p:sldLayoutId id="2147483741" r:id="rId16"/>
  </p:sldLayoutIdLst>
  <p:hf hd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7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10000"/>
        </a:lnSpc>
        <a:spcBef>
          <a:spcPts val="1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5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9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0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hyperlink" Target="http://wakeful-dev.brightoutcome.com/" TargetMode="External"/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12" Type="http://schemas.openxmlformats.org/officeDocument/2006/relationships/image" Target="../media/image27.sv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9.xml"/><Relationship Id="rId6" Type="http://schemas.openxmlformats.org/officeDocument/2006/relationships/diagramColors" Target="../diagrams/colors3.xml"/><Relationship Id="rId11" Type="http://schemas.openxmlformats.org/officeDocument/2006/relationships/image" Target="../media/image26.png"/><Relationship Id="rId5" Type="http://schemas.openxmlformats.org/officeDocument/2006/relationships/diagramQuickStyle" Target="../diagrams/quickStyle3.xml"/><Relationship Id="rId10" Type="http://schemas.openxmlformats.org/officeDocument/2006/relationships/image" Target="../media/image25.svg"/><Relationship Id="rId4" Type="http://schemas.openxmlformats.org/officeDocument/2006/relationships/diagramLayout" Target="../diagrams/layout3.xml"/><Relationship Id="rId9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hyperlink" Target="mailto:karmurph@wakehealth.edu" TargetMode="External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9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5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1B3DD-35BD-42F7-9AD7-7F3402B2623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8800" dirty="0">
                <a:solidFill>
                  <a:schemeClr val="bg1"/>
                </a:solidFill>
              </a:rPr>
              <a:t>Welcome!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5A2D86-784C-417D-9AD4-AF18311FBC6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sz="3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57736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37" name="Rectangle 36">
            <a:extLst>
              <a:ext uri="{FF2B5EF4-FFF2-40B4-BE49-F238E27FC236}">
                <a16:creationId xmlns:a16="http://schemas.microsoft.com/office/drawing/2014/main" id="{168AB93A-48BC-4C25-A3AD-C17B5A682A9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AF4AE179-A75B-4007-B5FA-8139ACFB9B8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658969" y="1168517"/>
            <a:ext cx="4889565" cy="4424065"/>
          </a:xfrm>
          <a:custGeom>
            <a:avLst/>
            <a:gdLst>
              <a:gd name="connsiteX0" fmla="*/ 2612540 w 5531319"/>
              <a:gd name="connsiteY0" fmla="*/ 836 h 4424065"/>
              <a:gd name="connsiteX1" fmla="*/ 2946310 w 5531319"/>
              <a:gd name="connsiteY1" fmla="*/ 35548 h 4424065"/>
              <a:gd name="connsiteX2" fmla="*/ 3961099 w 5531319"/>
              <a:gd name="connsiteY2" fmla="*/ 303581 h 4424065"/>
              <a:gd name="connsiteX3" fmla="*/ 4854587 w 5531319"/>
              <a:gd name="connsiteY3" fmla="*/ 764502 h 4424065"/>
              <a:gd name="connsiteX4" fmla="*/ 5377812 w 5531319"/>
              <a:gd name="connsiteY4" fmla="*/ 1339732 h 4424065"/>
              <a:gd name="connsiteX5" fmla="*/ 5526197 w 5531319"/>
              <a:gd name="connsiteY5" fmla="*/ 1825829 h 4424065"/>
              <a:gd name="connsiteX6" fmla="*/ 5510557 w 5531319"/>
              <a:gd name="connsiteY6" fmla="*/ 2199398 h 4424065"/>
              <a:gd name="connsiteX7" fmla="*/ 5509795 w 5531319"/>
              <a:gd name="connsiteY7" fmla="*/ 2402839 h 4424065"/>
              <a:gd name="connsiteX8" fmla="*/ 5323519 w 5531319"/>
              <a:gd name="connsiteY8" fmla="*/ 3144890 h 4424065"/>
              <a:gd name="connsiteX9" fmla="*/ 4853061 w 5531319"/>
              <a:gd name="connsiteY9" fmla="*/ 3612932 h 4424065"/>
              <a:gd name="connsiteX10" fmla="*/ 4316358 w 5531319"/>
              <a:gd name="connsiteY10" fmla="*/ 3982940 h 4424065"/>
              <a:gd name="connsiteX11" fmla="*/ 3352556 w 5531319"/>
              <a:gd name="connsiteY11" fmla="*/ 4386771 h 4424065"/>
              <a:gd name="connsiteX12" fmla="*/ 2770206 w 5531319"/>
              <a:gd name="connsiteY12" fmla="*/ 4412201 h 4424065"/>
              <a:gd name="connsiteX13" fmla="*/ 2514888 w 5531319"/>
              <a:gd name="connsiteY13" fmla="*/ 4393637 h 4424065"/>
              <a:gd name="connsiteX14" fmla="*/ 1903166 w 5531319"/>
              <a:gd name="connsiteY14" fmla="*/ 4263562 h 4424065"/>
              <a:gd name="connsiteX15" fmla="*/ 948392 w 5531319"/>
              <a:gd name="connsiteY15" fmla="*/ 3794249 h 4424065"/>
              <a:gd name="connsiteX16" fmla="*/ 223633 w 5531319"/>
              <a:gd name="connsiteY16" fmla="*/ 2975526 h 4424065"/>
              <a:gd name="connsiteX17" fmla="*/ 39519 w 5531319"/>
              <a:gd name="connsiteY17" fmla="*/ 2401695 h 4424065"/>
              <a:gd name="connsiteX18" fmla="*/ 16251 w 5531319"/>
              <a:gd name="connsiteY18" fmla="*/ 2300991 h 4424065"/>
              <a:gd name="connsiteX19" fmla="*/ 11800 w 5531319"/>
              <a:gd name="connsiteY19" fmla="*/ 2053556 h 4424065"/>
              <a:gd name="connsiteX20" fmla="*/ 812849 w 5531319"/>
              <a:gd name="connsiteY20" fmla="*/ 651084 h 4424065"/>
              <a:gd name="connsiteX21" fmla="*/ 2066809 w 5531319"/>
              <a:gd name="connsiteY21" fmla="*/ 52586 h 4424065"/>
              <a:gd name="connsiteX22" fmla="*/ 2332045 w 5531319"/>
              <a:gd name="connsiteY22" fmla="*/ 14441 h 4424065"/>
              <a:gd name="connsiteX23" fmla="*/ 2612540 w 5531319"/>
              <a:gd name="connsiteY23" fmla="*/ 836 h 4424065"/>
              <a:gd name="connsiteX24" fmla="*/ 5468597 w 5531319"/>
              <a:gd name="connsiteY24" fmla="*/ 2088522 h 4424065"/>
              <a:gd name="connsiteX25" fmla="*/ 5471140 w 5531319"/>
              <a:gd name="connsiteY25" fmla="*/ 1826083 h 4424065"/>
              <a:gd name="connsiteX26" fmla="*/ 5327079 w 5531319"/>
              <a:gd name="connsiteY26" fmla="*/ 1361348 h 4424065"/>
              <a:gd name="connsiteX27" fmla="*/ 4833353 w 5531319"/>
              <a:gd name="connsiteY27" fmla="*/ 816507 h 4424065"/>
              <a:gd name="connsiteX28" fmla="*/ 4063456 w 5531319"/>
              <a:gd name="connsiteY28" fmla="*/ 400724 h 4424065"/>
              <a:gd name="connsiteX29" fmla="*/ 3972543 w 5531319"/>
              <a:gd name="connsiteY29" fmla="*/ 365631 h 4424065"/>
              <a:gd name="connsiteX30" fmla="*/ 3885571 w 5531319"/>
              <a:gd name="connsiteY30" fmla="*/ 334733 h 4424065"/>
              <a:gd name="connsiteX31" fmla="*/ 4355012 w 5531319"/>
              <a:gd name="connsiteY31" fmla="*/ 579880 h 4424065"/>
              <a:gd name="connsiteX32" fmla="*/ 5144618 w 5531319"/>
              <a:gd name="connsiteY32" fmla="*/ 1290779 h 4424065"/>
              <a:gd name="connsiteX33" fmla="*/ 5468597 w 5531319"/>
              <a:gd name="connsiteY33" fmla="*/ 2088522 h 4424065"/>
              <a:gd name="connsiteX34" fmla="*/ 2219771 w 5531319"/>
              <a:gd name="connsiteY34" fmla="*/ 85645 h 4424065"/>
              <a:gd name="connsiteX35" fmla="*/ 2181626 w 5531319"/>
              <a:gd name="connsiteY35" fmla="*/ 89333 h 4424065"/>
              <a:gd name="connsiteX36" fmla="*/ 1462971 w 5531319"/>
              <a:gd name="connsiteY36" fmla="*/ 303073 h 4424065"/>
              <a:gd name="connsiteX37" fmla="*/ 308697 w 5531319"/>
              <a:gd name="connsiteY37" fmla="*/ 1338461 h 4424065"/>
              <a:gd name="connsiteX38" fmla="*/ 65839 w 5531319"/>
              <a:gd name="connsiteY38" fmla="*/ 2064364 h 4424065"/>
              <a:gd name="connsiteX39" fmla="*/ 82114 w 5531319"/>
              <a:gd name="connsiteY39" fmla="*/ 2022150 h 4424065"/>
              <a:gd name="connsiteX40" fmla="*/ 423260 w 5531319"/>
              <a:gd name="connsiteY40" fmla="*/ 1282260 h 4424065"/>
              <a:gd name="connsiteX41" fmla="*/ 1231811 w 5531319"/>
              <a:gd name="connsiteY41" fmla="*/ 454001 h 4424065"/>
              <a:gd name="connsiteX42" fmla="*/ 2219771 w 5531319"/>
              <a:gd name="connsiteY42" fmla="*/ 85645 h 4424065"/>
              <a:gd name="connsiteX43" fmla="*/ 2855524 w 5531319"/>
              <a:gd name="connsiteY43" fmla="*/ 4364392 h 4424065"/>
              <a:gd name="connsiteX44" fmla="*/ 4292327 w 5531319"/>
              <a:gd name="connsiteY44" fmla="*/ 3931444 h 4424065"/>
              <a:gd name="connsiteX45" fmla="*/ 2855652 w 5531319"/>
              <a:gd name="connsiteY45" fmla="*/ 4364392 h 4424065"/>
              <a:gd name="connsiteX46" fmla="*/ 3869805 w 5531319"/>
              <a:gd name="connsiteY46" fmla="*/ 330156 h 4424065"/>
              <a:gd name="connsiteX47" fmla="*/ 3865736 w 5531319"/>
              <a:gd name="connsiteY47" fmla="*/ 329520 h 4424065"/>
              <a:gd name="connsiteX48" fmla="*/ 3866499 w 5531319"/>
              <a:gd name="connsiteY48" fmla="*/ 330537 h 4424065"/>
              <a:gd name="connsiteX49" fmla="*/ 4302117 w 5531319"/>
              <a:gd name="connsiteY49" fmla="*/ 3923561 h 4424065"/>
              <a:gd name="connsiteX50" fmla="*/ 4301101 w 5531319"/>
              <a:gd name="connsiteY50" fmla="*/ 3924959 h 4424065"/>
              <a:gd name="connsiteX51" fmla="*/ 4302880 w 5531319"/>
              <a:gd name="connsiteY51" fmla="*/ 3924959 h 44240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</a:cxnLst>
            <a:rect l="l" t="t" r="r" b="b"/>
            <a:pathLst>
              <a:path w="5531319" h="4424065">
                <a:moveTo>
                  <a:pt x="2612540" y="836"/>
                </a:moveTo>
                <a:cubicBezTo>
                  <a:pt x="2715913" y="-4250"/>
                  <a:pt x="2831239" y="14695"/>
                  <a:pt x="2946310" y="35548"/>
                </a:cubicBezTo>
                <a:cubicBezTo>
                  <a:pt x="3291651" y="98106"/>
                  <a:pt x="3631143" y="182915"/>
                  <a:pt x="3961099" y="303581"/>
                </a:cubicBezTo>
                <a:cubicBezTo>
                  <a:pt x="4278340" y="419543"/>
                  <a:pt x="4581340" y="563350"/>
                  <a:pt x="4854587" y="764502"/>
                </a:cubicBezTo>
                <a:cubicBezTo>
                  <a:pt x="5067437" y="921152"/>
                  <a:pt x="5250407" y="1105521"/>
                  <a:pt x="5377812" y="1339732"/>
                </a:cubicBezTo>
                <a:cubicBezTo>
                  <a:pt x="5459811" y="1489986"/>
                  <a:pt x="5510303" y="1655396"/>
                  <a:pt x="5526197" y="1825829"/>
                </a:cubicBezTo>
                <a:cubicBezTo>
                  <a:pt x="5538276" y="1951327"/>
                  <a:pt x="5527341" y="2074917"/>
                  <a:pt x="5510557" y="2199398"/>
                </a:cubicBezTo>
                <a:cubicBezTo>
                  <a:pt x="5502966" y="2266991"/>
                  <a:pt x="5502712" y="2335195"/>
                  <a:pt x="5509795" y="2402839"/>
                </a:cubicBezTo>
                <a:cubicBezTo>
                  <a:pt x="5534207" y="2664197"/>
                  <a:pt x="5468471" y="2926051"/>
                  <a:pt x="5323519" y="3144890"/>
                </a:cubicBezTo>
                <a:cubicBezTo>
                  <a:pt x="5201339" y="3332234"/>
                  <a:pt x="5041041" y="3491719"/>
                  <a:pt x="4853061" y="3612932"/>
                </a:cubicBezTo>
                <a:cubicBezTo>
                  <a:pt x="4671109" y="3732072"/>
                  <a:pt x="4498565" y="3864563"/>
                  <a:pt x="4316358" y="3982940"/>
                </a:cubicBezTo>
                <a:cubicBezTo>
                  <a:pt x="4019716" y="4175573"/>
                  <a:pt x="3701076" y="4317347"/>
                  <a:pt x="3352556" y="4386771"/>
                </a:cubicBezTo>
                <a:cubicBezTo>
                  <a:pt x="3160953" y="4425590"/>
                  <a:pt x="2964455" y="4434173"/>
                  <a:pt x="2770206" y="4412201"/>
                </a:cubicBezTo>
                <a:cubicBezTo>
                  <a:pt x="2685524" y="4402537"/>
                  <a:pt x="2599952" y="4402410"/>
                  <a:pt x="2514888" y="4393637"/>
                </a:cubicBezTo>
                <a:cubicBezTo>
                  <a:pt x="2307136" y="4370851"/>
                  <a:pt x="2102208" y="4327277"/>
                  <a:pt x="1903166" y="4263562"/>
                </a:cubicBezTo>
                <a:cubicBezTo>
                  <a:pt x="1560622" y="4156119"/>
                  <a:pt x="1238931" y="4006972"/>
                  <a:pt x="948392" y="3794249"/>
                </a:cubicBezTo>
                <a:cubicBezTo>
                  <a:pt x="647553" y="3573897"/>
                  <a:pt x="396812" y="3308660"/>
                  <a:pt x="223633" y="2975526"/>
                </a:cubicBezTo>
                <a:cubicBezTo>
                  <a:pt x="129453" y="2796370"/>
                  <a:pt x="67149" y="2602198"/>
                  <a:pt x="39519" y="2401695"/>
                </a:cubicBezTo>
                <a:cubicBezTo>
                  <a:pt x="34509" y="2367555"/>
                  <a:pt x="26728" y="2333872"/>
                  <a:pt x="16251" y="2300991"/>
                </a:cubicBezTo>
                <a:cubicBezTo>
                  <a:pt x="-9180" y="2218598"/>
                  <a:pt x="-25" y="2135695"/>
                  <a:pt x="11800" y="2053556"/>
                </a:cubicBezTo>
                <a:cubicBezTo>
                  <a:pt x="93685" y="1480615"/>
                  <a:pt x="377867" y="1021983"/>
                  <a:pt x="812849" y="651084"/>
                </a:cubicBezTo>
                <a:cubicBezTo>
                  <a:pt x="1176754" y="340201"/>
                  <a:pt x="1598259" y="146042"/>
                  <a:pt x="2066809" y="52586"/>
                </a:cubicBezTo>
                <a:cubicBezTo>
                  <a:pt x="2154543" y="35039"/>
                  <a:pt x="2243040" y="23087"/>
                  <a:pt x="2332045" y="14441"/>
                </a:cubicBezTo>
                <a:cubicBezTo>
                  <a:pt x="2421051" y="5794"/>
                  <a:pt x="2508912" y="2107"/>
                  <a:pt x="2612540" y="836"/>
                </a:cubicBezTo>
                <a:close/>
                <a:moveTo>
                  <a:pt x="5468597" y="2088522"/>
                </a:moveTo>
                <a:cubicBezTo>
                  <a:pt x="5479329" y="2001424"/>
                  <a:pt x="5480181" y="1913385"/>
                  <a:pt x="5471140" y="1826083"/>
                </a:cubicBezTo>
                <a:cubicBezTo>
                  <a:pt x="5455336" y="1662962"/>
                  <a:pt x="5406306" y="1504799"/>
                  <a:pt x="5327079" y="1361348"/>
                </a:cubicBezTo>
                <a:cubicBezTo>
                  <a:pt x="5206159" y="1140233"/>
                  <a:pt x="5033361" y="965782"/>
                  <a:pt x="4833353" y="816507"/>
                </a:cubicBezTo>
                <a:cubicBezTo>
                  <a:pt x="4597234" y="640276"/>
                  <a:pt x="4336321" y="509438"/>
                  <a:pt x="4063456" y="400724"/>
                </a:cubicBezTo>
                <a:cubicBezTo>
                  <a:pt x="4033359" y="388607"/>
                  <a:pt x="4003059" y="376909"/>
                  <a:pt x="3972543" y="365631"/>
                </a:cubicBezTo>
                <a:cubicBezTo>
                  <a:pt x="3943679" y="354950"/>
                  <a:pt x="3914562" y="345033"/>
                  <a:pt x="3885571" y="334733"/>
                </a:cubicBezTo>
                <a:cubicBezTo>
                  <a:pt x="4046888" y="406840"/>
                  <a:pt x="4203652" y="488713"/>
                  <a:pt x="4355012" y="579880"/>
                </a:cubicBezTo>
                <a:cubicBezTo>
                  <a:pt x="4662081" y="768063"/>
                  <a:pt x="4933802" y="995790"/>
                  <a:pt x="5144618" y="1290779"/>
                </a:cubicBezTo>
                <a:cubicBezTo>
                  <a:pt x="5314364" y="1528042"/>
                  <a:pt x="5426257" y="1789591"/>
                  <a:pt x="5468597" y="2088522"/>
                </a:cubicBezTo>
                <a:close/>
                <a:moveTo>
                  <a:pt x="2219771" y="85645"/>
                </a:moveTo>
                <a:cubicBezTo>
                  <a:pt x="2206942" y="84005"/>
                  <a:pt x="2193909" y="85264"/>
                  <a:pt x="2181626" y="89333"/>
                </a:cubicBezTo>
                <a:cubicBezTo>
                  <a:pt x="1932919" y="125113"/>
                  <a:pt x="1690799" y="197118"/>
                  <a:pt x="1462971" y="303073"/>
                </a:cubicBezTo>
                <a:cubicBezTo>
                  <a:pt x="971788" y="529528"/>
                  <a:pt x="578129" y="865460"/>
                  <a:pt x="308697" y="1338461"/>
                </a:cubicBezTo>
                <a:cubicBezTo>
                  <a:pt x="180224" y="1561852"/>
                  <a:pt x="97652" y="1808638"/>
                  <a:pt x="65839" y="2064364"/>
                </a:cubicBezTo>
                <a:cubicBezTo>
                  <a:pt x="71942" y="2050505"/>
                  <a:pt x="77283" y="2036391"/>
                  <a:pt x="82114" y="2022150"/>
                </a:cubicBezTo>
                <a:cubicBezTo>
                  <a:pt x="170103" y="1763653"/>
                  <a:pt x="279579" y="1515073"/>
                  <a:pt x="423260" y="1282260"/>
                </a:cubicBezTo>
                <a:cubicBezTo>
                  <a:pt x="630769" y="945565"/>
                  <a:pt x="895370" y="664944"/>
                  <a:pt x="1231811" y="454001"/>
                </a:cubicBezTo>
                <a:cubicBezTo>
                  <a:pt x="1535192" y="263783"/>
                  <a:pt x="1866801" y="149729"/>
                  <a:pt x="2219771" y="85645"/>
                </a:cubicBezTo>
                <a:close/>
                <a:moveTo>
                  <a:pt x="2855524" y="4364392"/>
                </a:moveTo>
                <a:cubicBezTo>
                  <a:pt x="3386633" y="4394018"/>
                  <a:pt x="3853530" y="4210158"/>
                  <a:pt x="4292327" y="3931444"/>
                </a:cubicBezTo>
                <a:cubicBezTo>
                  <a:pt x="3830134" y="4131325"/>
                  <a:pt x="3346707" y="4259111"/>
                  <a:pt x="2855652" y="4364392"/>
                </a:cubicBezTo>
                <a:close/>
                <a:moveTo>
                  <a:pt x="3869805" y="330156"/>
                </a:moveTo>
                <a:lnTo>
                  <a:pt x="3865736" y="329520"/>
                </a:lnTo>
                <a:cubicBezTo>
                  <a:pt x="3865736" y="329520"/>
                  <a:pt x="3865736" y="330410"/>
                  <a:pt x="3866499" y="330537"/>
                </a:cubicBezTo>
                <a:close/>
                <a:moveTo>
                  <a:pt x="4302117" y="3923561"/>
                </a:moveTo>
                <a:lnTo>
                  <a:pt x="4301101" y="3924959"/>
                </a:lnTo>
                <a:lnTo>
                  <a:pt x="4302880" y="3924959"/>
                </a:lnTo>
                <a:close/>
              </a:path>
            </a:pathLst>
          </a:custGeom>
          <a:solidFill>
            <a:srgbClr val="F6542C"/>
          </a:solidFill>
          <a:ln w="12700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507BBF50-A1F8-C1DD-2A14-43A3E6CA7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24135" y="2156348"/>
            <a:ext cx="3971495" cy="1866748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5800">
                <a:solidFill>
                  <a:srgbClr val="FFFFFF"/>
                </a:solidFill>
              </a:rPr>
              <a:t>Brainstorming</a:t>
            </a:r>
          </a:p>
        </p:txBody>
      </p:sp>
      <p:sp>
        <p:nvSpPr>
          <p:cNvPr id="41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05874" y="4409267"/>
            <a:ext cx="3242551" cy="27432"/>
          </a:xfrm>
          <a:custGeom>
            <a:avLst/>
            <a:gdLst>
              <a:gd name="connsiteX0" fmla="*/ 0 w 3242551"/>
              <a:gd name="connsiteY0" fmla="*/ 0 h 27432"/>
              <a:gd name="connsiteX1" fmla="*/ 616085 w 3242551"/>
              <a:gd name="connsiteY1" fmla="*/ 0 h 27432"/>
              <a:gd name="connsiteX2" fmla="*/ 1264595 w 3242551"/>
              <a:gd name="connsiteY2" fmla="*/ 0 h 27432"/>
              <a:gd name="connsiteX3" fmla="*/ 1945531 w 3242551"/>
              <a:gd name="connsiteY3" fmla="*/ 0 h 27432"/>
              <a:gd name="connsiteX4" fmla="*/ 2626466 w 3242551"/>
              <a:gd name="connsiteY4" fmla="*/ 0 h 27432"/>
              <a:gd name="connsiteX5" fmla="*/ 3242551 w 3242551"/>
              <a:gd name="connsiteY5" fmla="*/ 0 h 27432"/>
              <a:gd name="connsiteX6" fmla="*/ 3242551 w 3242551"/>
              <a:gd name="connsiteY6" fmla="*/ 27432 h 27432"/>
              <a:gd name="connsiteX7" fmla="*/ 2529190 w 3242551"/>
              <a:gd name="connsiteY7" fmla="*/ 27432 h 27432"/>
              <a:gd name="connsiteX8" fmla="*/ 1815829 w 3242551"/>
              <a:gd name="connsiteY8" fmla="*/ 27432 h 27432"/>
              <a:gd name="connsiteX9" fmla="*/ 1167318 w 3242551"/>
              <a:gd name="connsiteY9" fmla="*/ 27432 h 27432"/>
              <a:gd name="connsiteX10" fmla="*/ 0 w 3242551"/>
              <a:gd name="connsiteY10" fmla="*/ 27432 h 27432"/>
              <a:gd name="connsiteX11" fmla="*/ 0 w 3242551"/>
              <a:gd name="connsiteY11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42551" h="27432" fill="none" extrusionOk="0">
                <a:moveTo>
                  <a:pt x="0" y="0"/>
                </a:moveTo>
                <a:cubicBezTo>
                  <a:pt x="194108" y="-30346"/>
                  <a:pt x="476260" y="9901"/>
                  <a:pt x="616085" y="0"/>
                </a:cubicBezTo>
                <a:cubicBezTo>
                  <a:pt x="755911" y="-9901"/>
                  <a:pt x="955441" y="-31994"/>
                  <a:pt x="1264595" y="0"/>
                </a:cubicBezTo>
                <a:cubicBezTo>
                  <a:pt x="1573749" y="31994"/>
                  <a:pt x="1618785" y="-7447"/>
                  <a:pt x="1945531" y="0"/>
                </a:cubicBezTo>
                <a:cubicBezTo>
                  <a:pt x="2272277" y="7447"/>
                  <a:pt x="2390625" y="1646"/>
                  <a:pt x="2626466" y="0"/>
                </a:cubicBezTo>
                <a:cubicBezTo>
                  <a:pt x="2862308" y="-1646"/>
                  <a:pt x="3064770" y="5184"/>
                  <a:pt x="3242551" y="0"/>
                </a:cubicBezTo>
                <a:cubicBezTo>
                  <a:pt x="3241385" y="7395"/>
                  <a:pt x="3242596" y="21864"/>
                  <a:pt x="3242551" y="27432"/>
                </a:cubicBezTo>
                <a:cubicBezTo>
                  <a:pt x="3023282" y="59750"/>
                  <a:pt x="2875833" y="36030"/>
                  <a:pt x="2529190" y="27432"/>
                </a:cubicBezTo>
                <a:cubicBezTo>
                  <a:pt x="2182547" y="18834"/>
                  <a:pt x="2011286" y="10066"/>
                  <a:pt x="1815829" y="27432"/>
                </a:cubicBezTo>
                <a:cubicBezTo>
                  <a:pt x="1620372" y="44798"/>
                  <a:pt x="1410011" y="-1058"/>
                  <a:pt x="1167318" y="27432"/>
                </a:cubicBezTo>
                <a:cubicBezTo>
                  <a:pt x="924625" y="55922"/>
                  <a:pt x="241931" y="85033"/>
                  <a:pt x="0" y="27432"/>
                </a:cubicBezTo>
                <a:cubicBezTo>
                  <a:pt x="-503" y="20663"/>
                  <a:pt x="1168" y="5855"/>
                  <a:pt x="0" y="0"/>
                </a:cubicBezTo>
                <a:close/>
              </a:path>
              <a:path w="3242551" h="27432" stroke="0" extrusionOk="0">
                <a:moveTo>
                  <a:pt x="0" y="0"/>
                </a:moveTo>
                <a:cubicBezTo>
                  <a:pt x="292987" y="-12051"/>
                  <a:pt x="313221" y="-4437"/>
                  <a:pt x="616085" y="0"/>
                </a:cubicBezTo>
                <a:cubicBezTo>
                  <a:pt x="918950" y="4437"/>
                  <a:pt x="1001475" y="-7765"/>
                  <a:pt x="1167318" y="0"/>
                </a:cubicBezTo>
                <a:cubicBezTo>
                  <a:pt x="1333161" y="7765"/>
                  <a:pt x="1642740" y="34995"/>
                  <a:pt x="1880680" y="0"/>
                </a:cubicBezTo>
                <a:cubicBezTo>
                  <a:pt x="2118620" y="-34995"/>
                  <a:pt x="2326628" y="756"/>
                  <a:pt x="2496764" y="0"/>
                </a:cubicBezTo>
                <a:cubicBezTo>
                  <a:pt x="2666900" y="-756"/>
                  <a:pt x="2887316" y="25599"/>
                  <a:pt x="3242551" y="0"/>
                </a:cubicBezTo>
                <a:cubicBezTo>
                  <a:pt x="3242744" y="12649"/>
                  <a:pt x="3241563" y="17989"/>
                  <a:pt x="3242551" y="27432"/>
                </a:cubicBezTo>
                <a:cubicBezTo>
                  <a:pt x="3008998" y="-2757"/>
                  <a:pt x="2799879" y="44559"/>
                  <a:pt x="2594041" y="27432"/>
                </a:cubicBezTo>
                <a:cubicBezTo>
                  <a:pt x="2388203" y="10306"/>
                  <a:pt x="2212925" y="-2221"/>
                  <a:pt x="1880680" y="27432"/>
                </a:cubicBezTo>
                <a:cubicBezTo>
                  <a:pt x="1548435" y="57085"/>
                  <a:pt x="1523943" y="37041"/>
                  <a:pt x="1329446" y="27432"/>
                </a:cubicBezTo>
                <a:cubicBezTo>
                  <a:pt x="1134949" y="17823"/>
                  <a:pt x="919920" y="28299"/>
                  <a:pt x="680936" y="27432"/>
                </a:cubicBezTo>
                <a:cubicBezTo>
                  <a:pt x="441952" y="26566"/>
                  <a:pt x="273000" y="57219"/>
                  <a:pt x="0" y="27432"/>
                </a:cubicBezTo>
                <a:cubicBezTo>
                  <a:pt x="1300" y="19678"/>
                  <a:pt x="-86" y="12044"/>
                  <a:pt x="0" y="0"/>
                </a:cubicBezTo>
                <a:close/>
              </a:path>
            </a:pathLst>
          </a:custGeom>
          <a:solidFill>
            <a:srgbClr val="F6542C"/>
          </a:solidFill>
          <a:ln w="38100" cap="rnd">
            <a:solidFill>
              <a:srgbClr val="F6542C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7">
            <a:extLst>
              <a:ext uri="{FF2B5EF4-FFF2-40B4-BE49-F238E27FC236}">
                <a16:creationId xmlns:a16="http://schemas.microsoft.com/office/drawing/2014/main" id="{C8A8B4C4-FD64-88BA-B079-2B165F67CA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2184" r="-631"/>
          <a:stretch/>
        </p:blipFill>
        <p:spPr>
          <a:xfrm>
            <a:off x="212850" y="1265417"/>
            <a:ext cx="6347086" cy="4413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45800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77" name="Rectangle 76">
            <a:extLst>
              <a:ext uri="{FF2B5EF4-FFF2-40B4-BE49-F238E27FC236}">
                <a16:creationId xmlns:a16="http://schemas.microsoft.com/office/drawing/2014/main" id="{9B7AD9F6-8CE7-4299-8FC6-328F4DCD3F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7A8C61D1-2BF0-787A-D8B8-69EDE7F78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0338" y="640080"/>
            <a:ext cx="3734014" cy="3566160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l">
              <a:lnSpc>
                <a:spcPct val="90000"/>
              </a:lnSpc>
            </a:pPr>
            <a:r>
              <a:rPr lang="en-US" sz="3800" dirty="0">
                <a:solidFill>
                  <a:schemeClr val="tx1"/>
                </a:solidFill>
              </a:rPr>
              <a:t>How might we use an online tool to help AYAs learn new Information and skills that they can use to manage depressive symptoms?</a:t>
            </a:r>
          </a:p>
        </p:txBody>
      </p:sp>
      <p:sp>
        <p:nvSpPr>
          <p:cNvPr id="79" name="Rectangle 6">
            <a:extLst>
              <a:ext uri="{FF2B5EF4-FFF2-40B4-BE49-F238E27FC236}">
                <a16:creationId xmlns:a16="http://schemas.microsoft.com/office/drawing/2014/main" id="{F49775AF-8896-43EE-92C6-83497D6DC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90338" y="4409267"/>
            <a:ext cx="3474720" cy="27432"/>
          </a:xfrm>
          <a:custGeom>
            <a:avLst/>
            <a:gdLst>
              <a:gd name="connsiteX0" fmla="*/ 0 w 3474720"/>
              <a:gd name="connsiteY0" fmla="*/ 0 h 27432"/>
              <a:gd name="connsiteX1" fmla="*/ 660197 w 3474720"/>
              <a:gd name="connsiteY1" fmla="*/ 0 h 27432"/>
              <a:gd name="connsiteX2" fmla="*/ 1355141 w 3474720"/>
              <a:gd name="connsiteY2" fmla="*/ 0 h 27432"/>
              <a:gd name="connsiteX3" fmla="*/ 2084832 w 3474720"/>
              <a:gd name="connsiteY3" fmla="*/ 0 h 27432"/>
              <a:gd name="connsiteX4" fmla="*/ 2814523 w 3474720"/>
              <a:gd name="connsiteY4" fmla="*/ 0 h 27432"/>
              <a:gd name="connsiteX5" fmla="*/ 3474720 w 3474720"/>
              <a:gd name="connsiteY5" fmla="*/ 0 h 27432"/>
              <a:gd name="connsiteX6" fmla="*/ 3474720 w 3474720"/>
              <a:gd name="connsiteY6" fmla="*/ 27432 h 27432"/>
              <a:gd name="connsiteX7" fmla="*/ 2710282 w 3474720"/>
              <a:gd name="connsiteY7" fmla="*/ 27432 h 27432"/>
              <a:gd name="connsiteX8" fmla="*/ 1945843 w 3474720"/>
              <a:gd name="connsiteY8" fmla="*/ 27432 h 27432"/>
              <a:gd name="connsiteX9" fmla="*/ 1250899 w 3474720"/>
              <a:gd name="connsiteY9" fmla="*/ 27432 h 27432"/>
              <a:gd name="connsiteX10" fmla="*/ 0 w 3474720"/>
              <a:gd name="connsiteY10" fmla="*/ 27432 h 27432"/>
              <a:gd name="connsiteX11" fmla="*/ 0 w 3474720"/>
              <a:gd name="connsiteY11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474720" h="27432" fill="none" extrusionOk="0">
                <a:moveTo>
                  <a:pt x="0" y="0"/>
                </a:moveTo>
                <a:cubicBezTo>
                  <a:pt x="307185" y="-8713"/>
                  <a:pt x="392307" y="-13121"/>
                  <a:pt x="660197" y="0"/>
                </a:cubicBezTo>
                <a:cubicBezTo>
                  <a:pt x="928087" y="13121"/>
                  <a:pt x="1167029" y="-2668"/>
                  <a:pt x="1355141" y="0"/>
                </a:cubicBezTo>
                <a:cubicBezTo>
                  <a:pt x="1543253" y="2668"/>
                  <a:pt x="1739408" y="-6709"/>
                  <a:pt x="2084832" y="0"/>
                </a:cubicBezTo>
                <a:cubicBezTo>
                  <a:pt x="2430256" y="6709"/>
                  <a:pt x="2538889" y="29706"/>
                  <a:pt x="2814523" y="0"/>
                </a:cubicBezTo>
                <a:cubicBezTo>
                  <a:pt x="3090157" y="-29706"/>
                  <a:pt x="3152920" y="-15446"/>
                  <a:pt x="3474720" y="0"/>
                </a:cubicBezTo>
                <a:cubicBezTo>
                  <a:pt x="3473554" y="7395"/>
                  <a:pt x="3474765" y="21864"/>
                  <a:pt x="3474720" y="27432"/>
                </a:cubicBezTo>
                <a:cubicBezTo>
                  <a:pt x="3275380" y="12730"/>
                  <a:pt x="2958934" y="10130"/>
                  <a:pt x="2710282" y="27432"/>
                </a:cubicBezTo>
                <a:cubicBezTo>
                  <a:pt x="2461630" y="44734"/>
                  <a:pt x="2131168" y="43757"/>
                  <a:pt x="1945843" y="27432"/>
                </a:cubicBezTo>
                <a:cubicBezTo>
                  <a:pt x="1760518" y="11107"/>
                  <a:pt x="1444829" y="-3738"/>
                  <a:pt x="1250899" y="27432"/>
                </a:cubicBezTo>
                <a:cubicBezTo>
                  <a:pt x="1056969" y="58602"/>
                  <a:pt x="444992" y="52761"/>
                  <a:pt x="0" y="27432"/>
                </a:cubicBezTo>
                <a:cubicBezTo>
                  <a:pt x="-503" y="20663"/>
                  <a:pt x="1168" y="5855"/>
                  <a:pt x="0" y="0"/>
                </a:cubicBezTo>
                <a:close/>
              </a:path>
              <a:path w="3474720" h="27432" stroke="0" extrusionOk="0">
                <a:moveTo>
                  <a:pt x="0" y="0"/>
                </a:moveTo>
                <a:cubicBezTo>
                  <a:pt x="300114" y="-5103"/>
                  <a:pt x="525093" y="-25284"/>
                  <a:pt x="660197" y="0"/>
                </a:cubicBezTo>
                <a:cubicBezTo>
                  <a:pt x="795301" y="25284"/>
                  <a:pt x="1023172" y="17955"/>
                  <a:pt x="1250899" y="0"/>
                </a:cubicBezTo>
                <a:cubicBezTo>
                  <a:pt x="1478626" y="-17955"/>
                  <a:pt x="1782079" y="-27844"/>
                  <a:pt x="2015338" y="0"/>
                </a:cubicBezTo>
                <a:cubicBezTo>
                  <a:pt x="2248597" y="27844"/>
                  <a:pt x="2491007" y="27648"/>
                  <a:pt x="2675534" y="0"/>
                </a:cubicBezTo>
                <a:cubicBezTo>
                  <a:pt x="2860061" y="-27648"/>
                  <a:pt x="3088679" y="-3661"/>
                  <a:pt x="3474720" y="0"/>
                </a:cubicBezTo>
                <a:cubicBezTo>
                  <a:pt x="3474913" y="12649"/>
                  <a:pt x="3473732" y="17989"/>
                  <a:pt x="3474720" y="27432"/>
                </a:cubicBezTo>
                <a:cubicBezTo>
                  <a:pt x="3317198" y="15714"/>
                  <a:pt x="2959205" y="52182"/>
                  <a:pt x="2779776" y="27432"/>
                </a:cubicBezTo>
                <a:cubicBezTo>
                  <a:pt x="2600347" y="2682"/>
                  <a:pt x="2382660" y="-684"/>
                  <a:pt x="2015338" y="27432"/>
                </a:cubicBezTo>
                <a:cubicBezTo>
                  <a:pt x="1648016" y="55548"/>
                  <a:pt x="1641073" y="39646"/>
                  <a:pt x="1424635" y="27432"/>
                </a:cubicBezTo>
                <a:cubicBezTo>
                  <a:pt x="1208197" y="15218"/>
                  <a:pt x="1021559" y="15893"/>
                  <a:pt x="729691" y="27432"/>
                </a:cubicBezTo>
                <a:cubicBezTo>
                  <a:pt x="437823" y="38971"/>
                  <a:pt x="153856" y="-2647"/>
                  <a:pt x="0" y="27432"/>
                </a:cubicBezTo>
                <a:cubicBezTo>
                  <a:pt x="1300" y="19678"/>
                  <a:pt x="-86" y="12044"/>
                  <a:pt x="0" y="0"/>
                </a:cubicBezTo>
                <a:close/>
              </a:path>
            </a:pathLst>
          </a:custGeom>
          <a:solidFill>
            <a:srgbClr val="F3FA31"/>
          </a:solidFill>
          <a:ln w="38100" cap="rnd">
            <a:solidFill>
              <a:srgbClr val="F3FA3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3A76F30-59B9-05CA-4C43-9DDE3CFA47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10" r="20712" b="-2"/>
          <a:stretch/>
        </p:blipFill>
        <p:spPr>
          <a:xfrm>
            <a:off x="5311702" y="10"/>
            <a:ext cx="6878775" cy="6857990"/>
          </a:xfrm>
          <a:custGeom>
            <a:avLst/>
            <a:gdLst/>
            <a:ahLst/>
            <a:cxnLst/>
            <a:rect l="l" t="t" r="r" b="b"/>
            <a:pathLst>
              <a:path w="6878775" h="6858000">
                <a:moveTo>
                  <a:pt x="1102973" y="0"/>
                </a:moveTo>
                <a:lnTo>
                  <a:pt x="1160688" y="0"/>
                </a:lnTo>
                <a:lnTo>
                  <a:pt x="983189" y="331786"/>
                </a:lnTo>
                <a:cubicBezTo>
                  <a:pt x="914866" y="469145"/>
                  <a:pt x="850355" y="608712"/>
                  <a:pt x="789261" y="750263"/>
                </a:cubicBezTo>
                <a:cubicBezTo>
                  <a:pt x="774307" y="784928"/>
                  <a:pt x="759992" y="819849"/>
                  <a:pt x="745295" y="854514"/>
                </a:cubicBezTo>
                <a:cubicBezTo>
                  <a:pt x="756682" y="845393"/>
                  <a:pt x="765489" y="833492"/>
                  <a:pt x="770857" y="819975"/>
                </a:cubicBezTo>
                <a:cubicBezTo>
                  <a:pt x="879943" y="589569"/>
                  <a:pt x="999605" y="365513"/>
                  <a:pt x="1131329" y="148742"/>
                </a:cubicBezTo>
                <a:lnTo>
                  <a:pt x="1227589" y="0"/>
                </a:lnTo>
                <a:lnTo>
                  <a:pt x="6878775" y="0"/>
                </a:lnTo>
                <a:lnTo>
                  <a:pt x="6878775" y="6858000"/>
                </a:lnTo>
                <a:lnTo>
                  <a:pt x="713521" y="6858000"/>
                </a:lnTo>
                <a:lnTo>
                  <a:pt x="625642" y="6670527"/>
                </a:lnTo>
                <a:cubicBezTo>
                  <a:pt x="507232" y="6398531"/>
                  <a:pt x="403083" y="6118381"/>
                  <a:pt x="312785" y="5830359"/>
                </a:cubicBezTo>
                <a:cubicBezTo>
                  <a:pt x="278149" y="5719759"/>
                  <a:pt x="248879" y="5607635"/>
                  <a:pt x="212198" y="5480401"/>
                </a:cubicBezTo>
                <a:cubicBezTo>
                  <a:pt x="212208" y="5491601"/>
                  <a:pt x="212803" y="5502788"/>
                  <a:pt x="213988" y="5513923"/>
                </a:cubicBezTo>
                <a:cubicBezTo>
                  <a:pt x="264089" y="5723695"/>
                  <a:pt x="307290" y="5935370"/>
                  <a:pt x="365826" y="6142729"/>
                </a:cubicBezTo>
                <a:cubicBezTo>
                  <a:pt x="433152" y="6380817"/>
                  <a:pt x="510068" y="6614016"/>
                  <a:pt x="597975" y="6841549"/>
                </a:cubicBezTo>
                <a:lnTo>
                  <a:pt x="604824" y="6858000"/>
                </a:lnTo>
                <a:lnTo>
                  <a:pt x="552056" y="6858000"/>
                </a:lnTo>
                <a:lnTo>
                  <a:pt x="539576" y="6828295"/>
                </a:lnTo>
                <a:cubicBezTo>
                  <a:pt x="380597" y="6414594"/>
                  <a:pt x="260223" y="5988893"/>
                  <a:pt x="171555" y="5552906"/>
                </a:cubicBezTo>
                <a:cubicBezTo>
                  <a:pt x="91163" y="5157998"/>
                  <a:pt x="43746" y="4758899"/>
                  <a:pt x="12305" y="4357388"/>
                </a:cubicBezTo>
                <a:cubicBezTo>
                  <a:pt x="-14281" y="4013908"/>
                  <a:pt x="4507" y="3672965"/>
                  <a:pt x="46684" y="3331516"/>
                </a:cubicBezTo>
                <a:cubicBezTo>
                  <a:pt x="127203" y="2664286"/>
                  <a:pt x="277819" y="2007265"/>
                  <a:pt x="496065" y="1371196"/>
                </a:cubicBezTo>
                <a:cubicBezTo>
                  <a:pt x="636273" y="966066"/>
                  <a:pt x="800445" y="573253"/>
                  <a:pt x="995723" y="196614"/>
                </a:cubicBez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9830023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66" name="Rectangle 65">
            <a:extLst>
              <a:ext uri="{FF2B5EF4-FFF2-40B4-BE49-F238E27FC236}">
                <a16:creationId xmlns:a16="http://schemas.microsoft.com/office/drawing/2014/main" id="{9B7AD9F6-8CE7-4299-8FC6-328F4DCD3F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7A8C61D1-2BF0-787A-D8B8-69EDE7F78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640080"/>
            <a:ext cx="6251110" cy="3566160"/>
          </a:xfrm>
        </p:spPr>
        <p:txBody>
          <a:bodyPr vert="horz" lIns="91440" tIns="45720" rIns="91440" bIns="45720" rtlCol="0" anchor="b">
            <a:noAutofit/>
          </a:bodyPr>
          <a:lstStyle/>
          <a:p>
            <a:pPr algn="l">
              <a:lnSpc>
                <a:spcPct val="90000"/>
              </a:lnSpc>
            </a:pPr>
            <a:r>
              <a:rPr lang="en-US" sz="5400" dirty="0">
                <a:solidFill>
                  <a:schemeClr val="tx1"/>
                </a:solidFill>
              </a:rPr>
              <a:t>How might we use an online tool to help AYAs practice new skills to manage depressive symptoms?</a:t>
            </a:r>
          </a:p>
        </p:txBody>
      </p:sp>
      <p:sp>
        <p:nvSpPr>
          <p:cNvPr id="68" name="Rectangle 6">
            <a:extLst>
              <a:ext uri="{FF2B5EF4-FFF2-40B4-BE49-F238E27FC236}">
                <a16:creationId xmlns:a16="http://schemas.microsoft.com/office/drawing/2014/main" id="{F49775AF-8896-43EE-92C6-83497D6DC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4409267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FEC470"/>
          </a:solidFill>
          <a:ln w="38100" cap="rnd">
            <a:solidFill>
              <a:srgbClr val="FEC470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3A76F30-59B9-05CA-4C43-9DDE3CFA47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614" t="4445" r="16225" b="-4445"/>
          <a:stretch/>
        </p:blipFill>
        <p:spPr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6066255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feedback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9969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46" name="Rectangle 49">
            <a:extLst>
              <a:ext uri="{FF2B5EF4-FFF2-40B4-BE49-F238E27FC236}">
                <a16:creationId xmlns:a16="http://schemas.microsoft.com/office/drawing/2014/main" id="{2B97F24A-32CE-4C1C-A50D-3016B394DCF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9BD76C87-ADA2-4A00-8542-52268D35D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936" y="639520"/>
            <a:ext cx="3429000" cy="1719072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l"/>
            <a:r>
              <a:rPr lang="en-US" sz="5400"/>
              <a:t>Wakeful</a:t>
            </a:r>
          </a:p>
        </p:txBody>
      </p:sp>
      <p:sp>
        <p:nvSpPr>
          <p:cNvPr id="47" name="Rectangle 6">
            <a:extLst>
              <a:ext uri="{FF2B5EF4-FFF2-40B4-BE49-F238E27FC236}">
                <a16:creationId xmlns:a16="http://schemas.microsoft.com/office/drawing/2014/main" id="{3CE8AF5E-D374-4CF1-90CC-35CF73B81C3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79084" y="2532888"/>
            <a:ext cx="3291840" cy="18288"/>
          </a:xfrm>
          <a:custGeom>
            <a:avLst/>
            <a:gdLst>
              <a:gd name="connsiteX0" fmla="*/ 0 w 3291840"/>
              <a:gd name="connsiteY0" fmla="*/ 0 h 18288"/>
              <a:gd name="connsiteX1" fmla="*/ 625450 w 3291840"/>
              <a:gd name="connsiteY1" fmla="*/ 0 h 18288"/>
              <a:gd name="connsiteX2" fmla="*/ 1283818 w 3291840"/>
              <a:gd name="connsiteY2" fmla="*/ 0 h 18288"/>
              <a:gd name="connsiteX3" fmla="*/ 1975104 w 3291840"/>
              <a:gd name="connsiteY3" fmla="*/ 0 h 18288"/>
              <a:gd name="connsiteX4" fmla="*/ 2666390 w 3291840"/>
              <a:gd name="connsiteY4" fmla="*/ 0 h 18288"/>
              <a:gd name="connsiteX5" fmla="*/ 3291840 w 3291840"/>
              <a:gd name="connsiteY5" fmla="*/ 0 h 18288"/>
              <a:gd name="connsiteX6" fmla="*/ 3291840 w 3291840"/>
              <a:gd name="connsiteY6" fmla="*/ 18288 h 18288"/>
              <a:gd name="connsiteX7" fmla="*/ 2567635 w 3291840"/>
              <a:gd name="connsiteY7" fmla="*/ 18288 h 18288"/>
              <a:gd name="connsiteX8" fmla="*/ 1843430 w 3291840"/>
              <a:gd name="connsiteY8" fmla="*/ 18288 h 18288"/>
              <a:gd name="connsiteX9" fmla="*/ 1185062 w 3291840"/>
              <a:gd name="connsiteY9" fmla="*/ 18288 h 18288"/>
              <a:gd name="connsiteX10" fmla="*/ 0 w 3291840"/>
              <a:gd name="connsiteY10" fmla="*/ 18288 h 18288"/>
              <a:gd name="connsiteX11" fmla="*/ 0 w 3291840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91840" h="18288" fill="none" extrusionOk="0">
                <a:moveTo>
                  <a:pt x="0" y="0"/>
                </a:moveTo>
                <a:cubicBezTo>
                  <a:pt x="173613" y="5552"/>
                  <a:pt x="489242" y="1770"/>
                  <a:pt x="625450" y="0"/>
                </a:cubicBezTo>
                <a:cubicBezTo>
                  <a:pt x="761658" y="-1770"/>
                  <a:pt x="1015131" y="32079"/>
                  <a:pt x="1283818" y="0"/>
                </a:cubicBezTo>
                <a:cubicBezTo>
                  <a:pt x="1552505" y="-32079"/>
                  <a:pt x="1752773" y="10771"/>
                  <a:pt x="1975104" y="0"/>
                </a:cubicBezTo>
                <a:cubicBezTo>
                  <a:pt x="2197435" y="-10771"/>
                  <a:pt x="2433070" y="21341"/>
                  <a:pt x="2666390" y="0"/>
                </a:cubicBezTo>
                <a:cubicBezTo>
                  <a:pt x="2899710" y="-21341"/>
                  <a:pt x="3028437" y="16612"/>
                  <a:pt x="3291840" y="0"/>
                </a:cubicBezTo>
                <a:cubicBezTo>
                  <a:pt x="3291131" y="8157"/>
                  <a:pt x="3291427" y="12125"/>
                  <a:pt x="3291840" y="18288"/>
                </a:cubicBezTo>
                <a:cubicBezTo>
                  <a:pt x="3043276" y="37868"/>
                  <a:pt x="2921041" y="-12908"/>
                  <a:pt x="2567635" y="18288"/>
                </a:cubicBezTo>
                <a:cubicBezTo>
                  <a:pt x="2214230" y="49484"/>
                  <a:pt x="2189623" y="-13019"/>
                  <a:pt x="1843430" y="18288"/>
                </a:cubicBezTo>
                <a:cubicBezTo>
                  <a:pt x="1497237" y="49595"/>
                  <a:pt x="1492584" y="29180"/>
                  <a:pt x="1185062" y="18288"/>
                </a:cubicBezTo>
                <a:cubicBezTo>
                  <a:pt x="877540" y="7396"/>
                  <a:pt x="313238" y="464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91840" h="18288" stroke="0" extrusionOk="0">
                <a:moveTo>
                  <a:pt x="0" y="0"/>
                </a:moveTo>
                <a:cubicBezTo>
                  <a:pt x="281971" y="23935"/>
                  <a:pt x="485873" y="-14021"/>
                  <a:pt x="625450" y="0"/>
                </a:cubicBezTo>
                <a:cubicBezTo>
                  <a:pt x="765027" y="14021"/>
                  <a:pt x="1048900" y="27914"/>
                  <a:pt x="1185062" y="0"/>
                </a:cubicBezTo>
                <a:cubicBezTo>
                  <a:pt x="1321224" y="-27914"/>
                  <a:pt x="1648252" y="-3988"/>
                  <a:pt x="1909267" y="0"/>
                </a:cubicBezTo>
                <a:cubicBezTo>
                  <a:pt x="2170282" y="3988"/>
                  <a:pt x="2301957" y="25891"/>
                  <a:pt x="2534717" y="0"/>
                </a:cubicBezTo>
                <a:cubicBezTo>
                  <a:pt x="2767477" y="-25891"/>
                  <a:pt x="3078800" y="21500"/>
                  <a:pt x="3291840" y="0"/>
                </a:cubicBezTo>
                <a:cubicBezTo>
                  <a:pt x="3291576" y="4493"/>
                  <a:pt x="3292224" y="9472"/>
                  <a:pt x="3291840" y="18288"/>
                </a:cubicBezTo>
                <a:cubicBezTo>
                  <a:pt x="3120474" y="15714"/>
                  <a:pt x="2816568" y="4633"/>
                  <a:pt x="2633472" y="18288"/>
                </a:cubicBezTo>
                <a:cubicBezTo>
                  <a:pt x="2450376" y="31943"/>
                  <a:pt x="2160769" y="37350"/>
                  <a:pt x="1909267" y="18288"/>
                </a:cubicBezTo>
                <a:cubicBezTo>
                  <a:pt x="1657765" y="-774"/>
                  <a:pt x="1623992" y="9648"/>
                  <a:pt x="1349654" y="18288"/>
                </a:cubicBezTo>
                <a:cubicBezTo>
                  <a:pt x="1075316" y="26928"/>
                  <a:pt x="833426" y="34181"/>
                  <a:pt x="691286" y="18288"/>
                </a:cubicBezTo>
                <a:cubicBezTo>
                  <a:pt x="549146" y="2395"/>
                  <a:pt x="342011" y="24201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rgbClr val="FD7658"/>
          </a:solidFill>
          <a:ln w="38100" cap="rnd">
            <a:solidFill>
              <a:srgbClr val="FD7658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A7E2950A-A857-4BFE-8B6F-7FDC01852F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30936" y="2807208"/>
            <a:ext cx="3429000" cy="3410712"/>
          </a:xfrm>
        </p:spPr>
        <p:txBody>
          <a:bodyPr vert="horz" lIns="91440" tIns="45720" rIns="91440" bIns="45720" rtlCol="0" anchor="t">
            <a:normAutofit/>
          </a:bodyPr>
          <a:lstStyle/>
          <a:p>
            <a:pPr>
              <a:lnSpc>
                <a:spcPct val="100000"/>
              </a:lnSpc>
            </a:pPr>
            <a:r>
              <a:rPr lang="en-US" sz="2000" dirty="0"/>
              <a:t>9-week online mindfulness course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New class opens each week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Each class takes ~90 minutes</a:t>
            </a:r>
          </a:p>
          <a:p>
            <a:pPr lvl="1">
              <a:lnSpc>
                <a:spcPct val="100000"/>
              </a:lnSpc>
            </a:pPr>
            <a:r>
              <a:rPr lang="en-US" sz="2000" dirty="0"/>
              <a:t>Recommended to complete over 1-3 days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Time in between classes to practice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49" name="Ink 53">
                <a:extLst>
                  <a:ext uri="{FF2B5EF4-FFF2-40B4-BE49-F238E27FC236}">
                    <a16:creationId xmlns:a16="http://schemas.microsoft.com/office/drawing/2014/main" id="{070477C5-0410-4E4F-97A1-F84C2465C187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14:cNvPr>
              <p14:cNvContentPartPr>
                <a14:cpLocks xmlns:a14="http://schemas.microsoft.com/office/drawing/2010/main" noGrp="1" noRot="1" noChangeAspect="1" noMove="1" noResize="1" noEditPoints="1" noAdjustHandles="1" noChangeArrowheads="1" noChangeShapeType="1"/>
              </p14:cNvContentPartPr>
              <p14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14:nvPr>
            </p14:nvContentPartPr>
            <p14:xfrm>
              <a:off x="5755403" y="1971579"/>
              <a:ext cx="360" cy="2160"/>
            </p14:xfrm>
          </p:contentPart>
        </mc:Choice>
        <mc:Fallback xmlns="">
          <p:pic>
            <p:nvPicPr>
              <p:cNvPr id="49" name="Ink 53">
                <a:extLst>
                  <a:ext uri="{FF2B5EF4-FFF2-40B4-BE49-F238E27FC236}">
                    <a16:creationId xmlns:a16="http://schemas.microsoft.com/office/drawing/2014/main" id="{070477C5-0410-4E4F-97A1-F84C2465C187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37403" y="1956150"/>
                <a:ext cx="36000" cy="32709"/>
              </a:xfrm>
              <a:prstGeom prst="rect">
                <a:avLst/>
              </a:prstGeom>
            </p:spPr>
          </p:pic>
        </mc:Fallback>
      </mc:AlternateContent>
      <p:pic>
        <p:nvPicPr>
          <p:cNvPr id="43" name="Content Placeholder 42">
            <a:extLst>
              <a:ext uri="{FF2B5EF4-FFF2-40B4-BE49-F238E27FC236}">
                <a16:creationId xmlns:a16="http://schemas.microsoft.com/office/drawing/2014/main" id="{EED26A06-DEBB-4EF1-AEF2-5D9C3758E9AC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l="14159" t="-24" r="14245" b="24"/>
          <a:stretch/>
        </p:blipFill>
        <p:spPr>
          <a:xfrm>
            <a:off x="4657342" y="1204967"/>
            <a:ext cx="6903720" cy="4411489"/>
          </a:xfrm>
          <a:custGeom>
            <a:avLst/>
            <a:gdLst>
              <a:gd name="connsiteX0" fmla="*/ 0 w 6903720"/>
              <a:gd name="connsiteY0" fmla="*/ 0 h 4411489"/>
              <a:gd name="connsiteX1" fmla="*/ 713384 w 6903720"/>
              <a:gd name="connsiteY1" fmla="*/ 0 h 4411489"/>
              <a:gd name="connsiteX2" fmla="*/ 1219657 w 6903720"/>
              <a:gd name="connsiteY2" fmla="*/ 0 h 4411489"/>
              <a:gd name="connsiteX3" fmla="*/ 1864004 w 6903720"/>
              <a:gd name="connsiteY3" fmla="*/ 0 h 4411489"/>
              <a:gd name="connsiteX4" fmla="*/ 2439314 w 6903720"/>
              <a:gd name="connsiteY4" fmla="*/ 0 h 4411489"/>
              <a:gd name="connsiteX5" fmla="*/ 2807513 w 6903720"/>
              <a:gd name="connsiteY5" fmla="*/ 0 h 4411489"/>
              <a:gd name="connsiteX6" fmla="*/ 3520897 w 6903720"/>
              <a:gd name="connsiteY6" fmla="*/ 0 h 4411489"/>
              <a:gd name="connsiteX7" fmla="*/ 4096207 w 6903720"/>
              <a:gd name="connsiteY7" fmla="*/ 0 h 4411489"/>
              <a:gd name="connsiteX8" fmla="*/ 4671517 w 6903720"/>
              <a:gd name="connsiteY8" fmla="*/ 0 h 4411489"/>
              <a:gd name="connsiteX9" fmla="*/ 5177790 w 6903720"/>
              <a:gd name="connsiteY9" fmla="*/ 0 h 4411489"/>
              <a:gd name="connsiteX10" fmla="*/ 5684063 w 6903720"/>
              <a:gd name="connsiteY10" fmla="*/ 0 h 4411489"/>
              <a:gd name="connsiteX11" fmla="*/ 6328410 w 6903720"/>
              <a:gd name="connsiteY11" fmla="*/ 0 h 4411489"/>
              <a:gd name="connsiteX12" fmla="*/ 6903720 w 6903720"/>
              <a:gd name="connsiteY12" fmla="*/ 0 h 4411489"/>
              <a:gd name="connsiteX13" fmla="*/ 6903720 w 6903720"/>
              <a:gd name="connsiteY13" fmla="*/ 419091 h 4411489"/>
              <a:gd name="connsiteX14" fmla="*/ 6903720 w 6903720"/>
              <a:gd name="connsiteY14" fmla="*/ 970528 h 4411489"/>
              <a:gd name="connsiteX15" fmla="*/ 6903720 w 6903720"/>
              <a:gd name="connsiteY15" fmla="*/ 1566079 h 4411489"/>
              <a:gd name="connsiteX16" fmla="*/ 6903720 w 6903720"/>
              <a:gd name="connsiteY16" fmla="*/ 2205745 h 4411489"/>
              <a:gd name="connsiteX17" fmla="*/ 6903720 w 6903720"/>
              <a:gd name="connsiteY17" fmla="*/ 2624836 h 4411489"/>
              <a:gd name="connsiteX18" fmla="*/ 6903720 w 6903720"/>
              <a:gd name="connsiteY18" fmla="*/ 3132157 h 4411489"/>
              <a:gd name="connsiteX19" fmla="*/ 6903720 w 6903720"/>
              <a:gd name="connsiteY19" fmla="*/ 3727708 h 4411489"/>
              <a:gd name="connsiteX20" fmla="*/ 6903720 w 6903720"/>
              <a:gd name="connsiteY20" fmla="*/ 4411489 h 4411489"/>
              <a:gd name="connsiteX21" fmla="*/ 6397447 w 6903720"/>
              <a:gd name="connsiteY21" fmla="*/ 4411489 h 4411489"/>
              <a:gd name="connsiteX22" fmla="*/ 5684063 w 6903720"/>
              <a:gd name="connsiteY22" fmla="*/ 4411489 h 4411489"/>
              <a:gd name="connsiteX23" fmla="*/ 5039716 w 6903720"/>
              <a:gd name="connsiteY23" fmla="*/ 4411489 h 4411489"/>
              <a:gd name="connsiteX24" fmla="*/ 4326331 w 6903720"/>
              <a:gd name="connsiteY24" fmla="*/ 4411489 h 4411489"/>
              <a:gd name="connsiteX25" fmla="*/ 3889096 w 6903720"/>
              <a:gd name="connsiteY25" fmla="*/ 4411489 h 4411489"/>
              <a:gd name="connsiteX26" fmla="*/ 3244748 w 6903720"/>
              <a:gd name="connsiteY26" fmla="*/ 4411489 h 4411489"/>
              <a:gd name="connsiteX27" fmla="*/ 2738476 w 6903720"/>
              <a:gd name="connsiteY27" fmla="*/ 4411489 h 4411489"/>
              <a:gd name="connsiteX28" fmla="*/ 2370277 w 6903720"/>
              <a:gd name="connsiteY28" fmla="*/ 4411489 h 4411489"/>
              <a:gd name="connsiteX29" fmla="*/ 1864004 w 6903720"/>
              <a:gd name="connsiteY29" fmla="*/ 4411489 h 4411489"/>
              <a:gd name="connsiteX30" fmla="*/ 1288694 w 6903720"/>
              <a:gd name="connsiteY30" fmla="*/ 4411489 h 4411489"/>
              <a:gd name="connsiteX31" fmla="*/ 575310 w 6903720"/>
              <a:gd name="connsiteY31" fmla="*/ 4411489 h 4411489"/>
              <a:gd name="connsiteX32" fmla="*/ 0 w 6903720"/>
              <a:gd name="connsiteY32" fmla="*/ 4411489 h 4411489"/>
              <a:gd name="connsiteX33" fmla="*/ 0 w 6903720"/>
              <a:gd name="connsiteY33" fmla="*/ 3904168 h 4411489"/>
              <a:gd name="connsiteX34" fmla="*/ 0 w 6903720"/>
              <a:gd name="connsiteY34" fmla="*/ 3485076 h 4411489"/>
              <a:gd name="connsiteX35" fmla="*/ 0 w 6903720"/>
              <a:gd name="connsiteY35" fmla="*/ 2933640 h 4411489"/>
              <a:gd name="connsiteX36" fmla="*/ 0 w 6903720"/>
              <a:gd name="connsiteY36" fmla="*/ 2426319 h 4411489"/>
              <a:gd name="connsiteX37" fmla="*/ 0 w 6903720"/>
              <a:gd name="connsiteY37" fmla="*/ 2007227 h 4411489"/>
              <a:gd name="connsiteX38" fmla="*/ 0 w 6903720"/>
              <a:gd name="connsiteY38" fmla="*/ 1411676 h 4411489"/>
              <a:gd name="connsiteX39" fmla="*/ 0 w 6903720"/>
              <a:gd name="connsiteY39" fmla="*/ 772011 h 4411489"/>
              <a:gd name="connsiteX40" fmla="*/ 0 w 6903720"/>
              <a:gd name="connsiteY40" fmla="*/ 0 h 44114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</a:cxnLst>
            <a:rect l="l" t="t" r="r" b="b"/>
            <a:pathLst>
              <a:path w="6903720" h="4411489" fill="none" extrusionOk="0">
                <a:moveTo>
                  <a:pt x="0" y="0"/>
                </a:moveTo>
                <a:cubicBezTo>
                  <a:pt x="275608" y="-61704"/>
                  <a:pt x="414643" y="28994"/>
                  <a:pt x="713384" y="0"/>
                </a:cubicBezTo>
                <a:cubicBezTo>
                  <a:pt x="1012125" y="-28994"/>
                  <a:pt x="1000456" y="32890"/>
                  <a:pt x="1219657" y="0"/>
                </a:cubicBezTo>
                <a:cubicBezTo>
                  <a:pt x="1438858" y="-32890"/>
                  <a:pt x="1565984" y="14409"/>
                  <a:pt x="1864004" y="0"/>
                </a:cubicBezTo>
                <a:cubicBezTo>
                  <a:pt x="2162024" y="-14409"/>
                  <a:pt x="2262378" y="9084"/>
                  <a:pt x="2439314" y="0"/>
                </a:cubicBezTo>
                <a:cubicBezTo>
                  <a:pt x="2616250" y="-9084"/>
                  <a:pt x="2711804" y="23171"/>
                  <a:pt x="2807513" y="0"/>
                </a:cubicBezTo>
                <a:cubicBezTo>
                  <a:pt x="2903222" y="-23171"/>
                  <a:pt x="3363819" y="18683"/>
                  <a:pt x="3520897" y="0"/>
                </a:cubicBezTo>
                <a:cubicBezTo>
                  <a:pt x="3677975" y="-18683"/>
                  <a:pt x="3859230" y="13257"/>
                  <a:pt x="4096207" y="0"/>
                </a:cubicBezTo>
                <a:cubicBezTo>
                  <a:pt x="4333184" y="-13257"/>
                  <a:pt x="4541303" y="35010"/>
                  <a:pt x="4671517" y="0"/>
                </a:cubicBezTo>
                <a:cubicBezTo>
                  <a:pt x="4801731" y="-35010"/>
                  <a:pt x="4967275" y="21224"/>
                  <a:pt x="5177790" y="0"/>
                </a:cubicBezTo>
                <a:cubicBezTo>
                  <a:pt x="5388305" y="-21224"/>
                  <a:pt x="5470325" y="48653"/>
                  <a:pt x="5684063" y="0"/>
                </a:cubicBezTo>
                <a:cubicBezTo>
                  <a:pt x="5897801" y="-48653"/>
                  <a:pt x="6049387" y="57390"/>
                  <a:pt x="6328410" y="0"/>
                </a:cubicBezTo>
                <a:cubicBezTo>
                  <a:pt x="6607433" y="-57390"/>
                  <a:pt x="6755329" y="53114"/>
                  <a:pt x="6903720" y="0"/>
                </a:cubicBezTo>
                <a:cubicBezTo>
                  <a:pt x="6923188" y="117278"/>
                  <a:pt x="6868248" y="249713"/>
                  <a:pt x="6903720" y="419091"/>
                </a:cubicBezTo>
                <a:cubicBezTo>
                  <a:pt x="6939192" y="588469"/>
                  <a:pt x="6880297" y="825941"/>
                  <a:pt x="6903720" y="970528"/>
                </a:cubicBezTo>
                <a:cubicBezTo>
                  <a:pt x="6927143" y="1115115"/>
                  <a:pt x="6877120" y="1396727"/>
                  <a:pt x="6903720" y="1566079"/>
                </a:cubicBezTo>
                <a:cubicBezTo>
                  <a:pt x="6930320" y="1735431"/>
                  <a:pt x="6868376" y="2027762"/>
                  <a:pt x="6903720" y="2205745"/>
                </a:cubicBezTo>
                <a:cubicBezTo>
                  <a:pt x="6939064" y="2383728"/>
                  <a:pt x="6865981" y="2421206"/>
                  <a:pt x="6903720" y="2624836"/>
                </a:cubicBezTo>
                <a:cubicBezTo>
                  <a:pt x="6941459" y="2828466"/>
                  <a:pt x="6853475" y="2881572"/>
                  <a:pt x="6903720" y="3132157"/>
                </a:cubicBezTo>
                <a:cubicBezTo>
                  <a:pt x="6953965" y="3382742"/>
                  <a:pt x="6867540" y="3537773"/>
                  <a:pt x="6903720" y="3727708"/>
                </a:cubicBezTo>
                <a:cubicBezTo>
                  <a:pt x="6939900" y="3917643"/>
                  <a:pt x="6903321" y="4259964"/>
                  <a:pt x="6903720" y="4411489"/>
                </a:cubicBezTo>
                <a:cubicBezTo>
                  <a:pt x="6753373" y="4428759"/>
                  <a:pt x="6626123" y="4364332"/>
                  <a:pt x="6397447" y="4411489"/>
                </a:cubicBezTo>
                <a:cubicBezTo>
                  <a:pt x="6168771" y="4458646"/>
                  <a:pt x="5945160" y="4345221"/>
                  <a:pt x="5684063" y="4411489"/>
                </a:cubicBezTo>
                <a:cubicBezTo>
                  <a:pt x="5422966" y="4477757"/>
                  <a:pt x="5196696" y="4369135"/>
                  <a:pt x="5039716" y="4411489"/>
                </a:cubicBezTo>
                <a:cubicBezTo>
                  <a:pt x="4882736" y="4453843"/>
                  <a:pt x="4484960" y="4352917"/>
                  <a:pt x="4326331" y="4411489"/>
                </a:cubicBezTo>
                <a:cubicBezTo>
                  <a:pt x="4167702" y="4470061"/>
                  <a:pt x="4063003" y="4374737"/>
                  <a:pt x="3889096" y="4411489"/>
                </a:cubicBezTo>
                <a:cubicBezTo>
                  <a:pt x="3715189" y="4448241"/>
                  <a:pt x="3526642" y="4361299"/>
                  <a:pt x="3244748" y="4411489"/>
                </a:cubicBezTo>
                <a:cubicBezTo>
                  <a:pt x="2962854" y="4461679"/>
                  <a:pt x="2949564" y="4368080"/>
                  <a:pt x="2738476" y="4411489"/>
                </a:cubicBezTo>
                <a:cubicBezTo>
                  <a:pt x="2527388" y="4454898"/>
                  <a:pt x="2483519" y="4377999"/>
                  <a:pt x="2370277" y="4411489"/>
                </a:cubicBezTo>
                <a:cubicBezTo>
                  <a:pt x="2257035" y="4444979"/>
                  <a:pt x="2109874" y="4390859"/>
                  <a:pt x="1864004" y="4411489"/>
                </a:cubicBezTo>
                <a:cubicBezTo>
                  <a:pt x="1618134" y="4432119"/>
                  <a:pt x="1491695" y="4387169"/>
                  <a:pt x="1288694" y="4411489"/>
                </a:cubicBezTo>
                <a:cubicBezTo>
                  <a:pt x="1085693" y="4435809"/>
                  <a:pt x="882334" y="4333089"/>
                  <a:pt x="575310" y="4411489"/>
                </a:cubicBezTo>
                <a:cubicBezTo>
                  <a:pt x="268286" y="4489889"/>
                  <a:pt x="219231" y="4348373"/>
                  <a:pt x="0" y="4411489"/>
                </a:cubicBezTo>
                <a:cubicBezTo>
                  <a:pt x="-6256" y="4209151"/>
                  <a:pt x="20605" y="4071145"/>
                  <a:pt x="0" y="3904168"/>
                </a:cubicBezTo>
                <a:cubicBezTo>
                  <a:pt x="-20605" y="3737191"/>
                  <a:pt x="49547" y="3630815"/>
                  <a:pt x="0" y="3485076"/>
                </a:cubicBezTo>
                <a:cubicBezTo>
                  <a:pt x="-49547" y="3339337"/>
                  <a:pt x="4352" y="3140238"/>
                  <a:pt x="0" y="2933640"/>
                </a:cubicBezTo>
                <a:cubicBezTo>
                  <a:pt x="-4352" y="2727042"/>
                  <a:pt x="31443" y="2611356"/>
                  <a:pt x="0" y="2426319"/>
                </a:cubicBezTo>
                <a:cubicBezTo>
                  <a:pt x="-31443" y="2241282"/>
                  <a:pt x="35269" y="2091876"/>
                  <a:pt x="0" y="2007227"/>
                </a:cubicBezTo>
                <a:cubicBezTo>
                  <a:pt x="-35269" y="1922578"/>
                  <a:pt x="65139" y="1618445"/>
                  <a:pt x="0" y="1411676"/>
                </a:cubicBezTo>
                <a:cubicBezTo>
                  <a:pt x="-65139" y="1204907"/>
                  <a:pt x="73551" y="1085474"/>
                  <a:pt x="0" y="772011"/>
                </a:cubicBezTo>
                <a:cubicBezTo>
                  <a:pt x="-73551" y="458548"/>
                  <a:pt x="1754" y="194463"/>
                  <a:pt x="0" y="0"/>
                </a:cubicBezTo>
                <a:close/>
              </a:path>
              <a:path w="6903720" h="4411489" stroke="0" extrusionOk="0">
                <a:moveTo>
                  <a:pt x="0" y="0"/>
                </a:moveTo>
                <a:cubicBezTo>
                  <a:pt x="220052" y="-70741"/>
                  <a:pt x="479975" y="63146"/>
                  <a:pt x="644347" y="0"/>
                </a:cubicBezTo>
                <a:cubicBezTo>
                  <a:pt x="808719" y="-63146"/>
                  <a:pt x="1073652" y="34141"/>
                  <a:pt x="1219657" y="0"/>
                </a:cubicBezTo>
                <a:cubicBezTo>
                  <a:pt x="1365662" y="-34141"/>
                  <a:pt x="1717983" y="14127"/>
                  <a:pt x="1864004" y="0"/>
                </a:cubicBezTo>
                <a:cubicBezTo>
                  <a:pt x="2010025" y="-14127"/>
                  <a:pt x="2160215" y="65467"/>
                  <a:pt x="2439314" y="0"/>
                </a:cubicBezTo>
                <a:cubicBezTo>
                  <a:pt x="2718413" y="-65467"/>
                  <a:pt x="2871519" y="8733"/>
                  <a:pt x="3014624" y="0"/>
                </a:cubicBezTo>
                <a:cubicBezTo>
                  <a:pt x="3157729" y="-8733"/>
                  <a:pt x="3463840" y="20929"/>
                  <a:pt x="3589934" y="0"/>
                </a:cubicBezTo>
                <a:cubicBezTo>
                  <a:pt x="3716028" y="-20929"/>
                  <a:pt x="3947582" y="73954"/>
                  <a:pt x="4234282" y="0"/>
                </a:cubicBezTo>
                <a:cubicBezTo>
                  <a:pt x="4520982" y="-73954"/>
                  <a:pt x="4708048" y="19590"/>
                  <a:pt x="4947666" y="0"/>
                </a:cubicBezTo>
                <a:cubicBezTo>
                  <a:pt x="5187284" y="-19590"/>
                  <a:pt x="5488942" y="27401"/>
                  <a:pt x="5661050" y="0"/>
                </a:cubicBezTo>
                <a:cubicBezTo>
                  <a:pt x="5833158" y="-27401"/>
                  <a:pt x="5963652" y="9962"/>
                  <a:pt x="6167323" y="0"/>
                </a:cubicBezTo>
                <a:cubicBezTo>
                  <a:pt x="6370994" y="-9962"/>
                  <a:pt x="6753168" y="72661"/>
                  <a:pt x="6903720" y="0"/>
                </a:cubicBezTo>
                <a:cubicBezTo>
                  <a:pt x="6916689" y="96909"/>
                  <a:pt x="6868331" y="243461"/>
                  <a:pt x="6903720" y="419091"/>
                </a:cubicBezTo>
                <a:cubicBezTo>
                  <a:pt x="6939109" y="594721"/>
                  <a:pt x="6851877" y="800233"/>
                  <a:pt x="6903720" y="1014642"/>
                </a:cubicBezTo>
                <a:cubicBezTo>
                  <a:pt x="6955563" y="1229051"/>
                  <a:pt x="6882530" y="1351375"/>
                  <a:pt x="6903720" y="1477849"/>
                </a:cubicBezTo>
                <a:cubicBezTo>
                  <a:pt x="6924910" y="1604323"/>
                  <a:pt x="6877437" y="1808210"/>
                  <a:pt x="6903720" y="1896940"/>
                </a:cubicBezTo>
                <a:cubicBezTo>
                  <a:pt x="6930003" y="1985670"/>
                  <a:pt x="6874031" y="2160633"/>
                  <a:pt x="6903720" y="2360147"/>
                </a:cubicBezTo>
                <a:cubicBezTo>
                  <a:pt x="6933409" y="2559661"/>
                  <a:pt x="6864245" y="2654011"/>
                  <a:pt x="6903720" y="2867468"/>
                </a:cubicBezTo>
                <a:cubicBezTo>
                  <a:pt x="6943195" y="3080925"/>
                  <a:pt x="6890794" y="3250345"/>
                  <a:pt x="6903720" y="3374789"/>
                </a:cubicBezTo>
                <a:cubicBezTo>
                  <a:pt x="6916646" y="3499233"/>
                  <a:pt x="6881485" y="3666269"/>
                  <a:pt x="6903720" y="3837995"/>
                </a:cubicBezTo>
                <a:cubicBezTo>
                  <a:pt x="6925955" y="4009721"/>
                  <a:pt x="6876863" y="4173422"/>
                  <a:pt x="6903720" y="4411489"/>
                </a:cubicBezTo>
                <a:cubicBezTo>
                  <a:pt x="6788295" y="4446070"/>
                  <a:pt x="6717516" y="4390791"/>
                  <a:pt x="6535522" y="4411489"/>
                </a:cubicBezTo>
                <a:cubicBezTo>
                  <a:pt x="6353528" y="4432187"/>
                  <a:pt x="6127656" y="4381581"/>
                  <a:pt x="5822137" y="4411489"/>
                </a:cubicBezTo>
                <a:cubicBezTo>
                  <a:pt x="5516618" y="4441397"/>
                  <a:pt x="5472037" y="4372346"/>
                  <a:pt x="5315864" y="4411489"/>
                </a:cubicBezTo>
                <a:cubicBezTo>
                  <a:pt x="5159691" y="4450632"/>
                  <a:pt x="5037467" y="4376105"/>
                  <a:pt x="4947666" y="4411489"/>
                </a:cubicBezTo>
                <a:cubicBezTo>
                  <a:pt x="4857865" y="4446873"/>
                  <a:pt x="4688377" y="4406217"/>
                  <a:pt x="4441393" y="4411489"/>
                </a:cubicBezTo>
                <a:cubicBezTo>
                  <a:pt x="4194409" y="4416761"/>
                  <a:pt x="4236892" y="4379240"/>
                  <a:pt x="4073195" y="4411489"/>
                </a:cubicBezTo>
                <a:cubicBezTo>
                  <a:pt x="3909498" y="4443738"/>
                  <a:pt x="3774267" y="4384712"/>
                  <a:pt x="3497885" y="4411489"/>
                </a:cubicBezTo>
                <a:cubicBezTo>
                  <a:pt x="3221503" y="4438266"/>
                  <a:pt x="3232091" y="4407887"/>
                  <a:pt x="3060649" y="4411489"/>
                </a:cubicBezTo>
                <a:cubicBezTo>
                  <a:pt x="2889207" y="4415091"/>
                  <a:pt x="2716377" y="4394061"/>
                  <a:pt x="2623414" y="4411489"/>
                </a:cubicBezTo>
                <a:cubicBezTo>
                  <a:pt x="2530451" y="4428917"/>
                  <a:pt x="2076383" y="4397713"/>
                  <a:pt x="1910029" y="4411489"/>
                </a:cubicBezTo>
                <a:cubicBezTo>
                  <a:pt x="1743675" y="4425265"/>
                  <a:pt x="1663529" y="4384778"/>
                  <a:pt x="1541831" y="4411489"/>
                </a:cubicBezTo>
                <a:cubicBezTo>
                  <a:pt x="1420133" y="4438200"/>
                  <a:pt x="1253583" y="4357968"/>
                  <a:pt x="1035558" y="4411489"/>
                </a:cubicBezTo>
                <a:cubicBezTo>
                  <a:pt x="817533" y="4465010"/>
                  <a:pt x="392143" y="4391055"/>
                  <a:pt x="0" y="4411489"/>
                </a:cubicBezTo>
                <a:cubicBezTo>
                  <a:pt x="-62548" y="4202692"/>
                  <a:pt x="41371" y="4035502"/>
                  <a:pt x="0" y="3860053"/>
                </a:cubicBezTo>
                <a:cubicBezTo>
                  <a:pt x="-41371" y="3684604"/>
                  <a:pt x="40067" y="3626590"/>
                  <a:pt x="0" y="3440961"/>
                </a:cubicBezTo>
                <a:cubicBezTo>
                  <a:pt x="-40067" y="3255332"/>
                  <a:pt x="33796" y="3115069"/>
                  <a:pt x="0" y="2933640"/>
                </a:cubicBezTo>
                <a:cubicBezTo>
                  <a:pt x="-33796" y="2752211"/>
                  <a:pt x="35261" y="2464534"/>
                  <a:pt x="0" y="2293974"/>
                </a:cubicBezTo>
                <a:cubicBezTo>
                  <a:pt x="-35261" y="2123414"/>
                  <a:pt x="11802" y="2047662"/>
                  <a:pt x="0" y="1830768"/>
                </a:cubicBezTo>
                <a:cubicBezTo>
                  <a:pt x="-11802" y="1613874"/>
                  <a:pt x="32109" y="1444899"/>
                  <a:pt x="0" y="1191102"/>
                </a:cubicBezTo>
                <a:cubicBezTo>
                  <a:pt x="-32109" y="937305"/>
                  <a:pt x="38351" y="887958"/>
                  <a:pt x="0" y="683781"/>
                </a:cubicBezTo>
                <a:cubicBezTo>
                  <a:pt x="-38351" y="479604"/>
                  <a:pt x="62349" y="184045"/>
                  <a:pt x="0" y="0"/>
                </a:cubicBezTo>
                <a:close/>
              </a:path>
            </a:pathLst>
          </a:custGeom>
          <a:ln>
            <a:solidFill>
              <a:schemeClr val="tx1"/>
            </a:solidFill>
            <a:extLst>
              <a:ext uri="{C807C97D-BFC1-408E-A445-0C87EB9F89A2}">
                <ask:lineSketchStyleProps xmlns:ask="http://schemas.microsoft.com/office/drawing/2018/sketchyshapes" sd="748639630">
                  <a:prstGeom prst="rect">
                    <a:avLst/>
                  </a:prstGeom>
                  <ask:type>
                    <ask:lineSketchScribble/>
                  </ask:type>
                </ask:lineSketchStyleProps>
              </a:ext>
            </a:extLst>
          </a:ln>
        </p:spPr>
      </p:pic>
    </p:spTree>
    <p:extLst>
      <p:ext uri="{BB962C8B-B14F-4D97-AF65-F5344CB8AC3E}">
        <p14:creationId xmlns:p14="http://schemas.microsoft.com/office/powerpoint/2010/main" val="27959964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29" name="Rectangle 16">
            <a:extLst>
              <a:ext uri="{FF2B5EF4-FFF2-40B4-BE49-F238E27FC236}">
                <a16:creationId xmlns:a16="http://schemas.microsoft.com/office/drawing/2014/main" id="{BCED4D40-4B67-4331-AC48-79B82B4A47D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E488B14-4C12-454D-998D-9FA053E7F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1" y="839865"/>
            <a:ext cx="10909640" cy="904970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lnSpc>
                <a:spcPct val="90000"/>
              </a:lnSpc>
            </a:pPr>
            <a:r>
              <a:rPr lang="en-US" sz="5600"/>
              <a:t>Dashboard &amp; Menus</a:t>
            </a:r>
          </a:p>
        </p:txBody>
      </p:sp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27135DAC-9B75-4039-9FCF-FB4B54140D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77023" y="1744835"/>
            <a:ext cx="10476777" cy="47931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8812F4-D355-4DF7-9A39-690F523223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1744834"/>
            <a:ext cx="10541581" cy="4793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63743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39" name="Rectangle 38">
            <a:extLst>
              <a:ext uri="{FF2B5EF4-FFF2-40B4-BE49-F238E27FC236}">
                <a16:creationId xmlns:a16="http://schemas.microsoft.com/office/drawing/2014/main" id="{C4879EFC-8E62-4E00-973C-C45EE9EC67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itle 16">
            <a:extLst>
              <a:ext uri="{FF2B5EF4-FFF2-40B4-BE49-F238E27FC236}">
                <a16:creationId xmlns:a16="http://schemas.microsoft.com/office/drawing/2014/main" id="{37667867-DCFA-47EB-9E4A-1A4E7AF54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1" y="759978"/>
            <a:ext cx="10909640" cy="1065836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6000"/>
              <a:t>Course overview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7CECAE-2397-4A6C-B76E-AD3A0D70E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136525"/>
            <a:ext cx="2743200" cy="3651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2C18C1E5-FB55-42F5-BD6D-9CC153FCDBE6}" type="slidenum">
              <a:rPr lang="en-US"/>
              <a:pPr>
                <a:spcAft>
                  <a:spcPts val="600"/>
                </a:spcAft>
              </a:pPr>
              <a:t>16</a:t>
            </a:fld>
            <a:endParaRPr lang="en-US"/>
          </a:p>
        </p:txBody>
      </p:sp>
      <p:sp>
        <p:nvSpPr>
          <p:cNvPr id="41" name="Rectangle 6">
            <a:extLst>
              <a:ext uri="{FF2B5EF4-FFF2-40B4-BE49-F238E27FC236}">
                <a16:creationId xmlns:a16="http://schemas.microsoft.com/office/drawing/2014/main" id="{D6A9C53F-5F90-40A5-8C85-5412D39C8C6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50080" y="1850683"/>
            <a:ext cx="3291840" cy="27432"/>
          </a:xfrm>
          <a:custGeom>
            <a:avLst/>
            <a:gdLst>
              <a:gd name="connsiteX0" fmla="*/ 0 w 3291840"/>
              <a:gd name="connsiteY0" fmla="*/ 0 h 27432"/>
              <a:gd name="connsiteX1" fmla="*/ 625450 w 3291840"/>
              <a:gd name="connsiteY1" fmla="*/ 0 h 27432"/>
              <a:gd name="connsiteX2" fmla="*/ 1283818 w 3291840"/>
              <a:gd name="connsiteY2" fmla="*/ 0 h 27432"/>
              <a:gd name="connsiteX3" fmla="*/ 1975104 w 3291840"/>
              <a:gd name="connsiteY3" fmla="*/ 0 h 27432"/>
              <a:gd name="connsiteX4" fmla="*/ 2666390 w 3291840"/>
              <a:gd name="connsiteY4" fmla="*/ 0 h 27432"/>
              <a:gd name="connsiteX5" fmla="*/ 3291840 w 3291840"/>
              <a:gd name="connsiteY5" fmla="*/ 0 h 27432"/>
              <a:gd name="connsiteX6" fmla="*/ 3291840 w 3291840"/>
              <a:gd name="connsiteY6" fmla="*/ 27432 h 27432"/>
              <a:gd name="connsiteX7" fmla="*/ 2567635 w 3291840"/>
              <a:gd name="connsiteY7" fmla="*/ 27432 h 27432"/>
              <a:gd name="connsiteX8" fmla="*/ 1843430 w 3291840"/>
              <a:gd name="connsiteY8" fmla="*/ 27432 h 27432"/>
              <a:gd name="connsiteX9" fmla="*/ 1185062 w 3291840"/>
              <a:gd name="connsiteY9" fmla="*/ 27432 h 27432"/>
              <a:gd name="connsiteX10" fmla="*/ 0 w 3291840"/>
              <a:gd name="connsiteY10" fmla="*/ 27432 h 27432"/>
              <a:gd name="connsiteX11" fmla="*/ 0 w 3291840"/>
              <a:gd name="connsiteY11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91840" h="27432" fill="none" extrusionOk="0">
                <a:moveTo>
                  <a:pt x="0" y="0"/>
                </a:moveTo>
                <a:cubicBezTo>
                  <a:pt x="173613" y="5552"/>
                  <a:pt x="489242" y="1770"/>
                  <a:pt x="625450" y="0"/>
                </a:cubicBezTo>
                <a:cubicBezTo>
                  <a:pt x="761658" y="-1770"/>
                  <a:pt x="1015131" y="32079"/>
                  <a:pt x="1283818" y="0"/>
                </a:cubicBezTo>
                <a:cubicBezTo>
                  <a:pt x="1552505" y="-32079"/>
                  <a:pt x="1752773" y="10771"/>
                  <a:pt x="1975104" y="0"/>
                </a:cubicBezTo>
                <a:cubicBezTo>
                  <a:pt x="2197435" y="-10771"/>
                  <a:pt x="2433070" y="21341"/>
                  <a:pt x="2666390" y="0"/>
                </a:cubicBezTo>
                <a:cubicBezTo>
                  <a:pt x="2899710" y="-21341"/>
                  <a:pt x="3028437" y="16612"/>
                  <a:pt x="3291840" y="0"/>
                </a:cubicBezTo>
                <a:cubicBezTo>
                  <a:pt x="3290674" y="7395"/>
                  <a:pt x="3291885" y="21864"/>
                  <a:pt x="3291840" y="27432"/>
                </a:cubicBezTo>
                <a:cubicBezTo>
                  <a:pt x="3043276" y="47012"/>
                  <a:pt x="2921041" y="-3764"/>
                  <a:pt x="2567635" y="27432"/>
                </a:cubicBezTo>
                <a:cubicBezTo>
                  <a:pt x="2214230" y="58628"/>
                  <a:pt x="2189623" y="-3875"/>
                  <a:pt x="1843430" y="27432"/>
                </a:cubicBezTo>
                <a:cubicBezTo>
                  <a:pt x="1497237" y="58739"/>
                  <a:pt x="1492584" y="38324"/>
                  <a:pt x="1185062" y="27432"/>
                </a:cubicBezTo>
                <a:cubicBezTo>
                  <a:pt x="877540" y="16540"/>
                  <a:pt x="313238" y="55587"/>
                  <a:pt x="0" y="27432"/>
                </a:cubicBezTo>
                <a:cubicBezTo>
                  <a:pt x="-503" y="20663"/>
                  <a:pt x="1168" y="5855"/>
                  <a:pt x="0" y="0"/>
                </a:cubicBezTo>
                <a:close/>
              </a:path>
              <a:path w="3291840" h="27432" stroke="0" extrusionOk="0">
                <a:moveTo>
                  <a:pt x="0" y="0"/>
                </a:moveTo>
                <a:cubicBezTo>
                  <a:pt x="281971" y="23935"/>
                  <a:pt x="485873" y="-14021"/>
                  <a:pt x="625450" y="0"/>
                </a:cubicBezTo>
                <a:cubicBezTo>
                  <a:pt x="765027" y="14021"/>
                  <a:pt x="1048900" y="27914"/>
                  <a:pt x="1185062" y="0"/>
                </a:cubicBezTo>
                <a:cubicBezTo>
                  <a:pt x="1321224" y="-27914"/>
                  <a:pt x="1648252" y="-3988"/>
                  <a:pt x="1909267" y="0"/>
                </a:cubicBezTo>
                <a:cubicBezTo>
                  <a:pt x="2170282" y="3988"/>
                  <a:pt x="2301957" y="25891"/>
                  <a:pt x="2534717" y="0"/>
                </a:cubicBezTo>
                <a:cubicBezTo>
                  <a:pt x="2767477" y="-25891"/>
                  <a:pt x="3078800" y="21500"/>
                  <a:pt x="3291840" y="0"/>
                </a:cubicBezTo>
                <a:cubicBezTo>
                  <a:pt x="3292033" y="12649"/>
                  <a:pt x="3290852" y="17989"/>
                  <a:pt x="3291840" y="27432"/>
                </a:cubicBezTo>
                <a:cubicBezTo>
                  <a:pt x="3120474" y="24858"/>
                  <a:pt x="2816568" y="13777"/>
                  <a:pt x="2633472" y="27432"/>
                </a:cubicBezTo>
                <a:cubicBezTo>
                  <a:pt x="2450376" y="41087"/>
                  <a:pt x="2160769" y="46494"/>
                  <a:pt x="1909267" y="27432"/>
                </a:cubicBezTo>
                <a:cubicBezTo>
                  <a:pt x="1657765" y="8370"/>
                  <a:pt x="1623992" y="18792"/>
                  <a:pt x="1349654" y="27432"/>
                </a:cubicBezTo>
                <a:cubicBezTo>
                  <a:pt x="1075316" y="36072"/>
                  <a:pt x="833426" y="43325"/>
                  <a:pt x="691286" y="27432"/>
                </a:cubicBezTo>
                <a:cubicBezTo>
                  <a:pt x="549146" y="11539"/>
                  <a:pt x="342011" y="33345"/>
                  <a:pt x="0" y="27432"/>
                </a:cubicBezTo>
                <a:cubicBezTo>
                  <a:pt x="1300" y="19678"/>
                  <a:pt x="-86" y="12044"/>
                  <a:pt x="0" y="0"/>
                </a:cubicBezTo>
                <a:close/>
              </a:path>
            </a:pathLst>
          </a:custGeom>
          <a:solidFill>
            <a:srgbClr val="F79076"/>
          </a:solidFill>
          <a:ln w="38100" cap="rnd">
            <a:solidFill>
              <a:srgbClr val="F79076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Content Placeholder 13" descr="Graphical user interface&#10;&#10;Description automatically generated">
            <a:extLst>
              <a:ext uri="{FF2B5EF4-FFF2-40B4-BE49-F238E27FC236}">
                <a16:creationId xmlns:a16="http://schemas.microsoft.com/office/drawing/2014/main" id="{7BAD13DA-109F-41B8-A6E4-1A317D3A9BA7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 rotWithShape="1">
          <a:blip r:embed="rId2"/>
          <a:stretch/>
        </p:blipFill>
        <p:spPr>
          <a:xfrm>
            <a:off x="323088" y="2084142"/>
            <a:ext cx="5452921" cy="4157853"/>
          </a:xfrm>
          <a:prstGeom prst="rect">
            <a:avLst/>
          </a:prstGeom>
        </p:spPr>
      </p:pic>
      <p:pic>
        <p:nvPicPr>
          <p:cNvPr id="32" name="Content Placeholder 31">
            <a:extLst>
              <a:ext uri="{FF2B5EF4-FFF2-40B4-BE49-F238E27FC236}">
                <a16:creationId xmlns:a16="http://schemas.microsoft.com/office/drawing/2014/main" id="{AA5791B0-D95F-44FB-AF02-1FBBDF4F8EE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6096000" y="2740915"/>
            <a:ext cx="5773485" cy="29877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1097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Placeholder 30">
            <a:extLst>
              <a:ext uri="{FF2B5EF4-FFF2-40B4-BE49-F238E27FC236}">
                <a16:creationId xmlns:a16="http://schemas.microsoft.com/office/drawing/2014/main" id="{FCE45278-0B6F-4781-B976-CBFB5CC06DCD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/>
          <a:srcRect l="-9950" r="-9950"/>
          <a:stretch/>
        </p:blipFill>
        <p:spPr/>
      </p:pic>
      <p:pic>
        <p:nvPicPr>
          <p:cNvPr id="25" name="Picture Placeholder 24">
            <a:extLst>
              <a:ext uri="{FF2B5EF4-FFF2-40B4-BE49-F238E27FC236}">
                <a16:creationId xmlns:a16="http://schemas.microsoft.com/office/drawing/2014/main" id="{6B9721F4-4903-48E9-A96E-D819093A66BC}"/>
              </a:ext>
            </a:extLst>
          </p:cNvPr>
          <p:cNvPicPr>
            <a:picLocks noGrp="1" noChangeAspect="1"/>
          </p:cNvPicPr>
          <p:nvPr>
            <p:ph type="pic" sz="quarter" idx="13"/>
          </p:nvPr>
        </p:nvPicPr>
        <p:blipFill rotWithShape="1">
          <a:blip r:embed="rId3"/>
          <a:srcRect l="5547" r="5547"/>
          <a:stretch/>
        </p:blipFill>
        <p:spPr/>
      </p:pic>
      <p:sp>
        <p:nvSpPr>
          <p:cNvPr id="8" name="Title 7">
            <a:extLst>
              <a:ext uri="{FF2B5EF4-FFF2-40B4-BE49-F238E27FC236}">
                <a16:creationId xmlns:a16="http://schemas.microsoft.com/office/drawing/2014/main" id="{747D5BDB-6B98-4B9C-B7F8-D3873B7EB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eekly classes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6CA0DE7D-29BA-4CB2-8949-9CDBFB2C8C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100000"/>
              </a:lnSpc>
            </a:pPr>
            <a:r>
              <a:rPr lang="en-US" sz="2400" dirty="0"/>
              <a:t>Each weekly class involves: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Text to read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Animated videos to watch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Scripts available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Audio-guided mindfulness exercises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Reflection questions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Multiple choice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Open-ended</a:t>
            </a:r>
          </a:p>
          <a:p>
            <a:pPr lvl="2">
              <a:lnSpc>
                <a:spcPct val="100000"/>
              </a:lnSpc>
            </a:pP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D9DECE-2EE4-4F77-9896-D6F332A61961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9448800" y="6356350"/>
            <a:ext cx="2743200" cy="365125"/>
          </a:xfrm>
        </p:spPr>
        <p:txBody>
          <a:bodyPr/>
          <a:lstStyle/>
          <a:p>
            <a:fld id="{2C18C1E5-FB55-42F5-BD6D-9CC153FCDBE6}" type="slidenum">
              <a:rPr lang="en-US" smtClean="0"/>
              <a:t>17</a:t>
            </a:fld>
            <a:endParaRPr lang="en-US" dirty="0"/>
          </a:p>
        </p:txBody>
      </p:sp>
      <p:pic>
        <p:nvPicPr>
          <p:cNvPr id="27" name="Picture Placeholder 26">
            <a:extLst>
              <a:ext uri="{FF2B5EF4-FFF2-40B4-BE49-F238E27FC236}">
                <a16:creationId xmlns:a16="http://schemas.microsoft.com/office/drawing/2014/main" id="{5B5470E1-1084-44E0-A2C4-DE8953890DD7}"/>
              </a:ext>
            </a:extLst>
          </p:cNvPr>
          <p:cNvPicPr>
            <a:picLocks noGrp="1" noChangeAspect="1"/>
          </p:cNvPicPr>
          <p:nvPr>
            <p:ph type="pic" sz="quarter" idx="15"/>
          </p:nvPr>
        </p:nvPicPr>
        <p:blipFill rotWithShape="1">
          <a:blip r:embed="rId4"/>
          <a:srcRect t="9737" b="21183"/>
          <a:stretch/>
        </p:blipFill>
        <p:spPr>
          <a:xfrm>
            <a:off x="8281029" y="4328340"/>
            <a:ext cx="3910962" cy="2529660"/>
          </a:xfrm>
        </p:spPr>
      </p:pic>
      <p:pic>
        <p:nvPicPr>
          <p:cNvPr id="23" name="Picture Placeholder 14">
            <a:extLst>
              <a:ext uri="{FF2B5EF4-FFF2-40B4-BE49-F238E27FC236}">
                <a16:creationId xmlns:a16="http://schemas.microsoft.com/office/drawing/2014/main" id="{3CEBCD1C-735A-4119-B557-0E18D8CB3172}"/>
              </a:ext>
            </a:extLst>
          </p:cNvPr>
          <p:cNvPicPr>
            <a:picLocks noGrp="1" noChangeAspect="1"/>
          </p:cNvPicPr>
          <p:nvPr>
            <p:ph type="pic" sz="quarter" idx="16"/>
          </p:nvPr>
        </p:nvPicPr>
        <p:blipFill rotWithShape="1">
          <a:blip r:embed="rId5"/>
          <a:srcRect t="-12542" b="-12542"/>
          <a:stretch/>
        </p:blipFill>
        <p:spPr>
          <a:xfrm>
            <a:off x="5021263" y="3792538"/>
            <a:ext cx="3041650" cy="3065462"/>
          </a:xfrm>
        </p:spPr>
      </p:pic>
    </p:spTree>
    <p:extLst>
      <p:ext uri="{BB962C8B-B14F-4D97-AF65-F5344CB8AC3E}">
        <p14:creationId xmlns:p14="http://schemas.microsoft.com/office/powerpoint/2010/main" val="199675695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A3F531A3-2EE4-4C7B-80BA-AF7F7F7252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ther features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A66D813A-B05D-40B6-9938-7C85934ADE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2211066"/>
            <a:ext cx="5157787" cy="823912"/>
          </a:xfrm>
        </p:spPr>
        <p:txBody>
          <a:bodyPr/>
          <a:lstStyle/>
          <a:p>
            <a:pPr algn="ctr"/>
            <a:r>
              <a:rPr lang="en-US" dirty="0"/>
              <a:t>Community</a:t>
            </a:r>
          </a:p>
        </p:txBody>
      </p:sp>
      <p:sp>
        <p:nvSpPr>
          <p:cNvPr id="11" name="Text Placeholder 10">
            <a:extLst>
              <a:ext uri="{FF2B5EF4-FFF2-40B4-BE49-F238E27FC236}">
                <a16:creationId xmlns:a16="http://schemas.microsoft.com/office/drawing/2014/main" id="{DD6D24E7-1DFC-4F58-A5DA-D4A9234E6D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94427" y="2166652"/>
            <a:ext cx="5183188" cy="823912"/>
          </a:xfrm>
        </p:spPr>
        <p:txBody>
          <a:bodyPr/>
          <a:lstStyle/>
          <a:p>
            <a:pPr algn="ctr"/>
            <a:r>
              <a:rPr lang="en-US" dirty="0"/>
              <a:t>Practice</a:t>
            </a:r>
          </a:p>
        </p:txBody>
      </p:sp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280B9545-4C18-45E4-AEEE-3EF7AF60C90C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2"/>
          <a:stretch>
            <a:fillRect/>
          </a:stretch>
        </p:blipFill>
        <p:spPr>
          <a:xfrm>
            <a:off x="6650751" y="3132967"/>
            <a:ext cx="4270539" cy="3272750"/>
          </a:xfrm>
        </p:spPr>
      </p:pic>
      <p:pic>
        <p:nvPicPr>
          <p:cNvPr id="20" name="Content Placeholder 19">
            <a:extLst>
              <a:ext uri="{FF2B5EF4-FFF2-40B4-BE49-F238E27FC236}">
                <a16:creationId xmlns:a16="http://schemas.microsoft.com/office/drawing/2014/main" id="{CA56B568-25C6-4F89-9720-7D47077FFE1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894400" y="3132967"/>
            <a:ext cx="5048561" cy="3139399"/>
          </a:xfrm>
        </p:spPr>
      </p:pic>
    </p:spTree>
    <p:extLst>
      <p:ext uri="{BB962C8B-B14F-4D97-AF65-F5344CB8AC3E}">
        <p14:creationId xmlns:p14="http://schemas.microsoft.com/office/powerpoint/2010/main" val="98184542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0F3D7C22-114C-403E-A232-4CA2422FD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ctr">
            <a:normAutofit/>
          </a:bodyPr>
          <a:lstStyle/>
          <a:p>
            <a:r>
              <a:rPr lang="en-US" sz="6000" dirty="0"/>
              <a:t>Wakeful feedback grid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224916A4-AFA4-4283-8A34-8159CAA8E1BD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3591377825"/>
              </p:ext>
            </p:extLst>
          </p:nvPr>
        </p:nvGraphicFramePr>
        <p:xfrm>
          <a:off x="838200" y="2305050"/>
          <a:ext cx="5181600" cy="38766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20" name="Content Placeholder 19">
            <a:extLst>
              <a:ext uri="{FF2B5EF4-FFF2-40B4-BE49-F238E27FC236}">
                <a16:creationId xmlns:a16="http://schemas.microsoft.com/office/drawing/2014/main" id="{F80D0526-C261-4096-B6B1-8CCB7D4652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3305174"/>
            <a:ext cx="5181600" cy="2876931"/>
          </a:xfrm>
        </p:spPr>
        <p:txBody>
          <a:bodyPr/>
          <a:lstStyle/>
          <a:p>
            <a:r>
              <a:rPr lang="en-US" dirty="0">
                <a:hlinkClick r:id="rId8"/>
              </a:rPr>
              <a:t>http://wakeful-dev.brightoutcome.com</a:t>
            </a:r>
            <a:endParaRPr lang="en-US" dirty="0"/>
          </a:p>
          <a:p>
            <a:pPr lvl="1"/>
            <a:r>
              <a:rPr lang="en-US" dirty="0"/>
              <a:t>Username: </a:t>
            </a:r>
            <a:r>
              <a:rPr lang="en-US" dirty="0" err="1"/>
              <a:t>iManageAYA</a:t>
            </a:r>
            <a:endParaRPr lang="en-US" dirty="0"/>
          </a:p>
          <a:p>
            <a:pPr lvl="1"/>
            <a:r>
              <a:rPr lang="en-US" dirty="0"/>
              <a:t>Password: Testing123!</a:t>
            </a:r>
          </a:p>
        </p:txBody>
      </p:sp>
      <p:pic>
        <p:nvPicPr>
          <p:cNvPr id="16" name="Graphic 15" descr="Add with solid fill">
            <a:extLst>
              <a:ext uri="{FF2B5EF4-FFF2-40B4-BE49-F238E27FC236}">
                <a16:creationId xmlns:a16="http://schemas.microsoft.com/office/drawing/2014/main" id="{16B2E809-ECB4-4653-B8C3-1BF4079663AA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7451638" y="1297049"/>
            <a:ext cx="457200" cy="457200"/>
          </a:xfrm>
          <a:prstGeom prst="rect">
            <a:avLst/>
          </a:prstGeom>
        </p:spPr>
      </p:pic>
      <p:pic>
        <p:nvPicPr>
          <p:cNvPr id="22" name="Graphic 21" descr="Transfer with solid fill">
            <a:extLst>
              <a:ext uri="{FF2B5EF4-FFF2-40B4-BE49-F238E27FC236}">
                <a16:creationId xmlns:a16="http://schemas.microsoft.com/office/drawing/2014/main" id="{DAF5F689-40A6-4BE0-9958-0BA66E5130DB}"/>
              </a:ext>
            </a:extLst>
          </p:cNvPr>
          <p:cNvPicPr>
            <a:picLocks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rcRect/>
          <a:stretch/>
        </p:blipFill>
        <p:spPr>
          <a:xfrm>
            <a:off x="9728200" y="1297049"/>
            <a:ext cx="457200" cy="45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644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4A1D1-DD07-4DD2-A527-4B1F52D6A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-design workshop Agend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7E8896-AA49-4FBF-8BB1-9480E622D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Introductions</a:t>
            </a:r>
          </a:p>
          <a:p>
            <a:pPr lvl="0"/>
            <a:r>
              <a:rPr lang="en-US" dirty="0"/>
              <a:t>Context &amp; Goals</a:t>
            </a:r>
          </a:p>
          <a:p>
            <a:pPr lvl="0"/>
            <a:r>
              <a:rPr lang="en-US" dirty="0"/>
              <a:t>Brainstorming Activities</a:t>
            </a:r>
          </a:p>
          <a:p>
            <a:pPr lvl="0"/>
            <a:r>
              <a:rPr lang="en-US" dirty="0"/>
              <a:t>Feedback Activity</a:t>
            </a:r>
          </a:p>
        </p:txBody>
      </p:sp>
    </p:spTree>
    <p:extLst>
      <p:ext uri="{BB962C8B-B14F-4D97-AF65-F5344CB8AC3E}">
        <p14:creationId xmlns:p14="http://schemas.microsoft.com/office/powerpoint/2010/main" val="244284296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rap-Up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1064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2C61293E-6EBE-43EF-A52C-9BEBFD7679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F09280CC-ABB3-D688-2D3F-3E6B20E09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329184"/>
            <a:ext cx="6251110" cy="1783080"/>
          </a:xfrm>
        </p:spPr>
        <p:txBody>
          <a:bodyPr anchor="b">
            <a:normAutofit/>
          </a:bodyPr>
          <a:lstStyle/>
          <a:p>
            <a:r>
              <a:rPr lang="en-US" dirty="0"/>
              <a:t>Contact info</a:t>
            </a:r>
          </a:p>
        </p:txBody>
      </p:sp>
      <p:sp>
        <p:nvSpPr>
          <p:cNvPr id="13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C8A06D"/>
          </a:solidFill>
          <a:ln w="38100" cap="rnd">
            <a:solidFill>
              <a:srgbClr val="C8A06D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4838B97-843A-1AD1-4F9E-01FD028FEB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97762" y="2706624"/>
            <a:ext cx="6251110" cy="3483864"/>
          </a:xfrm>
        </p:spPr>
        <p:txBody>
          <a:bodyPr>
            <a:normAutofit/>
          </a:bodyPr>
          <a:lstStyle/>
          <a:p>
            <a:r>
              <a:rPr lang="en-US" dirty="0"/>
              <a:t>Karly M. Murphy, PhD</a:t>
            </a:r>
          </a:p>
          <a:p>
            <a:r>
              <a:rPr lang="en-US" dirty="0">
                <a:hlinkClick r:id="rId2"/>
              </a:rPr>
              <a:t>karmurph@wakehealth.edu</a:t>
            </a:r>
            <a:endParaRPr lang="en-US" dirty="0"/>
          </a:p>
        </p:txBody>
      </p:sp>
      <p:pic>
        <p:nvPicPr>
          <p:cNvPr id="7" name="Picture 6" descr="Person holding mouse">
            <a:extLst>
              <a:ext uri="{FF2B5EF4-FFF2-40B4-BE49-F238E27FC236}">
                <a16:creationId xmlns:a16="http://schemas.microsoft.com/office/drawing/2014/main" id="{E8B0DDED-8D98-C967-42E6-F3658AC631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029" r="25639" b="-1"/>
          <a:stretch/>
        </p:blipFill>
        <p:spPr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35782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4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3106" name="Rectangle 3105">
            <a:extLst>
              <a:ext uri="{FF2B5EF4-FFF2-40B4-BE49-F238E27FC236}">
                <a16:creationId xmlns:a16="http://schemas.microsoft.com/office/drawing/2014/main" id="{43DAA0EF-336D-4CDC-A9A2-8460363E27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8" name="Freeform: Shape 3107">
            <a:extLst>
              <a:ext uri="{FF2B5EF4-FFF2-40B4-BE49-F238E27FC236}">
                <a16:creationId xmlns:a16="http://schemas.microsoft.com/office/drawing/2014/main" id="{FD079A19-B31E-4129-A464-7547FF05AE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4090556" cy="6858000"/>
          </a:xfrm>
          <a:custGeom>
            <a:avLst/>
            <a:gdLst>
              <a:gd name="connsiteX0" fmla="*/ 0 w 4090556"/>
              <a:gd name="connsiteY0" fmla="*/ 0 h 6858000"/>
              <a:gd name="connsiteX1" fmla="*/ 4077555 w 4090556"/>
              <a:gd name="connsiteY1" fmla="*/ 0 h 6858000"/>
              <a:gd name="connsiteX2" fmla="*/ 4077574 w 4090556"/>
              <a:gd name="connsiteY2" fmla="*/ 720 h 6858000"/>
              <a:gd name="connsiteX3" fmla="*/ 4075790 w 4090556"/>
              <a:gd name="connsiteY3" fmla="*/ 575485 h 6858000"/>
              <a:gd name="connsiteX4" fmla="*/ 4076555 w 4090556"/>
              <a:gd name="connsiteY4" fmla="*/ 932245 h 6858000"/>
              <a:gd name="connsiteX5" fmla="*/ 4076555 w 4090556"/>
              <a:gd name="connsiteY5" fmla="*/ 1286711 h 6858000"/>
              <a:gd name="connsiteX6" fmla="*/ 4082288 w 4090556"/>
              <a:gd name="connsiteY6" fmla="*/ 1595180 h 6858000"/>
              <a:gd name="connsiteX7" fmla="*/ 4078211 w 4090556"/>
              <a:gd name="connsiteY7" fmla="*/ 2133123 h 6858000"/>
              <a:gd name="connsiteX8" fmla="*/ 4071968 w 4090556"/>
              <a:gd name="connsiteY8" fmla="*/ 2946025 h 6858000"/>
              <a:gd name="connsiteX9" fmla="*/ 4068401 w 4090556"/>
              <a:gd name="connsiteY9" fmla="*/ 3502061 h 6858000"/>
              <a:gd name="connsiteX10" fmla="*/ 4087513 w 4090556"/>
              <a:gd name="connsiteY10" fmla="*/ 4076061 h 6858000"/>
              <a:gd name="connsiteX11" fmla="*/ 4076938 w 4090556"/>
              <a:gd name="connsiteY11" fmla="*/ 4442632 h 6858000"/>
              <a:gd name="connsiteX12" fmla="*/ 4071459 w 4090556"/>
              <a:gd name="connsiteY12" fmla="*/ 4827550 h 6858000"/>
              <a:gd name="connsiteX13" fmla="*/ 4071459 w 4090556"/>
              <a:gd name="connsiteY13" fmla="*/ 5019945 h 6858000"/>
              <a:gd name="connsiteX14" fmla="*/ 4084200 w 4090556"/>
              <a:gd name="connsiteY14" fmla="*/ 5490104 h 6858000"/>
              <a:gd name="connsiteX15" fmla="*/ 4077446 w 4090556"/>
              <a:gd name="connsiteY15" fmla="*/ 5844569 h 6858000"/>
              <a:gd name="connsiteX16" fmla="*/ 4082544 w 4090556"/>
              <a:gd name="connsiteY16" fmla="*/ 6260195 h 6858000"/>
              <a:gd name="connsiteX17" fmla="*/ 4086110 w 4090556"/>
              <a:gd name="connsiteY17" fmla="*/ 6706145 h 6858000"/>
              <a:gd name="connsiteX18" fmla="*/ 4086135 w 4090556"/>
              <a:gd name="connsiteY18" fmla="*/ 6794562 h 6858000"/>
              <a:gd name="connsiteX19" fmla="*/ 4080334 w 4090556"/>
              <a:gd name="connsiteY19" fmla="*/ 6858000 h 6858000"/>
              <a:gd name="connsiteX20" fmla="*/ 0 w 4090556"/>
              <a:gd name="connsiteY20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4090556" h="6858000">
                <a:moveTo>
                  <a:pt x="0" y="0"/>
                </a:moveTo>
                <a:lnTo>
                  <a:pt x="4077555" y="0"/>
                </a:lnTo>
                <a:lnTo>
                  <a:pt x="4077574" y="720"/>
                </a:lnTo>
                <a:cubicBezTo>
                  <a:pt x="4079358" y="192351"/>
                  <a:pt x="4064960" y="384364"/>
                  <a:pt x="4075790" y="575485"/>
                </a:cubicBezTo>
                <a:cubicBezTo>
                  <a:pt x="4082544" y="694108"/>
                  <a:pt x="4081269" y="814132"/>
                  <a:pt x="4076555" y="932245"/>
                </a:cubicBezTo>
                <a:cubicBezTo>
                  <a:pt x="4071840" y="1050357"/>
                  <a:pt x="4065470" y="1168597"/>
                  <a:pt x="4076555" y="1286711"/>
                </a:cubicBezTo>
                <a:cubicBezTo>
                  <a:pt x="4084710" y="1389317"/>
                  <a:pt x="4086621" y="1492332"/>
                  <a:pt x="4082288" y="1595180"/>
                </a:cubicBezTo>
                <a:cubicBezTo>
                  <a:pt x="4077319" y="1774452"/>
                  <a:pt x="4067637" y="1953851"/>
                  <a:pt x="4078211" y="2133123"/>
                </a:cubicBezTo>
                <a:cubicBezTo>
                  <a:pt x="4094393" y="2404260"/>
                  <a:pt x="4084710" y="2675143"/>
                  <a:pt x="4071968" y="2946025"/>
                </a:cubicBezTo>
                <a:cubicBezTo>
                  <a:pt x="4063049" y="3131413"/>
                  <a:pt x="4055659" y="3316673"/>
                  <a:pt x="4068401" y="3502061"/>
                </a:cubicBezTo>
                <a:cubicBezTo>
                  <a:pt x="4081396" y="3693182"/>
                  <a:pt x="4097323" y="3884176"/>
                  <a:pt x="4087513" y="4076061"/>
                </a:cubicBezTo>
                <a:cubicBezTo>
                  <a:pt x="4081142" y="4198251"/>
                  <a:pt x="4069037" y="4320315"/>
                  <a:pt x="4076938" y="4442632"/>
                </a:cubicBezTo>
                <a:cubicBezTo>
                  <a:pt x="4083270" y="4570925"/>
                  <a:pt x="4081435" y="4699486"/>
                  <a:pt x="4071459" y="4827550"/>
                </a:cubicBezTo>
                <a:cubicBezTo>
                  <a:pt x="4065725" y="4891550"/>
                  <a:pt x="4065725" y="4955945"/>
                  <a:pt x="4071459" y="5019945"/>
                </a:cubicBezTo>
                <a:cubicBezTo>
                  <a:pt x="4087742" y="5176105"/>
                  <a:pt x="4091997" y="5333296"/>
                  <a:pt x="4084200" y="5490104"/>
                </a:cubicBezTo>
                <a:cubicBezTo>
                  <a:pt x="4079740" y="5608217"/>
                  <a:pt x="4071968" y="5726202"/>
                  <a:pt x="4077446" y="5844569"/>
                </a:cubicBezTo>
                <a:cubicBezTo>
                  <a:pt x="4083944" y="5983069"/>
                  <a:pt x="4088914" y="6121696"/>
                  <a:pt x="4082544" y="6260195"/>
                </a:cubicBezTo>
                <a:cubicBezTo>
                  <a:pt x="4075841" y="6408803"/>
                  <a:pt x="4077026" y="6557662"/>
                  <a:pt x="4086110" y="6706145"/>
                </a:cubicBezTo>
                <a:cubicBezTo>
                  <a:pt x="4087467" y="6735616"/>
                  <a:pt x="4087474" y="6765120"/>
                  <a:pt x="4086135" y="6794562"/>
                </a:cubicBezTo>
                <a:lnTo>
                  <a:pt x="4080334" y="6858000"/>
                </a:lnTo>
                <a:lnTo>
                  <a:pt x="0" y="6858000"/>
                </a:lnTo>
                <a:close/>
              </a:path>
            </a:pathLst>
          </a:cu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536B713F-E1C7-E876-02D7-1FCDC9B71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5001" y="640823"/>
            <a:ext cx="3103194" cy="558314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l"/>
            <a:r>
              <a:rPr lang="en-US" sz="5400">
                <a:solidFill>
                  <a:schemeClr val="bg1"/>
                </a:solidFill>
              </a:rPr>
              <a:t>Introductions</a:t>
            </a:r>
          </a:p>
        </p:txBody>
      </p:sp>
      <p:graphicFrame>
        <p:nvGraphicFramePr>
          <p:cNvPr id="3100" name="Content Placeholder 7">
            <a:extLst>
              <a:ext uri="{FF2B5EF4-FFF2-40B4-BE49-F238E27FC236}">
                <a16:creationId xmlns:a16="http://schemas.microsoft.com/office/drawing/2014/main" id="{D764984C-E29A-841E-4AC6-541B46BA6156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765460421"/>
              </p:ext>
            </p:extLst>
          </p:nvPr>
        </p:nvGraphicFramePr>
        <p:xfrm>
          <a:off x="4648018" y="640822"/>
          <a:ext cx="6900512" cy="553614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703203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8000" dirty="0">
                <a:solidFill>
                  <a:schemeClr val="bg1"/>
                </a:solidFill>
              </a:rPr>
              <a:t>Goals &amp; Context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14321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1049" name="Rectangle 1043">
            <a:extLst>
              <a:ext uri="{FF2B5EF4-FFF2-40B4-BE49-F238E27FC236}">
                <a16:creationId xmlns:a16="http://schemas.microsoft.com/office/drawing/2014/main" id="{2C61293E-6EBE-43EF-A52C-9BEBFD7679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58C0DDC-D116-43DA-B0B5-A6A82668A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329184"/>
            <a:ext cx="6251110" cy="178308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dirty="0"/>
              <a:t>Project goal</a:t>
            </a:r>
          </a:p>
        </p:txBody>
      </p:sp>
      <p:sp>
        <p:nvSpPr>
          <p:cNvPr id="1050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D0A45D"/>
          </a:solidFill>
          <a:ln w="38100" cap="rnd">
            <a:solidFill>
              <a:srgbClr val="D0A45D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B430F02-9645-4F56-99F7-1DC2F76FFF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97762" y="2706624"/>
            <a:ext cx="6251110" cy="3483864"/>
          </a:xfrm>
        </p:spPr>
        <p:txBody>
          <a:bodyPr vert="horz" lIns="91440" tIns="45720" rIns="91440" bIns="45720" rtlCol="0">
            <a:normAutofit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Develop a tool that helps AYA cancer survivors manage symptoms of depression</a:t>
            </a:r>
          </a:p>
          <a:p>
            <a:pPr lvl="2"/>
            <a:r>
              <a:rPr lang="en-US" dirty="0"/>
              <a:t>Feeling sad or irritable</a:t>
            </a:r>
          </a:p>
          <a:p>
            <a:pPr lvl="2"/>
            <a:r>
              <a:rPr lang="en-US" dirty="0"/>
              <a:t>Loss of interest in and/or pleasure from fun activities</a:t>
            </a:r>
          </a:p>
          <a:p>
            <a:pPr lvl="2"/>
            <a:r>
              <a:rPr lang="en-US" dirty="0"/>
              <a:t>Feeling slowed down or restless</a:t>
            </a:r>
          </a:p>
          <a:p>
            <a:pPr lvl="2"/>
            <a:r>
              <a:rPr lang="en-US" dirty="0"/>
              <a:t>Fatigue or loss of energy</a:t>
            </a:r>
          </a:p>
          <a:p>
            <a:pPr lvl="2"/>
            <a:r>
              <a:rPr lang="en-US" dirty="0"/>
              <a:t>Feelings of worthlessness or guilt</a:t>
            </a:r>
          </a:p>
          <a:p>
            <a:pPr lvl="2"/>
            <a:r>
              <a:rPr lang="en-US" dirty="0"/>
              <a:t>Difficulty concentrating or making decisions</a:t>
            </a:r>
          </a:p>
          <a:p>
            <a:pPr lvl="2"/>
            <a:r>
              <a:rPr lang="en-US" dirty="0"/>
              <a:t>Feeling isolated or lonely</a:t>
            </a:r>
          </a:p>
        </p:txBody>
      </p:sp>
      <p:pic>
        <p:nvPicPr>
          <p:cNvPr id="1028" name="Picture 4" descr="person holding magnifying glass during sunset">
            <a:extLst>
              <a:ext uri="{FF2B5EF4-FFF2-40B4-BE49-F238E27FC236}">
                <a16:creationId xmlns:a16="http://schemas.microsoft.com/office/drawing/2014/main" id="{20F8DF73-9824-4339-B6CE-4050FE2E65AC}"/>
              </a:ext>
            </a:extLst>
          </p:cNvPr>
          <p:cNvPicPr>
            <a:picLocks noGrp="1" noChangeAspect="1" noChangeArrowheads="1"/>
          </p:cNvPicPr>
          <p:nvPr>
            <p:ph type="pic" sz="quarter" idx="13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5" r="4666"/>
          <a:stretch/>
        </p:blipFill>
        <p:spPr bwMode="auto"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953733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514003B0-8658-4DF1-90A0-E2D1759CF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Evidence-based treatments for depression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BB4301C3-99BC-452E-ABDF-29E684C6725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>
            <a:normAutofit lnSpcReduction="10000"/>
          </a:bodyPr>
          <a:lstStyle/>
          <a:p>
            <a:pPr algn="ctr"/>
            <a:r>
              <a:rPr lang="en-US" dirty="0"/>
              <a:t>Behavioral Activation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ADD95370-8C42-4401-ABCF-88212868EA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>
            <a:normAutofit lnSpcReduction="10000"/>
          </a:bodyPr>
          <a:lstStyle/>
          <a:p>
            <a:pPr algn="ctr"/>
            <a:r>
              <a:rPr lang="en-US" dirty="0"/>
              <a:t>Cognitive Restructuring</a:t>
            </a:r>
          </a:p>
        </p:txBody>
      </p:sp>
      <p:sp>
        <p:nvSpPr>
          <p:cNvPr id="22" name="Text Placeholder 21">
            <a:extLst>
              <a:ext uri="{FF2B5EF4-FFF2-40B4-BE49-F238E27FC236}">
                <a16:creationId xmlns:a16="http://schemas.microsoft.com/office/drawing/2014/main" id="{B7FF1001-E7ED-4A97-85F7-DEFDD3343677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>
            <a:noAutofit/>
          </a:bodyPr>
          <a:lstStyle/>
          <a:p>
            <a:pPr algn="ctr"/>
            <a:r>
              <a:rPr lang="en-US" dirty="0"/>
              <a:t>Mindfulness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79C1557-EE2B-C11A-840F-B57590936E98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1150796" y="3289852"/>
            <a:ext cx="2210374" cy="3312350"/>
          </a:xfrm>
          <a:prstGeom prst="rect">
            <a:avLst/>
          </a:prstGeom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2AB6B28C-397F-023C-20D1-FB87F9C112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7302" y="3289852"/>
            <a:ext cx="2211300" cy="331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woman wearing black sports bra">
            <a:extLst>
              <a:ext uri="{FF2B5EF4-FFF2-40B4-BE49-F238E27FC236}">
                <a16:creationId xmlns:a16="http://schemas.microsoft.com/office/drawing/2014/main" id="{3E2AFD9D-1E2C-E492-2DCF-5A0F6E40B2C4}"/>
              </a:ext>
            </a:extLst>
          </p:cNvPr>
          <p:cNvPicPr>
            <a:picLocks noGrp="1" noChangeAspect="1" noChangeArrowheads="1"/>
          </p:cNvPicPr>
          <p:nvPr>
            <p:ph sz="quarter" idx="14"/>
          </p:nvPr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1" r="5278"/>
          <a:stretch/>
        </p:blipFill>
        <p:spPr bwMode="auto">
          <a:xfrm>
            <a:off x="8836926" y="3289852"/>
            <a:ext cx="2210374" cy="32827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346338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1000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2" dur="1000" fill="hold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3" dur="1000" fill="hold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4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1000"/>
                                        <p:tgtEl>
                                          <p:spTgt spid="102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 build="p"/>
      <p:bldP spid="20" grpId="0" build="p"/>
      <p:bldP spid="22" grpId="0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BEE30-9E71-40C6-9521-1320EBF6F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ilored for AYA cancer survivor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5CF2C0-C2CF-47B9-8E9C-2F68FD783D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58368" y="2580596"/>
            <a:ext cx="3200400" cy="711244"/>
          </a:xfrm>
        </p:spPr>
        <p:txBody>
          <a:bodyPr>
            <a:normAutofit lnSpcReduction="10000"/>
          </a:bodyPr>
          <a:lstStyle/>
          <a:p>
            <a:pPr algn="ctr"/>
            <a:r>
              <a:rPr lang="en-US" dirty="0"/>
              <a:t>Peer Support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351B20-2DC3-497E-B638-867FB7BE29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Content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64AD90-74E3-412B-83C5-7A813982A858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/>
          <a:lstStyle/>
          <a:p>
            <a:r>
              <a:rPr lang="en-US" dirty="0"/>
              <a:t>Delivery</a:t>
            </a:r>
          </a:p>
          <a:p>
            <a:r>
              <a:rPr lang="en-US" dirty="0"/>
              <a:t>Scenarios &amp; Examples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851A8D83-081C-4B1F-9550-E8036BD00C3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Design</a:t>
            </a:r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69CBA1E0-571B-4C23-AAF8-9D885A6BD274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Visual</a:t>
            </a:r>
          </a:p>
          <a:p>
            <a:r>
              <a:rPr lang="en-US" dirty="0"/>
              <a:t>Functional</a:t>
            </a:r>
          </a:p>
          <a:p>
            <a:pPr lvl="1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3534AE0-80C5-4C0E-B7A6-283190A5F280}"/>
              </a:ext>
            </a:extLst>
          </p:cNvPr>
          <p:cNvSpPr/>
          <p:nvPr/>
        </p:nvSpPr>
        <p:spPr>
          <a:xfrm>
            <a:off x="4310742" y="2386149"/>
            <a:ext cx="6409509" cy="3804339"/>
          </a:xfrm>
          <a:prstGeom prst="rect">
            <a:avLst/>
          </a:prstGeom>
          <a:noFill/>
          <a:effectLst>
            <a:glow rad="228600">
              <a:schemeClr val="accent5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BD998EA-A56D-4100-A2C2-C04977387A9E}"/>
              </a:ext>
            </a:extLst>
          </p:cNvPr>
          <p:cNvSpPr/>
          <p:nvPr/>
        </p:nvSpPr>
        <p:spPr>
          <a:xfrm>
            <a:off x="5575509" y="4668536"/>
            <a:ext cx="3879973" cy="156966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9600" dirty="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YOU &amp; AYAs!</a:t>
            </a:r>
          </a:p>
        </p:txBody>
      </p:sp>
      <p:pic>
        <p:nvPicPr>
          <p:cNvPr id="2050" name="Picture 2" descr="row of four men sitting on mountain trail">
            <a:extLst>
              <a:ext uri="{FF2B5EF4-FFF2-40B4-BE49-F238E27FC236}">
                <a16:creationId xmlns:a16="http://schemas.microsoft.com/office/drawing/2014/main" id="{99782E9B-B34C-B676-BA01-78218DFA05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02" t="19248" r="6367" b="-1013"/>
          <a:stretch/>
        </p:blipFill>
        <p:spPr bwMode="auto">
          <a:xfrm>
            <a:off x="511752" y="3501776"/>
            <a:ext cx="3493631" cy="22381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424635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205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7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1000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1" dur="1000" fill="hold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1000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1000" fill="hold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9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1000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2" dur="1000" fill="hold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000" fill="hold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4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1000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7" dur="1000" fill="hold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8" dur="1000" fill="hold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2" presetClass="entr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3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4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5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7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8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5" grpId="0" build="p"/>
      <p:bldP spid="6" grpId="0" uiExpand="1" build="p"/>
      <p:bldP spid="10" grpId="0" build="p"/>
      <p:bldP spid="11" grpId="0" uiExpand="1" build="p"/>
      <p:bldP spid="12" grpId="0" animBg="1"/>
      <p:bldP spid="13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5C4F976C-BDEF-F466-6DC1-A58A26DF4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-design workshop goals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07F44882-4ECE-EA5F-2F31-94EFC308643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42967035"/>
              </p:ext>
            </p:extLst>
          </p:nvPr>
        </p:nvGraphicFramePr>
        <p:xfrm>
          <a:off x="838200" y="2076450"/>
          <a:ext cx="10515600" cy="41052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7959152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62253AAA-4C50-D5B1-B116-EFC4B9373D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ideas</a:t>
            </a:r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BC4C51FD-C981-A950-2A3D-8C30A9E9B880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238619"/>
      </p:ext>
    </p:extLst>
  </p:cSld>
  <p:clrMapOvr>
    <a:masterClrMapping/>
  </p:clrMapOvr>
</p:sld>
</file>

<file path=ppt/theme/theme1.xml><?xml version="1.0" encoding="utf-8"?>
<a:theme xmlns:a="http://schemas.openxmlformats.org/drawingml/2006/main" name="SketchyVTI">
  <a:themeElements>
    <a:clrScheme name="Blue Green">
      <a:dk1>
        <a:sysClr val="windowText" lastClr="000000"/>
      </a:dk1>
      <a:lt1>
        <a:sysClr val="window" lastClr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Custom 30">
      <a:majorFont>
        <a:latin typeface="The Serif Hand Black"/>
        <a:ea typeface=""/>
        <a:cs typeface=""/>
      </a:majorFont>
      <a:minorFont>
        <a:latin typeface="The Hand Black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ketchyVTI" id="{A6D2C935-A6E4-4DD9-BCC5-5AE2504DB8EA}" vid="{F0754072-50B6-4C01-B911-67246C9F58D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850A7996F154E4FA7785DDB182B98E3" ma:contentTypeVersion="15" ma:contentTypeDescription="Create a new document." ma:contentTypeScope="" ma:versionID="46cd5e81fe8b89db6854a313a15e1049">
  <xsd:schema xmlns:xsd="http://www.w3.org/2001/XMLSchema" xmlns:xs="http://www.w3.org/2001/XMLSchema" xmlns:p="http://schemas.microsoft.com/office/2006/metadata/properties" xmlns:ns2="ae82414a-0e8c-430a-a40a-968ff9054b21" xmlns:ns3="90947a30-aed6-487d-a00c-ffcd5d748952" targetNamespace="http://schemas.microsoft.com/office/2006/metadata/properties" ma:root="true" ma:fieldsID="3fae32e7894a58c685b8a9c8b4ab84dd" ns2:_="" ns3:_="">
    <xsd:import namespace="ae82414a-0e8c-430a-a40a-968ff9054b21"/>
    <xsd:import namespace="90947a30-aed6-487d-a00c-ffcd5d74895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82414a-0e8c-430a-a40a-968ff9054b2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a0cd38b-47d1-479b-a863-216ca283e7c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0947a30-aed6-487d-a00c-ffcd5d748952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0fcf107d-73f3-4176-ac55-37f5319deb37}" ma:internalName="TaxCatchAll" ma:showField="CatchAllData" ma:web="90947a30-aed6-487d-a00c-ffcd5d74895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e82414a-0e8c-430a-a40a-968ff9054b21">
      <Terms xmlns="http://schemas.microsoft.com/office/infopath/2007/PartnerControls"/>
    </lcf76f155ced4ddcb4097134ff3c332f>
    <TaxCatchAll xmlns="90947a30-aed6-487d-a00c-ffcd5d748952" xsi:nil="true"/>
    <SharedWithUsers xmlns="90947a30-aed6-487d-a00c-ffcd5d748952">
      <UserInfo>
        <DisplayName/>
        <AccountId xsi:nil="true"/>
        <AccountType/>
      </UserInfo>
    </SharedWithUsers>
    <MediaLengthInSeconds xmlns="ae82414a-0e8c-430a-a40a-968ff9054b21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05AEF95-C797-4AEA-A648-F324F9B663D3}"/>
</file>

<file path=customXml/itemProps2.xml><?xml version="1.0" encoding="utf-8"?>
<ds:datastoreItem xmlns:ds="http://schemas.openxmlformats.org/officeDocument/2006/customXml" ds:itemID="{DFA8DA88-2D67-4B30-8205-C52078711284}">
  <ds:schemaRefs>
    <ds:schemaRef ds:uri="http://schemas.microsoft.com/office/2006/documentManagement/types"/>
    <ds:schemaRef ds:uri="http://purl.org/dc/elements/1.1/"/>
    <ds:schemaRef ds:uri="71af3243-3dd4-4a8d-8c0d-dd76da1f02a5"/>
    <ds:schemaRef ds:uri="http://schemas.microsoft.com/office/2006/metadata/properties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16c05727-aa75-4e4a-9b5f-8a80a1165891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3D2896BB-5566-4403-84AA-2FD10D9622B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748</TotalTime>
  <Words>532</Words>
  <Application>Microsoft Office PowerPoint</Application>
  <PresentationFormat>Widescreen</PresentationFormat>
  <Paragraphs>98</Paragraphs>
  <Slides>21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</vt:lpstr>
      <vt:lpstr>Calibri</vt:lpstr>
      <vt:lpstr>The Hand Black</vt:lpstr>
      <vt:lpstr>The Serif Hand Black</vt:lpstr>
      <vt:lpstr>SketchyVTI</vt:lpstr>
      <vt:lpstr>Welcome!</vt:lpstr>
      <vt:lpstr>Co-design workshop Agenda</vt:lpstr>
      <vt:lpstr>Introductions</vt:lpstr>
      <vt:lpstr>Goals &amp; Context</vt:lpstr>
      <vt:lpstr>Project goal</vt:lpstr>
      <vt:lpstr>Evidence-based treatments for depression</vt:lpstr>
      <vt:lpstr>Tailored for AYA cancer survivors</vt:lpstr>
      <vt:lpstr>Co-design workshop goals</vt:lpstr>
      <vt:lpstr>Your ideas</vt:lpstr>
      <vt:lpstr>Brainstorming</vt:lpstr>
      <vt:lpstr>How might we use an online tool to help AYAs learn new Information and skills that they can use to manage depressive symptoms?</vt:lpstr>
      <vt:lpstr>How might we use an online tool to help AYAs practice new skills to manage depressive symptoms?</vt:lpstr>
      <vt:lpstr>Your feedback</vt:lpstr>
      <vt:lpstr>Wakeful</vt:lpstr>
      <vt:lpstr>Dashboard &amp; Menus</vt:lpstr>
      <vt:lpstr>Course overview</vt:lpstr>
      <vt:lpstr>Weekly classes</vt:lpstr>
      <vt:lpstr>Other features</vt:lpstr>
      <vt:lpstr>Wakeful feedback grid</vt:lpstr>
      <vt:lpstr>Wrap-Up</vt:lpstr>
      <vt:lpstr>Contact inf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ly M. Murphy</dc:creator>
  <cp:lastModifiedBy>Karly M. Murphy</cp:lastModifiedBy>
  <cp:revision>4</cp:revision>
  <dcterms:created xsi:type="dcterms:W3CDTF">2022-08-10T22:27:14Z</dcterms:created>
  <dcterms:modified xsi:type="dcterms:W3CDTF">2023-02-22T16:59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850A7996F154E4FA7785DDB182B98E3</vt:lpwstr>
  </property>
  <property fmtid="{D5CDD505-2E9C-101B-9397-08002B2CF9AE}" pid="3" name="Order">
    <vt:r8>182500</vt:r8>
  </property>
  <property fmtid="{D5CDD505-2E9C-101B-9397-08002B2CF9AE}" pid="4" name="_SourceUrl">
    <vt:lpwstr/>
  </property>
  <property fmtid="{D5CDD505-2E9C-101B-9397-08002B2CF9AE}" pid="5" name="_SharedFileIndex">
    <vt:lpwstr/>
  </property>
  <property fmtid="{D5CDD505-2E9C-101B-9397-08002B2CF9AE}" pid="6" name="ComplianceAssetId">
    <vt:lpwstr/>
  </property>
  <property fmtid="{D5CDD505-2E9C-101B-9397-08002B2CF9AE}" pid="7" name="_ExtendedDescription">
    <vt:lpwstr/>
  </property>
  <property fmtid="{D5CDD505-2E9C-101B-9397-08002B2CF9AE}" pid="8" name="TriggerFlowInfo">
    <vt:lpwstr/>
  </property>
  <property fmtid="{D5CDD505-2E9C-101B-9397-08002B2CF9AE}" pid="9" name="MediaServiceImageTags">
    <vt:lpwstr/>
  </property>
</Properties>
</file>